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0" r:id="rId3"/>
    <p:sldId id="262" r:id="rId4"/>
    <p:sldId id="264" r:id="rId5"/>
    <p:sldId id="267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4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453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35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539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796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76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915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627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628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092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483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581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93C3D-164B-482F-80E6-632119F7DC39}" type="datetimeFigureOut">
              <a:rPr lang="en-US" smtClean="0"/>
              <a:t>3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7D2D8-BBEB-4370-B721-BCD9CE295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203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png"/><Relationship Id="rId7" Type="http://schemas.openxmlformats.org/officeDocument/2006/relationships/image" Target="../media/image6.wmf"/><Relationship Id="rId12" Type="http://schemas.openxmlformats.org/officeDocument/2006/relationships/image" Target="../media/image11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w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image" Target="../media/image1.png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12" Type="http://schemas.openxmlformats.org/officeDocument/2006/relationships/image" Target="../media/image23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5" Type="http://schemas.openxmlformats.org/officeDocument/2006/relationships/image" Target="../media/image25.png"/><Relationship Id="rId10" Type="http://schemas.openxmlformats.org/officeDocument/2006/relationships/image" Target="../media/image21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Relationship Id="rId1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image" Target="../media/image36.emf"/><Relationship Id="rId7" Type="http://schemas.openxmlformats.org/officeDocument/2006/relationships/image" Target="../media/image40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emf"/><Relationship Id="rId5" Type="http://schemas.openxmlformats.org/officeDocument/2006/relationships/image" Target="../media/image38.emf"/><Relationship Id="rId10" Type="http://schemas.openxmlformats.org/officeDocument/2006/relationships/image" Target="../media/image43.emf"/><Relationship Id="rId4" Type="http://schemas.openxmlformats.org/officeDocument/2006/relationships/image" Target="../media/image37.emf"/><Relationship Id="rId9" Type="http://schemas.openxmlformats.org/officeDocument/2006/relationships/image" Target="../media/image4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6" name="Group 205">
            <a:extLst>
              <a:ext uri="{FF2B5EF4-FFF2-40B4-BE49-F238E27FC236}">
                <a16:creationId xmlns:a16="http://schemas.microsoft.com/office/drawing/2014/main" id="{BD961BF4-DB0B-7C3F-54E7-32919D99F420}"/>
              </a:ext>
            </a:extLst>
          </p:cNvPr>
          <p:cNvGrpSpPr/>
          <p:nvPr/>
        </p:nvGrpSpPr>
        <p:grpSpPr>
          <a:xfrm>
            <a:off x="45351" y="102970"/>
            <a:ext cx="3070787" cy="1402530"/>
            <a:chOff x="298445" y="30122"/>
            <a:chExt cx="3070787" cy="1402530"/>
          </a:xfrm>
        </p:grpSpPr>
        <p:cxnSp>
          <p:nvCxnSpPr>
            <p:cNvPr id="2" name="Straight Connector 1">
              <a:extLst>
                <a:ext uri="{FF2B5EF4-FFF2-40B4-BE49-F238E27FC236}">
                  <a16:creationId xmlns:a16="http://schemas.microsoft.com/office/drawing/2014/main" id="{FC263B65-FD24-9D37-B49B-7C850DC33819}"/>
                </a:ext>
              </a:extLst>
            </p:cNvPr>
            <p:cNvCxnSpPr>
              <a:cxnSpLocks/>
            </p:cNvCxnSpPr>
            <p:nvPr/>
          </p:nvCxnSpPr>
          <p:spPr>
            <a:xfrm>
              <a:off x="1063982" y="730763"/>
              <a:ext cx="2163933" cy="531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B793C52-2B5E-D0C1-F47C-8B8711A60A5F}"/>
                </a:ext>
              </a:extLst>
            </p:cNvPr>
            <p:cNvSpPr txBox="1"/>
            <p:nvPr/>
          </p:nvSpPr>
          <p:spPr>
            <a:xfrm>
              <a:off x="446839" y="30122"/>
              <a:ext cx="1253353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OVA-Texas Red +GC or PBS injected Sub Q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1688682-32AC-126F-429B-4292C41A274F}"/>
                </a:ext>
              </a:extLst>
            </p:cNvPr>
            <p:cNvSpPr txBox="1"/>
            <p:nvPr/>
          </p:nvSpPr>
          <p:spPr>
            <a:xfrm>
              <a:off x="658609" y="820734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95D739F-757F-506F-B80F-E45F73792222}"/>
                </a:ext>
              </a:extLst>
            </p:cNvPr>
            <p:cNvSpPr txBox="1"/>
            <p:nvPr/>
          </p:nvSpPr>
          <p:spPr>
            <a:xfrm>
              <a:off x="1673944" y="30122"/>
              <a:ext cx="1256469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Whole body fluorescence imaging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61CA104-5851-73A3-D415-8B2463491ADD}"/>
                </a:ext>
              </a:extLst>
            </p:cNvPr>
            <p:cNvSpPr txBox="1"/>
            <p:nvPr/>
          </p:nvSpPr>
          <p:spPr>
            <a:xfrm>
              <a:off x="2356854" y="434770"/>
              <a:ext cx="4504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5593C34-82DC-3D75-24EF-5D6270EBA3C2}"/>
                </a:ext>
              </a:extLst>
            </p:cNvPr>
            <p:cNvGrpSpPr/>
            <p:nvPr/>
          </p:nvGrpSpPr>
          <p:grpSpPr>
            <a:xfrm>
              <a:off x="298445" y="644926"/>
              <a:ext cx="855031" cy="787726"/>
              <a:chOff x="-3766236" y="1951416"/>
              <a:chExt cx="4769232" cy="3932697"/>
            </a:xfrm>
          </p:grpSpPr>
          <p:pic>
            <p:nvPicPr>
              <p:cNvPr id="8" name="Picture 2">
                <a:extLst>
                  <a:ext uri="{FF2B5EF4-FFF2-40B4-BE49-F238E27FC236}">
                    <a16:creationId xmlns:a16="http://schemas.microsoft.com/office/drawing/2014/main" id="{2532623A-0A36-12A9-351F-609D2DFD596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6030267" flipV="1">
                <a:off x="-3685625" y="1870805"/>
                <a:ext cx="2189088" cy="23503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BD0103CE-379E-BF7C-2ADC-43C50A0E0DCC}"/>
                  </a:ext>
                </a:extLst>
              </p:cNvPr>
              <p:cNvGrpSpPr/>
              <p:nvPr/>
            </p:nvGrpSpPr>
            <p:grpSpPr>
              <a:xfrm>
                <a:off x="-2219107" y="4183944"/>
                <a:ext cx="3222103" cy="1700169"/>
                <a:chOff x="-2219107" y="4183944"/>
                <a:chExt cx="3222103" cy="1700169"/>
              </a:xfrm>
            </p:grpSpPr>
            <p:sp>
              <p:nvSpPr>
                <p:cNvPr id="10" name="Isosceles Triangle 2">
                  <a:extLst>
                    <a:ext uri="{FF2B5EF4-FFF2-40B4-BE49-F238E27FC236}">
                      <a16:creationId xmlns:a16="http://schemas.microsoft.com/office/drawing/2014/main" id="{4259B07D-5F73-266C-CD8D-222F3CE8450E}"/>
                    </a:ext>
                  </a:extLst>
                </p:cNvPr>
                <p:cNvSpPr/>
                <p:nvPr/>
              </p:nvSpPr>
              <p:spPr>
                <a:xfrm rot="20837633">
                  <a:off x="-131151" y="4183944"/>
                  <a:ext cx="603764" cy="762170"/>
                </a:xfrm>
                <a:custGeom>
                  <a:avLst/>
                  <a:gdLst>
                    <a:gd name="connsiteX0" fmla="*/ 0 w 1060704"/>
                    <a:gd name="connsiteY0" fmla="*/ 914400 h 914400"/>
                    <a:gd name="connsiteX1" fmla="*/ 530352 w 1060704"/>
                    <a:gd name="connsiteY1" fmla="*/ 0 h 914400"/>
                    <a:gd name="connsiteX2" fmla="*/ 1060704 w 1060704"/>
                    <a:gd name="connsiteY2" fmla="*/ 914400 h 914400"/>
                    <a:gd name="connsiteX3" fmla="*/ 0 w 1060704"/>
                    <a:gd name="connsiteY3" fmla="*/ 914400 h 914400"/>
                    <a:gd name="connsiteX0" fmla="*/ 0 w 1072262"/>
                    <a:gd name="connsiteY0" fmla="*/ 914400 h 914400"/>
                    <a:gd name="connsiteX1" fmla="*/ 530352 w 1072262"/>
                    <a:gd name="connsiteY1" fmla="*/ 0 h 914400"/>
                    <a:gd name="connsiteX2" fmla="*/ 1060704 w 1072262"/>
                    <a:gd name="connsiteY2" fmla="*/ 914400 h 914400"/>
                    <a:gd name="connsiteX3" fmla="*/ 0 w 1072262"/>
                    <a:gd name="connsiteY3" fmla="*/ 914400 h 914400"/>
                    <a:gd name="connsiteX0" fmla="*/ 11558 w 1083820"/>
                    <a:gd name="connsiteY0" fmla="*/ 914400 h 914400"/>
                    <a:gd name="connsiteX1" fmla="*/ 541910 w 1083820"/>
                    <a:gd name="connsiteY1" fmla="*/ 0 h 914400"/>
                    <a:gd name="connsiteX2" fmla="*/ 1072262 w 1083820"/>
                    <a:gd name="connsiteY2" fmla="*/ 914400 h 914400"/>
                    <a:gd name="connsiteX3" fmla="*/ 11558 w 1083820"/>
                    <a:gd name="connsiteY3" fmla="*/ 914400 h 91440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83351 w 804599"/>
                    <a:gd name="connsiteY0" fmla="*/ 774849 h 970119"/>
                    <a:gd name="connsiteX1" fmla="*/ 270803 w 804599"/>
                    <a:gd name="connsiteY1" fmla="*/ 149 h 970119"/>
                    <a:gd name="connsiteX2" fmla="*/ 801155 w 804599"/>
                    <a:gd name="connsiteY2" fmla="*/ 914549 h 970119"/>
                    <a:gd name="connsiteX3" fmla="*/ 83351 w 804599"/>
                    <a:gd name="connsiteY3" fmla="*/ 774849 h 970119"/>
                    <a:gd name="connsiteX0" fmla="*/ 18984 w 763743"/>
                    <a:gd name="connsiteY0" fmla="*/ 597084 h 774288"/>
                    <a:gd name="connsiteX1" fmla="*/ 396936 w 763743"/>
                    <a:gd name="connsiteY1" fmla="*/ 184 h 774288"/>
                    <a:gd name="connsiteX2" fmla="*/ 736788 w 763743"/>
                    <a:gd name="connsiteY2" fmla="*/ 736784 h 774288"/>
                    <a:gd name="connsiteX3" fmla="*/ 18984 w 763743"/>
                    <a:gd name="connsiteY3" fmla="*/ 597084 h 7742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63743" h="774288">
                      <a:moveTo>
                        <a:pt x="18984" y="597084"/>
                      </a:moveTo>
                      <a:cubicBezTo>
                        <a:pt x="-37658" y="474317"/>
                        <a:pt x="16952" y="12884"/>
                        <a:pt x="396936" y="184"/>
                      </a:cubicBezTo>
                      <a:cubicBezTo>
                        <a:pt x="776920" y="-12516"/>
                        <a:pt x="799780" y="637301"/>
                        <a:pt x="736788" y="736784"/>
                      </a:cubicBezTo>
                      <a:cubicBezTo>
                        <a:pt x="673796" y="836267"/>
                        <a:pt x="75626" y="719851"/>
                        <a:pt x="18984" y="597084"/>
                      </a:cubicBez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1" name="Freeform 1">
                  <a:extLst>
                    <a:ext uri="{FF2B5EF4-FFF2-40B4-BE49-F238E27FC236}">
                      <a16:creationId xmlns:a16="http://schemas.microsoft.com/office/drawing/2014/main" id="{95F53083-534D-775F-3023-78308969C816}"/>
                    </a:ext>
                  </a:extLst>
                </p:cNvPr>
                <p:cNvSpPr/>
                <p:nvPr/>
              </p:nvSpPr>
              <p:spPr>
                <a:xfrm>
                  <a:off x="-1962985" y="4253096"/>
                  <a:ext cx="2905742" cy="1309420"/>
                </a:xfrm>
                <a:custGeom>
                  <a:avLst/>
                  <a:gdLst>
                    <a:gd name="connsiteX0" fmla="*/ 406400 w 3594100"/>
                    <a:gd name="connsiteY0" fmla="*/ 952500 h 952500"/>
                    <a:gd name="connsiteX1" fmla="*/ 3594100 w 3594100"/>
                    <a:gd name="connsiteY1" fmla="*/ 939800 h 952500"/>
                    <a:gd name="connsiteX2" fmla="*/ 2616200 w 3594100"/>
                    <a:gd name="connsiteY2" fmla="*/ 0 h 952500"/>
                    <a:gd name="connsiteX3" fmla="*/ 838200 w 3594100"/>
                    <a:gd name="connsiteY3" fmla="*/ 12700 h 952500"/>
                    <a:gd name="connsiteX4" fmla="*/ 177800 w 3594100"/>
                    <a:gd name="connsiteY4" fmla="*/ 177800 h 952500"/>
                    <a:gd name="connsiteX5" fmla="*/ 0 w 3594100"/>
                    <a:gd name="connsiteY5" fmla="*/ 520700 h 952500"/>
                    <a:gd name="connsiteX6" fmla="*/ 406400 w 3594100"/>
                    <a:gd name="connsiteY6" fmla="*/ 952500 h 952500"/>
                    <a:gd name="connsiteX0" fmla="*/ 406400 w 3681450"/>
                    <a:gd name="connsiteY0" fmla="*/ 1024552 h 1024552"/>
                    <a:gd name="connsiteX1" fmla="*/ 3594100 w 3681450"/>
                    <a:gd name="connsiteY1" fmla="*/ 1011852 h 1024552"/>
                    <a:gd name="connsiteX2" fmla="*/ 2616200 w 3681450"/>
                    <a:gd name="connsiteY2" fmla="*/ 72052 h 1024552"/>
                    <a:gd name="connsiteX3" fmla="*/ 838200 w 3681450"/>
                    <a:gd name="connsiteY3" fmla="*/ 84752 h 1024552"/>
                    <a:gd name="connsiteX4" fmla="*/ 177800 w 3681450"/>
                    <a:gd name="connsiteY4" fmla="*/ 249852 h 1024552"/>
                    <a:gd name="connsiteX5" fmla="*/ 0 w 3681450"/>
                    <a:gd name="connsiteY5" fmla="*/ 592752 h 1024552"/>
                    <a:gd name="connsiteX6" fmla="*/ 406400 w 3681450"/>
                    <a:gd name="connsiteY6" fmla="*/ 1024552 h 1024552"/>
                    <a:gd name="connsiteX0" fmla="*/ 406400 w 3681450"/>
                    <a:gd name="connsiteY0" fmla="*/ 1030895 h 1030895"/>
                    <a:gd name="connsiteX1" fmla="*/ 3594100 w 3681450"/>
                    <a:gd name="connsiteY1" fmla="*/ 1018195 h 1030895"/>
                    <a:gd name="connsiteX2" fmla="*/ 2616200 w 3681450"/>
                    <a:gd name="connsiteY2" fmla="*/ 78395 h 1030895"/>
                    <a:gd name="connsiteX3" fmla="*/ 838200 w 3681450"/>
                    <a:gd name="connsiteY3" fmla="*/ 91095 h 1030895"/>
                    <a:gd name="connsiteX4" fmla="*/ 177800 w 3681450"/>
                    <a:gd name="connsiteY4" fmla="*/ 256195 h 1030895"/>
                    <a:gd name="connsiteX5" fmla="*/ 0 w 3681450"/>
                    <a:gd name="connsiteY5" fmla="*/ 599095 h 1030895"/>
                    <a:gd name="connsiteX6" fmla="*/ 406400 w 3681450"/>
                    <a:gd name="connsiteY6" fmla="*/ 1030895 h 1030895"/>
                    <a:gd name="connsiteX0" fmla="*/ 426405 w 3701455"/>
                    <a:gd name="connsiteY0" fmla="*/ 1030895 h 1030895"/>
                    <a:gd name="connsiteX1" fmla="*/ 3614105 w 3701455"/>
                    <a:gd name="connsiteY1" fmla="*/ 1018195 h 1030895"/>
                    <a:gd name="connsiteX2" fmla="*/ 2636205 w 3701455"/>
                    <a:gd name="connsiteY2" fmla="*/ 78395 h 1030895"/>
                    <a:gd name="connsiteX3" fmla="*/ 858205 w 3701455"/>
                    <a:gd name="connsiteY3" fmla="*/ 91095 h 1030895"/>
                    <a:gd name="connsiteX4" fmla="*/ 197805 w 3701455"/>
                    <a:gd name="connsiteY4" fmla="*/ 256195 h 1030895"/>
                    <a:gd name="connsiteX5" fmla="*/ 20005 w 3701455"/>
                    <a:gd name="connsiteY5" fmla="*/ 599095 h 1030895"/>
                    <a:gd name="connsiteX6" fmla="*/ 426405 w 3701455"/>
                    <a:gd name="connsiteY6" fmla="*/ 1030895 h 1030895"/>
                    <a:gd name="connsiteX0" fmla="*/ 455433 w 3730483"/>
                    <a:gd name="connsiteY0" fmla="*/ 1030895 h 1030895"/>
                    <a:gd name="connsiteX1" fmla="*/ 3643133 w 3730483"/>
                    <a:gd name="connsiteY1" fmla="*/ 1018195 h 1030895"/>
                    <a:gd name="connsiteX2" fmla="*/ 2665233 w 3730483"/>
                    <a:gd name="connsiteY2" fmla="*/ 78395 h 1030895"/>
                    <a:gd name="connsiteX3" fmla="*/ 887233 w 3730483"/>
                    <a:gd name="connsiteY3" fmla="*/ 91095 h 1030895"/>
                    <a:gd name="connsiteX4" fmla="*/ 226833 w 3730483"/>
                    <a:gd name="connsiteY4" fmla="*/ 256195 h 1030895"/>
                    <a:gd name="connsiteX5" fmla="*/ 49033 w 3730483"/>
                    <a:gd name="connsiteY5" fmla="*/ 599095 h 1030895"/>
                    <a:gd name="connsiteX6" fmla="*/ 455433 w 3730483"/>
                    <a:gd name="connsiteY6" fmla="*/ 1030895 h 1030895"/>
                    <a:gd name="connsiteX0" fmla="*/ 455433 w 3730483"/>
                    <a:gd name="connsiteY0" fmla="*/ 1030895 h 1138085"/>
                    <a:gd name="connsiteX1" fmla="*/ 3643133 w 3730483"/>
                    <a:gd name="connsiteY1" fmla="*/ 1018195 h 1138085"/>
                    <a:gd name="connsiteX2" fmla="*/ 2665233 w 3730483"/>
                    <a:gd name="connsiteY2" fmla="*/ 78395 h 1138085"/>
                    <a:gd name="connsiteX3" fmla="*/ 887233 w 3730483"/>
                    <a:gd name="connsiteY3" fmla="*/ 91095 h 1138085"/>
                    <a:gd name="connsiteX4" fmla="*/ 226833 w 3730483"/>
                    <a:gd name="connsiteY4" fmla="*/ 256195 h 1138085"/>
                    <a:gd name="connsiteX5" fmla="*/ 49033 w 3730483"/>
                    <a:gd name="connsiteY5" fmla="*/ 599095 h 1138085"/>
                    <a:gd name="connsiteX6" fmla="*/ 455433 w 3730483"/>
                    <a:gd name="connsiteY6" fmla="*/ 1030895 h 1138085"/>
                    <a:gd name="connsiteX0" fmla="*/ 410132 w 3685182"/>
                    <a:gd name="connsiteY0" fmla="*/ 1018906 h 1126096"/>
                    <a:gd name="connsiteX1" fmla="*/ 3597832 w 3685182"/>
                    <a:gd name="connsiteY1" fmla="*/ 1006206 h 1126096"/>
                    <a:gd name="connsiteX2" fmla="*/ 2619932 w 3685182"/>
                    <a:gd name="connsiteY2" fmla="*/ 66406 h 1126096"/>
                    <a:gd name="connsiteX3" fmla="*/ 841932 w 3685182"/>
                    <a:gd name="connsiteY3" fmla="*/ 79106 h 1126096"/>
                    <a:gd name="connsiteX4" fmla="*/ 245032 w 3685182"/>
                    <a:gd name="connsiteY4" fmla="*/ 91806 h 1126096"/>
                    <a:gd name="connsiteX5" fmla="*/ 3732 w 3685182"/>
                    <a:gd name="connsiteY5" fmla="*/ 587106 h 1126096"/>
                    <a:gd name="connsiteX6" fmla="*/ 410132 w 3685182"/>
                    <a:gd name="connsiteY6" fmla="*/ 1018906 h 1126096"/>
                    <a:gd name="connsiteX0" fmla="*/ 460743 w 3743071"/>
                    <a:gd name="connsiteY0" fmla="*/ 1034427 h 1141617"/>
                    <a:gd name="connsiteX1" fmla="*/ 3648443 w 3743071"/>
                    <a:gd name="connsiteY1" fmla="*/ 1021727 h 1141617"/>
                    <a:gd name="connsiteX2" fmla="*/ 2670543 w 3743071"/>
                    <a:gd name="connsiteY2" fmla="*/ 81927 h 1141617"/>
                    <a:gd name="connsiteX3" fmla="*/ 295643 w 3743071"/>
                    <a:gd name="connsiteY3" fmla="*/ 107327 h 1141617"/>
                    <a:gd name="connsiteX4" fmla="*/ 54343 w 3743071"/>
                    <a:gd name="connsiteY4" fmla="*/ 602627 h 1141617"/>
                    <a:gd name="connsiteX5" fmla="*/ 460743 w 3743071"/>
                    <a:gd name="connsiteY5" fmla="*/ 1034427 h 1141617"/>
                    <a:gd name="connsiteX0" fmla="*/ 433140 w 3684200"/>
                    <a:gd name="connsiteY0" fmla="*/ 1157215 h 1264405"/>
                    <a:gd name="connsiteX1" fmla="*/ 3620840 w 3684200"/>
                    <a:gd name="connsiteY1" fmla="*/ 1144515 h 1264405"/>
                    <a:gd name="connsiteX2" fmla="*/ 2096840 w 3684200"/>
                    <a:gd name="connsiteY2" fmla="*/ 52315 h 1264405"/>
                    <a:gd name="connsiteX3" fmla="*/ 268040 w 3684200"/>
                    <a:gd name="connsiteY3" fmla="*/ 230115 h 1264405"/>
                    <a:gd name="connsiteX4" fmla="*/ 26740 w 3684200"/>
                    <a:gd name="connsiteY4" fmla="*/ 725415 h 1264405"/>
                    <a:gd name="connsiteX5" fmla="*/ 433140 w 3684200"/>
                    <a:gd name="connsiteY5" fmla="*/ 1157215 h 1264405"/>
                    <a:gd name="connsiteX0" fmla="*/ 407817 w 3658178"/>
                    <a:gd name="connsiteY0" fmla="*/ 1223049 h 1330239"/>
                    <a:gd name="connsiteX1" fmla="*/ 3595517 w 3658178"/>
                    <a:gd name="connsiteY1" fmla="*/ 1210349 h 1330239"/>
                    <a:gd name="connsiteX2" fmla="*/ 2071517 w 3658178"/>
                    <a:gd name="connsiteY2" fmla="*/ 118149 h 1330239"/>
                    <a:gd name="connsiteX3" fmla="*/ 357017 w 3658178"/>
                    <a:gd name="connsiteY3" fmla="*/ 105449 h 1330239"/>
                    <a:gd name="connsiteX4" fmla="*/ 1417 w 3658178"/>
                    <a:gd name="connsiteY4" fmla="*/ 791249 h 1330239"/>
                    <a:gd name="connsiteX5" fmla="*/ 407817 w 3658178"/>
                    <a:gd name="connsiteY5" fmla="*/ 1223049 h 1330239"/>
                    <a:gd name="connsiteX0" fmla="*/ 407817 w 3658178"/>
                    <a:gd name="connsiteY0" fmla="*/ 1223049 h 1330239"/>
                    <a:gd name="connsiteX1" fmla="*/ 3595517 w 3658178"/>
                    <a:gd name="connsiteY1" fmla="*/ 1210349 h 1330239"/>
                    <a:gd name="connsiteX2" fmla="*/ 2071517 w 3658178"/>
                    <a:gd name="connsiteY2" fmla="*/ 118149 h 1330239"/>
                    <a:gd name="connsiteX3" fmla="*/ 357017 w 3658178"/>
                    <a:gd name="connsiteY3" fmla="*/ 105449 h 1330239"/>
                    <a:gd name="connsiteX4" fmla="*/ 1417 w 3658178"/>
                    <a:gd name="connsiteY4" fmla="*/ 791249 h 1330239"/>
                    <a:gd name="connsiteX5" fmla="*/ 407817 w 3658178"/>
                    <a:gd name="connsiteY5" fmla="*/ 1223049 h 1330239"/>
                    <a:gd name="connsiteX0" fmla="*/ 425312 w 3675673"/>
                    <a:gd name="connsiteY0" fmla="*/ 1223049 h 1330239"/>
                    <a:gd name="connsiteX1" fmla="*/ 3613012 w 3675673"/>
                    <a:gd name="connsiteY1" fmla="*/ 1210349 h 1330239"/>
                    <a:gd name="connsiteX2" fmla="*/ 2089012 w 3675673"/>
                    <a:gd name="connsiteY2" fmla="*/ 118149 h 1330239"/>
                    <a:gd name="connsiteX3" fmla="*/ 374512 w 3675673"/>
                    <a:gd name="connsiteY3" fmla="*/ 105449 h 1330239"/>
                    <a:gd name="connsiteX4" fmla="*/ 18912 w 3675673"/>
                    <a:gd name="connsiteY4" fmla="*/ 791249 h 1330239"/>
                    <a:gd name="connsiteX5" fmla="*/ 425312 w 3675673"/>
                    <a:gd name="connsiteY5" fmla="*/ 1223049 h 133023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3675673" h="1330239">
                      <a:moveTo>
                        <a:pt x="425312" y="1223049"/>
                      </a:moveTo>
                      <a:cubicBezTo>
                        <a:pt x="560779" y="1366982"/>
                        <a:pt x="3244712" y="1369099"/>
                        <a:pt x="3613012" y="1210349"/>
                      </a:cubicBezTo>
                      <a:cubicBezTo>
                        <a:pt x="3981312" y="1051599"/>
                        <a:pt x="2628762" y="302299"/>
                        <a:pt x="2089012" y="118149"/>
                      </a:cubicBezTo>
                      <a:cubicBezTo>
                        <a:pt x="1549262" y="-66001"/>
                        <a:pt x="719529" y="-6734"/>
                        <a:pt x="374512" y="105449"/>
                      </a:cubicBezTo>
                      <a:cubicBezTo>
                        <a:pt x="29495" y="217632"/>
                        <a:pt x="-40355" y="579582"/>
                        <a:pt x="18912" y="791249"/>
                      </a:cubicBezTo>
                      <a:cubicBezTo>
                        <a:pt x="78179" y="1002916"/>
                        <a:pt x="289845" y="1079116"/>
                        <a:pt x="425312" y="1223049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n>
                      <a:solidFill>
                        <a:sysClr val="windowText" lastClr="000000"/>
                      </a:solidFill>
                    </a:ln>
                    <a:solidFill>
                      <a:sysClr val="windowText" lastClr="000000"/>
                    </a:solidFill>
                  </a:endParaRPr>
                </a:p>
              </p:txBody>
            </p:sp>
            <p:sp>
              <p:nvSpPr>
                <p:cNvPr id="12" name="Isosceles Triangle 2">
                  <a:extLst>
                    <a:ext uri="{FF2B5EF4-FFF2-40B4-BE49-F238E27FC236}">
                      <a16:creationId xmlns:a16="http://schemas.microsoft.com/office/drawing/2014/main" id="{477C9083-BA02-97D0-8F32-8537979D80D7}"/>
                    </a:ext>
                  </a:extLst>
                </p:cNvPr>
                <p:cNvSpPr/>
                <p:nvPr/>
              </p:nvSpPr>
              <p:spPr>
                <a:xfrm rot="20837633">
                  <a:off x="-311866" y="4258951"/>
                  <a:ext cx="603764" cy="762170"/>
                </a:xfrm>
                <a:custGeom>
                  <a:avLst/>
                  <a:gdLst>
                    <a:gd name="connsiteX0" fmla="*/ 0 w 1060704"/>
                    <a:gd name="connsiteY0" fmla="*/ 914400 h 914400"/>
                    <a:gd name="connsiteX1" fmla="*/ 530352 w 1060704"/>
                    <a:gd name="connsiteY1" fmla="*/ 0 h 914400"/>
                    <a:gd name="connsiteX2" fmla="*/ 1060704 w 1060704"/>
                    <a:gd name="connsiteY2" fmla="*/ 914400 h 914400"/>
                    <a:gd name="connsiteX3" fmla="*/ 0 w 1060704"/>
                    <a:gd name="connsiteY3" fmla="*/ 914400 h 914400"/>
                    <a:gd name="connsiteX0" fmla="*/ 0 w 1072262"/>
                    <a:gd name="connsiteY0" fmla="*/ 914400 h 914400"/>
                    <a:gd name="connsiteX1" fmla="*/ 530352 w 1072262"/>
                    <a:gd name="connsiteY1" fmla="*/ 0 h 914400"/>
                    <a:gd name="connsiteX2" fmla="*/ 1060704 w 1072262"/>
                    <a:gd name="connsiteY2" fmla="*/ 914400 h 914400"/>
                    <a:gd name="connsiteX3" fmla="*/ 0 w 1072262"/>
                    <a:gd name="connsiteY3" fmla="*/ 914400 h 914400"/>
                    <a:gd name="connsiteX0" fmla="*/ 11558 w 1083820"/>
                    <a:gd name="connsiteY0" fmla="*/ 914400 h 914400"/>
                    <a:gd name="connsiteX1" fmla="*/ 541910 w 1083820"/>
                    <a:gd name="connsiteY1" fmla="*/ 0 h 914400"/>
                    <a:gd name="connsiteX2" fmla="*/ 1072262 w 1083820"/>
                    <a:gd name="connsiteY2" fmla="*/ 914400 h 914400"/>
                    <a:gd name="connsiteX3" fmla="*/ 11558 w 1083820"/>
                    <a:gd name="connsiteY3" fmla="*/ 914400 h 91440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83351 w 804599"/>
                    <a:gd name="connsiteY0" fmla="*/ 774849 h 970119"/>
                    <a:gd name="connsiteX1" fmla="*/ 270803 w 804599"/>
                    <a:gd name="connsiteY1" fmla="*/ 149 h 970119"/>
                    <a:gd name="connsiteX2" fmla="*/ 801155 w 804599"/>
                    <a:gd name="connsiteY2" fmla="*/ 914549 h 970119"/>
                    <a:gd name="connsiteX3" fmla="*/ 83351 w 804599"/>
                    <a:gd name="connsiteY3" fmla="*/ 774849 h 970119"/>
                    <a:gd name="connsiteX0" fmla="*/ 18984 w 763743"/>
                    <a:gd name="connsiteY0" fmla="*/ 597084 h 774288"/>
                    <a:gd name="connsiteX1" fmla="*/ 396936 w 763743"/>
                    <a:gd name="connsiteY1" fmla="*/ 184 h 774288"/>
                    <a:gd name="connsiteX2" fmla="*/ 736788 w 763743"/>
                    <a:gd name="connsiteY2" fmla="*/ 736784 h 774288"/>
                    <a:gd name="connsiteX3" fmla="*/ 18984 w 763743"/>
                    <a:gd name="connsiteY3" fmla="*/ 597084 h 7742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63743" h="774288">
                      <a:moveTo>
                        <a:pt x="18984" y="597084"/>
                      </a:moveTo>
                      <a:cubicBezTo>
                        <a:pt x="-37658" y="474317"/>
                        <a:pt x="16952" y="12884"/>
                        <a:pt x="396936" y="184"/>
                      </a:cubicBezTo>
                      <a:cubicBezTo>
                        <a:pt x="776920" y="-12516"/>
                        <a:pt x="799780" y="637301"/>
                        <a:pt x="736788" y="736784"/>
                      </a:cubicBezTo>
                      <a:cubicBezTo>
                        <a:pt x="673796" y="836267"/>
                        <a:pt x="75626" y="719851"/>
                        <a:pt x="18984" y="597084"/>
                      </a:cubicBez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3" name="Oval 12">
                  <a:extLst>
                    <a:ext uri="{FF2B5EF4-FFF2-40B4-BE49-F238E27FC236}">
                      <a16:creationId xmlns:a16="http://schemas.microsoft.com/office/drawing/2014/main" id="{E89D00D4-F610-5480-E708-DAF319B51235}"/>
                    </a:ext>
                  </a:extLst>
                </p:cNvPr>
                <p:cNvSpPr/>
                <p:nvPr/>
              </p:nvSpPr>
              <p:spPr>
                <a:xfrm>
                  <a:off x="412059" y="4960584"/>
                  <a:ext cx="240955" cy="267769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4" name="Freeform 5">
                  <a:extLst>
                    <a:ext uri="{FF2B5EF4-FFF2-40B4-BE49-F238E27FC236}">
                      <a16:creationId xmlns:a16="http://schemas.microsoft.com/office/drawing/2014/main" id="{8D31BD5A-18DE-2C4F-9138-CF2062AE65A5}"/>
                    </a:ext>
                  </a:extLst>
                </p:cNvPr>
                <p:cNvSpPr/>
                <p:nvPr/>
              </p:nvSpPr>
              <p:spPr>
                <a:xfrm>
                  <a:off x="-2219107" y="4619420"/>
                  <a:ext cx="1589856" cy="1264693"/>
                </a:xfrm>
                <a:custGeom>
                  <a:avLst/>
                  <a:gdLst>
                    <a:gd name="connsiteX0" fmla="*/ 292672 w 2007172"/>
                    <a:gd name="connsiteY0" fmla="*/ 152400 h 1282700"/>
                    <a:gd name="connsiteX1" fmla="*/ 191072 w 2007172"/>
                    <a:gd name="connsiteY1" fmla="*/ 292100 h 1282700"/>
                    <a:gd name="connsiteX2" fmla="*/ 127572 w 2007172"/>
                    <a:gd name="connsiteY2" fmla="*/ 622300 h 1282700"/>
                    <a:gd name="connsiteX3" fmla="*/ 241872 w 2007172"/>
                    <a:gd name="connsiteY3" fmla="*/ 825500 h 1282700"/>
                    <a:gd name="connsiteX4" fmla="*/ 470472 w 2007172"/>
                    <a:gd name="connsiteY4" fmla="*/ 1041400 h 1282700"/>
                    <a:gd name="connsiteX5" fmla="*/ 851472 w 2007172"/>
                    <a:gd name="connsiteY5" fmla="*/ 1143000 h 1282700"/>
                    <a:gd name="connsiteX6" fmla="*/ 1168972 w 2007172"/>
                    <a:gd name="connsiteY6" fmla="*/ 1155700 h 1282700"/>
                    <a:gd name="connsiteX7" fmla="*/ 1588072 w 2007172"/>
                    <a:gd name="connsiteY7" fmla="*/ 1130300 h 1282700"/>
                    <a:gd name="connsiteX8" fmla="*/ 2007172 w 2007172"/>
                    <a:gd name="connsiteY8" fmla="*/ 1028700 h 1282700"/>
                    <a:gd name="connsiteX9" fmla="*/ 1778572 w 2007172"/>
                    <a:gd name="connsiteY9" fmla="*/ 1206500 h 1282700"/>
                    <a:gd name="connsiteX10" fmla="*/ 1295972 w 2007172"/>
                    <a:gd name="connsiteY10" fmla="*/ 1270000 h 1282700"/>
                    <a:gd name="connsiteX11" fmla="*/ 991172 w 2007172"/>
                    <a:gd name="connsiteY11" fmla="*/ 1282700 h 1282700"/>
                    <a:gd name="connsiteX12" fmla="*/ 584772 w 2007172"/>
                    <a:gd name="connsiteY12" fmla="*/ 1270000 h 1282700"/>
                    <a:gd name="connsiteX13" fmla="*/ 292672 w 2007172"/>
                    <a:gd name="connsiteY13" fmla="*/ 1104900 h 1282700"/>
                    <a:gd name="connsiteX14" fmla="*/ 102172 w 2007172"/>
                    <a:gd name="connsiteY14" fmla="*/ 889000 h 1282700"/>
                    <a:gd name="connsiteX15" fmla="*/ 13272 w 2007172"/>
                    <a:gd name="connsiteY15" fmla="*/ 660400 h 1282700"/>
                    <a:gd name="connsiteX16" fmla="*/ 572 w 2007172"/>
                    <a:gd name="connsiteY16" fmla="*/ 419100 h 1282700"/>
                    <a:gd name="connsiteX17" fmla="*/ 572 w 2007172"/>
                    <a:gd name="connsiteY17" fmla="*/ 419100 h 1282700"/>
                    <a:gd name="connsiteX18" fmla="*/ 89472 w 2007172"/>
                    <a:gd name="connsiteY18" fmla="*/ 139700 h 1282700"/>
                    <a:gd name="connsiteX19" fmla="*/ 279972 w 2007172"/>
                    <a:gd name="connsiteY19" fmla="*/ 0 h 1282700"/>
                    <a:gd name="connsiteX20" fmla="*/ 356172 w 2007172"/>
                    <a:gd name="connsiteY20" fmla="*/ 0 h 1282700"/>
                    <a:gd name="connsiteX21" fmla="*/ 356172 w 2007172"/>
                    <a:gd name="connsiteY21" fmla="*/ 152400 h 1282700"/>
                    <a:gd name="connsiteX22" fmla="*/ 356172 w 2007172"/>
                    <a:gd name="connsiteY22" fmla="*/ 152400 h 1282700"/>
                    <a:gd name="connsiteX23" fmla="*/ 292672 w 2007172"/>
                    <a:gd name="connsiteY23" fmla="*/ 152400 h 1282700"/>
                    <a:gd name="connsiteX0" fmla="*/ 292672 w 2007172"/>
                    <a:gd name="connsiteY0" fmla="*/ 152400 h 1282700"/>
                    <a:gd name="connsiteX1" fmla="*/ 191072 w 2007172"/>
                    <a:gd name="connsiteY1" fmla="*/ 292100 h 1282700"/>
                    <a:gd name="connsiteX2" fmla="*/ 127572 w 2007172"/>
                    <a:gd name="connsiteY2" fmla="*/ 622300 h 1282700"/>
                    <a:gd name="connsiteX3" fmla="*/ 241872 w 2007172"/>
                    <a:gd name="connsiteY3" fmla="*/ 825500 h 1282700"/>
                    <a:gd name="connsiteX4" fmla="*/ 470472 w 2007172"/>
                    <a:gd name="connsiteY4" fmla="*/ 1041400 h 1282700"/>
                    <a:gd name="connsiteX5" fmla="*/ 851472 w 2007172"/>
                    <a:gd name="connsiteY5" fmla="*/ 1143000 h 1282700"/>
                    <a:gd name="connsiteX6" fmla="*/ 1168972 w 2007172"/>
                    <a:gd name="connsiteY6" fmla="*/ 1155700 h 1282700"/>
                    <a:gd name="connsiteX7" fmla="*/ 1588072 w 2007172"/>
                    <a:gd name="connsiteY7" fmla="*/ 1130300 h 1282700"/>
                    <a:gd name="connsiteX8" fmla="*/ 2007172 w 2007172"/>
                    <a:gd name="connsiteY8" fmla="*/ 1028700 h 1282700"/>
                    <a:gd name="connsiteX9" fmla="*/ 1778572 w 2007172"/>
                    <a:gd name="connsiteY9" fmla="*/ 1206500 h 1282700"/>
                    <a:gd name="connsiteX10" fmla="*/ 1295972 w 2007172"/>
                    <a:gd name="connsiteY10" fmla="*/ 1270000 h 1282700"/>
                    <a:gd name="connsiteX11" fmla="*/ 991172 w 2007172"/>
                    <a:gd name="connsiteY11" fmla="*/ 1282700 h 1282700"/>
                    <a:gd name="connsiteX12" fmla="*/ 584772 w 2007172"/>
                    <a:gd name="connsiteY12" fmla="*/ 1270000 h 1282700"/>
                    <a:gd name="connsiteX13" fmla="*/ 292672 w 2007172"/>
                    <a:gd name="connsiteY13" fmla="*/ 1104900 h 1282700"/>
                    <a:gd name="connsiteX14" fmla="*/ 102172 w 2007172"/>
                    <a:gd name="connsiteY14" fmla="*/ 889000 h 1282700"/>
                    <a:gd name="connsiteX15" fmla="*/ 13272 w 2007172"/>
                    <a:gd name="connsiteY15" fmla="*/ 660400 h 1282700"/>
                    <a:gd name="connsiteX16" fmla="*/ 572 w 2007172"/>
                    <a:gd name="connsiteY16" fmla="*/ 419100 h 1282700"/>
                    <a:gd name="connsiteX17" fmla="*/ 572 w 2007172"/>
                    <a:gd name="connsiteY17" fmla="*/ 419100 h 1282700"/>
                    <a:gd name="connsiteX18" fmla="*/ 89472 w 2007172"/>
                    <a:gd name="connsiteY18" fmla="*/ 139700 h 1282700"/>
                    <a:gd name="connsiteX19" fmla="*/ 279972 w 2007172"/>
                    <a:gd name="connsiteY19" fmla="*/ 0 h 1282700"/>
                    <a:gd name="connsiteX20" fmla="*/ 356172 w 2007172"/>
                    <a:gd name="connsiteY20" fmla="*/ 0 h 1282700"/>
                    <a:gd name="connsiteX21" fmla="*/ 356172 w 2007172"/>
                    <a:gd name="connsiteY21" fmla="*/ 152400 h 1282700"/>
                    <a:gd name="connsiteX22" fmla="*/ 356172 w 2007172"/>
                    <a:gd name="connsiteY22" fmla="*/ 152400 h 1282700"/>
                    <a:gd name="connsiteX23" fmla="*/ 292672 w 2007172"/>
                    <a:gd name="connsiteY23" fmla="*/ 152400 h 1282700"/>
                    <a:gd name="connsiteX0" fmla="*/ 292672 w 2007172"/>
                    <a:gd name="connsiteY0" fmla="*/ 152400 h 1282700"/>
                    <a:gd name="connsiteX1" fmla="*/ 191072 w 2007172"/>
                    <a:gd name="connsiteY1" fmla="*/ 292100 h 1282700"/>
                    <a:gd name="connsiteX2" fmla="*/ 127572 w 2007172"/>
                    <a:gd name="connsiteY2" fmla="*/ 622300 h 1282700"/>
                    <a:gd name="connsiteX3" fmla="*/ 241872 w 2007172"/>
                    <a:gd name="connsiteY3" fmla="*/ 825500 h 1282700"/>
                    <a:gd name="connsiteX4" fmla="*/ 470472 w 2007172"/>
                    <a:gd name="connsiteY4" fmla="*/ 1041400 h 1282700"/>
                    <a:gd name="connsiteX5" fmla="*/ 851472 w 2007172"/>
                    <a:gd name="connsiteY5" fmla="*/ 1143000 h 1282700"/>
                    <a:gd name="connsiteX6" fmla="*/ 1168972 w 2007172"/>
                    <a:gd name="connsiteY6" fmla="*/ 1155700 h 1282700"/>
                    <a:gd name="connsiteX7" fmla="*/ 1588072 w 2007172"/>
                    <a:gd name="connsiteY7" fmla="*/ 1130300 h 1282700"/>
                    <a:gd name="connsiteX8" fmla="*/ 2007172 w 2007172"/>
                    <a:gd name="connsiteY8" fmla="*/ 1028700 h 1282700"/>
                    <a:gd name="connsiteX9" fmla="*/ 1778572 w 2007172"/>
                    <a:gd name="connsiteY9" fmla="*/ 1206500 h 1282700"/>
                    <a:gd name="connsiteX10" fmla="*/ 1295972 w 2007172"/>
                    <a:gd name="connsiteY10" fmla="*/ 1270000 h 1282700"/>
                    <a:gd name="connsiteX11" fmla="*/ 991172 w 2007172"/>
                    <a:gd name="connsiteY11" fmla="*/ 1282700 h 1282700"/>
                    <a:gd name="connsiteX12" fmla="*/ 584772 w 2007172"/>
                    <a:gd name="connsiteY12" fmla="*/ 1270000 h 1282700"/>
                    <a:gd name="connsiteX13" fmla="*/ 292672 w 2007172"/>
                    <a:gd name="connsiteY13" fmla="*/ 1104900 h 1282700"/>
                    <a:gd name="connsiteX14" fmla="*/ 102172 w 2007172"/>
                    <a:gd name="connsiteY14" fmla="*/ 889000 h 1282700"/>
                    <a:gd name="connsiteX15" fmla="*/ 13272 w 2007172"/>
                    <a:gd name="connsiteY15" fmla="*/ 660400 h 1282700"/>
                    <a:gd name="connsiteX16" fmla="*/ 572 w 2007172"/>
                    <a:gd name="connsiteY16" fmla="*/ 419100 h 1282700"/>
                    <a:gd name="connsiteX17" fmla="*/ 572 w 2007172"/>
                    <a:gd name="connsiteY17" fmla="*/ 419100 h 1282700"/>
                    <a:gd name="connsiteX18" fmla="*/ 89472 w 2007172"/>
                    <a:gd name="connsiteY18" fmla="*/ 139700 h 1282700"/>
                    <a:gd name="connsiteX19" fmla="*/ 279972 w 2007172"/>
                    <a:gd name="connsiteY19" fmla="*/ 0 h 1282700"/>
                    <a:gd name="connsiteX20" fmla="*/ 356172 w 2007172"/>
                    <a:gd name="connsiteY20" fmla="*/ 0 h 1282700"/>
                    <a:gd name="connsiteX21" fmla="*/ 356172 w 2007172"/>
                    <a:gd name="connsiteY21" fmla="*/ 152400 h 1282700"/>
                    <a:gd name="connsiteX22" fmla="*/ 356172 w 2007172"/>
                    <a:gd name="connsiteY22" fmla="*/ 152400 h 1282700"/>
                    <a:gd name="connsiteX23" fmla="*/ 292672 w 2007172"/>
                    <a:gd name="connsiteY23" fmla="*/ 152400 h 1282700"/>
                    <a:gd name="connsiteX0" fmla="*/ 292100 w 2006600"/>
                    <a:gd name="connsiteY0" fmla="*/ 152400 h 1282700"/>
                    <a:gd name="connsiteX1" fmla="*/ 190500 w 2006600"/>
                    <a:gd name="connsiteY1" fmla="*/ 292100 h 1282700"/>
                    <a:gd name="connsiteX2" fmla="*/ 127000 w 2006600"/>
                    <a:gd name="connsiteY2" fmla="*/ 622300 h 1282700"/>
                    <a:gd name="connsiteX3" fmla="*/ 241300 w 2006600"/>
                    <a:gd name="connsiteY3" fmla="*/ 825500 h 1282700"/>
                    <a:gd name="connsiteX4" fmla="*/ 469900 w 2006600"/>
                    <a:gd name="connsiteY4" fmla="*/ 1041400 h 1282700"/>
                    <a:gd name="connsiteX5" fmla="*/ 850900 w 2006600"/>
                    <a:gd name="connsiteY5" fmla="*/ 1143000 h 1282700"/>
                    <a:gd name="connsiteX6" fmla="*/ 1168400 w 2006600"/>
                    <a:gd name="connsiteY6" fmla="*/ 1155700 h 1282700"/>
                    <a:gd name="connsiteX7" fmla="*/ 1587500 w 2006600"/>
                    <a:gd name="connsiteY7" fmla="*/ 1130300 h 1282700"/>
                    <a:gd name="connsiteX8" fmla="*/ 2006600 w 2006600"/>
                    <a:gd name="connsiteY8" fmla="*/ 1028700 h 1282700"/>
                    <a:gd name="connsiteX9" fmla="*/ 1778000 w 2006600"/>
                    <a:gd name="connsiteY9" fmla="*/ 1206500 h 1282700"/>
                    <a:gd name="connsiteX10" fmla="*/ 1295400 w 2006600"/>
                    <a:gd name="connsiteY10" fmla="*/ 1270000 h 1282700"/>
                    <a:gd name="connsiteX11" fmla="*/ 990600 w 2006600"/>
                    <a:gd name="connsiteY11" fmla="*/ 1282700 h 1282700"/>
                    <a:gd name="connsiteX12" fmla="*/ 584200 w 2006600"/>
                    <a:gd name="connsiteY12" fmla="*/ 1270000 h 1282700"/>
                    <a:gd name="connsiteX13" fmla="*/ 292100 w 2006600"/>
                    <a:gd name="connsiteY13" fmla="*/ 1104900 h 1282700"/>
                    <a:gd name="connsiteX14" fmla="*/ 101600 w 2006600"/>
                    <a:gd name="connsiteY14" fmla="*/ 889000 h 1282700"/>
                    <a:gd name="connsiteX15" fmla="*/ 12700 w 2006600"/>
                    <a:gd name="connsiteY15" fmla="*/ 660400 h 1282700"/>
                    <a:gd name="connsiteX16" fmla="*/ 0 w 2006600"/>
                    <a:gd name="connsiteY16" fmla="*/ 419100 h 1282700"/>
                    <a:gd name="connsiteX17" fmla="*/ 0 w 2006600"/>
                    <a:gd name="connsiteY17" fmla="*/ 419100 h 1282700"/>
                    <a:gd name="connsiteX18" fmla="*/ 88900 w 2006600"/>
                    <a:gd name="connsiteY18" fmla="*/ 139700 h 1282700"/>
                    <a:gd name="connsiteX19" fmla="*/ 279400 w 2006600"/>
                    <a:gd name="connsiteY19" fmla="*/ 0 h 1282700"/>
                    <a:gd name="connsiteX20" fmla="*/ 355600 w 2006600"/>
                    <a:gd name="connsiteY20" fmla="*/ 0 h 1282700"/>
                    <a:gd name="connsiteX21" fmla="*/ 355600 w 2006600"/>
                    <a:gd name="connsiteY21" fmla="*/ 152400 h 1282700"/>
                    <a:gd name="connsiteX22" fmla="*/ 355600 w 2006600"/>
                    <a:gd name="connsiteY22" fmla="*/ 152400 h 1282700"/>
                    <a:gd name="connsiteX23" fmla="*/ 292100 w 2006600"/>
                    <a:gd name="connsiteY23" fmla="*/ 152400 h 1282700"/>
                    <a:gd name="connsiteX0" fmla="*/ 292100 w 2006600"/>
                    <a:gd name="connsiteY0" fmla="*/ 152400 h 1282700"/>
                    <a:gd name="connsiteX1" fmla="*/ 190500 w 2006600"/>
                    <a:gd name="connsiteY1" fmla="*/ 292100 h 1282700"/>
                    <a:gd name="connsiteX2" fmla="*/ 127000 w 2006600"/>
                    <a:gd name="connsiteY2" fmla="*/ 622300 h 1282700"/>
                    <a:gd name="connsiteX3" fmla="*/ 241300 w 2006600"/>
                    <a:gd name="connsiteY3" fmla="*/ 825500 h 1282700"/>
                    <a:gd name="connsiteX4" fmla="*/ 469900 w 2006600"/>
                    <a:gd name="connsiteY4" fmla="*/ 1041400 h 1282700"/>
                    <a:gd name="connsiteX5" fmla="*/ 850900 w 2006600"/>
                    <a:gd name="connsiteY5" fmla="*/ 1143000 h 1282700"/>
                    <a:gd name="connsiteX6" fmla="*/ 1168400 w 2006600"/>
                    <a:gd name="connsiteY6" fmla="*/ 1155700 h 1282700"/>
                    <a:gd name="connsiteX7" fmla="*/ 1587500 w 2006600"/>
                    <a:gd name="connsiteY7" fmla="*/ 1130300 h 1282700"/>
                    <a:gd name="connsiteX8" fmla="*/ 2006600 w 2006600"/>
                    <a:gd name="connsiteY8" fmla="*/ 1028700 h 1282700"/>
                    <a:gd name="connsiteX9" fmla="*/ 1778000 w 2006600"/>
                    <a:gd name="connsiteY9" fmla="*/ 1206500 h 1282700"/>
                    <a:gd name="connsiteX10" fmla="*/ 1295400 w 2006600"/>
                    <a:gd name="connsiteY10" fmla="*/ 1270000 h 1282700"/>
                    <a:gd name="connsiteX11" fmla="*/ 990600 w 2006600"/>
                    <a:gd name="connsiteY11" fmla="*/ 1282700 h 1282700"/>
                    <a:gd name="connsiteX12" fmla="*/ 584200 w 2006600"/>
                    <a:gd name="connsiteY12" fmla="*/ 1270000 h 1282700"/>
                    <a:gd name="connsiteX13" fmla="*/ 292100 w 2006600"/>
                    <a:gd name="connsiteY13" fmla="*/ 1104900 h 1282700"/>
                    <a:gd name="connsiteX14" fmla="*/ 101600 w 2006600"/>
                    <a:gd name="connsiteY14" fmla="*/ 889000 h 1282700"/>
                    <a:gd name="connsiteX15" fmla="*/ 12700 w 2006600"/>
                    <a:gd name="connsiteY15" fmla="*/ 660400 h 1282700"/>
                    <a:gd name="connsiteX16" fmla="*/ 0 w 2006600"/>
                    <a:gd name="connsiteY16" fmla="*/ 419100 h 1282700"/>
                    <a:gd name="connsiteX17" fmla="*/ 0 w 2006600"/>
                    <a:gd name="connsiteY17" fmla="*/ 419100 h 1282700"/>
                    <a:gd name="connsiteX18" fmla="*/ 88900 w 2006600"/>
                    <a:gd name="connsiteY18" fmla="*/ 139700 h 1282700"/>
                    <a:gd name="connsiteX19" fmla="*/ 279400 w 2006600"/>
                    <a:gd name="connsiteY19" fmla="*/ 0 h 1282700"/>
                    <a:gd name="connsiteX20" fmla="*/ 355600 w 2006600"/>
                    <a:gd name="connsiteY20" fmla="*/ 0 h 1282700"/>
                    <a:gd name="connsiteX21" fmla="*/ 355600 w 2006600"/>
                    <a:gd name="connsiteY21" fmla="*/ 152400 h 1282700"/>
                    <a:gd name="connsiteX22" fmla="*/ 355600 w 2006600"/>
                    <a:gd name="connsiteY22" fmla="*/ 152400 h 1282700"/>
                    <a:gd name="connsiteX23" fmla="*/ 292100 w 2006600"/>
                    <a:gd name="connsiteY23" fmla="*/ 152400 h 1282700"/>
                    <a:gd name="connsiteX0" fmla="*/ 292100 w 2006600"/>
                    <a:gd name="connsiteY0" fmla="*/ 152400 h 1282700"/>
                    <a:gd name="connsiteX1" fmla="*/ 190500 w 2006600"/>
                    <a:gd name="connsiteY1" fmla="*/ 292100 h 1282700"/>
                    <a:gd name="connsiteX2" fmla="*/ 127000 w 2006600"/>
                    <a:gd name="connsiteY2" fmla="*/ 622300 h 1282700"/>
                    <a:gd name="connsiteX3" fmla="*/ 241300 w 2006600"/>
                    <a:gd name="connsiteY3" fmla="*/ 825500 h 1282700"/>
                    <a:gd name="connsiteX4" fmla="*/ 469900 w 2006600"/>
                    <a:gd name="connsiteY4" fmla="*/ 1041400 h 1282700"/>
                    <a:gd name="connsiteX5" fmla="*/ 850900 w 2006600"/>
                    <a:gd name="connsiteY5" fmla="*/ 1143000 h 1282700"/>
                    <a:gd name="connsiteX6" fmla="*/ 1168400 w 2006600"/>
                    <a:gd name="connsiteY6" fmla="*/ 1155700 h 1282700"/>
                    <a:gd name="connsiteX7" fmla="*/ 1587500 w 2006600"/>
                    <a:gd name="connsiteY7" fmla="*/ 1130300 h 1282700"/>
                    <a:gd name="connsiteX8" fmla="*/ 2006600 w 2006600"/>
                    <a:gd name="connsiteY8" fmla="*/ 1028700 h 1282700"/>
                    <a:gd name="connsiteX9" fmla="*/ 1778000 w 2006600"/>
                    <a:gd name="connsiteY9" fmla="*/ 1206500 h 1282700"/>
                    <a:gd name="connsiteX10" fmla="*/ 1295400 w 2006600"/>
                    <a:gd name="connsiteY10" fmla="*/ 1270000 h 1282700"/>
                    <a:gd name="connsiteX11" fmla="*/ 990600 w 2006600"/>
                    <a:gd name="connsiteY11" fmla="*/ 1282700 h 1282700"/>
                    <a:gd name="connsiteX12" fmla="*/ 584200 w 2006600"/>
                    <a:gd name="connsiteY12" fmla="*/ 1270000 h 1282700"/>
                    <a:gd name="connsiteX13" fmla="*/ 292100 w 2006600"/>
                    <a:gd name="connsiteY13" fmla="*/ 1104900 h 1282700"/>
                    <a:gd name="connsiteX14" fmla="*/ 101600 w 2006600"/>
                    <a:gd name="connsiteY14" fmla="*/ 889000 h 1282700"/>
                    <a:gd name="connsiteX15" fmla="*/ 12700 w 2006600"/>
                    <a:gd name="connsiteY15" fmla="*/ 660400 h 1282700"/>
                    <a:gd name="connsiteX16" fmla="*/ 0 w 2006600"/>
                    <a:gd name="connsiteY16" fmla="*/ 419100 h 1282700"/>
                    <a:gd name="connsiteX17" fmla="*/ 0 w 2006600"/>
                    <a:gd name="connsiteY17" fmla="*/ 419100 h 1282700"/>
                    <a:gd name="connsiteX18" fmla="*/ 88900 w 2006600"/>
                    <a:gd name="connsiteY18" fmla="*/ 139700 h 1282700"/>
                    <a:gd name="connsiteX19" fmla="*/ 279400 w 2006600"/>
                    <a:gd name="connsiteY19" fmla="*/ 0 h 1282700"/>
                    <a:gd name="connsiteX20" fmla="*/ 355600 w 2006600"/>
                    <a:gd name="connsiteY20" fmla="*/ 0 h 1282700"/>
                    <a:gd name="connsiteX21" fmla="*/ 355600 w 2006600"/>
                    <a:gd name="connsiteY21" fmla="*/ 152400 h 1282700"/>
                    <a:gd name="connsiteX22" fmla="*/ 355600 w 2006600"/>
                    <a:gd name="connsiteY22" fmla="*/ 152400 h 1282700"/>
                    <a:gd name="connsiteX23" fmla="*/ 292100 w 2006600"/>
                    <a:gd name="connsiteY23" fmla="*/ 152400 h 1282700"/>
                    <a:gd name="connsiteX0" fmla="*/ 292100 w 2006600"/>
                    <a:gd name="connsiteY0" fmla="*/ 152400 h 1287516"/>
                    <a:gd name="connsiteX1" fmla="*/ 190500 w 2006600"/>
                    <a:gd name="connsiteY1" fmla="*/ 292100 h 1287516"/>
                    <a:gd name="connsiteX2" fmla="*/ 127000 w 2006600"/>
                    <a:gd name="connsiteY2" fmla="*/ 622300 h 1287516"/>
                    <a:gd name="connsiteX3" fmla="*/ 241300 w 2006600"/>
                    <a:gd name="connsiteY3" fmla="*/ 825500 h 1287516"/>
                    <a:gd name="connsiteX4" fmla="*/ 469900 w 2006600"/>
                    <a:gd name="connsiteY4" fmla="*/ 1041400 h 1287516"/>
                    <a:gd name="connsiteX5" fmla="*/ 850900 w 2006600"/>
                    <a:gd name="connsiteY5" fmla="*/ 1143000 h 1287516"/>
                    <a:gd name="connsiteX6" fmla="*/ 1168400 w 2006600"/>
                    <a:gd name="connsiteY6" fmla="*/ 1155700 h 1287516"/>
                    <a:gd name="connsiteX7" fmla="*/ 1587500 w 2006600"/>
                    <a:gd name="connsiteY7" fmla="*/ 1130300 h 1287516"/>
                    <a:gd name="connsiteX8" fmla="*/ 2006600 w 2006600"/>
                    <a:gd name="connsiteY8" fmla="*/ 1028700 h 1287516"/>
                    <a:gd name="connsiteX9" fmla="*/ 1778000 w 2006600"/>
                    <a:gd name="connsiteY9" fmla="*/ 1206500 h 1287516"/>
                    <a:gd name="connsiteX10" fmla="*/ 1295400 w 2006600"/>
                    <a:gd name="connsiteY10" fmla="*/ 1270000 h 1287516"/>
                    <a:gd name="connsiteX11" fmla="*/ 990600 w 2006600"/>
                    <a:gd name="connsiteY11" fmla="*/ 1282700 h 1287516"/>
                    <a:gd name="connsiteX12" fmla="*/ 584200 w 2006600"/>
                    <a:gd name="connsiteY12" fmla="*/ 1270000 h 1287516"/>
                    <a:gd name="connsiteX13" fmla="*/ 292100 w 2006600"/>
                    <a:gd name="connsiteY13" fmla="*/ 1104900 h 1287516"/>
                    <a:gd name="connsiteX14" fmla="*/ 101600 w 2006600"/>
                    <a:gd name="connsiteY14" fmla="*/ 889000 h 1287516"/>
                    <a:gd name="connsiteX15" fmla="*/ 12700 w 2006600"/>
                    <a:gd name="connsiteY15" fmla="*/ 660400 h 1287516"/>
                    <a:gd name="connsiteX16" fmla="*/ 0 w 2006600"/>
                    <a:gd name="connsiteY16" fmla="*/ 419100 h 1287516"/>
                    <a:gd name="connsiteX17" fmla="*/ 0 w 2006600"/>
                    <a:gd name="connsiteY17" fmla="*/ 419100 h 1287516"/>
                    <a:gd name="connsiteX18" fmla="*/ 88900 w 2006600"/>
                    <a:gd name="connsiteY18" fmla="*/ 139700 h 1287516"/>
                    <a:gd name="connsiteX19" fmla="*/ 279400 w 2006600"/>
                    <a:gd name="connsiteY19" fmla="*/ 0 h 1287516"/>
                    <a:gd name="connsiteX20" fmla="*/ 355600 w 2006600"/>
                    <a:gd name="connsiteY20" fmla="*/ 0 h 1287516"/>
                    <a:gd name="connsiteX21" fmla="*/ 355600 w 2006600"/>
                    <a:gd name="connsiteY21" fmla="*/ 152400 h 1287516"/>
                    <a:gd name="connsiteX22" fmla="*/ 355600 w 2006600"/>
                    <a:gd name="connsiteY22" fmla="*/ 152400 h 1287516"/>
                    <a:gd name="connsiteX23" fmla="*/ 292100 w 2006600"/>
                    <a:gd name="connsiteY23" fmla="*/ 152400 h 1287516"/>
                    <a:gd name="connsiteX0" fmla="*/ 292100 w 2006600"/>
                    <a:gd name="connsiteY0" fmla="*/ 152400 h 1287516"/>
                    <a:gd name="connsiteX1" fmla="*/ 190500 w 2006600"/>
                    <a:gd name="connsiteY1" fmla="*/ 292100 h 1287516"/>
                    <a:gd name="connsiteX2" fmla="*/ 127000 w 2006600"/>
                    <a:gd name="connsiteY2" fmla="*/ 622300 h 1287516"/>
                    <a:gd name="connsiteX3" fmla="*/ 241300 w 2006600"/>
                    <a:gd name="connsiteY3" fmla="*/ 825500 h 1287516"/>
                    <a:gd name="connsiteX4" fmla="*/ 469900 w 2006600"/>
                    <a:gd name="connsiteY4" fmla="*/ 1041400 h 1287516"/>
                    <a:gd name="connsiteX5" fmla="*/ 850900 w 2006600"/>
                    <a:gd name="connsiteY5" fmla="*/ 1143000 h 1287516"/>
                    <a:gd name="connsiteX6" fmla="*/ 1168400 w 2006600"/>
                    <a:gd name="connsiteY6" fmla="*/ 1155700 h 1287516"/>
                    <a:gd name="connsiteX7" fmla="*/ 1587500 w 2006600"/>
                    <a:gd name="connsiteY7" fmla="*/ 1130300 h 1287516"/>
                    <a:gd name="connsiteX8" fmla="*/ 2006600 w 2006600"/>
                    <a:gd name="connsiteY8" fmla="*/ 1028700 h 1287516"/>
                    <a:gd name="connsiteX9" fmla="*/ 1778000 w 2006600"/>
                    <a:gd name="connsiteY9" fmla="*/ 1206500 h 1287516"/>
                    <a:gd name="connsiteX10" fmla="*/ 1295400 w 2006600"/>
                    <a:gd name="connsiteY10" fmla="*/ 1270000 h 1287516"/>
                    <a:gd name="connsiteX11" fmla="*/ 990600 w 2006600"/>
                    <a:gd name="connsiteY11" fmla="*/ 1282700 h 1287516"/>
                    <a:gd name="connsiteX12" fmla="*/ 584200 w 2006600"/>
                    <a:gd name="connsiteY12" fmla="*/ 1270000 h 1287516"/>
                    <a:gd name="connsiteX13" fmla="*/ 292100 w 2006600"/>
                    <a:gd name="connsiteY13" fmla="*/ 1104900 h 1287516"/>
                    <a:gd name="connsiteX14" fmla="*/ 101600 w 2006600"/>
                    <a:gd name="connsiteY14" fmla="*/ 889000 h 1287516"/>
                    <a:gd name="connsiteX15" fmla="*/ 12700 w 2006600"/>
                    <a:gd name="connsiteY15" fmla="*/ 660400 h 1287516"/>
                    <a:gd name="connsiteX16" fmla="*/ 0 w 2006600"/>
                    <a:gd name="connsiteY16" fmla="*/ 419100 h 1287516"/>
                    <a:gd name="connsiteX17" fmla="*/ 0 w 2006600"/>
                    <a:gd name="connsiteY17" fmla="*/ 419100 h 1287516"/>
                    <a:gd name="connsiteX18" fmla="*/ 88900 w 2006600"/>
                    <a:gd name="connsiteY18" fmla="*/ 139700 h 1287516"/>
                    <a:gd name="connsiteX19" fmla="*/ 279400 w 2006600"/>
                    <a:gd name="connsiteY19" fmla="*/ 0 h 1287516"/>
                    <a:gd name="connsiteX20" fmla="*/ 355600 w 2006600"/>
                    <a:gd name="connsiteY20" fmla="*/ 0 h 1287516"/>
                    <a:gd name="connsiteX21" fmla="*/ 355600 w 2006600"/>
                    <a:gd name="connsiteY21" fmla="*/ 152400 h 1287516"/>
                    <a:gd name="connsiteX22" fmla="*/ 355600 w 2006600"/>
                    <a:gd name="connsiteY22" fmla="*/ 152400 h 1287516"/>
                    <a:gd name="connsiteX23" fmla="*/ 292100 w 2006600"/>
                    <a:gd name="connsiteY23" fmla="*/ 152400 h 1287516"/>
                    <a:gd name="connsiteX0" fmla="*/ 292100 w 2006600"/>
                    <a:gd name="connsiteY0" fmla="*/ 152400 h 1287516"/>
                    <a:gd name="connsiteX1" fmla="*/ 190500 w 2006600"/>
                    <a:gd name="connsiteY1" fmla="*/ 292100 h 1287516"/>
                    <a:gd name="connsiteX2" fmla="*/ 127000 w 2006600"/>
                    <a:gd name="connsiteY2" fmla="*/ 622300 h 1287516"/>
                    <a:gd name="connsiteX3" fmla="*/ 241300 w 2006600"/>
                    <a:gd name="connsiteY3" fmla="*/ 825500 h 1287516"/>
                    <a:gd name="connsiteX4" fmla="*/ 469900 w 2006600"/>
                    <a:gd name="connsiteY4" fmla="*/ 1041400 h 1287516"/>
                    <a:gd name="connsiteX5" fmla="*/ 850900 w 2006600"/>
                    <a:gd name="connsiteY5" fmla="*/ 1143000 h 1287516"/>
                    <a:gd name="connsiteX6" fmla="*/ 1168400 w 2006600"/>
                    <a:gd name="connsiteY6" fmla="*/ 1155700 h 1287516"/>
                    <a:gd name="connsiteX7" fmla="*/ 1587500 w 2006600"/>
                    <a:gd name="connsiteY7" fmla="*/ 1130300 h 1287516"/>
                    <a:gd name="connsiteX8" fmla="*/ 2006600 w 2006600"/>
                    <a:gd name="connsiteY8" fmla="*/ 1028700 h 1287516"/>
                    <a:gd name="connsiteX9" fmla="*/ 1778000 w 2006600"/>
                    <a:gd name="connsiteY9" fmla="*/ 1206500 h 1287516"/>
                    <a:gd name="connsiteX10" fmla="*/ 1295400 w 2006600"/>
                    <a:gd name="connsiteY10" fmla="*/ 1270000 h 1287516"/>
                    <a:gd name="connsiteX11" fmla="*/ 990600 w 2006600"/>
                    <a:gd name="connsiteY11" fmla="*/ 1282700 h 1287516"/>
                    <a:gd name="connsiteX12" fmla="*/ 584200 w 2006600"/>
                    <a:gd name="connsiteY12" fmla="*/ 1270000 h 1287516"/>
                    <a:gd name="connsiteX13" fmla="*/ 292100 w 2006600"/>
                    <a:gd name="connsiteY13" fmla="*/ 1104900 h 1287516"/>
                    <a:gd name="connsiteX14" fmla="*/ 101600 w 2006600"/>
                    <a:gd name="connsiteY14" fmla="*/ 889000 h 1287516"/>
                    <a:gd name="connsiteX15" fmla="*/ 12700 w 2006600"/>
                    <a:gd name="connsiteY15" fmla="*/ 660400 h 1287516"/>
                    <a:gd name="connsiteX16" fmla="*/ 0 w 2006600"/>
                    <a:gd name="connsiteY16" fmla="*/ 419100 h 1287516"/>
                    <a:gd name="connsiteX17" fmla="*/ 0 w 2006600"/>
                    <a:gd name="connsiteY17" fmla="*/ 419100 h 1287516"/>
                    <a:gd name="connsiteX18" fmla="*/ 88900 w 2006600"/>
                    <a:gd name="connsiteY18" fmla="*/ 139700 h 1287516"/>
                    <a:gd name="connsiteX19" fmla="*/ 279400 w 2006600"/>
                    <a:gd name="connsiteY19" fmla="*/ 0 h 1287516"/>
                    <a:gd name="connsiteX20" fmla="*/ 355600 w 2006600"/>
                    <a:gd name="connsiteY20" fmla="*/ 0 h 1287516"/>
                    <a:gd name="connsiteX21" fmla="*/ 355600 w 2006600"/>
                    <a:gd name="connsiteY21" fmla="*/ 152400 h 1287516"/>
                    <a:gd name="connsiteX22" fmla="*/ 355600 w 2006600"/>
                    <a:gd name="connsiteY22" fmla="*/ 152400 h 1287516"/>
                    <a:gd name="connsiteX23" fmla="*/ 292100 w 2006600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707243 w 2011119"/>
                    <a:gd name="connsiteY7" fmla="*/ 11139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93800 h 1287516"/>
                    <a:gd name="connsiteX7" fmla="*/ 1707243 w 2011119"/>
                    <a:gd name="connsiteY7" fmla="*/ 11139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93800 h 1287516"/>
                    <a:gd name="connsiteX7" fmla="*/ 1707243 w 2011119"/>
                    <a:gd name="connsiteY7" fmla="*/ 11520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774700 w 2011119"/>
                    <a:gd name="connsiteY5" fmla="*/ 1159328 h 1287516"/>
                    <a:gd name="connsiteX6" fmla="*/ 1168400 w 2011119"/>
                    <a:gd name="connsiteY6" fmla="*/ 1193800 h 1287516"/>
                    <a:gd name="connsiteX7" fmla="*/ 1707243 w 2011119"/>
                    <a:gd name="connsiteY7" fmla="*/ 11520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4801"/>
                    <a:gd name="connsiteX1" fmla="*/ 190500 w 2011119"/>
                    <a:gd name="connsiteY1" fmla="*/ 292100 h 1284801"/>
                    <a:gd name="connsiteX2" fmla="*/ 127000 w 2011119"/>
                    <a:gd name="connsiteY2" fmla="*/ 622300 h 1284801"/>
                    <a:gd name="connsiteX3" fmla="*/ 241300 w 2011119"/>
                    <a:gd name="connsiteY3" fmla="*/ 825500 h 1284801"/>
                    <a:gd name="connsiteX4" fmla="*/ 469900 w 2011119"/>
                    <a:gd name="connsiteY4" fmla="*/ 1041400 h 1284801"/>
                    <a:gd name="connsiteX5" fmla="*/ 774700 w 2011119"/>
                    <a:gd name="connsiteY5" fmla="*/ 1159328 h 1284801"/>
                    <a:gd name="connsiteX6" fmla="*/ 1168400 w 2011119"/>
                    <a:gd name="connsiteY6" fmla="*/ 1193800 h 1284801"/>
                    <a:gd name="connsiteX7" fmla="*/ 1707243 w 2011119"/>
                    <a:gd name="connsiteY7" fmla="*/ 1152071 h 1284801"/>
                    <a:gd name="connsiteX8" fmla="*/ 2006600 w 2011119"/>
                    <a:gd name="connsiteY8" fmla="*/ 1028700 h 1284801"/>
                    <a:gd name="connsiteX9" fmla="*/ 1778000 w 2011119"/>
                    <a:gd name="connsiteY9" fmla="*/ 1206500 h 1284801"/>
                    <a:gd name="connsiteX10" fmla="*/ 1295400 w 2011119"/>
                    <a:gd name="connsiteY10" fmla="*/ 1270000 h 1284801"/>
                    <a:gd name="connsiteX11" fmla="*/ 990600 w 2011119"/>
                    <a:gd name="connsiteY11" fmla="*/ 1282700 h 1284801"/>
                    <a:gd name="connsiteX12" fmla="*/ 573314 w 2011119"/>
                    <a:gd name="connsiteY12" fmla="*/ 1237343 h 1284801"/>
                    <a:gd name="connsiteX13" fmla="*/ 292100 w 2011119"/>
                    <a:gd name="connsiteY13" fmla="*/ 1104900 h 1284801"/>
                    <a:gd name="connsiteX14" fmla="*/ 101600 w 2011119"/>
                    <a:gd name="connsiteY14" fmla="*/ 889000 h 1284801"/>
                    <a:gd name="connsiteX15" fmla="*/ 12700 w 2011119"/>
                    <a:gd name="connsiteY15" fmla="*/ 660400 h 1284801"/>
                    <a:gd name="connsiteX16" fmla="*/ 0 w 2011119"/>
                    <a:gd name="connsiteY16" fmla="*/ 419100 h 1284801"/>
                    <a:gd name="connsiteX17" fmla="*/ 0 w 2011119"/>
                    <a:gd name="connsiteY17" fmla="*/ 419100 h 1284801"/>
                    <a:gd name="connsiteX18" fmla="*/ 88900 w 2011119"/>
                    <a:gd name="connsiteY18" fmla="*/ 139700 h 1284801"/>
                    <a:gd name="connsiteX19" fmla="*/ 279400 w 2011119"/>
                    <a:gd name="connsiteY19" fmla="*/ 0 h 1284801"/>
                    <a:gd name="connsiteX20" fmla="*/ 404586 w 2011119"/>
                    <a:gd name="connsiteY20" fmla="*/ 0 h 1284801"/>
                    <a:gd name="connsiteX21" fmla="*/ 355600 w 2011119"/>
                    <a:gd name="connsiteY21" fmla="*/ 152400 h 1284801"/>
                    <a:gd name="connsiteX22" fmla="*/ 355600 w 2011119"/>
                    <a:gd name="connsiteY22" fmla="*/ 152400 h 1284801"/>
                    <a:gd name="connsiteX23" fmla="*/ 292100 w 2011119"/>
                    <a:gd name="connsiteY23" fmla="*/ 152400 h 1284801"/>
                    <a:gd name="connsiteX0" fmla="*/ 292100 w 2011119"/>
                    <a:gd name="connsiteY0" fmla="*/ 152400 h 1284801"/>
                    <a:gd name="connsiteX1" fmla="*/ 190500 w 2011119"/>
                    <a:gd name="connsiteY1" fmla="*/ 292100 h 1284801"/>
                    <a:gd name="connsiteX2" fmla="*/ 159657 w 2011119"/>
                    <a:gd name="connsiteY2" fmla="*/ 622300 h 1284801"/>
                    <a:gd name="connsiteX3" fmla="*/ 241300 w 2011119"/>
                    <a:gd name="connsiteY3" fmla="*/ 825500 h 1284801"/>
                    <a:gd name="connsiteX4" fmla="*/ 469900 w 2011119"/>
                    <a:gd name="connsiteY4" fmla="*/ 1041400 h 1284801"/>
                    <a:gd name="connsiteX5" fmla="*/ 774700 w 2011119"/>
                    <a:gd name="connsiteY5" fmla="*/ 1159328 h 1284801"/>
                    <a:gd name="connsiteX6" fmla="*/ 1168400 w 2011119"/>
                    <a:gd name="connsiteY6" fmla="*/ 1193800 h 1284801"/>
                    <a:gd name="connsiteX7" fmla="*/ 1707243 w 2011119"/>
                    <a:gd name="connsiteY7" fmla="*/ 1152071 h 1284801"/>
                    <a:gd name="connsiteX8" fmla="*/ 2006600 w 2011119"/>
                    <a:gd name="connsiteY8" fmla="*/ 1028700 h 1284801"/>
                    <a:gd name="connsiteX9" fmla="*/ 1778000 w 2011119"/>
                    <a:gd name="connsiteY9" fmla="*/ 1206500 h 1284801"/>
                    <a:gd name="connsiteX10" fmla="*/ 1295400 w 2011119"/>
                    <a:gd name="connsiteY10" fmla="*/ 1270000 h 1284801"/>
                    <a:gd name="connsiteX11" fmla="*/ 990600 w 2011119"/>
                    <a:gd name="connsiteY11" fmla="*/ 1282700 h 1284801"/>
                    <a:gd name="connsiteX12" fmla="*/ 573314 w 2011119"/>
                    <a:gd name="connsiteY12" fmla="*/ 1237343 h 1284801"/>
                    <a:gd name="connsiteX13" fmla="*/ 292100 w 2011119"/>
                    <a:gd name="connsiteY13" fmla="*/ 1104900 h 1284801"/>
                    <a:gd name="connsiteX14" fmla="*/ 101600 w 2011119"/>
                    <a:gd name="connsiteY14" fmla="*/ 889000 h 1284801"/>
                    <a:gd name="connsiteX15" fmla="*/ 12700 w 2011119"/>
                    <a:gd name="connsiteY15" fmla="*/ 660400 h 1284801"/>
                    <a:gd name="connsiteX16" fmla="*/ 0 w 2011119"/>
                    <a:gd name="connsiteY16" fmla="*/ 419100 h 1284801"/>
                    <a:gd name="connsiteX17" fmla="*/ 0 w 2011119"/>
                    <a:gd name="connsiteY17" fmla="*/ 419100 h 1284801"/>
                    <a:gd name="connsiteX18" fmla="*/ 88900 w 2011119"/>
                    <a:gd name="connsiteY18" fmla="*/ 139700 h 1284801"/>
                    <a:gd name="connsiteX19" fmla="*/ 279400 w 2011119"/>
                    <a:gd name="connsiteY19" fmla="*/ 0 h 1284801"/>
                    <a:gd name="connsiteX20" fmla="*/ 404586 w 2011119"/>
                    <a:gd name="connsiteY20" fmla="*/ 0 h 1284801"/>
                    <a:gd name="connsiteX21" fmla="*/ 355600 w 2011119"/>
                    <a:gd name="connsiteY21" fmla="*/ 152400 h 1284801"/>
                    <a:gd name="connsiteX22" fmla="*/ 355600 w 2011119"/>
                    <a:gd name="connsiteY22" fmla="*/ 152400 h 1284801"/>
                    <a:gd name="connsiteX23" fmla="*/ 292100 w 2011119"/>
                    <a:gd name="connsiteY23" fmla="*/ 152400 h 128480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</a:cxnLst>
                  <a:rect l="l" t="t" r="r" b="b"/>
                  <a:pathLst>
                    <a:path w="2011119" h="1284801">
                      <a:moveTo>
                        <a:pt x="292100" y="152400"/>
                      </a:moveTo>
                      <a:cubicBezTo>
                        <a:pt x="264583" y="175683"/>
                        <a:pt x="212574" y="213783"/>
                        <a:pt x="190500" y="292100"/>
                      </a:cubicBezTo>
                      <a:cubicBezTo>
                        <a:pt x="168426" y="370417"/>
                        <a:pt x="151190" y="533400"/>
                        <a:pt x="159657" y="622300"/>
                      </a:cubicBezTo>
                      <a:cubicBezTo>
                        <a:pt x="168124" y="711200"/>
                        <a:pt x="189593" y="755650"/>
                        <a:pt x="241300" y="825500"/>
                      </a:cubicBezTo>
                      <a:cubicBezTo>
                        <a:pt x="293007" y="895350"/>
                        <a:pt x="381000" y="985762"/>
                        <a:pt x="469900" y="1041400"/>
                      </a:cubicBezTo>
                      <a:cubicBezTo>
                        <a:pt x="558800" y="1097038"/>
                        <a:pt x="658283" y="1133928"/>
                        <a:pt x="774700" y="1159328"/>
                      </a:cubicBezTo>
                      <a:cubicBezTo>
                        <a:pt x="891117" y="1184728"/>
                        <a:pt x="1012976" y="1195009"/>
                        <a:pt x="1168400" y="1193800"/>
                      </a:cubicBezTo>
                      <a:cubicBezTo>
                        <a:pt x="1323824" y="1192591"/>
                        <a:pt x="1567543" y="1179588"/>
                        <a:pt x="1707243" y="1152071"/>
                      </a:cubicBezTo>
                      <a:cubicBezTo>
                        <a:pt x="1846943" y="1124554"/>
                        <a:pt x="1906814" y="1057124"/>
                        <a:pt x="2006600" y="1028700"/>
                      </a:cubicBezTo>
                      <a:cubicBezTo>
                        <a:pt x="2038350" y="1041400"/>
                        <a:pt x="1896533" y="1166283"/>
                        <a:pt x="1778000" y="1206500"/>
                      </a:cubicBezTo>
                      <a:cubicBezTo>
                        <a:pt x="1659467" y="1246717"/>
                        <a:pt x="1426633" y="1257300"/>
                        <a:pt x="1295400" y="1270000"/>
                      </a:cubicBezTo>
                      <a:cubicBezTo>
                        <a:pt x="1164167" y="1282700"/>
                        <a:pt x="1110948" y="1288143"/>
                        <a:pt x="990600" y="1282700"/>
                      </a:cubicBezTo>
                      <a:cubicBezTo>
                        <a:pt x="870252" y="1277257"/>
                        <a:pt x="689731" y="1266976"/>
                        <a:pt x="573314" y="1237343"/>
                      </a:cubicBezTo>
                      <a:cubicBezTo>
                        <a:pt x="456897" y="1207710"/>
                        <a:pt x="370719" y="1162957"/>
                        <a:pt x="292100" y="1104900"/>
                      </a:cubicBezTo>
                      <a:cubicBezTo>
                        <a:pt x="213481" y="1046843"/>
                        <a:pt x="148167" y="963083"/>
                        <a:pt x="101600" y="889000"/>
                      </a:cubicBezTo>
                      <a:cubicBezTo>
                        <a:pt x="55033" y="814917"/>
                        <a:pt x="29633" y="738717"/>
                        <a:pt x="12700" y="660400"/>
                      </a:cubicBezTo>
                      <a:cubicBezTo>
                        <a:pt x="-4233" y="582083"/>
                        <a:pt x="2117" y="459317"/>
                        <a:pt x="0" y="419100"/>
                      </a:cubicBezTo>
                      <a:lnTo>
                        <a:pt x="0" y="419100"/>
                      </a:lnTo>
                      <a:cubicBezTo>
                        <a:pt x="0" y="419100"/>
                        <a:pt x="42333" y="209550"/>
                        <a:pt x="88900" y="139700"/>
                      </a:cubicBezTo>
                      <a:cubicBezTo>
                        <a:pt x="135467" y="69850"/>
                        <a:pt x="234950" y="23283"/>
                        <a:pt x="279400" y="0"/>
                      </a:cubicBezTo>
                      <a:lnTo>
                        <a:pt x="404586" y="0"/>
                      </a:lnTo>
                      <a:lnTo>
                        <a:pt x="355600" y="152400"/>
                      </a:lnTo>
                      <a:lnTo>
                        <a:pt x="355600" y="152400"/>
                      </a:lnTo>
                      <a:lnTo>
                        <a:pt x="292100" y="152400"/>
                      </a:ln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5" name="Oval 14">
                  <a:extLst>
                    <a:ext uri="{FF2B5EF4-FFF2-40B4-BE49-F238E27FC236}">
                      <a16:creationId xmlns:a16="http://schemas.microsoft.com/office/drawing/2014/main" id="{83E2BB1E-DE24-3101-1473-8E94CCC59BF3}"/>
                    </a:ext>
                  </a:extLst>
                </p:cNvPr>
                <p:cNvSpPr/>
                <p:nvPr/>
              </p:nvSpPr>
              <p:spPr>
                <a:xfrm>
                  <a:off x="882519" y="5251766"/>
                  <a:ext cx="120477" cy="150015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</p:grpSp>
        </p:grp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8F7B2600-122B-EDDB-093B-327746700996}"/>
                </a:ext>
              </a:extLst>
            </p:cNvPr>
            <p:cNvCxnSpPr>
              <a:cxnSpLocks/>
            </p:cNvCxnSpPr>
            <p:nvPr/>
          </p:nvCxnSpPr>
          <p:spPr>
            <a:xfrm>
              <a:off x="1063981" y="641599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E7CC289-AB6B-15B3-6CFA-53397F5C8E54}"/>
                </a:ext>
              </a:extLst>
            </p:cNvPr>
            <p:cNvSpPr txBox="1"/>
            <p:nvPr/>
          </p:nvSpPr>
          <p:spPr>
            <a:xfrm>
              <a:off x="1255114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4CC9DA6F-926E-18F4-ED6D-7F4D67C2B485}"/>
                </a:ext>
              </a:extLst>
            </p:cNvPr>
            <p:cNvCxnSpPr>
              <a:cxnSpLocks/>
            </p:cNvCxnSpPr>
            <p:nvPr/>
          </p:nvCxnSpPr>
          <p:spPr>
            <a:xfrm>
              <a:off x="1372744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C82EBDF-A256-25B6-EFAB-F8A7DEA1ADEE}"/>
                </a:ext>
              </a:extLst>
            </p:cNvPr>
            <p:cNvCxnSpPr>
              <a:cxnSpLocks/>
            </p:cNvCxnSpPr>
            <p:nvPr/>
          </p:nvCxnSpPr>
          <p:spPr>
            <a:xfrm>
              <a:off x="1681507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FBEB859A-F76B-CB71-B2EE-569B0527291B}"/>
                </a:ext>
              </a:extLst>
            </p:cNvPr>
            <p:cNvCxnSpPr>
              <a:cxnSpLocks/>
            </p:cNvCxnSpPr>
            <p:nvPr/>
          </p:nvCxnSpPr>
          <p:spPr>
            <a:xfrm>
              <a:off x="1990270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3ABE5934-0282-9C01-5E53-660048FE2AE0}"/>
                </a:ext>
              </a:extLst>
            </p:cNvPr>
            <p:cNvCxnSpPr>
              <a:cxnSpLocks/>
            </p:cNvCxnSpPr>
            <p:nvPr/>
          </p:nvCxnSpPr>
          <p:spPr>
            <a:xfrm>
              <a:off x="2299033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87991DC9-4767-6DDA-2FA9-E2F7DD52537D}"/>
                </a:ext>
              </a:extLst>
            </p:cNvPr>
            <p:cNvCxnSpPr>
              <a:cxnSpLocks/>
            </p:cNvCxnSpPr>
            <p:nvPr/>
          </p:nvCxnSpPr>
          <p:spPr>
            <a:xfrm>
              <a:off x="2607796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5A8840E8-D15A-3490-3CEB-1052A25A438F}"/>
                </a:ext>
              </a:extLst>
            </p:cNvPr>
            <p:cNvCxnSpPr>
              <a:cxnSpLocks/>
            </p:cNvCxnSpPr>
            <p:nvPr/>
          </p:nvCxnSpPr>
          <p:spPr>
            <a:xfrm>
              <a:off x="2916559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180B8094-B64E-0774-7D65-9D9DA9321F72}"/>
                </a:ext>
              </a:extLst>
            </p:cNvPr>
            <p:cNvCxnSpPr>
              <a:cxnSpLocks/>
            </p:cNvCxnSpPr>
            <p:nvPr/>
          </p:nvCxnSpPr>
          <p:spPr>
            <a:xfrm>
              <a:off x="3225322" y="644255"/>
              <a:ext cx="0" cy="17721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121DD93-C301-3E4A-600C-7488161FF8D2}"/>
                </a:ext>
              </a:extLst>
            </p:cNvPr>
            <p:cNvSpPr txBox="1"/>
            <p:nvPr/>
          </p:nvSpPr>
          <p:spPr>
            <a:xfrm>
              <a:off x="1561541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37B9006-A940-DA26-1977-75E72E58F654}"/>
                </a:ext>
              </a:extLst>
            </p:cNvPr>
            <p:cNvSpPr txBox="1"/>
            <p:nvPr/>
          </p:nvSpPr>
          <p:spPr>
            <a:xfrm>
              <a:off x="1863809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260DFEB-C338-8768-D42A-D17AEA840176}"/>
                </a:ext>
              </a:extLst>
            </p:cNvPr>
            <p:cNvSpPr txBox="1"/>
            <p:nvPr/>
          </p:nvSpPr>
          <p:spPr>
            <a:xfrm>
              <a:off x="2170235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07C8646-2470-7738-A56F-61E6DDC3B138}"/>
                </a:ext>
              </a:extLst>
            </p:cNvPr>
            <p:cNvSpPr txBox="1"/>
            <p:nvPr/>
          </p:nvSpPr>
          <p:spPr>
            <a:xfrm>
              <a:off x="2478272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38509D4-AA57-EEAE-A0C6-CA832CC75223}"/>
                </a:ext>
              </a:extLst>
            </p:cNvPr>
            <p:cNvSpPr txBox="1"/>
            <p:nvPr/>
          </p:nvSpPr>
          <p:spPr>
            <a:xfrm>
              <a:off x="2787188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C3A7435-9CD9-E5B7-3625-9F8FF714181A}"/>
                </a:ext>
              </a:extLst>
            </p:cNvPr>
            <p:cNvSpPr txBox="1"/>
            <p:nvPr/>
          </p:nvSpPr>
          <p:spPr>
            <a:xfrm>
              <a:off x="3106018" y="8207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B222F45B-667D-94F8-D437-BEEF20919C57}"/>
              </a:ext>
            </a:extLst>
          </p:cNvPr>
          <p:cNvSpPr txBox="1"/>
          <p:nvPr/>
        </p:nvSpPr>
        <p:spPr>
          <a:xfrm>
            <a:off x="3350845" y="-16323"/>
            <a:ext cx="2169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86" name="Group 285">
            <a:extLst>
              <a:ext uri="{FF2B5EF4-FFF2-40B4-BE49-F238E27FC236}">
                <a16:creationId xmlns:a16="http://schemas.microsoft.com/office/drawing/2014/main" id="{E882560D-3426-4C16-3E07-C1B844994836}"/>
              </a:ext>
            </a:extLst>
          </p:cNvPr>
          <p:cNvGrpSpPr/>
          <p:nvPr/>
        </p:nvGrpSpPr>
        <p:grpSpPr>
          <a:xfrm>
            <a:off x="1464384" y="4646722"/>
            <a:ext cx="6145706" cy="5342773"/>
            <a:chOff x="1286961" y="4564835"/>
            <a:chExt cx="6145706" cy="5342773"/>
          </a:xfrm>
        </p:grpSpPr>
        <p:grpSp>
          <p:nvGrpSpPr>
            <p:cNvPr id="285" name="Group 284">
              <a:extLst>
                <a:ext uri="{FF2B5EF4-FFF2-40B4-BE49-F238E27FC236}">
                  <a16:creationId xmlns:a16="http://schemas.microsoft.com/office/drawing/2014/main" id="{029267AC-AA85-B734-22EA-93098F54B98D}"/>
                </a:ext>
              </a:extLst>
            </p:cNvPr>
            <p:cNvGrpSpPr/>
            <p:nvPr/>
          </p:nvGrpSpPr>
          <p:grpSpPr>
            <a:xfrm>
              <a:off x="1286961" y="4830230"/>
              <a:ext cx="6145706" cy="5077378"/>
              <a:chOff x="1286961" y="4830230"/>
              <a:chExt cx="6145706" cy="5077378"/>
            </a:xfrm>
          </p:grpSpPr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5781D089-2E46-81F0-6134-6B0E6A27C84C}"/>
                  </a:ext>
                </a:extLst>
              </p:cNvPr>
              <p:cNvSpPr txBox="1"/>
              <p:nvPr/>
            </p:nvSpPr>
            <p:spPr>
              <a:xfrm>
                <a:off x="7145409" y="4921045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pic>
            <p:nvPicPr>
              <p:cNvPr id="120" name="Picture 119">
                <a:extLst>
                  <a:ext uri="{FF2B5EF4-FFF2-40B4-BE49-F238E27FC236}">
                    <a16:creationId xmlns:a16="http://schemas.microsoft.com/office/drawing/2014/main" id="{548ED990-412E-287F-C63A-5C2BE17663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3996" t="3983" r="-1" b="5330"/>
              <a:stretch/>
            </p:blipFill>
            <p:spPr>
              <a:xfrm>
                <a:off x="6046691" y="4870374"/>
                <a:ext cx="1331007" cy="4625646"/>
              </a:xfrm>
              <a:prstGeom prst="rect">
                <a:avLst/>
              </a:prstGeom>
            </p:spPr>
          </p:pic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613DED89-2732-F770-85EE-0217A54CBF3E}"/>
                  </a:ext>
                </a:extLst>
              </p:cNvPr>
              <p:cNvSpPr txBox="1"/>
              <p:nvPr/>
            </p:nvSpPr>
            <p:spPr>
              <a:xfrm>
                <a:off x="4940105" y="4830230"/>
                <a:ext cx="11737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 cell Activation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2CAD6C0E-FA46-A59D-8B86-7CF69AB441DD}"/>
                  </a:ext>
                </a:extLst>
              </p:cNvPr>
              <p:cNvSpPr txBox="1"/>
              <p:nvPr/>
            </p:nvSpPr>
            <p:spPr>
              <a:xfrm>
                <a:off x="4430350" y="4994447"/>
                <a:ext cx="168347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 cell Mediated Immunity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F5364FE5-80A8-7088-7C00-7A538C670237}"/>
                  </a:ext>
                </a:extLst>
              </p:cNvPr>
              <p:cNvSpPr txBox="1"/>
              <p:nvPr/>
            </p:nvSpPr>
            <p:spPr>
              <a:xfrm>
                <a:off x="3399619" y="5145016"/>
                <a:ext cx="271420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Adaptive Immune Response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24A5D13E-4217-F7F3-1FF7-076850C7FA30}"/>
                  </a:ext>
                </a:extLst>
              </p:cNvPr>
              <p:cNvSpPr txBox="1"/>
              <p:nvPr/>
            </p:nvSpPr>
            <p:spPr>
              <a:xfrm>
                <a:off x="4377451" y="5304714"/>
                <a:ext cx="173637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 Proliferation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82E4F21E-98DB-8A08-A75E-1C9789827667}"/>
                  </a:ext>
                </a:extLst>
              </p:cNvPr>
              <p:cNvSpPr txBox="1"/>
              <p:nvPr/>
            </p:nvSpPr>
            <p:spPr>
              <a:xfrm>
                <a:off x="4792628" y="5469835"/>
                <a:ext cx="132119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l-G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T cell Activation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F75C1360-FB82-F8FC-A117-9DEEBC774202}"/>
                  </a:ext>
                </a:extLst>
              </p:cNvPr>
              <p:cNvSpPr txBox="1"/>
              <p:nvPr/>
            </p:nvSpPr>
            <p:spPr>
              <a:xfrm>
                <a:off x="4682022" y="5622077"/>
                <a:ext cx="1431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 cell Differentiation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D27F6924-8812-882A-6119-82386D6E0598}"/>
                  </a:ext>
                </a:extLst>
              </p:cNvPr>
              <p:cNvSpPr txBox="1"/>
              <p:nvPr/>
            </p:nvSpPr>
            <p:spPr>
              <a:xfrm>
                <a:off x="4151427" y="5782045"/>
                <a:ext cx="196239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T cell Activation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1DE3894E-9A10-9A7C-6358-86741F779E3C}"/>
                  </a:ext>
                </a:extLst>
              </p:cNvPr>
              <p:cNvSpPr txBox="1"/>
              <p:nvPr/>
            </p:nvSpPr>
            <p:spPr>
              <a:xfrm>
                <a:off x="3707396" y="5939437"/>
                <a:ext cx="240642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ntigen Processing and Presentation</a:t>
                </a: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3E2C4C82-20B7-5BF3-3954-CB675F1AF82C}"/>
                  </a:ext>
                </a:extLst>
              </p:cNvPr>
              <p:cNvSpPr txBox="1"/>
              <p:nvPr/>
            </p:nvSpPr>
            <p:spPr>
              <a:xfrm>
                <a:off x="1286961" y="6094254"/>
                <a:ext cx="482055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Regulation of Adaptive Immune Response Based on Somatic </a:t>
                </a:r>
                <a:r>
                  <a:rPr lang="en-US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com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2D959D89-431A-EA68-94AA-975C2406E872}"/>
                  </a:ext>
                </a:extLst>
              </p:cNvPr>
              <p:cNvSpPr txBox="1"/>
              <p:nvPr/>
            </p:nvSpPr>
            <p:spPr>
              <a:xfrm>
                <a:off x="3641672" y="6254223"/>
                <a:ext cx="24721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Regulation of T cell Activation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2553483D-B2A8-6D25-92AE-8970C79564BB}"/>
                  </a:ext>
                </a:extLst>
              </p:cNvPr>
              <p:cNvSpPr txBox="1"/>
              <p:nvPr/>
            </p:nvSpPr>
            <p:spPr>
              <a:xfrm>
                <a:off x="4260432" y="6406466"/>
                <a:ext cx="18533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 Differentiation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BD66C135-53A6-A1F8-C526-77EDE1CABD99}"/>
                  </a:ext>
                </a:extLst>
              </p:cNvPr>
              <p:cNvSpPr txBox="1"/>
              <p:nvPr/>
            </p:nvSpPr>
            <p:spPr>
              <a:xfrm>
                <a:off x="1325145" y="6566435"/>
                <a:ext cx="478528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Adaptive Immune Response Based on Somatic Recombination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29CD5054-D266-D183-B6A4-9D7EF3DB5FC1}"/>
                  </a:ext>
                </a:extLst>
              </p:cNvPr>
              <p:cNvSpPr txBox="1"/>
              <p:nvPr/>
            </p:nvSpPr>
            <p:spPr>
              <a:xfrm>
                <a:off x="2889865" y="6721250"/>
                <a:ext cx="322395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Regulation of Adaptive Immune Response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C7539BCC-C800-9DE4-8093-01459DE31CA7}"/>
                  </a:ext>
                </a:extLst>
              </p:cNvPr>
              <p:cNvSpPr txBox="1"/>
              <p:nvPr/>
            </p:nvSpPr>
            <p:spPr>
              <a:xfrm>
                <a:off x="4799040" y="6876070"/>
                <a:ext cx="13147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 cell Proliferation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E2821FAE-9D1E-E239-5C58-4CCC7D515A0C}"/>
                  </a:ext>
                </a:extLst>
              </p:cNvPr>
              <p:cNvSpPr txBox="1"/>
              <p:nvPr/>
            </p:nvSpPr>
            <p:spPr>
              <a:xfrm>
                <a:off x="2681474" y="7038837"/>
                <a:ext cx="343235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Regulation of Lymphocyte Mediated Immunity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D8F7E7CE-AF03-2BE1-E085-61B9A67E4DE5}"/>
                  </a:ext>
                </a:extLst>
              </p:cNvPr>
              <p:cNvSpPr txBox="1"/>
              <p:nvPr/>
            </p:nvSpPr>
            <p:spPr>
              <a:xfrm>
                <a:off x="3191229" y="7196482"/>
                <a:ext cx="292259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Lymphocyte Mediated Immunity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938C2601-F577-678D-8658-77134146E63A}"/>
                  </a:ext>
                </a:extLst>
              </p:cNvPr>
              <p:cNvSpPr txBox="1"/>
              <p:nvPr/>
            </p:nvSpPr>
            <p:spPr>
              <a:xfrm>
                <a:off x="4287683" y="7351767"/>
                <a:ext cx="182614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 cell Mediated Cytotoxicity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24A80FFB-24B2-FAE9-79FA-5700F8ECF0D9}"/>
                  </a:ext>
                </a:extLst>
              </p:cNvPr>
              <p:cNvSpPr txBox="1"/>
              <p:nvPr/>
            </p:nvSpPr>
            <p:spPr>
              <a:xfrm>
                <a:off x="2726358" y="7665034"/>
                <a:ext cx="338746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 Activation Involved in Immune Response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5AB2EF3E-7D46-E5D3-8EB3-15CD059A8DB6}"/>
                  </a:ext>
                </a:extLst>
              </p:cNvPr>
              <p:cNvSpPr txBox="1"/>
              <p:nvPr/>
            </p:nvSpPr>
            <p:spPr>
              <a:xfrm>
                <a:off x="4369436" y="7819920"/>
                <a:ext cx="174438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D4+, </a:t>
                </a:r>
                <a:r>
                  <a:rPr lang="el-G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T cell Activation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435F5795-7E35-7B74-FBD7-BB27F6EA7995}"/>
                  </a:ext>
                </a:extLst>
              </p:cNvPr>
              <p:cNvSpPr txBox="1"/>
              <p:nvPr/>
            </p:nvSpPr>
            <p:spPr>
              <a:xfrm>
                <a:off x="4189899" y="7978603"/>
                <a:ext cx="192392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h1 Type Immune Response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F6313C21-597D-D821-1917-86C01CFA1280}"/>
                  </a:ext>
                </a:extLst>
              </p:cNvPr>
              <p:cNvSpPr txBox="1"/>
              <p:nvPr/>
            </p:nvSpPr>
            <p:spPr>
              <a:xfrm>
                <a:off x="4015173" y="8137790"/>
                <a:ext cx="209865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T cell Proliferation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2FFE2649-7FA2-338B-2D4C-60AE7BB574F8}"/>
                  </a:ext>
                </a:extLst>
              </p:cNvPr>
              <p:cNvSpPr txBox="1"/>
              <p:nvPr/>
            </p:nvSpPr>
            <p:spPr>
              <a:xfrm>
                <a:off x="2883452" y="8295324"/>
                <a:ext cx="323037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 cell Differentiation Involved in Immune Response</a:t>
                </a: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01E199BD-92FC-7FB1-5021-7D0209B11092}"/>
                  </a:ext>
                </a:extLst>
              </p:cNvPr>
              <p:cNvSpPr txBox="1"/>
              <p:nvPr/>
            </p:nvSpPr>
            <p:spPr>
              <a:xfrm>
                <a:off x="3497402" y="8607236"/>
                <a:ext cx="261642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Lymphocyte Differentiation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85BD25F6-66D4-1A35-F85E-AAA95FFF85AA}"/>
                  </a:ext>
                </a:extLst>
              </p:cNvPr>
              <p:cNvSpPr txBox="1"/>
              <p:nvPr/>
            </p:nvSpPr>
            <p:spPr>
              <a:xfrm>
                <a:off x="4550576" y="8765339"/>
                <a:ext cx="15632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 Migration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35CA3C68-AD2A-48C9-9358-E550FFB9790F}"/>
                  </a:ext>
                </a:extLst>
              </p:cNvPr>
              <p:cNvSpPr txBox="1"/>
              <p:nvPr/>
            </p:nvSpPr>
            <p:spPr>
              <a:xfrm>
                <a:off x="4024791" y="8922547"/>
                <a:ext cx="208903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 Mediated Immunity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9EF9B4CD-9D1B-4798-10FB-0B0037EA0EE1}"/>
                  </a:ext>
                </a:extLst>
              </p:cNvPr>
              <p:cNvSpPr txBox="1"/>
              <p:nvPr/>
            </p:nvSpPr>
            <p:spPr>
              <a:xfrm>
                <a:off x="4544164" y="7508658"/>
                <a:ext cx="156966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l-G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 T cell Differentiation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4D260A48-6C35-3E70-A3C1-AA4D6A538B5A}"/>
                  </a:ext>
                </a:extLst>
              </p:cNvPr>
              <p:cNvSpPr txBox="1"/>
              <p:nvPr/>
            </p:nvSpPr>
            <p:spPr>
              <a:xfrm>
                <a:off x="3236113" y="9074570"/>
                <a:ext cx="287771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 Regulation of Lymphocyte Activation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F695C12C-3C75-D0C1-4D10-3E2181157F4F}"/>
                  </a:ext>
                </a:extLst>
              </p:cNvPr>
              <p:cNvSpPr txBox="1"/>
              <p:nvPr/>
            </p:nvSpPr>
            <p:spPr>
              <a:xfrm>
                <a:off x="4758966" y="9230396"/>
                <a:ext cx="13548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B Cell Proliferation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C4D3A8EF-E723-9E48-49D7-07D2DED64C0F}"/>
                  </a:ext>
                </a:extLst>
              </p:cNvPr>
              <p:cNvSpPr txBox="1"/>
              <p:nvPr/>
            </p:nvSpPr>
            <p:spPr>
              <a:xfrm>
                <a:off x="2162101" y="8449424"/>
                <a:ext cx="395172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daptive Immune Response Based on Somatic Recombination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49E1DAF6-3F93-A88B-854E-1C60FCFF0478}"/>
                  </a:ext>
                </a:extLst>
              </p:cNvPr>
              <p:cNvSpPr txBox="1"/>
              <p:nvPr/>
            </p:nvSpPr>
            <p:spPr>
              <a:xfrm>
                <a:off x="5979850" y="944647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ECDE8325-E2AD-9D9C-1F9E-D369E89AD806}"/>
                  </a:ext>
                </a:extLst>
              </p:cNvPr>
              <p:cNvSpPr txBox="1"/>
              <p:nvPr/>
            </p:nvSpPr>
            <p:spPr>
              <a:xfrm>
                <a:off x="6353106" y="944647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7D373080-DEFB-5712-48BD-A3D48511B437}"/>
                  </a:ext>
                </a:extLst>
              </p:cNvPr>
              <p:cNvSpPr txBox="1"/>
              <p:nvPr/>
            </p:nvSpPr>
            <p:spPr>
              <a:xfrm>
                <a:off x="6689291" y="944647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6A98D394-8CB9-A09B-682F-B46B4E0E394B}"/>
                  </a:ext>
                </a:extLst>
              </p:cNvPr>
              <p:cNvSpPr txBox="1"/>
              <p:nvPr/>
            </p:nvSpPr>
            <p:spPr>
              <a:xfrm>
                <a:off x="7066712" y="944647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0EBE0F63-9771-5235-D4BF-0A850EDBC58B}"/>
                  </a:ext>
                </a:extLst>
              </p:cNvPr>
              <p:cNvSpPr txBox="1"/>
              <p:nvPr/>
            </p:nvSpPr>
            <p:spPr>
              <a:xfrm>
                <a:off x="6293513" y="9645998"/>
                <a:ext cx="76495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-log10(P)</a:t>
                </a:r>
              </a:p>
            </p:txBody>
          </p:sp>
        </p:grp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5FFB5740-6517-AFF9-420A-6A627AE7F08A}"/>
                </a:ext>
              </a:extLst>
            </p:cNvPr>
            <p:cNvSpPr txBox="1"/>
            <p:nvPr/>
          </p:nvSpPr>
          <p:spPr>
            <a:xfrm>
              <a:off x="4832057" y="4564835"/>
              <a:ext cx="24916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ene Ontology Pathway Analysis </a:t>
              </a:r>
            </a:p>
          </p:txBody>
        </p:sp>
      </p:grpSp>
      <p:sp>
        <p:nvSpPr>
          <p:cNvPr id="156" name="TextBox 155">
            <a:extLst>
              <a:ext uri="{FF2B5EF4-FFF2-40B4-BE49-F238E27FC236}">
                <a16:creationId xmlns:a16="http://schemas.microsoft.com/office/drawing/2014/main" id="{C6A8C8D6-4353-EF26-7915-52F4D14A9866}"/>
              </a:ext>
            </a:extLst>
          </p:cNvPr>
          <p:cNvSpPr txBox="1"/>
          <p:nvPr/>
        </p:nvSpPr>
        <p:spPr>
          <a:xfrm>
            <a:off x="4694462" y="4469750"/>
            <a:ext cx="1205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05" name="Group 204">
            <a:extLst>
              <a:ext uri="{FF2B5EF4-FFF2-40B4-BE49-F238E27FC236}">
                <a16:creationId xmlns:a16="http://schemas.microsoft.com/office/drawing/2014/main" id="{C748DE0E-E938-512C-8DAA-909B5B179FCE}"/>
              </a:ext>
            </a:extLst>
          </p:cNvPr>
          <p:cNvGrpSpPr/>
          <p:nvPr/>
        </p:nvGrpSpPr>
        <p:grpSpPr>
          <a:xfrm>
            <a:off x="4531548" y="2346559"/>
            <a:ext cx="2283154" cy="1904255"/>
            <a:chOff x="6164876" y="170156"/>
            <a:chExt cx="2283154" cy="1904255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A8BE2945-857D-95AA-94E9-52F45E8FB4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816" t="17219" b="21700"/>
            <a:stretch/>
          </p:blipFill>
          <p:spPr>
            <a:xfrm>
              <a:off x="6771982" y="221096"/>
              <a:ext cx="1676048" cy="1267807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57BA8AB-97AC-F4F7-D69B-30794CED1D98}"/>
                </a:ext>
              </a:extLst>
            </p:cNvPr>
            <p:cNvSpPr txBox="1"/>
            <p:nvPr/>
          </p:nvSpPr>
          <p:spPr>
            <a:xfrm>
              <a:off x="7996932" y="143710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grpSp>
          <p:nvGrpSpPr>
            <p:cNvPr id="161" name="Group 160">
              <a:extLst>
                <a:ext uri="{FF2B5EF4-FFF2-40B4-BE49-F238E27FC236}">
                  <a16:creationId xmlns:a16="http://schemas.microsoft.com/office/drawing/2014/main" id="{E94093F1-90AB-01DF-E959-C2583C9B3B85}"/>
                </a:ext>
              </a:extLst>
            </p:cNvPr>
            <p:cNvGrpSpPr/>
            <p:nvPr/>
          </p:nvGrpSpPr>
          <p:grpSpPr>
            <a:xfrm>
              <a:off x="6164876" y="170156"/>
              <a:ext cx="1930198" cy="1904255"/>
              <a:chOff x="6164876" y="170156"/>
              <a:chExt cx="1930198" cy="1904255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CA50933-8775-1BD2-123D-AA8DFFE83A71}"/>
                  </a:ext>
                </a:extLst>
              </p:cNvPr>
              <p:cNvSpPr txBox="1"/>
              <p:nvPr/>
            </p:nvSpPr>
            <p:spPr>
              <a:xfrm>
                <a:off x="6443101" y="188439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55A3FD4-B5B9-D05C-33B8-C1C169C0E346}"/>
                  </a:ext>
                </a:extLst>
              </p:cNvPr>
              <p:cNvSpPr txBox="1"/>
              <p:nvPr/>
            </p:nvSpPr>
            <p:spPr>
              <a:xfrm>
                <a:off x="6512411" y="408885"/>
                <a:ext cx="3417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83A21F0-7EEE-196D-29A6-15C918D3429D}"/>
                  </a:ext>
                </a:extLst>
              </p:cNvPr>
              <p:cNvSpPr txBox="1"/>
              <p:nvPr/>
            </p:nvSpPr>
            <p:spPr>
              <a:xfrm>
                <a:off x="6512411" y="641764"/>
                <a:ext cx="3417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7C71F22B-B2A1-190C-949B-BB1A06077379}"/>
                  </a:ext>
                </a:extLst>
              </p:cNvPr>
              <p:cNvSpPr txBox="1"/>
              <p:nvPr/>
            </p:nvSpPr>
            <p:spPr>
              <a:xfrm>
                <a:off x="6581719" y="1317314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4D4D08AF-CB25-6876-9824-B808AFC10BF0}"/>
                  </a:ext>
                </a:extLst>
              </p:cNvPr>
              <p:cNvSpPr txBox="1"/>
              <p:nvPr/>
            </p:nvSpPr>
            <p:spPr>
              <a:xfrm>
                <a:off x="6966840" y="1643524"/>
                <a:ext cx="985417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Post Injection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E613011-3047-605A-911A-6579EFDEB8FC}"/>
                  </a:ext>
                </a:extLst>
              </p:cNvPr>
              <p:cNvSpPr txBox="1"/>
              <p:nvPr/>
            </p:nvSpPr>
            <p:spPr>
              <a:xfrm rot="16200000">
                <a:off x="5665558" y="669474"/>
                <a:ext cx="1429523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ercent Change in ROI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ED492A66-1A44-E103-52EF-71184FE488AF}"/>
                  </a:ext>
                </a:extLst>
              </p:cNvPr>
              <p:cNvSpPr txBox="1"/>
              <p:nvPr/>
            </p:nvSpPr>
            <p:spPr>
              <a:xfrm>
                <a:off x="6512410" y="1092188"/>
                <a:ext cx="3417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6844AAA-19E6-DE19-49EC-02E6FD6CCD08}"/>
                  </a:ext>
                </a:extLst>
              </p:cNvPr>
              <p:cNvSpPr txBox="1"/>
              <p:nvPr/>
            </p:nvSpPr>
            <p:spPr>
              <a:xfrm>
                <a:off x="6512410" y="863359"/>
                <a:ext cx="3417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0E3622C-FEC3-4E58-BEF7-5A8165F92C4C}"/>
                  </a:ext>
                </a:extLst>
              </p:cNvPr>
              <p:cNvSpPr txBox="1"/>
              <p:nvPr/>
            </p:nvSpPr>
            <p:spPr>
              <a:xfrm>
                <a:off x="7498392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BA3C453-4301-FE2A-3BB6-EA8907BA158C}"/>
                  </a:ext>
                </a:extLst>
              </p:cNvPr>
              <p:cNvSpPr txBox="1"/>
              <p:nvPr/>
            </p:nvSpPr>
            <p:spPr>
              <a:xfrm>
                <a:off x="7332629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45ADB4AB-360E-96A6-8321-335A7C10ECFC}"/>
                  </a:ext>
                </a:extLst>
              </p:cNvPr>
              <p:cNvSpPr txBox="1"/>
              <p:nvPr/>
            </p:nvSpPr>
            <p:spPr>
              <a:xfrm>
                <a:off x="7167572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73174694-40D1-17C5-F41D-2A839E88A785}"/>
                  </a:ext>
                </a:extLst>
              </p:cNvPr>
              <p:cNvSpPr txBox="1"/>
              <p:nvPr/>
            </p:nvSpPr>
            <p:spPr>
              <a:xfrm>
                <a:off x="6664602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47A33C85-A394-8777-7704-49DCA5D92230}"/>
                  </a:ext>
                </a:extLst>
              </p:cNvPr>
              <p:cNvSpPr txBox="1"/>
              <p:nvPr/>
            </p:nvSpPr>
            <p:spPr>
              <a:xfrm>
                <a:off x="6832500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6BDD4EBF-90A9-428F-E294-B84FCB13357A}"/>
                  </a:ext>
                </a:extLst>
              </p:cNvPr>
              <p:cNvSpPr txBox="1"/>
              <p:nvPr/>
            </p:nvSpPr>
            <p:spPr>
              <a:xfrm>
                <a:off x="6997524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F1E31278-4E9D-F45C-C3F5-3627CF5D4014}"/>
                  </a:ext>
                </a:extLst>
              </p:cNvPr>
              <p:cNvSpPr txBox="1"/>
              <p:nvPr/>
            </p:nvSpPr>
            <p:spPr>
              <a:xfrm>
                <a:off x="7831860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BE28DECA-520D-2A17-9C4A-84859EFEC79C}"/>
                  </a:ext>
                </a:extLst>
              </p:cNvPr>
              <p:cNvSpPr txBox="1"/>
              <p:nvPr/>
            </p:nvSpPr>
            <p:spPr>
              <a:xfrm>
                <a:off x="7665421" y="143710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1163F8C-BEBF-2989-9A3E-7C63292625B6}"/>
                </a:ext>
              </a:extLst>
            </p:cNvPr>
            <p:cNvSpPr txBox="1"/>
            <p:nvPr/>
          </p:nvSpPr>
          <p:spPr>
            <a:xfrm>
              <a:off x="7268407" y="823563"/>
              <a:ext cx="4235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=2</a:t>
              </a:r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FABA3818-C359-5577-BE12-BCD019EB968F}"/>
                </a:ext>
              </a:extLst>
            </p:cNvPr>
            <p:cNvSpPr/>
            <p:nvPr/>
          </p:nvSpPr>
          <p:spPr>
            <a:xfrm>
              <a:off x="7224348" y="221096"/>
              <a:ext cx="924678" cy="5718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03C2B569-0196-E46B-D2EC-CE78A8D3B5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6303" t="37940" r="48324" b="50786"/>
            <a:stretch/>
          </p:blipFill>
          <p:spPr>
            <a:xfrm>
              <a:off x="7375966" y="410028"/>
              <a:ext cx="162854" cy="309520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47AAD2D-D6BD-5A15-225B-1766A1F59BAA}"/>
                </a:ext>
              </a:extLst>
            </p:cNvPr>
            <p:cNvSpPr txBox="1"/>
            <p:nvPr/>
          </p:nvSpPr>
          <p:spPr>
            <a:xfrm>
              <a:off x="7463638" y="379262"/>
              <a:ext cx="5319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9DDCC241-CE4B-4203-98CF-64734FF8782B}"/>
                </a:ext>
              </a:extLst>
            </p:cNvPr>
            <p:cNvSpPr txBox="1"/>
            <p:nvPr/>
          </p:nvSpPr>
          <p:spPr>
            <a:xfrm>
              <a:off x="7463638" y="531662"/>
              <a:ext cx="7722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% GC</a:t>
              </a:r>
            </a:p>
          </p:txBody>
        </p:sp>
      </p:grpSp>
      <p:grpSp>
        <p:nvGrpSpPr>
          <p:cNvPr id="204" name="Group 203">
            <a:extLst>
              <a:ext uri="{FF2B5EF4-FFF2-40B4-BE49-F238E27FC236}">
                <a16:creationId xmlns:a16="http://schemas.microsoft.com/office/drawing/2014/main" id="{74AC181C-A301-3FE5-6A1B-E82B9A3EAA01}"/>
              </a:ext>
            </a:extLst>
          </p:cNvPr>
          <p:cNvGrpSpPr/>
          <p:nvPr/>
        </p:nvGrpSpPr>
        <p:grpSpPr>
          <a:xfrm>
            <a:off x="5578520" y="116983"/>
            <a:ext cx="2397201" cy="2052791"/>
            <a:chOff x="1007009" y="1369502"/>
            <a:chExt cx="2397201" cy="2052791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7FB8C309-C159-05F5-0F10-91D2085F9A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8993" t="17219" r="13004" b="22163"/>
            <a:stretch/>
          </p:blipFill>
          <p:spPr>
            <a:xfrm>
              <a:off x="1616263" y="1581890"/>
              <a:ext cx="1417799" cy="1250469"/>
            </a:xfrm>
            <a:prstGeom prst="rect">
              <a:avLst/>
            </a:prstGeom>
          </p:spPr>
        </p:pic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CB8F0CA0-E5B6-6EED-F563-B37C68A3EEF3}"/>
                </a:ext>
              </a:extLst>
            </p:cNvPr>
            <p:cNvSpPr/>
            <p:nvPr/>
          </p:nvSpPr>
          <p:spPr>
            <a:xfrm>
              <a:off x="2088051" y="1369502"/>
              <a:ext cx="1316159" cy="7871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grpSp>
          <p:nvGrpSpPr>
            <p:cNvPr id="179" name="Group 178">
              <a:extLst>
                <a:ext uri="{FF2B5EF4-FFF2-40B4-BE49-F238E27FC236}">
                  <a16:creationId xmlns:a16="http://schemas.microsoft.com/office/drawing/2014/main" id="{1B1AD790-9024-7C19-F572-EE89CEA9DC29}"/>
                </a:ext>
              </a:extLst>
            </p:cNvPr>
            <p:cNvGrpSpPr/>
            <p:nvPr/>
          </p:nvGrpSpPr>
          <p:grpSpPr>
            <a:xfrm>
              <a:off x="2120847" y="1674933"/>
              <a:ext cx="978512" cy="682501"/>
              <a:chOff x="3376643" y="1855439"/>
              <a:chExt cx="978512" cy="682501"/>
            </a:xfrm>
          </p:grpSpPr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6EF99CC8-6EAF-8894-A5AB-F4B2E60257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46303" t="37940" r="48324" b="50786"/>
              <a:stretch/>
            </p:blipFill>
            <p:spPr>
              <a:xfrm>
                <a:off x="3432900" y="1877811"/>
                <a:ext cx="162854" cy="309520"/>
              </a:xfrm>
              <a:prstGeom prst="rect">
                <a:avLst/>
              </a:prstGeom>
            </p:spPr>
          </p:pic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B6DDB9FE-D086-2E5E-3EC6-FA1C589E7257}"/>
                  </a:ext>
                </a:extLst>
              </p:cNvPr>
              <p:cNvSpPr txBox="1"/>
              <p:nvPr/>
            </p:nvSpPr>
            <p:spPr>
              <a:xfrm>
                <a:off x="3525135" y="1855439"/>
                <a:ext cx="5124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E83A6668-8085-0C48-F09D-A60A025C6D55}"/>
                  </a:ext>
                </a:extLst>
              </p:cNvPr>
              <p:cNvSpPr txBox="1"/>
              <p:nvPr/>
            </p:nvSpPr>
            <p:spPr>
              <a:xfrm>
                <a:off x="3525135" y="2005752"/>
                <a:ext cx="8300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.75% GC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B2432B08-AE81-BFFF-E0B5-3934A4C715A9}"/>
                  </a:ext>
                </a:extLst>
              </p:cNvPr>
              <p:cNvSpPr txBox="1"/>
              <p:nvPr/>
            </p:nvSpPr>
            <p:spPr>
              <a:xfrm>
                <a:off x="3376643" y="2276330"/>
                <a:ext cx="4235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=1</a:t>
                </a:r>
              </a:p>
            </p:txBody>
          </p: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2C3C45F0-9015-C004-938A-8416726E3622}"/>
                </a:ext>
              </a:extLst>
            </p:cNvPr>
            <p:cNvGrpSpPr/>
            <p:nvPr/>
          </p:nvGrpSpPr>
          <p:grpSpPr>
            <a:xfrm>
              <a:off x="1007009" y="1518038"/>
              <a:ext cx="2107895" cy="1904255"/>
              <a:chOff x="1007009" y="1518038"/>
              <a:chExt cx="2107895" cy="1904255"/>
            </a:xfrm>
          </p:grpSpPr>
          <p:grpSp>
            <p:nvGrpSpPr>
              <p:cNvPr id="162" name="Group 161">
                <a:extLst>
                  <a:ext uri="{FF2B5EF4-FFF2-40B4-BE49-F238E27FC236}">
                    <a16:creationId xmlns:a16="http://schemas.microsoft.com/office/drawing/2014/main" id="{6D98C906-B138-EE91-B582-7C3A5F35DE30}"/>
                  </a:ext>
                </a:extLst>
              </p:cNvPr>
              <p:cNvGrpSpPr/>
              <p:nvPr/>
            </p:nvGrpSpPr>
            <p:grpSpPr>
              <a:xfrm>
                <a:off x="1007009" y="1518038"/>
                <a:ext cx="1930198" cy="1904255"/>
                <a:chOff x="6164876" y="170156"/>
                <a:chExt cx="1930198" cy="1904255"/>
              </a:xfrm>
            </p:grpSpPr>
            <p:sp>
              <p:nvSpPr>
                <p:cNvPr id="163" name="TextBox 162">
                  <a:extLst>
                    <a:ext uri="{FF2B5EF4-FFF2-40B4-BE49-F238E27FC236}">
                      <a16:creationId xmlns:a16="http://schemas.microsoft.com/office/drawing/2014/main" id="{72D3F96C-19C7-2C06-AD31-28A08D2CF5D2}"/>
                    </a:ext>
                  </a:extLst>
                </p:cNvPr>
                <p:cNvSpPr txBox="1"/>
                <p:nvPr/>
              </p:nvSpPr>
              <p:spPr>
                <a:xfrm>
                  <a:off x="6443101" y="188439"/>
                  <a:ext cx="42030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164" name="TextBox 163">
                  <a:extLst>
                    <a:ext uri="{FF2B5EF4-FFF2-40B4-BE49-F238E27FC236}">
                      <a16:creationId xmlns:a16="http://schemas.microsoft.com/office/drawing/2014/main" id="{61E77843-01D0-588D-4A66-FE391148C5EA}"/>
                    </a:ext>
                  </a:extLst>
                </p:cNvPr>
                <p:cNvSpPr txBox="1"/>
                <p:nvPr/>
              </p:nvSpPr>
              <p:spPr>
                <a:xfrm>
                  <a:off x="6512411" y="408885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</p:txBody>
            </p:sp>
            <p:sp>
              <p:nvSpPr>
                <p:cNvPr id="165" name="TextBox 164">
                  <a:extLst>
                    <a:ext uri="{FF2B5EF4-FFF2-40B4-BE49-F238E27FC236}">
                      <a16:creationId xmlns:a16="http://schemas.microsoft.com/office/drawing/2014/main" id="{DDF28EED-74C0-43FC-A0D4-C8DAC646C571}"/>
                    </a:ext>
                  </a:extLst>
                </p:cNvPr>
                <p:cNvSpPr txBox="1"/>
                <p:nvPr/>
              </p:nvSpPr>
              <p:spPr>
                <a:xfrm>
                  <a:off x="6512411" y="641764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166" name="TextBox 165">
                  <a:extLst>
                    <a:ext uri="{FF2B5EF4-FFF2-40B4-BE49-F238E27FC236}">
                      <a16:creationId xmlns:a16="http://schemas.microsoft.com/office/drawing/2014/main" id="{A739F5F8-A88B-9B78-530F-501A4BCB77FF}"/>
                    </a:ext>
                  </a:extLst>
                </p:cNvPr>
                <p:cNvSpPr txBox="1"/>
                <p:nvPr/>
              </p:nvSpPr>
              <p:spPr>
                <a:xfrm>
                  <a:off x="6581719" y="1317314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67" name="TextBox 166">
                  <a:extLst>
                    <a:ext uri="{FF2B5EF4-FFF2-40B4-BE49-F238E27FC236}">
                      <a16:creationId xmlns:a16="http://schemas.microsoft.com/office/drawing/2014/main" id="{8DF0758A-92AB-E881-F1B2-667F79F35FE7}"/>
                    </a:ext>
                  </a:extLst>
                </p:cNvPr>
                <p:cNvSpPr txBox="1"/>
                <p:nvPr/>
              </p:nvSpPr>
              <p:spPr>
                <a:xfrm>
                  <a:off x="6966840" y="1643524"/>
                  <a:ext cx="985417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s Post Injection</a:t>
                  </a:r>
                </a:p>
              </p:txBody>
            </p: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F4019D9F-4D03-5CAF-0101-95B354CE508B}"/>
                    </a:ext>
                  </a:extLst>
                </p:cNvPr>
                <p:cNvSpPr txBox="1"/>
                <p:nvPr/>
              </p:nvSpPr>
              <p:spPr>
                <a:xfrm rot="16200000">
                  <a:off x="5665558" y="669474"/>
                  <a:ext cx="1429523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rcent Change in ROI</a:t>
                  </a:r>
                </a:p>
              </p:txBody>
            </p:sp>
            <p:sp>
              <p:nvSpPr>
                <p:cNvPr id="169" name="TextBox 168">
                  <a:extLst>
                    <a:ext uri="{FF2B5EF4-FFF2-40B4-BE49-F238E27FC236}">
                      <a16:creationId xmlns:a16="http://schemas.microsoft.com/office/drawing/2014/main" id="{DFC7B490-DA4C-035B-6D73-71F0414709FA}"/>
                    </a:ext>
                  </a:extLst>
                </p:cNvPr>
                <p:cNvSpPr txBox="1"/>
                <p:nvPr/>
              </p:nvSpPr>
              <p:spPr>
                <a:xfrm>
                  <a:off x="6512410" y="1092188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170" name="TextBox 169">
                  <a:extLst>
                    <a:ext uri="{FF2B5EF4-FFF2-40B4-BE49-F238E27FC236}">
                      <a16:creationId xmlns:a16="http://schemas.microsoft.com/office/drawing/2014/main" id="{0EFD242C-1417-B548-4FF0-829552BB2812}"/>
                    </a:ext>
                  </a:extLst>
                </p:cNvPr>
                <p:cNvSpPr txBox="1"/>
                <p:nvPr/>
              </p:nvSpPr>
              <p:spPr>
                <a:xfrm>
                  <a:off x="6512410" y="863359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171" name="TextBox 170">
                  <a:extLst>
                    <a:ext uri="{FF2B5EF4-FFF2-40B4-BE49-F238E27FC236}">
                      <a16:creationId xmlns:a16="http://schemas.microsoft.com/office/drawing/2014/main" id="{6C5127C6-D8A6-5DBB-B2B0-9D8B5698A6CD}"/>
                    </a:ext>
                  </a:extLst>
                </p:cNvPr>
                <p:cNvSpPr txBox="1"/>
                <p:nvPr/>
              </p:nvSpPr>
              <p:spPr>
                <a:xfrm>
                  <a:off x="7498392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72" name="TextBox 171">
                  <a:extLst>
                    <a:ext uri="{FF2B5EF4-FFF2-40B4-BE49-F238E27FC236}">
                      <a16:creationId xmlns:a16="http://schemas.microsoft.com/office/drawing/2014/main" id="{3ADF8310-0650-A152-2425-F12472B33F0C}"/>
                    </a:ext>
                  </a:extLst>
                </p:cNvPr>
                <p:cNvSpPr txBox="1"/>
                <p:nvPr/>
              </p:nvSpPr>
              <p:spPr>
                <a:xfrm>
                  <a:off x="7332629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73" name="TextBox 172">
                  <a:extLst>
                    <a:ext uri="{FF2B5EF4-FFF2-40B4-BE49-F238E27FC236}">
                      <a16:creationId xmlns:a16="http://schemas.microsoft.com/office/drawing/2014/main" id="{FAC16955-D4C8-7716-5B8B-C70388B7B5E6}"/>
                    </a:ext>
                  </a:extLst>
                </p:cNvPr>
                <p:cNvSpPr txBox="1"/>
                <p:nvPr/>
              </p:nvSpPr>
              <p:spPr>
                <a:xfrm>
                  <a:off x="7167572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74" name="TextBox 173">
                  <a:extLst>
                    <a:ext uri="{FF2B5EF4-FFF2-40B4-BE49-F238E27FC236}">
                      <a16:creationId xmlns:a16="http://schemas.microsoft.com/office/drawing/2014/main" id="{BB031D2D-FCAD-C150-0D2E-B38FFB34D22F}"/>
                    </a:ext>
                  </a:extLst>
                </p:cNvPr>
                <p:cNvSpPr txBox="1"/>
                <p:nvPr/>
              </p:nvSpPr>
              <p:spPr>
                <a:xfrm>
                  <a:off x="6653970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75" name="TextBox 174">
                  <a:extLst>
                    <a:ext uri="{FF2B5EF4-FFF2-40B4-BE49-F238E27FC236}">
                      <a16:creationId xmlns:a16="http://schemas.microsoft.com/office/drawing/2014/main" id="{3CE3F6BC-A25E-CA42-C157-66B2693D3CE5}"/>
                    </a:ext>
                  </a:extLst>
                </p:cNvPr>
                <p:cNvSpPr txBox="1"/>
                <p:nvPr/>
              </p:nvSpPr>
              <p:spPr>
                <a:xfrm>
                  <a:off x="6827184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76" name="TextBox 175">
                  <a:extLst>
                    <a:ext uri="{FF2B5EF4-FFF2-40B4-BE49-F238E27FC236}">
                      <a16:creationId xmlns:a16="http://schemas.microsoft.com/office/drawing/2014/main" id="{E3134C63-6985-76BC-2C26-D35BD7FC931A}"/>
                    </a:ext>
                  </a:extLst>
                </p:cNvPr>
                <p:cNvSpPr txBox="1"/>
                <p:nvPr/>
              </p:nvSpPr>
              <p:spPr>
                <a:xfrm>
                  <a:off x="6997524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77" name="TextBox 176">
                  <a:extLst>
                    <a:ext uri="{FF2B5EF4-FFF2-40B4-BE49-F238E27FC236}">
                      <a16:creationId xmlns:a16="http://schemas.microsoft.com/office/drawing/2014/main" id="{50BFEB2C-F449-12AC-D26E-654A35949BD9}"/>
                    </a:ext>
                  </a:extLst>
                </p:cNvPr>
                <p:cNvSpPr txBox="1"/>
                <p:nvPr/>
              </p:nvSpPr>
              <p:spPr>
                <a:xfrm>
                  <a:off x="7831860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178" name="TextBox 177">
                  <a:extLst>
                    <a:ext uri="{FF2B5EF4-FFF2-40B4-BE49-F238E27FC236}">
                      <a16:creationId xmlns:a16="http://schemas.microsoft.com/office/drawing/2014/main" id="{2575AA65-70FA-9B85-73FC-DB0644201074}"/>
                    </a:ext>
                  </a:extLst>
                </p:cNvPr>
                <p:cNvSpPr txBox="1"/>
                <p:nvPr/>
              </p:nvSpPr>
              <p:spPr>
                <a:xfrm>
                  <a:off x="7665421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</p:grp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27C94759-990F-D8CA-0D3D-850AE29334B9}"/>
                  </a:ext>
                </a:extLst>
              </p:cNvPr>
              <p:cNvSpPr txBox="1"/>
              <p:nvPr/>
            </p:nvSpPr>
            <p:spPr>
              <a:xfrm>
                <a:off x="2851690" y="2781161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</p:grpSp>
      <p:grpSp>
        <p:nvGrpSpPr>
          <p:cNvPr id="202" name="Group 201">
            <a:extLst>
              <a:ext uri="{FF2B5EF4-FFF2-40B4-BE49-F238E27FC236}">
                <a16:creationId xmlns:a16="http://schemas.microsoft.com/office/drawing/2014/main" id="{D065B3A6-83DB-9D83-0E5D-C6C81DF62A33}"/>
              </a:ext>
            </a:extLst>
          </p:cNvPr>
          <p:cNvGrpSpPr/>
          <p:nvPr/>
        </p:nvGrpSpPr>
        <p:grpSpPr>
          <a:xfrm>
            <a:off x="3431223" y="260676"/>
            <a:ext cx="2247440" cy="1904255"/>
            <a:chOff x="3093555" y="1525407"/>
            <a:chExt cx="2247440" cy="1904255"/>
          </a:xfrm>
        </p:grpSpPr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77EDA48C-9CDD-2048-5E03-20FC4AA380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8551" t="17219" r="12583" b="21851"/>
            <a:stretch/>
          </p:blipFill>
          <p:spPr>
            <a:xfrm>
              <a:off x="3701075" y="1584276"/>
              <a:ext cx="1431983" cy="1257353"/>
            </a:xfrm>
            <a:prstGeom prst="rect">
              <a:avLst/>
            </a:prstGeom>
          </p:spPr>
        </p:pic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7DED23E8-5C81-9431-5284-078DA347D490}"/>
                </a:ext>
              </a:extLst>
            </p:cNvPr>
            <p:cNvSpPr/>
            <p:nvPr/>
          </p:nvSpPr>
          <p:spPr>
            <a:xfrm>
              <a:off x="4071223" y="1544539"/>
              <a:ext cx="1269772" cy="6017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grpSp>
          <p:nvGrpSpPr>
            <p:cNvPr id="182" name="Group 181">
              <a:extLst>
                <a:ext uri="{FF2B5EF4-FFF2-40B4-BE49-F238E27FC236}">
                  <a16:creationId xmlns:a16="http://schemas.microsoft.com/office/drawing/2014/main" id="{247184CA-0480-F54B-F4F7-4EB7E46A1DF2}"/>
                </a:ext>
              </a:extLst>
            </p:cNvPr>
            <p:cNvGrpSpPr/>
            <p:nvPr/>
          </p:nvGrpSpPr>
          <p:grpSpPr>
            <a:xfrm>
              <a:off x="4193880" y="1599679"/>
              <a:ext cx="925606" cy="749016"/>
              <a:chOff x="5342502" y="1683458"/>
              <a:chExt cx="925606" cy="749016"/>
            </a:xfrm>
          </p:grpSpPr>
          <p:pic>
            <p:nvPicPr>
              <p:cNvPr id="115" name="Picture 114">
                <a:extLst>
                  <a:ext uri="{FF2B5EF4-FFF2-40B4-BE49-F238E27FC236}">
                    <a16:creationId xmlns:a16="http://schemas.microsoft.com/office/drawing/2014/main" id="{E9920093-B529-1B53-D307-66B3604B52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46303" t="37940" r="48324" b="50786"/>
              <a:stretch/>
            </p:blipFill>
            <p:spPr>
              <a:xfrm>
                <a:off x="5388429" y="1688740"/>
                <a:ext cx="173672" cy="374454"/>
              </a:xfrm>
              <a:prstGeom prst="rect">
                <a:avLst/>
              </a:prstGeom>
            </p:spPr>
          </p:pic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69A97F66-18FF-3490-B8BA-CDA43A82719E}"/>
                  </a:ext>
                </a:extLst>
              </p:cNvPr>
              <p:cNvSpPr txBox="1"/>
              <p:nvPr/>
            </p:nvSpPr>
            <p:spPr>
              <a:xfrm>
                <a:off x="5486773" y="1683458"/>
                <a:ext cx="47256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4D6FE550-3A6F-0495-E62D-BF6B164964FE}"/>
                  </a:ext>
                </a:extLst>
              </p:cNvPr>
              <p:cNvSpPr txBox="1"/>
              <p:nvPr/>
            </p:nvSpPr>
            <p:spPr>
              <a:xfrm>
                <a:off x="5486773" y="1858877"/>
                <a:ext cx="78133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.9% GC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C6E80BFA-6DDF-4D48-7BB3-99196952FF88}"/>
                  </a:ext>
                </a:extLst>
              </p:cNvPr>
              <p:cNvSpPr txBox="1"/>
              <p:nvPr/>
            </p:nvSpPr>
            <p:spPr>
              <a:xfrm>
                <a:off x="5342502" y="2170864"/>
                <a:ext cx="4235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=1</a:t>
                </a:r>
              </a:p>
            </p:txBody>
          </p:sp>
        </p:grpSp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0975ED2C-0D9E-F985-00B9-E1457C31BEFE}"/>
                </a:ext>
              </a:extLst>
            </p:cNvPr>
            <p:cNvGrpSpPr/>
            <p:nvPr/>
          </p:nvGrpSpPr>
          <p:grpSpPr>
            <a:xfrm>
              <a:off x="3093555" y="1525407"/>
              <a:ext cx="2107895" cy="1904255"/>
              <a:chOff x="1007009" y="1518038"/>
              <a:chExt cx="2107895" cy="1904255"/>
            </a:xfrm>
          </p:grpSpPr>
          <p:grpSp>
            <p:nvGrpSpPr>
              <p:cNvPr id="184" name="Group 183">
                <a:extLst>
                  <a:ext uri="{FF2B5EF4-FFF2-40B4-BE49-F238E27FC236}">
                    <a16:creationId xmlns:a16="http://schemas.microsoft.com/office/drawing/2014/main" id="{25F47B5F-17F2-16D4-0827-1C79A2ACF32F}"/>
                  </a:ext>
                </a:extLst>
              </p:cNvPr>
              <p:cNvGrpSpPr/>
              <p:nvPr/>
            </p:nvGrpSpPr>
            <p:grpSpPr>
              <a:xfrm>
                <a:off x="1007009" y="1518038"/>
                <a:ext cx="1946146" cy="1904255"/>
                <a:chOff x="6164876" y="170156"/>
                <a:chExt cx="1946146" cy="1904255"/>
              </a:xfrm>
            </p:grpSpPr>
            <p:sp>
              <p:nvSpPr>
                <p:cNvPr id="186" name="TextBox 185">
                  <a:extLst>
                    <a:ext uri="{FF2B5EF4-FFF2-40B4-BE49-F238E27FC236}">
                      <a16:creationId xmlns:a16="http://schemas.microsoft.com/office/drawing/2014/main" id="{A563CF66-0F66-BE44-46CD-7DDF6108BC0B}"/>
                    </a:ext>
                  </a:extLst>
                </p:cNvPr>
                <p:cNvSpPr txBox="1"/>
                <p:nvPr/>
              </p:nvSpPr>
              <p:spPr>
                <a:xfrm>
                  <a:off x="6443101" y="188439"/>
                  <a:ext cx="42030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187" name="TextBox 186">
                  <a:extLst>
                    <a:ext uri="{FF2B5EF4-FFF2-40B4-BE49-F238E27FC236}">
                      <a16:creationId xmlns:a16="http://schemas.microsoft.com/office/drawing/2014/main" id="{13324FE7-16F4-BD0B-3DEA-0F6EF8F6C51A}"/>
                    </a:ext>
                  </a:extLst>
                </p:cNvPr>
                <p:cNvSpPr txBox="1"/>
                <p:nvPr/>
              </p:nvSpPr>
              <p:spPr>
                <a:xfrm>
                  <a:off x="6512411" y="408885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</p:txBody>
            </p:sp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E3F94FCB-735F-E733-AEEB-34A77050C2AA}"/>
                    </a:ext>
                  </a:extLst>
                </p:cNvPr>
                <p:cNvSpPr txBox="1"/>
                <p:nvPr/>
              </p:nvSpPr>
              <p:spPr>
                <a:xfrm>
                  <a:off x="6512411" y="641764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7BCF3257-7445-48D0-CE4E-EFF75964C198}"/>
                    </a:ext>
                  </a:extLst>
                </p:cNvPr>
                <p:cNvSpPr txBox="1"/>
                <p:nvPr/>
              </p:nvSpPr>
              <p:spPr>
                <a:xfrm>
                  <a:off x="6581719" y="1317314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497C54BC-3099-56CD-2360-51653D003F19}"/>
                    </a:ext>
                  </a:extLst>
                </p:cNvPr>
                <p:cNvSpPr txBox="1"/>
                <p:nvPr/>
              </p:nvSpPr>
              <p:spPr>
                <a:xfrm>
                  <a:off x="6966840" y="1643524"/>
                  <a:ext cx="985417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s Post Injection</a:t>
                  </a:r>
                </a:p>
              </p:txBody>
            </p:sp>
            <p:sp>
              <p:nvSpPr>
                <p:cNvPr id="191" name="TextBox 190">
                  <a:extLst>
                    <a:ext uri="{FF2B5EF4-FFF2-40B4-BE49-F238E27FC236}">
                      <a16:creationId xmlns:a16="http://schemas.microsoft.com/office/drawing/2014/main" id="{1599EF87-FF41-3B61-65DE-6010CB3FFEAB}"/>
                    </a:ext>
                  </a:extLst>
                </p:cNvPr>
                <p:cNvSpPr txBox="1"/>
                <p:nvPr/>
              </p:nvSpPr>
              <p:spPr>
                <a:xfrm rot="16200000">
                  <a:off x="5665558" y="669474"/>
                  <a:ext cx="1429523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rcent Change in ROI</a:t>
                  </a:r>
                </a:p>
              </p:txBody>
            </p:sp>
            <p:sp>
              <p:nvSpPr>
                <p:cNvPr id="192" name="TextBox 191">
                  <a:extLst>
                    <a:ext uri="{FF2B5EF4-FFF2-40B4-BE49-F238E27FC236}">
                      <a16:creationId xmlns:a16="http://schemas.microsoft.com/office/drawing/2014/main" id="{E111D656-00FE-F4FA-EC40-A7CD4C2D02FC}"/>
                    </a:ext>
                  </a:extLst>
                </p:cNvPr>
                <p:cNvSpPr txBox="1"/>
                <p:nvPr/>
              </p:nvSpPr>
              <p:spPr>
                <a:xfrm>
                  <a:off x="6512410" y="1092188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1151EE5A-92B9-5CB5-85E5-77119495A217}"/>
                    </a:ext>
                  </a:extLst>
                </p:cNvPr>
                <p:cNvSpPr txBox="1"/>
                <p:nvPr/>
              </p:nvSpPr>
              <p:spPr>
                <a:xfrm>
                  <a:off x="6512410" y="863359"/>
                  <a:ext cx="34176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69399755-A5B9-869D-F001-5D776926D42F}"/>
                    </a:ext>
                  </a:extLst>
                </p:cNvPr>
                <p:cNvSpPr txBox="1"/>
                <p:nvPr/>
              </p:nvSpPr>
              <p:spPr>
                <a:xfrm>
                  <a:off x="7509024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12009592-A433-3BFF-B601-D1E24294AE11}"/>
                    </a:ext>
                  </a:extLst>
                </p:cNvPr>
                <p:cNvSpPr txBox="1"/>
                <p:nvPr/>
              </p:nvSpPr>
              <p:spPr>
                <a:xfrm>
                  <a:off x="7343261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15CDA603-6C43-606E-2724-6972B1559FDF}"/>
                    </a:ext>
                  </a:extLst>
                </p:cNvPr>
                <p:cNvSpPr txBox="1"/>
                <p:nvPr/>
              </p:nvSpPr>
              <p:spPr>
                <a:xfrm>
                  <a:off x="7172888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E4A84BA0-C665-0E1A-75E9-DBD803F84273}"/>
                    </a:ext>
                  </a:extLst>
                </p:cNvPr>
                <p:cNvSpPr txBox="1"/>
                <p:nvPr/>
              </p:nvSpPr>
              <p:spPr>
                <a:xfrm>
                  <a:off x="6664602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AF4967D9-FCAD-E0CE-4BD4-958FDC7634A4}"/>
                    </a:ext>
                  </a:extLst>
                </p:cNvPr>
                <p:cNvSpPr txBox="1"/>
                <p:nvPr/>
              </p:nvSpPr>
              <p:spPr>
                <a:xfrm>
                  <a:off x="6837816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id="{36F8FD4F-1496-44BD-7AA0-0BB634B4714E}"/>
                    </a:ext>
                  </a:extLst>
                </p:cNvPr>
                <p:cNvSpPr txBox="1"/>
                <p:nvPr/>
              </p:nvSpPr>
              <p:spPr>
                <a:xfrm>
                  <a:off x="7002840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0505952C-352B-0B3E-3A7E-40E047F578F0}"/>
                    </a:ext>
                  </a:extLst>
                </p:cNvPr>
                <p:cNvSpPr txBox="1"/>
                <p:nvPr/>
              </p:nvSpPr>
              <p:spPr>
                <a:xfrm>
                  <a:off x="7847808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201" name="TextBox 200">
                  <a:extLst>
                    <a:ext uri="{FF2B5EF4-FFF2-40B4-BE49-F238E27FC236}">
                      <a16:creationId xmlns:a16="http://schemas.microsoft.com/office/drawing/2014/main" id="{FE83A688-851B-7D35-2538-8DA6AFEE4B98}"/>
                    </a:ext>
                  </a:extLst>
                </p:cNvPr>
                <p:cNvSpPr txBox="1"/>
                <p:nvPr/>
              </p:nvSpPr>
              <p:spPr>
                <a:xfrm>
                  <a:off x="7681369" y="1437109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</p:grp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BCA00D76-1B56-C246-4C92-0A22A7DAB6FB}"/>
                  </a:ext>
                </a:extLst>
              </p:cNvPr>
              <p:cNvSpPr txBox="1"/>
              <p:nvPr/>
            </p:nvSpPr>
            <p:spPr>
              <a:xfrm>
                <a:off x="2851690" y="2781161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</p:grpSp>
      <p:sp>
        <p:nvSpPr>
          <p:cNvPr id="207" name="TextBox 206">
            <a:extLst>
              <a:ext uri="{FF2B5EF4-FFF2-40B4-BE49-F238E27FC236}">
                <a16:creationId xmlns:a16="http://schemas.microsoft.com/office/drawing/2014/main" id="{F3E3EF84-C916-9FBF-7B0F-53945F54BED0}"/>
              </a:ext>
            </a:extLst>
          </p:cNvPr>
          <p:cNvSpPr txBox="1"/>
          <p:nvPr/>
        </p:nvSpPr>
        <p:spPr>
          <a:xfrm>
            <a:off x="3700371" y="-25998"/>
            <a:ext cx="2075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tigen Retention at the Site of Injection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4D36FC10-252B-1D15-EF27-62DC04610BE4}"/>
              </a:ext>
            </a:extLst>
          </p:cNvPr>
          <p:cNvSpPr txBox="1"/>
          <p:nvPr/>
        </p:nvSpPr>
        <p:spPr>
          <a:xfrm>
            <a:off x="5803772" y="-25998"/>
            <a:ext cx="2075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tigen Retention at the Site of Injection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EC780486-2C26-2D71-F34A-BF1B3E3D5F58}"/>
              </a:ext>
            </a:extLst>
          </p:cNvPr>
          <p:cNvSpPr txBox="1"/>
          <p:nvPr/>
        </p:nvSpPr>
        <p:spPr>
          <a:xfrm>
            <a:off x="4766110" y="2160022"/>
            <a:ext cx="2075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tigen Retention at the Site of Injection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ABEE8D9E-B4F4-74FA-7DAD-1C829D6C2C38}"/>
              </a:ext>
            </a:extLst>
          </p:cNvPr>
          <p:cNvSpPr txBox="1"/>
          <p:nvPr/>
        </p:nvSpPr>
        <p:spPr>
          <a:xfrm>
            <a:off x="53735" y="-16323"/>
            <a:ext cx="1205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87" name="Group 286">
            <a:extLst>
              <a:ext uri="{FF2B5EF4-FFF2-40B4-BE49-F238E27FC236}">
                <a16:creationId xmlns:a16="http://schemas.microsoft.com/office/drawing/2014/main" id="{7335008E-FCE6-0935-87AF-129088996AA7}"/>
              </a:ext>
            </a:extLst>
          </p:cNvPr>
          <p:cNvGrpSpPr/>
          <p:nvPr/>
        </p:nvGrpSpPr>
        <p:grpSpPr>
          <a:xfrm>
            <a:off x="53735" y="2118158"/>
            <a:ext cx="4022875" cy="3065164"/>
            <a:chOff x="53735" y="1831551"/>
            <a:chExt cx="4022875" cy="3065164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204A8599-A07D-2764-8158-31A9DC2F2367}"/>
                </a:ext>
              </a:extLst>
            </p:cNvPr>
            <p:cNvSpPr txBox="1"/>
            <p:nvPr/>
          </p:nvSpPr>
          <p:spPr>
            <a:xfrm>
              <a:off x="53735" y="1831551"/>
              <a:ext cx="1205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248" name="Group 247">
              <a:extLst>
                <a:ext uri="{FF2B5EF4-FFF2-40B4-BE49-F238E27FC236}">
                  <a16:creationId xmlns:a16="http://schemas.microsoft.com/office/drawing/2014/main" id="{766FB2E2-68C2-3B76-D488-F60602B093DE}"/>
                </a:ext>
              </a:extLst>
            </p:cNvPr>
            <p:cNvGrpSpPr/>
            <p:nvPr/>
          </p:nvGrpSpPr>
          <p:grpSpPr>
            <a:xfrm>
              <a:off x="2686936" y="1952384"/>
              <a:ext cx="1389674" cy="1448991"/>
              <a:chOff x="2666464" y="1952384"/>
              <a:chExt cx="1389674" cy="1448991"/>
            </a:xfrm>
          </p:grpSpPr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59CF866F-556A-F765-FE29-20C68778FA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6925" t="23233" r="16090" b="18551"/>
              <a:stretch/>
            </p:blipFill>
            <p:spPr>
              <a:xfrm>
                <a:off x="3128123" y="2308434"/>
                <a:ext cx="723573" cy="891966"/>
              </a:xfrm>
              <a:prstGeom prst="rect">
                <a:avLst/>
              </a:prstGeom>
            </p:spPr>
          </p:pic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B5A6D262-AD0D-E4C2-2610-386DFEDDF325}"/>
                  </a:ext>
                </a:extLst>
              </p:cNvPr>
              <p:cNvSpPr txBox="1"/>
              <p:nvPr/>
            </p:nvSpPr>
            <p:spPr>
              <a:xfrm>
                <a:off x="2955211" y="303670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4209CE34-7679-AACD-189C-DD77E1933E86}"/>
                  </a:ext>
                </a:extLst>
              </p:cNvPr>
              <p:cNvSpPr txBox="1"/>
              <p:nvPr/>
            </p:nvSpPr>
            <p:spPr>
              <a:xfrm>
                <a:off x="2802110" y="27584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e4</a:t>
                </a: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8101329D-F2C0-FE75-C05A-161F1C0AF7CE}"/>
                  </a:ext>
                </a:extLst>
              </p:cNvPr>
              <p:cNvSpPr txBox="1"/>
              <p:nvPr/>
            </p:nvSpPr>
            <p:spPr>
              <a:xfrm>
                <a:off x="2802110" y="248958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e4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AE430786-EEC8-7D4A-B05F-A430FF764EF8}"/>
                  </a:ext>
                </a:extLst>
              </p:cNvPr>
              <p:cNvSpPr txBox="1"/>
              <p:nvPr/>
            </p:nvSpPr>
            <p:spPr>
              <a:xfrm>
                <a:off x="2802110" y="2213056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e4</a:t>
                </a: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2588CCA0-68F8-55B9-CBF3-67AF5093E7F4}"/>
                  </a:ext>
                </a:extLst>
              </p:cNvPr>
              <p:cNvSpPr txBox="1"/>
              <p:nvPr/>
            </p:nvSpPr>
            <p:spPr>
              <a:xfrm>
                <a:off x="3117478" y="3139765"/>
                <a:ext cx="4683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CD8B939A-4CE5-71C3-1460-CDDB3AD2D681}"/>
                  </a:ext>
                </a:extLst>
              </p:cNvPr>
              <p:cNvSpPr txBox="1"/>
              <p:nvPr/>
            </p:nvSpPr>
            <p:spPr>
              <a:xfrm>
                <a:off x="3451337" y="3139765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218" name="Rectangle 217">
                <a:extLst>
                  <a:ext uri="{FF2B5EF4-FFF2-40B4-BE49-F238E27FC236}">
                    <a16:creationId xmlns:a16="http://schemas.microsoft.com/office/drawing/2014/main" id="{31FE7342-F86D-120F-B470-4B078BA33125}"/>
                  </a:ext>
                </a:extLst>
              </p:cNvPr>
              <p:cNvSpPr/>
              <p:nvPr/>
            </p:nvSpPr>
            <p:spPr>
              <a:xfrm>
                <a:off x="3296944" y="2268357"/>
                <a:ext cx="112530" cy="52577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9" name="Rectangle 218">
                <a:extLst>
                  <a:ext uri="{FF2B5EF4-FFF2-40B4-BE49-F238E27FC236}">
                    <a16:creationId xmlns:a16="http://schemas.microsoft.com/office/drawing/2014/main" id="{6B561988-4E03-2D3A-8F6C-29A8E2FBF891}"/>
                  </a:ext>
                </a:extLst>
              </p:cNvPr>
              <p:cNvSpPr/>
              <p:nvPr/>
            </p:nvSpPr>
            <p:spPr>
              <a:xfrm>
                <a:off x="3585876" y="2274935"/>
                <a:ext cx="126482" cy="7820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2B67D381-0745-39C2-F008-31E84601129F}"/>
                  </a:ext>
                </a:extLst>
              </p:cNvPr>
              <p:cNvSpPr txBox="1"/>
              <p:nvPr/>
            </p:nvSpPr>
            <p:spPr>
              <a:xfrm>
                <a:off x="2916082" y="1952384"/>
                <a:ext cx="114005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igrating DCs</a:t>
                </a: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2B19D300-1DA3-3A6D-B75A-72998E077A1D}"/>
                  </a:ext>
                </a:extLst>
              </p:cNvPr>
              <p:cNvSpPr txBox="1"/>
              <p:nvPr/>
            </p:nvSpPr>
            <p:spPr>
              <a:xfrm rot="16200000">
                <a:off x="2393953" y="2620252"/>
                <a:ext cx="8066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ularity</a:t>
                </a:r>
              </a:p>
            </p:txBody>
          </p:sp>
        </p:grpSp>
        <p:grpSp>
          <p:nvGrpSpPr>
            <p:cNvPr id="249" name="Group 248">
              <a:extLst>
                <a:ext uri="{FF2B5EF4-FFF2-40B4-BE49-F238E27FC236}">
                  <a16:creationId xmlns:a16="http://schemas.microsoft.com/office/drawing/2014/main" id="{B1E1AFC7-30E6-87FE-DE1E-458B0B809E37}"/>
                </a:ext>
              </a:extLst>
            </p:cNvPr>
            <p:cNvGrpSpPr/>
            <p:nvPr/>
          </p:nvGrpSpPr>
          <p:grpSpPr>
            <a:xfrm>
              <a:off x="1396763" y="1952384"/>
              <a:ext cx="1309891" cy="1444056"/>
              <a:chOff x="1396763" y="1952384"/>
              <a:chExt cx="1309891" cy="1444056"/>
            </a:xfrm>
          </p:grpSpPr>
          <p:pic>
            <p:nvPicPr>
              <p:cNvPr id="86" name="Picture 85">
                <a:extLst>
                  <a:ext uri="{FF2B5EF4-FFF2-40B4-BE49-F238E27FC236}">
                    <a16:creationId xmlns:a16="http://schemas.microsoft.com/office/drawing/2014/main" id="{20135264-428C-71C1-6E70-D451D5BFE9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7006" t="18229" r="13805" b="20088"/>
              <a:stretch/>
            </p:blipFill>
            <p:spPr>
              <a:xfrm>
                <a:off x="1953086" y="2327669"/>
                <a:ext cx="753568" cy="872732"/>
              </a:xfrm>
              <a:prstGeom prst="rect">
                <a:avLst/>
              </a:prstGeom>
            </p:spPr>
          </p:pic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1FDFD4F9-6FEF-3C8E-F277-A5D7A8429B1D}"/>
                  </a:ext>
                </a:extLst>
              </p:cNvPr>
              <p:cNvSpPr txBox="1"/>
              <p:nvPr/>
            </p:nvSpPr>
            <p:spPr>
              <a:xfrm>
                <a:off x="1997817" y="1952384"/>
                <a:ext cx="6623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 Cells</a:t>
                </a:r>
              </a:p>
            </p:txBody>
          </p:sp>
          <p:grpSp>
            <p:nvGrpSpPr>
              <p:cNvPr id="234" name="Group 233">
                <a:extLst>
                  <a:ext uri="{FF2B5EF4-FFF2-40B4-BE49-F238E27FC236}">
                    <a16:creationId xmlns:a16="http://schemas.microsoft.com/office/drawing/2014/main" id="{E4F89347-01BB-D489-8DDE-BDC26E1098F4}"/>
                  </a:ext>
                </a:extLst>
              </p:cNvPr>
              <p:cNvGrpSpPr/>
              <p:nvPr/>
            </p:nvGrpSpPr>
            <p:grpSpPr>
              <a:xfrm>
                <a:off x="1396763" y="2219103"/>
                <a:ext cx="1276671" cy="1177337"/>
                <a:chOff x="1215927" y="2219103"/>
                <a:chExt cx="1276671" cy="1177337"/>
              </a:xfrm>
            </p:grpSpPr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5383A0B0-BEF6-55E8-BE5B-C5A13E343230}"/>
                    </a:ext>
                  </a:extLst>
                </p:cNvPr>
                <p:cNvSpPr txBox="1"/>
                <p:nvPr/>
              </p:nvSpPr>
              <p:spPr>
                <a:xfrm>
                  <a:off x="1603622" y="3031767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305593B0-1B01-E688-CCC9-0C36F9891FAB}"/>
                    </a:ext>
                  </a:extLst>
                </p:cNvPr>
                <p:cNvSpPr txBox="1"/>
                <p:nvPr/>
              </p:nvSpPr>
              <p:spPr>
                <a:xfrm>
                  <a:off x="1341337" y="2831953"/>
                  <a:ext cx="53732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e7</a:t>
                  </a:r>
                </a:p>
              </p:txBody>
            </p:sp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1CBE272C-A09D-01F6-8EE8-A917FAB5D593}"/>
                    </a:ext>
                  </a:extLst>
                </p:cNvPr>
                <p:cNvSpPr txBox="1"/>
                <p:nvPr/>
              </p:nvSpPr>
              <p:spPr>
                <a:xfrm>
                  <a:off x="1341337" y="2624541"/>
                  <a:ext cx="53732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e7</a:t>
                  </a:r>
                </a:p>
              </p:txBody>
            </p: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CDE39AF4-ACB5-DE9D-4EB1-C94228DD1AAB}"/>
                    </a:ext>
                  </a:extLst>
                </p:cNvPr>
                <p:cNvSpPr txBox="1"/>
                <p:nvPr/>
              </p:nvSpPr>
              <p:spPr>
                <a:xfrm>
                  <a:off x="1341337" y="2418440"/>
                  <a:ext cx="53732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e7</a:t>
                  </a:r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A014C15A-439F-049D-F323-02B604488284}"/>
                    </a:ext>
                  </a:extLst>
                </p:cNvPr>
                <p:cNvSpPr txBox="1"/>
                <p:nvPr/>
              </p:nvSpPr>
              <p:spPr>
                <a:xfrm>
                  <a:off x="1765889" y="3134830"/>
                  <a:ext cx="4683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S</a:t>
                  </a:r>
                </a:p>
              </p:txBody>
            </p:sp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9241D1E3-6A1F-FD5D-6DBB-2CADD7BC0ACA}"/>
                    </a:ext>
                  </a:extLst>
                </p:cNvPr>
                <p:cNvSpPr txBox="1"/>
                <p:nvPr/>
              </p:nvSpPr>
              <p:spPr>
                <a:xfrm>
                  <a:off x="2096336" y="3134830"/>
                  <a:ext cx="39626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0EFEABB5-C768-3394-6DDB-E0EE00856BA9}"/>
                    </a:ext>
                  </a:extLst>
                </p:cNvPr>
                <p:cNvSpPr txBox="1"/>
                <p:nvPr/>
              </p:nvSpPr>
              <p:spPr>
                <a:xfrm rot="16200000">
                  <a:off x="943416" y="2628965"/>
                  <a:ext cx="80663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ularity</a:t>
                  </a:r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07A39183-6F0F-E1EE-6525-F83650C4B5DD}"/>
                    </a:ext>
                  </a:extLst>
                </p:cNvPr>
                <p:cNvSpPr txBox="1"/>
                <p:nvPr/>
              </p:nvSpPr>
              <p:spPr>
                <a:xfrm>
                  <a:off x="1341337" y="2219103"/>
                  <a:ext cx="53732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e7</a:t>
                  </a:r>
                </a:p>
              </p:txBody>
            </p:sp>
          </p:grpSp>
        </p:grpSp>
        <p:grpSp>
          <p:nvGrpSpPr>
            <p:cNvPr id="246" name="Group 245">
              <a:extLst>
                <a:ext uri="{FF2B5EF4-FFF2-40B4-BE49-F238E27FC236}">
                  <a16:creationId xmlns:a16="http://schemas.microsoft.com/office/drawing/2014/main" id="{C2B53A8A-9C7D-EDEA-DD37-B3B4B563AF89}"/>
                </a:ext>
              </a:extLst>
            </p:cNvPr>
            <p:cNvGrpSpPr/>
            <p:nvPr/>
          </p:nvGrpSpPr>
          <p:grpSpPr>
            <a:xfrm>
              <a:off x="183925" y="1867746"/>
              <a:ext cx="1372086" cy="1537974"/>
              <a:chOff x="156629" y="1867746"/>
              <a:chExt cx="1372086" cy="1537974"/>
            </a:xfrm>
          </p:grpSpPr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17068D60-9F3D-1B14-9788-1595C5AC88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7182" t="17913" r="16257" b="19551"/>
              <a:stretch/>
            </p:blipFill>
            <p:spPr>
              <a:xfrm>
                <a:off x="618323" y="2289456"/>
                <a:ext cx="718196" cy="910825"/>
              </a:xfrm>
              <a:prstGeom prst="rect">
                <a:avLst/>
              </a:prstGeom>
            </p:spPr>
          </p:pic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DA9B1C53-903D-ADCD-00A6-5FE21A8D9FCE}"/>
                  </a:ext>
                </a:extLst>
              </p:cNvPr>
              <p:cNvSpPr txBox="1"/>
              <p:nvPr/>
            </p:nvSpPr>
            <p:spPr>
              <a:xfrm>
                <a:off x="433543" y="1867746"/>
                <a:ext cx="1095172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</a:t>
                </a:r>
              </a:p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s</a:t>
                </a:r>
              </a:p>
            </p:txBody>
          </p: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BE6255A2-B066-7717-5D90-C60604458631}"/>
                  </a:ext>
                </a:extLst>
              </p:cNvPr>
              <p:cNvSpPr txBox="1"/>
              <p:nvPr/>
            </p:nvSpPr>
            <p:spPr>
              <a:xfrm>
                <a:off x="448788" y="3041047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31975A43-9769-63FC-F984-DA20202701A6}"/>
                  </a:ext>
                </a:extLst>
              </p:cNvPr>
              <p:cNvSpPr txBox="1"/>
              <p:nvPr/>
            </p:nvSpPr>
            <p:spPr>
              <a:xfrm>
                <a:off x="299099" y="276347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e7</a:t>
                </a: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73145E2A-665A-B3AF-9B31-50DF9890BEE5}"/>
                  </a:ext>
                </a:extLst>
              </p:cNvPr>
              <p:cNvSpPr txBox="1"/>
              <p:nvPr/>
            </p:nvSpPr>
            <p:spPr>
              <a:xfrm>
                <a:off x="299099" y="249937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e7</a:t>
                </a: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7515887C-39AF-C8EC-DA94-2D5807EAE2D4}"/>
                  </a:ext>
                </a:extLst>
              </p:cNvPr>
              <p:cNvSpPr txBox="1"/>
              <p:nvPr/>
            </p:nvSpPr>
            <p:spPr>
              <a:xfrm>
                <a:off x="611055" y="3144110"/>
                <a:ext cx="4683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BE9014C2-A23F-F33B-1F05-C0B21DC9BB30}"/>
                  </a:ext>
                </a:extLst>
              </p:cNvPr>
              <p:cNvSpPr txBox="1"/>
              <p:nvPr/>
            </p:nvSpPr>
            <p:spPr>
              <a:xfrm>
                <a:off x="941502" y="3144110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24B7F2EA-50DB-B056-3528-970C45AD822C}"/>
                  </a:ext>
                </a:extLst>
              </p:cNvPr>
              <p:cNvSpPr txBox="1"/>
              <p:nvPr/>
            </p:nvSpPr>
            <p:spPr>
              <a:xfrm rot="16200000">
                <a:off x="-115882" y="2631421"/>
                <a:ext cx="8066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ularity</a:t>
                </a:r>
              </a:p>
            </p:txBody>
          </p:sp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BAA1F766-6F5E-8B1F-D63D-A98504CCF7A2}"/>
                  </a:ext>
                </a:extLst>
              </p:cNvPr>
              <p:cNvSpPr txBox="1"/>
              <p:nvPr/>
            </p:nvSpPr>
            <p:spPr>
              <a:xfrm>
                <a:off x="299099" y="2221559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e7</a:t>
                </a:r>
              </a:p>
            </p:txBody>
          </p:sp>
        </p:grpSp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B1D441BD-C55D-415F-84B5-A33CDAE227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7154" t="15461" r="15861" b="20386"/>
            <a:stretch/>
          </p:blipFill>
          <p:spPr>
            <a:xfrm>
              <a:off x="3148595" y="3755327"/>
              <a:ext cx="723573" cy="914957"/>
            </a:xfrm>
            <a:prstGeom prst="rect">
              <a:avLst/>
            </a:prstGeom>
          </p:spPr>
        </p:pic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EA7E72BF-A420-BA02-93BD-CCD48DC01C98}"/>
                </a:ext>
              </a:extLst>
            </p:cNvPr>
            <p:cNvSpPr txBox="1"/>
            <p:nvPr/>
          </p:nvSpPr>
          <p:spPr>
            <a:xfrm>
              <a:off x="2977955" y="451633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E1A09565-C454-5D66-7631-BD4DE1E82189}"/>
                </a:ext>
              </a:extLst>
            </p:cNvPr>
            <p:cNvSpPr txBox="1"/>
            <p:nvPr/>
          </p:nvSpPr>
          <p:spPr>
            <a:xfrm>
              <a:off x="2824854" y="430969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e4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CCADF6D1-15F2-AD5E-3A60-76488AF855F8}"/>
                </a:ext>
              </a:extLst>
            </p:cNvPr>
            <p:cNvSpPr txBox="1"/>
            <p:nvPr/>
          </p:nvSpPr>
          <p:spPr>
            <a:xfrm>
              <a:off x="2824854" y="4102286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e4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B928EF28-8B00-2F1A-5B86-0405DFFE19FD}"/>
                </a:ext>
              </a:extLst>
            </p:cNvPr>
            <p:cNvSpPr txBox="1"/>
            <p:nvPr/>
          </p:nvSpPr>
          <p:spPr>
            <a:xfrm>
              <a:off x="2824854" y="3900822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e4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84CF2E0-F7AD-F1E6-262B-900D7DF7DB3E}"/>
                </a:ext>
              </a:extLst>
            </p:cNvPr>
            <p:cNvSpPr txBox="1"/>
            <p:nvPr/>
          </p:nvSpPr>
          <p:spPr>
            <a:xfrm>
              <a:off x="3140222" y="4619399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DA276087-CDFE-2C4C-6A45-6531B0DC47F0}"/>
                </a:ext>
              </a:extLst>
            </p:cNvPr>
            <p:cNvSpPr txBox="1"/>
            <p:nvPr/>
          </p:nvSpPr>
          <p:spPr>
            <a:xfrm>
              <a:off x="3474081" y="4619399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F0F73307-8762-0183-B18D-E110F7262588}"/>
                </a:ext>
              </a:extLst>
            </p:cNvPr>
            <p:cNvSpPr txBox="1"/>
            <p:nvPr/>
          </p:nvSpPr>
          <p:spPr>
            <a:xfrm rot="16200000">
              <a:off x="2413285" y="4106710"/>
              <a:ext cx="8066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D7EB2D64-4D11-4570-BCF0-04DC7DE3EF88}"/>
                </a:ext>
              </a:extLst>
            </p:cNvPr>
            <p:cNvSpPr txBox="1"/>
            <p:nvPr/>
          </p:nvSpPr>
          <p:spPr>
            <a:xfrm>
              <a:off x="2823714" y="3694962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e4</a:t>
              </a:r>
            </a:p>
          </p:txBody>
        </p:sp>
        <p:grpSp>
          <p:nvGrpSpPr>
            <p:cNvPr id="281" name="Group 280">
              <a:extLst>
                <a:ext uri="{FF2B5EF4-FFF2-40B4-BE49-F238E27FC236}">
                  <a16:creationId xmlns:a16="http://schemas.microsoft.com/office/drawing/2014/main" id="{C1731DD2-EFDE-6C13-7348-6FD15A70F127}"/>
                </a:ext>
              </a:extLst>
            </p:cNvPr>
            <p:cNvGrpSpPr/>
            <p:nvPr/>
          </p:nvGrpSpPr>
          <p:grpSpPr>
            <a:xfrm>
              <a:off x="182140" y="3712554"/>
              <a:ext cx="1181135" cy="1184161"/>
              <a:chOff x="178728" y="3695494"/>
              <a:chExt cx="1181135" cy="1184161"/>
            </a:xfrm>
          </p:grpSpPr>
          <p:pic>
            <p:nvPicPr>
              <p:cNvPr id="89" name="Picture 88">
                <a:extLst>
                  <a:ext uri="{FF2B5EF4-FFF2-40B4-BE49-F238E27FC236}">
                    <a16:creationId xmlns:a16="http://schemas.microsoft.com/office/drawing/2014/main" id="{80C31349-B0DA-193F-3861-390AD469DF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27046" t="20275" r="16342" b="20101"/>
              <a:stretch/>
            </p:blipFill>
            <p:spPr>
              <a:xfrm>
                <a:off x="645620" y="3819927"/>
                <a:ext cx="713172" cy="850358"/>
              </a:xfrm>
              <a:prstGeom prst="rect">
                <a:avLst/>
              </a:prstGeom>
            </p:spPr>
          </p:pic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89B57CA6-BC27-5CA0-2BC8-112AA2F5CF94}"/>
                  </a:ext>
                </a:extLst>
              </p:cNvPr>
              <p:cNvSpPr txBox="1"/>
              <p:nvPr/>
            </p:nvSpPr>
            <p:spPr>
              <a:xfrm>
                <a:off x="470887" y="451498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BD18BCE8-4E1B-178B-B2A4-FF791F0E6BEE}"/>
                  </a:ext>
                </a:extLst>
              </p:cNvPr>
              <p:cNvSpPr txBox="1"/>
              <p:nvPr/>
            </p:nvSpPr>
            <p:spPr>
              <a:xfrm>
                <a:off x="321198" y="42374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e6</a:t>
                </a:r>
              </a:p>
            </p:txBody>
          </p: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DEB32B4B-A74C-51EF-06B7-B754A433C853}"/>
                  </a:ext>
                </a:extLst>
              </p:cNvPr>
              <p:cNvSpPr txBox="1"/>
              <p:nvPr/>
            </p:nvSpPr>
            <p:spPr>
              <a:xfrm>
                <a:off x="321198" y="397330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e6</a:t>
                </a: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DC65FDCC-9344-4824-A505-EF2259E5BD1D}"/>
                  </a:ext>
                </a:extLst>
              </p:cNvPr>
              <p:cNvSpPr txBox="1"/>
              <p:nvPr/>
            </p:nvSpPr>
            <p:spPr>
              <a:xfrm>
                <a:off x="633154" y="4618045"/>
                <a:ext cx="4683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F3931FF7-5FB3-E72D-6DE6-EAE724F1495E}"/>
                  </a:ext>
                </a:extLst>
              </p:cNvPr>
              <p:cNvSpPr txBox="1"/>
              <p:nvPr/>
            </p:nvSpPr>
            <p:spPr>
              <a:xfrm>
                <a:off x="963601" y="4618045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AC4B3EB6-5990-9720-B878-EEFC817FD603}"/>
                  </a:ext>
                </a:extLst>
              </p:cNvPr>
              <p:cNvSpPr txBox="1"/>
              <p:nvPr/>
            </p:nvSpPr>
            <p:spPr>
              <a:xfrm rot="16200000">
                <a:off x="-93783" y="4105356"/>
                <a:ext cx="8066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ularity</a:t>
                </a:r>
              </a:p>
            </p:txBody>
          </p: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342F154A-7AC4-F0CA-0AA7-64DFC2BD8970}"/>
                  </a:ext>
                </a:extLst>
              </p:cNvPr>
              <p:cNvSpPr txBox="1"/>
              <p:nvPr/>
            </p:nvSpPr>
            <p:spPr>
              <a:xfrm>
                <a:off x="321198" y="369549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e6</a:t>
                </a:r>
              </a:p>
            </p:txBody>
          </p:sp>
          <p:sp>
            <p:nvSpPr>
              <p:cNvPr id="268" name="Rectangle 267">
                <a:extLst>
                  <a:ext uri="{FF2B5EF4-FFF2-40B4-BE49-F238E27FC236}">
                    <a16:creationId xmlns:a16="http://schemas.microsoft.com/office/drawing/2014/main" id="{2B381654-6957-D547-65AF-9BB49F67906A}"/>
                  </a:ext>
                </a:extLst>
              </p:cNvPr>
              <p:cNvSpPr/>
              <p:nvPr/>
            </p:nvSpPr>
            <p:spPr>
              <a:xfrm>
                <a:off x="837637" y="3799085"/>
                <a:ext cx="418847" cy="13244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9" name="Rectangle 268">
                <a:extLst>
                  <a:ext uri="{FF2B5EF4-FFF2-40B4-BE49-F238E27FC236}">
                    <a16:creationId xmlns:a16="http://schemas.microsoft.com/office/drawing/2014/main" id="{DC7AEC6E-6619-2B12-E726-09D21CADA8E2}"/>
                  </a:ext>
                </a:extLst>
              </p:cNvPr>
              <p:cNvSpPr/>
              <p:nvPr/>
            </p:nvSpPr>
            <p:spPr>
              <a:xfrm>
                <a:off x="794438" y="3871458"/>
                <a:ext cx="164434" cy="44847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80" name="Group 279">
              <a:extLst>
                <a:ext uri="{FF2B5EF4-FFF2-40B4-BE49-F238E27FC236}">
                  <a16:creationId xmlns:a16="http://schemas.microsoft.com/office/drawing/2014/main" id="{069475E1-7FED-BABA-BC80-8E026AF92BCB}"/>
                </a:ext>
              </a:extLst>
            </p:cNvPr>
            <p:cNvGrpSpPr/>
            <p:nvPr/>
          </p:nvGrpSpPr>
          <p:grpSpPr>
            <a:xfrm>
              <a:off x="1484363" y="3701178"/>
              <a:ext cx="1196085" cy="1184161"/>
              <a:chOff x="1358119" y="3694354"/>
              <a:chExt cx="1196085" cy="1184161"/>
            </a:xfrm>
          </p:grpSpPr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755512A6-DA66-AB09-FD84-A5363D488B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27318" t="22204" r="14985" b="19484"/>
              <a:stretch/>
            </p:blipFill>
            <p:spPr>
              <a:xfrm>
                <a:off x="1821591" y="3796718"/>
                <a:ext cx="732613" cy="873567"/>
              </a:xfrm>
              <a:prstGeom prst="rect">
                <a:avLst/>
              </a:prstGeom>
            </p:spPr>
          </p:pic>
          <p:sp>
            <p:nvSpPr>
              <p:cNvPr id="270" name="Rectangle 269">
                <a:extLst>
                  <a:ext uri="{FF2B5EF4-FFF2-40B4-BE49-F238E27FC236}">
                    <a16:creationId xmlns:a16="http://schemas.microsoft.com/office/drawing/2014/main" id="{9685ECC3-5DCA-9242-F297-17D6DD290642}"/>
                  </a:ext>
                </a:extLst>
              </p:cNvPr>
              <p:cNvSpPr/>
              <p:nvPr/>
            </p:nvSpPr>
            <p:spPr>
              <a:xfrm>
                <a:off x="2016981" y="3733883"/>
                <a:ext cx="418847" cy="13244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1" name="Rectangle 270">
                <a:extLst>
                  <a:ext uri="{FF2B5EF4-FFF2-40B4-BE49-F238E27FC236}">
                    <a16:creationId xmlns:a16="http://schemas.microsoft.com/office/drawing/2014/main" id="{ED6F2859-9CB0-0EFF-4069-202706F0B3FB}"/>
                  </a:ext>
                </a:extLst>
              </p:cNvPr>
              <p:cNvSpPr/>
              <p:nvPr/>
            </p:nvSpPr>
            <p:spPr>
              <a:xfrm>
                <a:off x="1973782" y="3795116"/>
                <a:ext cx="164434" cy="5756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3" name="TextBox 272">
                <a:extLst>
                  <a:ext uri="{FF2B5EF4-FFF2-40B4-BE49-F238E27FC236}">
                    <a16:creationId xmlns:a16="http://schemas.microsoft.com/office/drawing/2014/main" id="{69984FC5-EC5F-F60C-C424-ABE6DCBD138B}"/>
                  </a:ext>
                </a:extLst>
              </p:cNvPr>
              <p:cNvSpPr txBox="1"/>
              <p:nvPr/>
            </p:nvSpPr>
            <p:spPr>
              <a:xfrm>
                <a:off x="1650278" y="451384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74" name="TextBox 273">
                <a:extLst>
                  <a:ext uri="{FF2B5EF4-FFF2-40B4-BE49-F238E27FC236}">
                    <a16:creationId xmlns:a16="http://schemas.microsoft.com/office/drawing/2014/main" id="{D9623D47-EEFA-58F5-BDE7-EAF49BC3FD32}"/>
                  </a:ext>
                </a:extLst>
              </p:cNvPr>
              <p:cNvSpPr txBox="1"/>
              <p:nvPr/>
            </p:nvSpPr>
            <p:spPr>
              <a:xfrm>
                <a:off x="1500589" y="423627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e6</a:t>
                </a:r>
              </a:p>
            </p:txBody>
          </p:sp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id="{0063E7C8-A3BD-DC66-9620-EB2671436AD5}"/>
                  </a:ext>
                </a:extLst>
              </p:cNvPr>
              <p:cNvSpPr txBox="1"/>
              <p:nvPr/>
            </p:nvSpPr>
            <p:spPr>
              <a:xfrm>
                <a:off x="1500589" y="397216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e6</a:t>
                </a:r>
              </a:p>
            </p:txBody>
          </p:sp>
          <p:sp>
            <p:nvSpPr>
              <p:cNvPr id="276" name="TextBox 275">
                <a:extLst>
                  <a:ext uri="{FF2B5EF4-FFF2-40B4-BE49-F238E27FC236}">
                    <a16:creationId xmlns:a16="http://schemas.microsoft.com/office/drawing/2014/main" id="{68D30268-CDE1-8576-443F-1ED2E6C58758}"/>
                  </a:ext>
                </a:extLst>
              </p:cNvPr>
              <p:cNvSpPr txBox="1"/>
              <p:nvPr/>
            </p:nvSpPr>
            <p:spPr>
              <a:xfrm>
                <a:off x="1812545" y="4616905"/>
                <a:ext cx="46839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277" name="TextBox 276">
                <a:extLst>
                  <a:ext uri="{FF2B5EF4-FFF2-40B4-BE49-F238E27FC236}">
                    <a16:creationId xmlns:a16="http://schemas.microsoft.com/office/drawing/2014/main" id="{87A743F8-8973-267A-997E-BA08C1504B4B}"/>
                  </a:ext>
                </a:extLst>
              </p:cNvPr>
              <p:cNvSpPr txBox="1"/>
              <p:nvPr/>
            </p:nvSpPr>
            <p:spPr>
              <a:xfrm>
                <a:off x="2142992" y="4616905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278" name="TextBox 277">
                <a:extLst>
                  <a:ext uri="{FF2B5EF4-FFF2-40B4-BE49-F238E27FC236}">
                    <a16:creationId xmlns:a16="http://schemas.microsoft.com/office/drawing/2014/main" id="{A1F00959-0B85-0306-911C-17D47C8EA8C9}"/>
                  </a:ext>
                </a:extLst>
              </p:cNvPr>
              <p:cNvSpPr txBox="1"/>
              <p:nvPr/>
            </p:nvSpPr>
            <p:spPr>
              <a:xfrm rot="16200000">
                <a:off x="1085608" y="4104216"/>
                <a:ext cx="8066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ularity</a:t>
                </a:r>
              </a:p>
            </p:txBody>
          </p:sp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3DBE5744-7D67-9EC2-B9E8-19F3F1C0604C}"/>
                  </a:ext>
                </a:extLst>
              </p:cNvPr>
              <p:cNvSpPr txBox="1"/>
              <p:nvPr/>
            </p:nvSpPr>
            <p:spPr>
              <a:xfrm>
                <a:off x="1500589" y="369435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e6</a:t>
                </a:r>
              </a:p>
            </p:txBody>
          </p:sp>
        </p:grpSp>
        <p:sp>
          <p:nvSpPr>
            <p:cNvPr id="283" name="Rectangle 282">
              <a:extLst>
                <a:ext uri="{FF2B5EF4-FFF2-40B4-BE49-F238E27FC236}">
                  <a16:creationId xmlns:a16="http://schemas.microsoft.com/office/drawing/2014/main" id="{93D6CA49-1418-5AA4-F5A5-2CA8E8C14D3E}"/>
                </a:ext>
              </a:extLst>
            </p:cNvPr>
            <p:cNvSpPr/>
            <p:nvPr/>
          </p:nvSpPr>
          <p:spPr>
            <a:xfrm>
              <a:off x="3332191" y="3699608"/>
              <a:ext cx="418847" cy="2337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CE9CC5B3-D7AF-1D86-A292-13756A088E39}"/>
                </a:ext>
              </a:extLst>
            </p:cNvPr>
            <p:cNvSpPr/>
            <p:nvPr/>
          </p:nvSpPr>
          <p:spPr>
            <a:xfrm>
              <a:off x="3288992" y="3800692"/>
              <a:ext cx="164434" cy="5756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18AC2371-A470-657E-F47E-1CAC82F0AD93}"/>
                </a:ext>
              </a:extLst>
            </p:cNvPr>
            <p:cNvSpPr txBox="1"/>
            <p:nvPr/>
          </p:nvSpPr>
          <p:spPr>
            <a:xfrm>
              <a:off x="2959298" y="3480341"/>
              <a:ext cx="11031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sident DCs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4A9E7E63-565B-574A-ECAF-EFD2589F8CD9}"/>
                </a:ext>
              </a:extLst>
            </p:cNvPr>
            <p:cNvSpPr txBox="1"/>
            <p:nvPr/>
          </p:nvSpPr>
          <p:spPr>
            <a:xfrm>
              <a:off x="683476" y="3395703"/>
              <a:ext cx="64633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50F60D6E-9068-C4CA-1A1E-174091EC9AD1}"/>
                </a:ext>
              </a:extLst>
            </p:cNvPr>
            <p:cNvSpPr txBox="1"/>
            <p:nvPr/>
          </p:nvSpPr>
          <p:spPr>
            <a:xfrm>
              <a:off x="1958403" y="3395703"/>
              <a:ext cx="64633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</p:grpSp>
      <p:sp>
        <p:nvSpPr>
          <p:cNvPr id="288" name="TextBox 287">
            <a:extLst>
              <a:ext uri="{FF2B5EF4-FFF2-40B4-BE49-F238E27FC236}">
                <a16:creationId xmlns:a16="http://schemas.microsoft.com/office/drawing/2014/main" id="{2207A3D5-847A-F8BF-9255-22B6386FEF88}"/>
              </a:ext>
            </a:extLst>
          </p:cNvPr>
          <p:cNvSpPr txBox="1"/>
          <p:nvPr/>
        </p:nvSpPr>
        <p:spPr>
          <a:xfrm>
            <a:off x="-41754" y="9727885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5594764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4" name="Group 323">
            <a:extLst>
              <a:ext uri="{FF2B5EF4-FFF2-40B4-BE49-F238E27FC236}">
                <a16:creationId xmlns:a16="http://schemas.microsoft.com/office/drawing/2014/main" id="{986593ED-F664-819B-0268-2FF720291C0E}"/>
              </a:ext>
            </a:extLst>
          </p:cNvPr>
          <p:cNvGrpSpPr/>
          <p:nvPr/>
        </p:nvGrpSpPr>
        <p:grpSpPr>
          <a:xfrm>
            <a:off x="10238" y="1132769"/>
            <a:ext cx="7655432" cy="8451690"/>
            <a:chOff x="10238" y="1"/>
            <a:chExt cx="7655432" cy="845169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B3792C0-03EB-5488-306C-113D4FFBD0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277" t="17829" r="29228" b="28320"/>
            <a:stretch/>
          </p:blipFill>
          <p:spPr>
            <a:xfrm>
              <a:off x="714242" y="2603259"/>
              <a:ext cx="1290593" cy="90464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029A850-E5FE-DA9B-819C-40428E27E4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8190" t="16975" r="27960" b="27910"/>
            <a:stretch/>
          </p:blipFill>
          <p:spPr>
            <a:xfrm>
              <a:off x="2590810" y="2579571"/>
              <a:ext cx="1327024" cy="92955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2672986-0FBC-340F-198A-2C3000799B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9670" t="18147" r="27178" b="28216"/>
            <a:stretch/>
          </p:blipFill>
          <p:spPr>
            <a:xfrm>
              <a:off x="4483269" y="2603259"/>
              <a:ext cx="1327024" cy="904645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0A1A86B-5F09-6BE8-3D4A-F73600D6C6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9444" t="26347" r="28683" b="24484"/>
            <a:stretch/>
          </p:blipFill>
          <p:spPr>
            <a:xfrm>
              <a:off x="6249532" y="2579571"/>
              <a:ext cx="1295084" cy="93745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4DB5DB1-4FB2-EB34-5909-D0EE79541E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7289" t="17865" r="28770" b="28607"/>
            <a:stretch/>
          </p:blipFill>
          <p:spPr>
            <a:xfrm>
              <a:off x="738881" y="4541056"/>
              <a:ext cx="1301345" cy="89923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6E8CFFC-51CA-ACBC-E480-4F6C2FBD9E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8272" t="17799" r="27878" b="28563"/>
            <a:stretch/>
          </p:blipFill>
          <p:spPr>
            <a:xfrm>
              <a:off x="2585345" y="4529027"/>
              <a:ext cx="1327024" cy="90464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1839EED-735D-CB19-7140-226B0C14A3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8250" t="17820" r="27901" b="28037"/>
            <a:stretch/>
          </p:blipFill>
          <p:spPr>
            <a:xfrm>
              <a:off x="4482436" y="4507994"/>
              <a:ext cx="1327024" cy="92761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ED46EE0-9FE4-7DD7-0E0B-1C8303B0DA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7533" t="18480" r="26941" b="27768"/>
            <a:stretch/>
          </p:blipFill>
          <p:spPr>
            <a:xfrm>
              <a:off x="6250569" y="4529027"/>
              <a:ext cx="1350372" cy="90657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4E1CEB0-4636-420A-C738-D12610EED9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9226" t="15122" r="27264" b="22544"/>
            <a:stretch/>
          </p:blipFill>
          <p:spPr>
            <a:xfrm>
              <a:off x="795987" y="6254438"/>
              <a:ext cx="1301345" cy="95158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FB1416F2-DA8F-A90C-6A1C-922F2B632D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1755" t="15381" r="12036" b="26420"/>
            <a:stretch/>
          </p:blipFill>
          <p:spPr>
            <a:xfrm>
              <a:off x="4478977" y="398094"/>
              <a:ext cx="1307911" cy="96152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51EA748-E6CE-0E07-1592-A8FE63AAA156}"/>
                </a:ext>
              </a:extLst>
            </p:cNvPr>
            <p:cNvSpPr txBox="1"/>
            <p:nvPr/>
          </p:nvSpPr>
          <p:spPr>
            <a:xfrm>
              <a:off x="4669861" y="132452"/>
              <a:ext cx="9637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gG</a:t>
              </a:r>
            </a:p>
          </p:txBody>
        </p:sp>
        <p:grpSp>
          <p:nvGrpSpPr>
            <p:cNvPr id="249" name="Group 248">
              <a:extLst>
                <a:ext uri="{FF2B5EF4-FFF2-40B4-BE49-F238E27FC236}">
                  <a16:creationId xmlns:a16="http://schemas.microsoft.com/office/drawing/2014/main" id="{757A854B-CCC0-1EAC-6353-0EF9FCD905B5}"/>
                </a:ext>
              </a:extLst>
            </p:cNvPr>
            <p:cNvGrpSpPr/>
            <p:nvPr/>
          </p:nvGrpSpPr>
          <p:grpSpPr>
            <a:xfrm>
              <a:off x="5818227" y="401625"/>
              <a:ext cx="1825038" cy="1046896"/>
              <a:chOff x="2081883" y="2346683"/>
              <a:chExt cx="1825038" cy="1046896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8C3BA987-8906-5539-BE94-CC67BE5382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20447" t="15601" r="12094" b="26319"/>
              <a:stretch/>
            </p:blipFill>
            <p:spPr>
              <a:xfrm>
                <a:off x="2599010" y="2346683"/>
                <a:ext cx="1307911" cy="961520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3324FDC7-3E24-90E3-667F-4232F597B1AB}"/>
                  </a:ext>
                </a:extLst>
              </p:cNvPr>
              <p:cNvSpPr txBox="1"/>
              <p:nvPr/>
            </p:nvSpPr>
            <p:spPr>
              <a:xfrm>
                <a:off x="2245847" y="2463382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e4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09F14BB5-BCD4-003D-2366-E31BBD3DD2CC}"/>
                  </a:ext>
                </a:extLst>
              </p:cNvPr>
              <p:cNvSpPr txBox="1"/>
              <p:nvPr/>
            </p:nvSpPr>
            <p:spPr>
              <a:xfrm>
                <a:off x="2245847" y="268181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e4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5126C96-AECF-1401-477F-6140E872A839}"/>
                  </a:ext>
                </a:extLst>
              </p:cNvPr>
              <p:cNvSpPr txBox="1"/>
              <p:nvPr/>
            </p:nvSpPr>
            <p:spPr>
              <a:xfrm>
                <a:off x="2245847" y="289620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e4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EEA6F85-2093-672A-FA78-39734B53258C}"/>
                  </a:ext>
                </a:extLst>
              </p:cNvPr>
              <p:cNvSpPr txBox="1"/>
              <p:nvPr/>
            </p:nvSpPr>
            <p:spPr>
              <a:xfrm>
                <a:off x="2415765" y="311658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5E9A6AD-C7F9-0370-9AAF-C50FBA99BBDA}"/>
                  </a:ext>
                </a:extLst>
              </p:cNvPr>
              <p:cNvSpPr txBox="1"/>
              <p:nvPr/>
            </p:nvSpPr>
            <p:spPr>
              <a:xfrm rot="16200000">
                <a:off x="1779044" y="2682138"/>
                <a:ext cx="8826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gA ng/ml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AE391BE-FE7C-4DFB-74A9-1D0D0F08DEA0}"/>
                </a:ext>
              </a:extLst>
            </p:cNvPr>
            <p:cNvSpPr txBox="1"/>
            <p:nvPr/>
          </p:nvSpPr>
          <p:spPr>
            <a:xfrm>
              <a:off x="5985712" y="29800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4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8367D5C-0673-21C5-4AA5-BB7FB061880F}"/>
                </a:ext>
              </a:extLst>
            </p:cNvPr>
            <p:cNvSpPr txBox="1"/>
            <p:nvPr/>
          </p:nvSpPr>
          <p:spPr>
            <a:xfrm>
              <a:off x="6554233" y="132452"/>
              <a:ext cx="9541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Ig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A003FAE-3E91-3A40-4C16-0C383D482653}"/>
                </a:ext>
              </a:extLst>
            </p:cNvPr>
            <p:cNvSpPr txBox="1"/>
            <p:nvPr/>
          </p:nvSpPr>
          <p:spPr>
            <a:xfrm>
              <a:off x="363985" y="270085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e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A6558E6-D4E4-8658-EF97-43D5365584AF}"/>
                </a:ext>
              </a:extLst>
            </p:cNvPr>
            <p:cNvSpPr txBox="1"/>
            <p:nvPr/>
          </p:nvSpPr>
          <p:spPr>
            <a:xfrm>
              <a:off x="363985" y="290713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2EC8878-C5C3-3122-89AC-F1871252D45A}"/>
                </a:ext>
              </a:extLst>
            </p:cNvPr>
            <p:cNvSpPr txBox="1"/>
            <p:nvPr/>
          </p:nvSpPr>
          <p:spPr>
            <a:xfrm>
              <a:off x="363985" y="311642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e6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0A5197A-8F2F-06B3-DAD2-37B23D31641C}"/>
                </a:ext>
              </a:extLst>
            </p:cNvPr>
            <p:cNvSpPr txBox="1"/>
            <p:nvPr/>
          </p:nvSpPr>
          <p:spPr>
            <a:xfrm>
              <a:off x="533903" y="332817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AA75C2B-002F-6DF7-B216-730399A12CEB}"/>
                </a:ext>
              </a:extLst>
            </p:cNvPr>
            <p:cNvSpPr txBox="1"/>
            <p:nvPr/>
          </p:nvSpPr>
          <p:spPr>
            <a:xfrm>
              <a:off x="363985" y="249546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e6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438ED59-9C0E-0F13-8BEA-61A16319EA8D}"/>
                </a:ext>
              </a:extLst>
            </p:cNvPr>
            <p:cNvSpPr txBox="1"/>
            <p:nvPr/>
          </p:nvSpPr>
          <p:spPr>
            <a:xfrm rot="16200000">
              <a:off x="-118297" y="2915957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AD627AB-9D30-16C1-D596-AE46F15491E5}"/>
                </a:ext>
              </a:extLst>
            </p:cNvPr>
            <p:cNvSpPr txBox="1"/>
            <p:nvPr/>
          </p:nvSpPr>
          <p:spPr>
            <a:xfrm>
              <a:off x="2121607" y="2820035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5e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8204E26-15FE-E631-8254-368EAD10D788}"/>
                </a:ext>
              </a:extLst>
            </p:cNvPr>
            <p:cNvSpPr txBox="1"/>
            <p:nvPr/>
          </p:nvSpPr>
          <p:spPr>
            <a:xfrm>
              <a:off x="2121607" y="2986757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0e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8DE685D-3D98-098D-4326-F6E298A50246}"/>
                </a:ext>
              </a:extLst>
            </p:cNvPr>
            <p:cNvSpPr txBox="1"/>
            <p:nvPr/>
          </p:nvSpPr>
          <p:spPr>
            <a:xfrm>
              <a:off x="2121607" y="3149352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5e5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5D587EC-B921-46E5-5892-4A4E32575BBC}"/>
                </a:ext>
              </a:extLst>
            </p:cNvPr>
            <p:cNvSpPr txBox="1"/>
            <p:nvPr/>
          </p:nvSpPr>
          <p:spPr>
            <a:xfrm>
              <a:off x="2419765" y="33212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B655F6C-B01D-5B60-339A-90AE0772521F}"/>
                </a:ext>
              </a:extLst>
            </p:cNvPr>
            <p:cNvSpPr txBox="1"/>
            <p:nvPr/>
          </p:nvSpPr>
          <p:spPr>
            <a:xfrm rot="16200000">
              <a:off x="1633146" y="2903908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5D89F9D-7247-6BAB-15DD-ED22DB6A21AC}"/>
                </a:ext>
              </a:extLst>
            </p:cNvPr>
            <p:cNvSpPr txBox="1"/>
            <p:nvPr/>
          </p:nvSpPr>
          <p:spPr>
            <a:xfrm>
              <a:off x="2121607" y="2484782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.5e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392EFF9-A12A-7B68-F313-9C6B5B60D807}"/>
                </a:ext>
              </a:extLst>
            </p:cNvPr>
            <p:cNvSpPr txBox="1"/>
            <p:nvPr/>
          </p:nvSpPr>
          <p:spPr>
            <a:xfrm>
              <a:off x="2121607" y="2651506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.0e5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DE6C817-D3A5-9103-EBBE-A18F53A42E15}"/>
                </a:ext>
              </a:extLst>
            </p:cNvPr>
            <p:cNvSpPr txBox="1"/>
            <p:nvPr/>
          </p:nvSpPr>
          <p:spPr>
            <a:xfrm>
              <a:off x="2759158" y="2190622"/>
              <a:ext cx="100059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844AE0C-D62D-BE4B-EF83-93E97341F44D}"/>
                </a:ext>
              </a:extLst>
            </p:cNvPr>
            <p:cNvSpPr txBox="1"/>
            <p:nvPr/>
          </p:nvSpPr>
          <p:spPr>
            <a:xfrm>
              <a:off x="4006520" y="2820610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5e6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7B830B7-C664-FADF-5EE0-5E96180C88F8}"/>
                </a:ext>
              </a:extLst>
            </p:cNvPr>
            <p:cNvSpPr txBox="1"/>
            <p:nvPr/>
          </p:nvSpPr>
          <p:spPr>
            <a:xfrm>
              <a:off x="4006520" y="2991665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0e6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29E2BD0-AD2A-BD12-9840-0A5989E0134B}"/>
                </a:ext>
              </a:extLst>
            </p:cNvPr>
            <p:cNvSpPr txBox="1"/>
            <p:nvPr/>
          </p:nvSpPr>
          <p:spPr>
            <a:xfrm>
              <a:off x="4006520" y="3154260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5e6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2159B90-624D-1067-EF1F-06C7DA914CE9}"/>
                </a:ext>
              </a:extLst>
            </p:cNvPr>
            <p:cNvSpPr txBox="1"/>
            <p:nvPr/>
          </p:nvSpPr>
          <p:spPr>
            <a:xfrm>
              <a:off x="4304678" y="333050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00F3142-7FE0-E3FF-CDAD-9F8D7B2B5121}"/>
                </a:ext>
              </a:extLst>
            </p:cNvPr>
            <p:cNvSpPr txBox="1"/>
            <p:nvPr/>
          </p:nvSpPr>
          <p:spPr>
            <a:xfrm rot="16200000">
              <a:off x="3527375" y="2900149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9BCFC1C-6A74-D0A1-7B4E-5A4B2ABB9F14}"/>
                </a:ext>
              </a:extLst>
            </p:cNvPr>
            <p:cNvSpPr txBox="1"/>
            <p:nvPr/>
          </p:nvSpPr>
          <p:spPr>
            <a:xfrm>
              <a:off x="4006520" y="2489692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.5e6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3584B2A-2FC0-EF73-88D8-CE5021E26FD4}"/>
                </a:ext>
              </a:extLst>
            </p:cNvPr>
            <p:cNvSpPr txBox="1"/>
            <p:nvPr/>
          </p:nvSpPr>
          <p:spPr>
            <a:xfrm>
              <a:off x="4006520" y="2656411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.0e6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6B8E3F2-B789-BBD3-2096-D3737F04F579}"/>
                </a:ext>
              </a:extLst>
            </p:cNvPr>
            <p:cNvSpPr txBox="1"/>
            <p:nvPr/>
          </p:nvSpPr>
          <p:spPr>
            <a:xfrm>
              <a:off x="4376000" y="2190622"/>
              <a:ext cx="15456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71EFADC-2BD2-4E80-BAD6-48FEEF76CA58}"/>
                </a:ext>
              </a:extLst>
            </p:cNvPr>
            <p:cNvSpPr txBox="1"/>
            <p:nvPr/>
          </p:nvSpPr>
          <p:spPr>
            <a:xfrm>
              <a:off x="5903749" y="282263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e6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06F9C2CB-59E6-8A02-5830-2F30A21BCDDE}"/>
                </a:ext>
              </a:extLst>
            </p:cNvPr>
            <p:cNvSpPr txBox="1"/>
            <p:nvPr/>
          </p:nvSpPr>
          <p:spPr>
            <a:xfrm>
              <a:off x="5903749" y="298935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e6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C45C365-77C2-A50B-C074-87B13D8315BB}"/>
                </a:ext>
              </a:extLst>
            </p:cNvPr>
            <p:cNvSpPr txBox="1"/>
            <p:nvPr/>
          </p:nvSpPr>
          <p:spPr>
            <a:xfrm>
              <a:off x="5903749" y="315628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e6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2EB8034-14E9-45A3-FFAC-EFD035D85BEC}"/>
                </a:ext>
              </a:extLst>
            </p:cNvPr>
            <p:cNvSpPr txBox="1"/>
            <p:nvPr/>
          </p:nvSpPr>
          <p:spPr>
            <a:xfrm>
              <a:off x="6073667" y="332819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65C4462-7DC5-6A2B-80FC-BE3493EA241F}"/>
                </a:ext>
              </a:extLst>
            </p:cNvPr>
            <p:cNvSpPr txBox="1"/>
            <p:nvPr/>
          </p:nvSpPr>
          <p:spPr>
            <a:xfrm rot="16200000">
              <a:off x="5434509" y="2905213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6820F3C8-9684-DCC4-B912-CBF81FE4F6CA}"/>
                </a:ext>
              </a:extLst>
            </p:cNvPr>
            <p:cNvSpPr txBox="1"/>
            <p:nvPr/>
          </p:nvSpPr>
          <p:spPr>
            <a:xfrm>
              <a:off x="5903749" y="24873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e6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D91DA19-4C4A-73B7-D86C-A8E2F68BDB0F}"/>
                </a:ext>
              </a:extLst>
            </p:cNvPr>
            <p:cNvSpPr txBox="1"/>
            <p:nvPr/>
          </p:nvSpPr>
          <p:spPr>
            <a:xfrm>
              <a:off x="5903749" y="265843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6</a:t>
              </a: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FAB1B1EB-767C-F8F4-EDD8-976ED61F7463}"/>
                </a:ext>
              </a:extLst>
            </p:cNvPr>
            <p:cNvSpPr/>
            <p:nvPr/>
          </p:nvSpPr>
          <p:spPr>
            <a:xfrm>
              <a:off x="6361529" y="2388884"/>
              <a:ext cx="313260" cy="6405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FCEBB033-77DA-D285-7C05-2D5566E2F887}"/>
                </a:ext>
              </a:extLst>
            </p:cNvPr>
            <p:cNvSpPr/>
            <p:nvPr/>
          </p:nvSpPr>
          <p:spPr>
            <a:xfrm>
              <a:off x="894480" y="2567070"/>
              <a:ext cx="960577" cy="224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7DD9982F-1AAA-815E-E549-C42DC3144599}"/>
                </a:ext>
              </a:extLst>
            </p:cNvPr>
            <p:cNvSpPr/>
            <p:nvPr/>
          </p:nvSpPr>
          <p:spPr>
            <a:xfrm>
              <a:off x="873083" y="2722489"/>
              <a:ext cx="190957" cy="2540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C594EAED-1589-946C-58BD-D61994146363}"/>
                </a:ext>
              </a:extLst>
            </p:cNvPr>
            <p:cNvCxnSpPr>
              <a:cxnSpLocks/>
            </p:cNvCxnSpPr>
            <p:nvPr/>
          </p:nvCxnSpPr>
          <p:spPr>
            <a:xfrm>
              <a:off x="939114" y="2731427"/>
              <a:ext cx="87403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A4B3E65-78D8-18BF-F6F3-8B2ACBFD57B8}"/>
                </a:ext>
              </a:extLst>
            </p:cNvPr>
            <p:cNvSpPr txBox="1"/>
            <p:nvPr/>
          </p:nvSpPr>
          <p:spPr>
            <a:xfrm>
              <a:off x="1246474" y="2573531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5F59C19A-4B7B-5232-15AC-6CE2B9EC2A78}"/>
                </a:ext>
              </a:extLst>
            </p:cNvPr>
            <p:cNvSpPr/>
            <p:nvPr/>
          </p:nvSpPr>
          <p:spPr>
            <a:xfrm rot="5400000">
              <a:off x="6854168" y="2187327"/>
              <a:ext cx="322868" cy="9144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8D9FDF2-8613-FE63-D65E-4075291BE8CF}"/>
                </a:ext>
              </a:extLst>
            </p:cNvPr>
            <p:cNvSpPr txBox="1"/>
            <p:nvPr/>
          </p:nvSpPr>
          <p:spPr>
            <a:xfrm>
              <a:off x="6377717" y="2190622"/>
              <a:ext cx="10951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0E963FE1-9FA1-3DFB-B203-BA4F74A082AD}"/>
                </a:ext>
              </a:extLst>
            </p:cNvPr>
            <p:cNvSpPr/>
            <p:nvPr/>
          </p:nvSpPr>
          <p:spPr>
            <a:xfrm>
              <a:off x="6666245" y="2731427"/>
              <a:ext cx="205379" cy="3176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13777885-CB3A-DFBA-B4C3-8E2969F74366}"/>
                </a:ext>
              </a:extLst>
            </p:cNvPr>
            <p:cNvCxnSpPr>
              <a:cxnSpLocks/>
            </p:cNvCxnSpPr>
            <p:nvPr/>
          </p:nvCxnSpPr>
          <p:spPr>
            <a:xfrm>
              <a:off x="6473838" y="2658697"/>
              <a:ext cx="87403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8E581F2A-DF60-5C79-D38C-D856AFF81F04}"/>
                </a:ext>
              </a:extLst>
            </p:cNvPr>
            <p:cNvSpPr txBox="1"/>
            <p:nvPr/>
          </p:nvSpPr>
          <p:spPr>
            <a:xfrm>
              <a:off x="7176340" y="2500801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42BC1D15-4279-B977-A3E3-63AA199EDEEE}"/>
                </a:ext>
              </a:extLst>
            </p:cNvPr>
            <p:cNvCxnSpPr>
              <a:cxnSpLocks/>
            </p:cNvCxnSpPr>
            <p:nvPr/>
          </p:nvCxnSpPr>
          <p:spPr>
            <a:xfrm>
              <a:off x="6765183" y="2697194"/>
              <a:ext cx="58268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0D3FCB8D-8646-BF12-9DB0-E455F16C88F0}"/>
                </a:ext>
              </a:extLst>
            </p:cNvPr>
            <p:cNvSpPr txBox="1"/>
            <p:nvPr/>
          </p:nvSpPr>
          <p:spPr>
            <a:xfrm>
              <a:off x="382145" y="463666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e6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F559053-E6CD-5842-4658-0DC7BD19C443}"/>
                </a:ext>
              </a:extLst>
            </p:cNvPr>
            <p:cNvSpPr txBox="1"/>
            <p:nvPr/>
          </p:nvSpPr>
          <p:spPr>
            <a:xfrm>
              <a:off x="382145" y="48429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6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524F2E77-6B2A-E170-54D8-1F477833367A}"/>
                </a:ext>
              </a:extLst>
            </p:cNvPr>
            <p:cNvSpPr txBox="1"/>
            <p:nvPr/>
          </p:nvSpPr>
          <p:spPr>
            <a:xfrm>
              <a:off x="382145" y="505223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e6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1D29403A-DADB-5319-54FB-5D55C244F9CE}"/>
                </a:ext>
              </a:extLst>
            </p:cNvPr>
            <p:cNvSpPr txBox="1"/>
            <p:nvPr/>
          </p:nvSpPr>
          <p:spPr>
            <a:xfrm>
              <a:off x="552063" y="526398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847BFC2-37F7-E21A-9400-BB131C7B7DB6}"/>
                </a:ext>
              </a:extLst>
            </p:cNvPr>
            <p:cNvSpPr txBox="1"/>
            <p:nvPr/>
          </p:nvSpPr>
          <p:spPr>
            <a:xfrm>
              <a:off x="382145" y="442693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e6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2BD3455-D47D-03B6-7382-6A863C641B68}"/>
                </a:ext>
              </a:extLst>
            </p:cNvPr>
            <p:cNvSpPr txBox="1"/>
            <p:nvPr/>
          </p:nvSpPr>
          <p:spPr>
            <a:xfrm>
              <a:off x="902673" y="4130296"/>
              <a:ext cx="950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otal CD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6971426-8AB0-F31D-6EEA-5BFE677311BD}"/>
                </a:ext>
              </a:extLst>
            </p:cNvPr>
            <p:cNvSpPr txBox="1"/>
            <p:nvPr/>
          </p:nvSpPr>
          <p:spPr>
            <a:xfrm rot="16200000">
              <a:off x="-93658" y="4850011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26F955B-8FB9-8223-B811-760EC20B15AC}"/>
                </a:ext>
              </a:extLst>
            </p:cNvPr>
            <p:cNvSpPr txBox="1"/>
            <p:nvPr/>
          </p:nvSpPr>
          <p:spPr>
            <a:xfrm>
              <a:off x="2227368" y="462713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e5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801849B6-90C0-72ED-96CF-6F89DFF473BD}"/>
                </a:ext>
              </a:extLst>
            </p:cNvPr>
            <p:cNvSpPr txBox="1"/>
            <p:nvPr/>
          </p:nvSpPr>
          <p:spPr>
            <a:xfrm>
              <a:off x="2227368" y="483341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5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521D335-F3CD-AD3A-D0AE-8E1925D4262C}"/>
                </a:ext>
              </a:extLst>
            </p:cNvPr>
            <p:cNvSpPr txBox="1"/>
            <p:nvPr/>
          </p:nvSpPr>
          <p:spPr>
            <a:xfrm>
              <a:off x="2227368" y="504271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e5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0A0C571-5FF1-CB7E-DC05-E6FC5443D18A}"/>
                </a:ext>
              </a:extLst>
            </p:cNvPr>
            <p:cNvSpPr txBox="1"/>
            <p:nvPr/>
          </p:nvSpPr>
          <p:spPr>
            <a:xfrm>
              <a:off x="2397286" y="525445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8DDFA701-6987-832A-9273-7C98B0175B7E}"/>
                </a:ext>
              </a:extLst>
            </p:cNvPr>
            <p:cNvSpPr txBox="1"/>
            <p:nvPr/>
          </p:nvSpPr>
          <p:spPr>
            <a:xfrm>
              <a:off x="2227368" y="441741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e5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600D86E-9846-7AAB-99F2-9A8B69886B3F}"/>
                </a:ext>
              </a:extLst>
            </p:cNvPr>
            <p:cNvSpPr txBox="1"/>
            <p:nvPr/>
          </p:nvSpPr>
          <p:spPr>
            <a:xfrm rot="16200000">
              <a:off x="1745815" y="4835525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88822117-2977-61F9-8C15-ADC9764F3715}"/>
                </a:ext>
              </a:extLst>
            </p:cNvPr>
            <p:cNvSpPr txBox="1"/>
            <p:nvPr/>
          </p:nvSpPr>
          <p:spPr>
            <a:xfrm>
              <a:off x="2743685" y="4130296"/>
              <a:ext cx="100059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44D51BF1-4826-9EBE-75B8-B70EED8804D2}"/>
                </a:ext>
              </a:extLst>
            </p:cNvPr>
            <p:cNvSpPr txBox="1"/>
            <p:nvPr/>
          </p:nvSpPr>
          <p:spPr>
            <a:xfrm>
              <a:off x="4122859" y="458150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5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1092363-E4BA-A272-87A4-AFDAB89D2586}"/>
                </a:ext>
              </a:extLst>
            </p:cNvPr>
            <p:cNvSpPr txBox="1"/>
            <p:nvPr/>
          </p:nvSpPr>
          <p:spPr>
            <a:xfrm>
              <a:off x="4122859" y="475257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e5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F6D50953-AB65-EDF1-1EF5-B6396AA28E01}"/>
                </a:ext>
              </a:extLst>
            </p:cNvPr>
            <p:cNvSpPr txBox="1"/>
            <p:nvPr/>
          </p:nvSpPr>
          <p:spPr>
            <a:xfrm>
              <a:off x="4122859" y="492104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e5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24E8F6C5-9E09-3B49-C6F6-8BE7AC9FABFD}"/>
                </a:ext>
              </a:extLst>
            </p:cNvPr>
            <p:cNvSpPr txBox="1"/>
            <p:nvPr/>
          </p:nvSpPr>
          <p:spPr>
            <a:xfrm>
              <a:off x="4292777" y="523661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3F755DDF-51E7-F9E6-3D42-D44F1C062B45}"/>
                </a:ext>
              </a:extLst>
            </p:cNvPr>
            <p:cNvSpPr txBox="1"/>
            <p:nvPr/>
          </p:nvSpPr>
          <p:spPr>
            <a:xfrm>
              <a:off x="4122859" y="441305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e5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ABB4C4D-EA66-AA20-B5F3-4372F8C6476B}"/>
                </a:ext>
              </a:extLst>
            </p:cNvPr>
            <p:cNvSpPr txBox="1"/>
            <p:nvPr/>
          </p:nvSpPr>
          <p:spPr>
            <a:xfrm rot="16200000">
              <a:off x="3637337" y="4834209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D5A87C17-141A-E54C-30AE-9E6CECA512A4}"/>
                </a:ext>
              </a:extLst>
            </p:cNvPr>
            <p:cNvSpPr txBox="1"/>
            <p:nvPr/>
          </p:nvSpPr>
          <p:spPr>
            <a:xfrm>
              <a:off x="4122859" y="508801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e5</a:t>
              </a: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55A7755D-0ECE-E319-BBEB-30A486EA2C76}"/>
                </a:ext>
              </a:extLst>
            </p:cNvPr>
            <p:cNvSpPr/>
            <p:nvPr/>
          </p:nvSpPr>
          <p:spPr>
            <a:xfrm>
              <a:off x="4604027" y="4254808"/>
              <a:ext cx="313260" cy="6405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D11EDEE7-CE9A-1563-44C0-1CE6E6FF6EEF}"/>
                </a:ext>
              </a:extLst>
            </p:cNvPr>
            <p:cNvSpPr/>
            <p:nvPr/>
          </p:nvSpPr>
          <p:spPr>
            <a:xfrm rot="5400000">
              <a:off x="5096667" y="4053251"/>
              <a:ext cx="322868" cy="9144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32DFDC7-C3DA-551A-BC3F-69DBE0EF6615}"/>
                </a:ext>
              </a:extLst>
            </p:cNvPr>
            <p:cNvSpPr txBox="1"/>
            <p:nvPr/>
          </p:nvSpPr>
          <p:spPr>
            <a:xfrm>
              <a:off x="5040890" y="4495596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347BF10-5EEA-A245-7DBD-7821987FD005}"/>
                </a:ext>
              </a:extLst>
            </p:cNvPr>
            <p:cNvSpPr txBox="1"/>
            <p:nvPr/>
          </p:nvSpPr>
          <p:spPr>
            <a:xfrm>
              <a:off x="4389161" y="4130296"/>
              <a:ext cx="15456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3E120E04-F83D-0F9A-FC63-FCAA2842B95C}"/>
                </a:ext>
              </a:extLst>
            </p:cNvPr>
            <p:cNvSpPr/>
            <p:nvPr/>
          </p:nvSpPr>
          <p:spPr>
            <a:xfrm>
              <a:off x="5555341" y="4627675"/>
              <a:ext cx="99085" cy="221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F63D6930-56B7-3765-4593-89B2EE2BFE7D}"/>
                </a:ext>
              </a:extLst>
            </p:cNvPr>
            <p:cNvSpPr/>
            <p:nvPr/>
          </p:nvSpPr>
          <p:spPr>
            <a:xfrm>
              <a:off x="4671750" y="4781314"/>
              <a:ext cx="99085" cy="221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7CF93E54-4AB8-0AD2-58EC-D067648AB4EF}"/>
                </a:ext>
              </a:extLst>
            </p:cNvPr>
            <p:cNvSpPr txBox="1"/>
            <p:nvPr/>
          </p:nvSpPr>
          <p:spPr>
            <a:xfrm>
              <a:off x="5897337" y="440375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e6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CD0F7085-1AEB-02AD-91A9-66CEC1B99488}"/>
                </a:ext>
              </a:extLst>
            </p:cNvPr>
            <p:cNvSpPr txBox="1"/>
            <p:nvPr/>
          </p:nvSpPr>
          <p:spPr>
            <a:xfrm>
              <a:off x="5897337" y="468243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6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B7168504-7B10-FDAF-8629-76720D4855A6}"/>
                </a:ext>
              </a:extLst>
            </p:cNvPr>
            <p:cNvSpPr txBox="1"/>
            <p:nvPr/>
          </p:nvSpPr>
          <p:spPr>
            <a:xfrm>
              <a:off x="5897337" y="496068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e6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92428FD5-AB9B-2B47-845A-8538FF7B643E}"/>
                </a:ext>
              </a:extLst>
            </p:cNvPr>
            <p:cNvSpPr txBox="1"/>
            <p:nvPr/>
          </p:nvSpPr>
          <p:spPr>
            <a:xfrm>
              <a:off x="6067255" y="524137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5D56EE6F-FDBB-A279-C915-379EC1A61B55}"/>
                </a:ext>
              </a:extLst>
            </p:cNvPr>
            <p:cNvSpPr txBox="1"/>
            <p:nvPr/>
          </p:nvSpPr>
          <p:spPr>
            <a:xfrm rot="16200000">
              <a:off x="5432987" y="4817062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BF3CA6B-E159-A6B2-BEFC-362C15397C55}"/>
                </a:ext>
              </a:extLst>
            </p:cNvPr>
            <p:cNvSpPr txBox="1"/>
            <p:nvPr/>
          </p:nvSpPr>
          <p:spPr>
            <a:xfrm>
              <a:off x="6366900" y="4130296"/>
              <a:ext cx="10951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A02A9A69-25CE-2F3F-050C-B6F7F9368D51}"/>
                </a:ext>
              </a:extLst>
            </p:cNvPr>
            <p:cNvSpPr txBox="1"/>
            <p:nvPr/>
          </p:nvSpPr>
          <p:spPr>
            <a:xfrm>
              <a:off x="3722768" y="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6A985F5-00A6-319A-AA0D-94934E4E78A9}"/>
                </a:ext>
              </a:extLst>
            </p:cNvPr>
            <p:cNvSpPr txBox="1"/>
            <p:nvPr/>
          </p:nvSpPr>
          <p:spPr>
            <a:xfrm>
              <a:off x="103443" y="213566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5EE51C52-89AB-1E00-94F5-C2CB0A111B48}"/>
                </a:ext>
              </a:extLst>
            </p:cNvPr>
            <p:cNvSpPr txBox="1"/>
            <p:nvPr/>
          </p:nvSpPr>
          <p:spPr>
            <a:xfrm>
              <a:off x="103443" y="410708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1DBDE2D-ED23-40CD-8FC3-9D6E8A14EFCD}"/>
                </a:ext>
              </a:extLst>
            </p:cNvPr>
            <p:cNvSpPr txBox="1"/>
            <p:nvPr/>
          </p:nvSpPr>
          <p:spPr>
            <a:xfrm>
              <a:off x="320116" y="6211426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5e7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474B4CB0-9AA0-3E32-1A68-8D5EF5CE21DB}"/>
                </a:ext>
              </a:extLst>
            </p:cNvPr>
            <p:cNvSpPr txBox="1"/>
            <p:nvPr/>
          </p:nvSpPr>
          <p:spPr>
            <a:xfrm>
              <a:off x="448356" y="648507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e7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CA72D00E-90ED-345A-3D4C-7FB564C8E31B}"/>
                </a:ext>
              </a:extLst>
            </p:cNvPr>
            <p:cNvSpPr txBox="1"/>
            <p:nvPr/>
          </p:nvSpPr>
          <p:spPr>
            <a:xfrm>
              <a:off x="448356" y="675697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e6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1AF86BE-1991-559B-5D82-A801D98C66CB}"/>
                </a:ext>
              </a:extLst>
            </p:cNvPr>
            <p:cNvSpPr txBox="1"/>
            <p:nvPr/>
          </p:nvSpPr>
          <p:spPr>
            <a:xfrm>
              <a:off x="618274" y="702656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27F3F2BF-1FED-3E28-83BC-CB98312C0F15}"/>
                </a:ext>
              </a:extLst>
            </p:cNvPr>
            <p:cNvSpPr txBox="1"/>
            <p:nvPr/>
          </p:nvSpPr>
          <p:spPr>
            <a:xfrm rot="16200000">
              <a:off x="-95070" y="6612815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BCE1ECEC-D401-4D3F-E269-5933B74DB118}"/>
                </a:ext>
              </a:extLst>
            </p:cNvPr>
            <p:cNvSpPr txBox="1"/>
            <p:nvPr/>
          </p:nvSpPr>
          <p:spPr>
            <a:xfrm>
              <a:off x="1069147" y="6042531"/>
              <a:ext cx="7056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 Cells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C9060255-4760-6960-FA48-E83BE603E95F}"/>
                </a:ext>
              </a:extLst>
            </p:cNvPr>
            <p:cNvSpPr txBox="1"/>
            <p:nvPr/>
          </p:nvSpPr>
          <p:spPr>
            <a:xfrm>
              <a:off x="111459" y="5994458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0D43BF67-80B4-2C88-880B-3E116B1A80E3}"/>
                </a:ext>
              </a:extLst>
            </p:cNvPr>
            <p:cNvGrpSpPr/>
            <p:nvPr/>
          </p:nvGrpSpPr>
          <p:grpSpPr>
            <a:xfrm>
              <a:off x="837437" y="471266"/>
              <a:ext cx="1919426" cy="287563"/>
              <a:chOff x="5240959" y="6595532"/>
              <a:chExt cx="10994316" cy="2641600"/>
            </a:xfrm>
          </p:grpSpPr>
          <p:cxnSp>
            <p:nvCxnSpPr>
              <p:cNvPr id="157" name="Straight Connector 156">
                <a:extLst>
                  <a:ext uri="{FF2B5EF4-FFF2-40B4-BE49-F238E27FC236}">
                    <a16:creationId xmlns:a16="http://schemas.microsoft.com/office/drawing/2014/main" id="{08BFCEF4-8500-7D18-6EEC-12E4846299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49333" y="7916332"/>
                <a:ext cx="109728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>
                <a:extLst>
                  <a:ext uri="{FF2B5EF4-FFF2-40B4-BE49-F238E27FC236}">
                    <a16:creationId xmlns:a16="http://schemas.microsoft.com/office/drawing/2014/main" id="{6BC1DF1E-57B9-F645-90BE-DCD1510487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40959" y="6595532"/>
                <a:ext cx="0" cy="2641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>
                <a:extLst>
                  <a:ext uri="{FF2B5EF4-FFF2-40B4-BE49-F238E27FC236}">
                    <a16:creationId xmlns:a16="http://schemas.microsoft.com/office/drawing/2014/main" id="{F813CB4F-8915-1B11-1B45-87C1C2DF6F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235275" y="6595532"/>
                <a:ext cx="0" cy="2641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C22CCAA6-F2AE-C045-2C5D-E98B96E03052}"/>
                </a:ext>
              </a:extLst>
            </p:cNvPr>
            <p:cNvSpPr txBox="1"/>
            <p:nvPr/>
          </p:nvSpPr>
          <p:spPr>
            <a:xfrm>
              <a:off x="548885" y="14788"/>
              <a:ext cx="593432" cy="46166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ax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A2DF8176-7CDF-E761-326F-02E259ED9974}"/>
                </a:ext>
              </a:extLst>
            </p:cNvPr>
            <p:cNvSpPr txBox="1"/>
            <p:nvPr/>
          </p:nvSpPr>
          <p:spPr>
            <a:xfrm>
              <a:off x="2319818" y="14788"/>
              <a:ext cx="875896" cy="46166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arvest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y 14</a:t>
              </a:r>
            </a:p>
          </p:txBody>
        </p:sp>
        <p:pic>
          <p:nvPicPr>
            <p:cNvPr id="124" name="Picture 2">
              <a:extLst>
                <a:ext uri="{FF2B5EF4-FFF2-40B4-BE49-F238E27FC236}">
                  <a16:creationId xmlns:a16="http://schemas.microsoft.com/office/drawing/2014/main" id="{7C79BE17-87FE-69D5-BE93-8D5EF733879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1246099" flipV="1">
              <a:off x="1143145" y="943540"/>
              <a:ext cx="536525" cy="5937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5" name="TextBox 38">
              <a:extLst>
                <a:ext uri="{FF2B5EF4-FFF2-40B4-BE49-F238E27FC236}">
                  <a16:creationId xmlns:a16="http://schemas.microsoft.com/office/drawing/2014/main" id="{6B3B9E39-BB40-6CF9-ECCB-C6EF89F497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0290" y="832397"/>
              <a:ext cx="803211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None/>
                <a:defRPr/>
              </a:pPr>
              <a:r>
                <a:rPr lang="en-US" altLang="zh-CN" sz="1200" b="1" kern="0" dirty="0">
                  <a:solidFill>
                    <a:prstClr val="black"/>
                  </a:solidFill>
                  <a:latin typeface="Arial" panose="020B0604020202020204" pitchFamily="34" charset="0"/>
                  <a:ea typeface="Kai"/>
                  <a:cs typeface="Arial" panose="020B0604020202020204" pitchFamily="34" charset="0"/>
                </a:rPr>
                <a:t>I.N. GC+RVPs</a:t>
              </a:r>
            </a:p>
          </p:txBody>
        </p:sp>
        <p:sp>
          <p:nvSpPr>
            <p:cNvPr id="126" name="TextBox 10">
              <a:extLst>
                <a:ext uri="{FF2B5EF4-FFF2-40B4-BE49-F238E27FC236}">
                  <a16:creationId xmlns:a16="http://schemas.microsoft.com/office/drawing/2014/main" id="{1980374C-E61B-2F42-7540-48BE71B175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68032" y="1431030"/>
              <a:ext cx="1500152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9144" rIns="9144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None/>
                <a:defRPr/>
              </a:pPr>
              <a:r>
                <a:rPr lang="en-US" altLang="en-US" sz="1200" b="1" kern="0" dirty="0">
                  <a:solidFill>
                    <a:prstClr val="black"/>
                  </a:solidFill>
                  <a:latin typeface="Arial" panose="020B0604020202020204" pitchFamily="34" charset="0"/>
                  <a:ea typeface="Kai"/>
                  <a:cs typeface="Arial" panose="020B0604020202020204" pitchFamily="34" charset="0"/>
                </a:rPr>
                <a:t>Humoral and Cellular Immune responses</a:t>
              </a:r>
            </a:p>
          </p:txBody>
        </p:sp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2DCD83E4-1CC8-85CE-8BC1-BE07BF6AAA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 rot="11239546">
              <a:off x="2434599" y="797583"/>
              <a:ext cx="232834" cy="322849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5AFB4886-1157-44C9-6A0E-A9421CBF09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rot="5861459">
              <a:off x="1915459" y="903627"/>
              <a:ext cx="695652" cy="375522"/>
            </a:xfrm>
            <a:prstGeom prst="rect">
              <a:avLst/>
            </a:prstGeom>
          </p:spPr>
        </p:pic>
        <p:sp>
          <p:nvSpPr>
            <p:cNvPr id="129" name="TextBox 10">
              <a:extLst>
                <a:ext uri="{FF2B5EF4-FFF2-40B4-BE49-F238E27FC236}">
                  <a16:creationId xmlns:a16="http://schemas.microsoft.com/office/drawing/2014/main" id="{BEDAFD5F-C583-18FC-2B44-5C894B1549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53043" y="1108895"/>
              <a:ext cx="2937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9144" rIns="9144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None/>
                <a:defRPr/>
              </a:pPr>
              <a:r>
                <a:rPr lang="en-US" altLang="en-US" sz="1200" b="1" kern="0" dirty="0">
                  <a:solidFill>
                    <a:prstClr val="black"/>
                  </a:solidFill>
                  <a:latin typeface="Arial" panose="020B0604020202020204" pitchFamily="34" charset="0"/>
                  <a:ea typeface="Kai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30" name="TextBox 10">
              <a:extLst>
                <a:ext uri="{FF2B5EF4-FFF2-40B4-BE49-F238E27FC236}">
                  <a16:creationId xmlns:a16="http://schemas.microsoft.com/office/drawing/2014/main" id="{E339762F-CEFD-61FC-731B-78924D9E9F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02495" y="1031674"/>
              <a:ext cx="33431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9144" rIns="9144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None/>
                <a:defRPr/>
              </a:pPr>
              <a:r>
                <a:rPr lang="en-US" altLang="en-US" sz="1200" b="1" kern="0" dirty="0">
                  <a:solidFill>
                    <a:prstClr val="black"/>
                  </a:solidFill>
                  <a:latin typeface="Arial" panose="020B0604020202020204" pitchFamily="34" charset="0"/>
                  <a:ea typeface="Kai"/>
                  <a:cs typeface="Arial" panose="020B0604020202020204" pitchFamily="34" charset="0"/>
                </a:rPr>
                <a:t>IgA</a:t>
              </a:r>
            </a:p>
          </p:txBody>
        </p:sp>
        <p:grpSp>
          <p:nvGrpSpPr>
            <p:cNvPr id="131" name="Group 130">
              <a:extLst>
                <a:ext uri="{FF2B5EF4-FFF2-40B4-BE49-F238E27FC236}">
                  <a16:creationId xmlns:a16="http://schemas.microsoft.com/office/drawing/2014/main" id="{A2FB2A54-01F2-AE7E-2FDD-A4F3CEF6514C}"/>
                </a:ext>
              </a:extLst>
            </p:cNvPr>
            <p:cNvGrpSpPr/>
            <p:nvPr/>
          </p:nvGrpSpPr>
          <p:grpSpPr>
            <a:xfrm>
              <a:off x="3218872" y="779040"/>
              <a:ext cx="334314" cy="242493"/>
              <a:chOff x="3225500" y="2776870"/>
              <a:chExt cx="481527" cy="457200"/>
            </a:xfrm>
          </p:grpSpPr>
          <p:sp>
            <p:nvSpPr>
              <p:cNvPr id="151" name="Oval 150">
                <a:extLst>
                  <a:ext uri="{FF2B5EF4-FFF2-40B4-BE49-F238E27FC236}">
                    <a16:creationId xmlns:a16="http://schemas.microsoft.com/office/drawing/2014/main" id="{75B4A170-E938-BEA3-8ECF-00D57D5F96F8}"/>
                  </a:ext>
                </a:extLst>
              </p:cNvPr>
              <p:cNvSpPr/>
              <p:nvPr/>
            </p:nvSpPr>
            <p:spPr>
              <a:xfrm>
                <a:off x="3225500" y="2776870"/>
                <a:ext cx="481527" cy="45720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52" name="Oval 151">
                <a:extLst>
                  <a:ext uri="{FF2B5EF4-FFF2-40B4-BE49-F238E27FC236}">
                    <a16:creationId xmlns:a16="http://schemas.microsoft.com/office/drawing/2014/main" id="{97DD5621-5A4A-56AE-AD0F-6D3A85964F8B}"/>
                  </a:ext>
                </a:extLst>
              </p:cNvPr>
              <p:cNvSpPr/>
              <p:nvPr/>
            </p:nvSpPr>
            <p:spPr>
              <a:xfrm>
                <a:off x="3308179" y="2819400"/>
                <a:ext cx="370754" cy="372140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82C92960-B0FC-7561-FBB5-8D2661EB3A73}"/>
                </a:ext>
              </a:extLst>
            </p:cNvPr>
            <p:cNvGrpSpPr/>
            <p:nvPr/>
          </p:nvGrpSpPr>
          <p:grpSpPr>
            <a:xfrm>
              <a:off x="3145477" y="1021636"/>
              <a:ext cx="334314" cy="242493"/>
              <a:chOff x="3434994" y="2298405"/>
              <a:chExt cx="481527" cy="457200"/>
            </a:xfrm>
          </p:grpSpPr>
          <p:sp>
            <p:nvSpPr>
              <p:cNvPr id="149" name="Oval 148">
                <a:extLst>
                  <a:ext uri="{FF2B5EF4-FFF2-40B4-BE49-F238E27FC236}">
                    <a16:creationId xmlns:a16="http://schemas.microsoft.com/office/drawing/2014/main" id="{AA91CAC1-E10C-1FD0-93EF-775B6E7DFAB6}"/>
                  </a:ext>
                </a:extLst>
              </p:cNvPr>
              <p:cNvSpPr/>
              <p:nvPr/>
            </p:nvSpPr>
            <p:spPr>
              <a:xfrm>
                <a:off x="3434994" y="2298405"/>
                <a:ext cx="481527" cy="45720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50" name="Oval 149">
                <a:extLst>
                  <a:ext uri="{FF2B5EF4-FFF2-40B4-BE49-F238E27FC236}">
                    <a16:creationId xmlns:a16="http://schemas.microsoft.com/office/drawing/2014/main" id="{5AC69B2B-83C0-6D7A-47FA-E8F5CE388D82}"/>
                  </a:ext>
                </a:extLst>
              </p:cNvPr>
              <p:cNvSpPr/>
              <p:nvPr/>
            </p:nvSpPr>
            <p:spPr>
              <a:xfrm>
                <a:off x="3517673" y="2340935"/>
                <a:ext cx="370754" cy="372140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FCD3B3C9-D2D0-902D-56F3-0C6E1A65BCCC}"/>
                </a:ext>
              </a:extLst>
            </p:cNvPr>
            <p:cNvGrpSpPr/>
            <p:nvPr/>
          </p:nvGrpSpPr>
          <p:grpSpPr>
            <a:xfrm>
              <a:off x="2940269" y="853446"/>
              <a:ext cx="334314" cy="242493"/>
              <a:chOff x="3731144" y="2697036"/>
              <a:chExt cx="481527" cy="457200"/>
            </a:xfrm>
          </p:grpSpPr>
          <p:sp>
            <p:nvSpPr>
              <p:cNvPr id="147" name="Oval 146">
                <a:extLst>
                  <a:ext uri="{FF2B5EF4-FFF2-40B4-BE49-F238E27FC236}">
                    <a16:creationId xmlns:a16="http://schemas.microsoft.com/office/drawing/2014/main" id="{8B95BE75-7248-D13C-DD81-DBEF3FD832D7}"/>
                  </a:ext>
                </a:extLst>
              </p:cNvPr>
              <p:cNvSpPr/>
              <p:nvPr/>
            </p:nvSpPr>
            <p:spPr>
              <a:xfrm>
                <a:off x="3731144" y="2697036"/>
                <a:ext cx="481527" cy="45720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8" name="Oval 147">
                <a:extLst>
                  <a:ext uri="{FF2B5EF4-FFF2-40B4-BE49-F238E27FC236}">
                    <a16:creationId xmlns:a16="http://schemas.microsoft.com/office/drawing/2014/main" id="{7FB8042D-780E-1A58-780E-4D1963BBF48B}"/>
                  </a:ext>
                </a:extLst>
              </p:cNvPr>
              <p:cNvSpPr/>
              <p:nvPr/>
            </p:nvSpPr>
            <p:spPr>
              <a:xfrm>
                <a:off x="3789706" y="2754208"/>
                <a:ext cx="370754" cy="372140"/>
              </a:xfrm>
              <a:prstGeom prst="ellipse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533F4609-555C-D1FF-A55E-00BAD8CA2466}"/>
                </a:ext>
              </a:extLst>
            </p:cNvPr>
            <p:cNvGrpSpPr/>
            <p:nvPr/>
          </p:nvGrpSpPr>
          <p:grpSpPr>
            <a:xfrm>
              <a:off x="2865184" y="1118497"/>
              <a:ext cx="334314" cy="242493"/>
              <a:chOff x="3987863" y="2269121"/>
              <a:chExt cx="481527" cy="457200"/>
            </a:xfrm>
          </p:grpSpPr>
          <p:sp>
            <p:nvSpPr>
              <p:cNvPr id="145" name="Oval 144">
                <a:extLst>
                  <a:ext uri="{FF2B5EF4-FFF2-40B4-BE49-F238E27FC236}">
                    <a16:creationId xmlns:a16="http://schemas.microsoft.com/office/drawing/2014/main" id="{D7DA365B-6D6E-157E-B3DB-E1FCFAD38200}"/>
                  </a:ext>
                </a:extLst>
              </p:cNvPr>
              <p:cNvSpPr/>
              <p:nvPr/>
            </p:nvSpPr>
            <p:spPr>
              <a:xfrm>
                <a:off x="3987863" y="2269121"/>
                <a:ext cx="481527" cy="457200"/>
              </a:xfrm>
              <a:prstGeom prst="ellips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6" name="Oval 145">
                <a:extLst>
                  <a:ext uri="{FF2B5EF4-FFF2-40B4-BE49-F238E27FC236}">
                    <a16:creationId xmlns:a16="http://schemas.microsoft.com/office/drawing/2014/main" id="{24BFF33C-CDFD-07B9-0C7F-25EF63BAFB71}"/>
                  </a:ext>
                </a:extLst>
              </p:cNvPr>
              <p:cNvSpPr/>
              <p:nvPr/>
            </p:nvSpPr>
            <p:spPr>
              <a:xfrm>
                <a:off x="4070542" y="2311651"/>
                <a:ext cx="370754" cy="372140"/>
              </a:xfrm>
              <a:prstGeom prst="ellipse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>
                <a:solidFill>
                  <a:schemeClr val="tx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sp>
          <p:nvSpPr>
            <p:cNvPr id="135" name="TextBox 10">
              <a:extLst>
                <a:ext uri="{FF2B5EF4-FFF2-40B4-BE49-F238E27FC236}">
                  <a16:creationId xmlns:a16="http://schemas.microsoft.com/office/drawing/2014/main" id="{3AC16F57-3887-9D41-61E9-9E825241FB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33183" y="586660"/>
              <a:ext cx="73939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9144" rIns="9144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None/>
                <a:defRPr/>
              </a:pPr>
              <a:r>
                <a:rPr lang="en-US" altLang="en-US" sz="1200" b="1" kern="0" dirty="0">
                  <a:solidFill>
                    <a:prstClr val="black"/>
                  </a:solidFill>
                  <a:latin typeface="Arial" panose="020B0604020202020204" pitchFamily="34" charset="0"/>
                  <a:ea typeface="Kai"/>
                  <a:cs typeface="Arial" panose="020B0604020202020204" pitchFamily="34" charset="0"/>
                </a:rPr>
                <a:t>T cells </a:t>
              </a:r>
            </a:p>
          </p:txBody>
        </p: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5D59AFEF-2270-3B8F-894B-29C74DD0D380}"/>
                </a:ext>
              </a:extLst>
            </p:cNvPr>
            <p:cNvGrpSpPr/>
            <p:nvPr/>
          </p:nvGrpSpPr>
          <p:grpSpPr>
            <a:xfrm>
              <a:off x="336227" y="1245197"/>
              <a:ext cx="789708" cy="429476"/>
              <a:chOff x="-2590800" y="304800"/>
              <a:chExt cx="4075860" cy="1727201"/>
            </a:xfrm>
          </p:grpSpPr>
          <p:grpSp>
            <p:nvGrpSpPr>
              <p:cNvPr id="138" name="Group 137">
                <a:extLst>
                  <a:ext uri="{FF2B5EF4-FFF2-40B4-BE49-F238E27FC236}">
                    <a16:creationId xmlns:a16="http://schemas.microsoft.com/office/drawing/2014/main" id="{EA1A288D-B298-D3E2-1CEC-D83AD029BA6F}"/>
                  </a:ext>
                </a:extLst>
              </p:cNvPr>
              <p:cNvGrpSpPr/>
              <p:nvPr/>
            </p:nvGrpSpPr>
            <p:grpSpPr>
              <a:xfrm>
                <a:off x="-2590800" y="304800"/>
                <a:ext cx="3999660" cy="1727201"/>
                <a:chOff x="1397000" y="2351599"/>
                <a:chExt cx="3999660" cy="1727201"/>
              </a:xfrm>
            </p:grpSpPr>
            <p:sp>
              <p:nvSpPr>
                <p:cNvPr id="140" name="Isosceles Triangle 2">
                  <a:extLst>
                    <a:ext uri="{FF2B5EF4-FFF2-40B4-BE49-F238E27FC236}">
                      <a16:creationId xmlns:a16="http://schemas.microsoft.com/office/drawing/2014/main" id="{62677637-A37B-82D8-2583-20989FA9E723}"/>
                    </a:ext>
                  </a:extLst>
                </p:cNvPr>
                <p:cNvSpPr/>
                <p:nvPr/>
              </p:nvSpPr>
              <p:spPr>
                <a:xfrm rot="20837633">
                  <a:off x="4038200" y="2351599"/>
                  <a:ext cx="763743" cy="774288"/>
                </a:xfrm>
                <a:custGeom>
                  <a:avLst/>
                  <a:gdLst>
                    <a:gd name="connsiteX0" fmla="*/ 0 w 1060704"/>
                    <a:gd name="connsiteY0" fmla="*/ 914400 h 914400"/>
                    <a:gd name="connsiteX1" fmla="*/ 530352 w 1060704"/>
                    <a:gd name="connsiteY1" fmla="*/ 0 h 914400"/>
                    <a:gd name="connsiteX2" fmla="*/ 1060704 w 1060704"/>
                    <a:gd name="connsiteY2" fmla="*/ 914400 h 914400"/>
                    <a:gd name="connsiteX3" fmla="*/ 0 w 1060704"/>
                    <a:gd name="connsiteY3" fmla="*/ 914400 h 914400"/>
                    <a:gd name="connsiteX0" fmla="*/ 0 w 1072262"/>
                    <a:gd name="connsiteY0" fmla="*/ 914400 h 914400"/>
                    <a:gd name="connsiteX1" fmla="*/ 530352 w 1072262"/>
                    <a:gd name="connsiteY1" fmla="*/ 0 h 914400"/>
                    <a:gd name="connsiteX2" fmla="*/ 1060704 w 1072262"/>
                    <a:gd name="connsiteY2" fmla="*/ 914400 h 914400"/>
                    <a:gd name="connsiteX3" fmla="*/ 0 w 1072262"/>
                    <a:gd name="connsiteY3" fmla="*/ 914400 h 914400"/>
                    <a:gd name="connsiteX0" fmla="*/ 11558 w 1083820"/>
                    <a:gd name="connsiteY0" fmla="*/ 914400 h 914400"/>
                    <a:gd name="connsiteX1" fmla="*/ 541910 w 1083820"/>
                    <a:gd name="connsiteY1" fmla="*/ 0 h 914400"/>
                    <a:gd name="connsiteX2" fmla="*/ 1072262 w 1083820"/>
                    <a:gd name="connsiteY2" fmla="*/ 914400 h 914400"/>
                    <a:gd name="connsiteX3" fmla="*/ 11558 w 1083820"/>
                    <a:gd name="connsiteY3" fmla="*/ 914400 h 91440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83351 w 804599"/>
                    <a:gd name="connsiteY0" fmla="*/ 774849 h 970119"/>
                    <a:gd name="connsiteX1" fmla="*/ 270803 w 804599"/>
                    <a:gd name="connsiteY1" fmla="*/ 149 h 970119"/>
                    <a:gd name="connsiteX2" fmla="*/ 801155 w 804599"/>
                    <a:gd name="connsiteY2" fmla="*/ 914549 h 970119"/>
                    <a:gd name="connsiteX3" fmla="*/ 83351 w 804599"/>
                    <a:gd name="connsiteY3" fmla="*/ 774849 h 970119"/>
                    <a:gd name="connsiteX0" fmla="*/ 18984 w 763743"/>
                    <a:gd name="connsiteY0" fmla="*/ 597084 h 774288"/>
                    <a:gd name="connsiteX1" fmla="*/ 396936 w 763743"/>
                    <a:gd name="connsiteY1" fmla="*/ 184 h 774288"/>
                    <a:gd name="connsiteX2" fmla="*/ 736788 w 763743"/>
                    <a:gd name="connsiteY2" fmla="*/ 736784 h 774288"/>
                    <a:gd name="connsiteX3" fmla="*/ 18984 w 763743"/>
                    <a:gd name="connsiteY3" fmla="*/ 597084 h 7742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63743" h="774288">
                      <a:moveTo>
                        <a:pt x="18984" y="597084"/>
                      </a:moveTo>
                      <a:cubicBezTo>
                        <a:pt x="-37658" y="474317"/>
                        <a:pt x="16952" y="12884"/>
                        <a:pt x="396936" y="184"/>
                      </a:cubicBezTo>
                      <a:cubicBezTo>
                        <a:pt x="776920" y="-12516"/>
                        <a:pt x="799780" y="637301"/>
                        <a:pt x="736788" y="736784"/>
                      </a:cubicBezTo>
                      <a:cubicBezTo>
                        <a:pt x="673796" y="836267"/>
                        <a:pt x="75626" y="719851"/>
                        <a:pt x="18984" y="597084"/>
                      </a:cubicBez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41" name="Freeform 1">
                  <a:extLst>
                    <a:ext uri="{FF2B5EF4-FFF2-40B4-BE49-F238E27FC236}">
                      <a16:creationId xmlns:a16="http://schemas.microsoft.com/office/drawing/2014/main" id="{4C2D3FE3-3F9A-0661-300E-1BEE6B26D679}"/>
                    </a:ext>
                  </a:extLst>
                </p:cNvPr>
                <p:cNvSpPr/>
                <p:nvPr/>
              </p:nvSpPr>
              <p:spPr>
                <a:xfrm>
                  <a:off x="1720987" y="2421850"/>
                  <a:ext cx="3675673" cy="1330239"/>
                </a:xfrm>
                <a:custGeom>
                  <a:avLst/>
                  <a:gdLst>
                    <a:gd name="connsiteX0" fmla="*/ 406400 w 3594100"/>
                    <a:gd name="connsiteY0" fmla="*/ 952500 h 952500"/>
                    <a:gd name="connsiteX1" fmla="*/ 3594100 w 3594100"/>
                    <a:gd name="connsiteY1" fmla="*/ 939800 h 952500"/>
                    <a:gd name="connsiteX2" fmla="*/ 2616200 w 3594100"/>
                    <a:gd name="connsiteY2" fmla="*/ 0 h 952500"/>
                    <a:gd name="connsiteX3" fmla="*/ 838200 w 3594100"/>
                    <a:gd name="connsiteY3" fmla="*/ 12700 h 952500"/>
                    <a:gd name="connsiteX4" fmla="*/ 177800 w 3594100"/>
                    <a:gd name="connsiteY4" fmla="*/ 177800 h 952500"/>
                    <a:gd name="connsiteX5" fmla="*/ 0 w 3594100"/>
                    <a:gd name="connsiteY5" fmla="*/ 520700 h 952500"/>
                    <a:gd name="connsiteX6" fmla="*/ 406400 w 3594100"/>
                    <a:gd name="connsiteY6" fmla="*/ 952500 h 952500"/>
                    <a:gd name="connsiteX0" fmla="*/ 406400 w 3681450"/>
                    <a:gd name="connsiteY0" fmla="*/ 1024552 h 1024552"/>
                    <a:gd name="connsiteX1" fmla="*/ 3594100 w 3681450"/>
                    <a:gd name="connsiteY1" fmla="*/ 1011852 h 1024552"/>
                    <a:gd name="connsiteX2" fmla="*/ 2616200 w 3681450"/>
                    <a:gd name="connsiteY2" fmla="*/ 72052 h 1024552"/>
                    <a:gd name="connsiteX3" fmla="*/ 838200 w 3681450"/>
                    <a:gd name="connsiteY3" fmla="*/ 84752 h 1024552"/>
                    <a:gd name="connsiteX4" fmla="*/ 177800 w 3681450"/>
                    <a:gd name="connsiteY4" fmla="*/ 249852 h 1024552"/>
                    <a:gd name="connsiteX5" fmla="*/ 0 w 3681450"/>
                    <a:gd name="connsiteY5" fmla="*/ 592752 h 1024552"/>
                    <a:gd name="connsiteX6" fmla="*/ 406400 w 3681450"/>
                    <a:gd name="connsiteY6" fmla="*/ 1024552 h 1024552"/>
                    <a:gd name="connsiteX0" fmla="*/ 406400 w 3681450"/>
                    <a:gd name="connsiteY0" fmla="*/ 1030895 h 1030895"/>
                    <a:gd name="connsiteX1" fmla="*/ 3594100 w 3681450"/>
                    <a:gd name="connsiteY1" fmla="*/ 1018195 h 1030895"/>
                    <a:gd name="connsiteX2" fmla="*/ 2616200 w 3681450"/>
                    <a:gd name="connsiteY2" fmla="*/ 78395 h 1030895"/>
                    <a:gd name="connsiteX3" fmla="*/ 838200 w 3681450"/>
                    <a:gd name="connsiteY3" fmla="*/ 91095 h 1030895"/>
                    <a:gd name="connsiteX4" fmla="*/ 177800 w 3681450"/>
                    <a:gd name="connsiteY4" fmla="*/ 256195 h 1030895"/>
                    <a:gd name="connsiteX5" fmla="*/ 0 w 3681450"/>
                    <a:gd name="connsiteY5" fmla="*/ 599095 h 1030895"/>
                    <a:gd name="connsiteX6" fmla="*/ 406400 w 3681450"/>
                    <a:gd name="connsiteY6" fmla="*/ 1030895 h 1030895"/>
                    <a:gd name="connsiteX0" fmla="*/ 426405 w 3701455"/>
                    <a:gd name="connsiteY0" fmla="*/ 1030895 h 1030895"/>
                    <a:gd name="connsiteX1" fmla="*/ 3614105 w 3701455"/>
                    <a:gd name="connsiteY1" fmla="*/ 1018195 h 1030895"/>
                    <a:gd name="connsiteX2" fmla="*/ 2636205 w 3701455"/>
                    <a:gd name="connsiteY2" fmla="*/ 78395 h 1030895"/>
                    <a:gd name="connsiteX3" fmla="*/ 858205 w 3701455"/>
                    <a:gd name="connsiteY3" fmla="*/ 91095 h 1030895"/>
                    <a:gd name="connsiteX4" fmla="*/ 197805 w 3701455"/>
                    <a:gd name="connsiteY4" fmla="*/ 256195 h 1030895"/>
                    <a:gd name="connsiteX5" fmla="*/ 20005 w 3701455"/>
                    <a:gd name="connsiteY5" fmla="*/ 599095 h 1030895"/>
                    <a:gd name="connsiteX6" fmla="*/ 426405 w 3701455"/>
                    <a:gd name="connsiteY6" fmla="*/ 1030895 h 1030895"/>
                    <a:gd name="connsiteX0" fmla="*/ 455433 w 3730483"/>
                    <a:gd name="connsiteY0" fmla="*/ 1030895 h 1030895"/>
                    <a:gd name="connsiteX1" fmla="*/ 3643133 w 3730483"/>
                    <a:gd name="connsiteY1" fmla="*/ 1018195 h 1030895"/>
                    <a:gd name="connsiteX2" fmla="*/ 2665233 w 3730483"/>
                    <a:gd name="connsiteY2" fmla="*/ 78395 h 1030895"/>
                    <a:gd name="connsiteX3" fmla="*/ 887233 w 3730483"/>
                    <a:gd name="connsiteY3" fmla="*/ 91095 h 1030895"/>
                    <a:gd name="connsiteX4" fmla="*/ 226833 w 3730483"/>
                    <a:gd name="connsiteY4" fmla="*/ 256195 h 1030895"/>
                    <a:gd name="connsiteX5" fmla="*/ 49033 w 3730483"/>
                    <a:gd name="connsiteY5" fmla="*/ 599095 h 1030895"/>
                    <a:gd name="connsiteX6" fmla="*/ 455433 w 3730483"/>
                    <a:gd name="connsiteY6" fmla="*/ 1030895 h 1030895"/>
                    <a:gd name="connsiteX0" fmla="*/ 455433 w 3730483"/>
                    <a:gd name="connsiteY0" fmla="*/ 1030895 h 1138085"/>
                    <a:gd name="connsiteX1" fmla="*/ 3643133 w 3730483"/>
                    <a:gd name="connsiteY1" fmla="*/ 1018195 h 1138085"/>
                    <a:gd name="connsiteX2" fmla="*/ 2665233 w 3730483"/>
                    <a:gd name="connsiteY2" fmla="*/ 78395 h 1138085"/>
                    <a:gd name="connsiteX3" fmla="*/ 887233 w 3730483"/>
                    <a:gd name="connsiteY3" fmla="*/ 91095 h 1138085"/>
                    <a:gd name="connsiteX4" fmla="*/ 226833 w 3730483"/>
                    <a:gd name="connsiteY4" fmla="*/ 256195 h 1138085"/>
                    <a:gd name="connsiteX5" fmla="*/ 49033 w 3730483"/>
                    <a:gd name="connsiteY5" fmla="*/ 599095 h 1138085"/>
                    <a:gd name="connsiteX6" fmla="*/ 455433 w 3730483"/>
                    <a:gd name="connsiteY6" fmla="*/ 1030895 h 1138085"/>
                    <a:gd name="connsiteX0" fmla="*/ 410132 w 3685182"/>
                    <a:gd name="connsiteY0" fmla="*/ 1018906 h 1126096"/>
                    <a:gd name="connsiteX1" fmla="*/ 3597832 w 3685182"/>
                    <a:gd name="connsiteY1" fmla="*/ 1006206 h 1126096"/>
                    <a:gd name="connsiteX2" fmla="*/ 2619932 w 3685182"/>
                    <a:gd name="connsiteY2" fmla="*/ 66406 h 1126096"/>
                    <a:gd name="connsiteX3" fmla="*/ 841932 w 3685182"/>
                    <a:gd name="connsiteY3" fmla="*/ 79106 h 1126096"/>
                    <a:gd name="connsiteX4" fmla="*/ 245032 w 3685182"/>
                    <a:gd name="connsiteY4" fmla="*/ 91806 h 1126096"/>
                    <a:gd name="connsiteX5" fmla="*/ 3732 w 3685182"/>
                    <a:gd name="connsiteY5" fmla="*/ 587106 h 1126096"/>
                    <a:gd name="connsiteX6" fmla="*/ 410132 w 3685182"/>
                    <a:gd name="connsiteY6" fmla="*/ 1018906 h 1126096"/>
                    <a:gd name="connsiteX0" fmla="*/ 460743 w 3743071"/>
                    <a:gd name="connsiteY0" fmla="*/ 1034427 h 1141617"/>
                    <a:gd name="connsiteX1" fmla="*/ 3648443 w 3743071"/>
                    <a:gd name="connsiteY1" fmla="*/ 1021727 h 1141617"/>
                    <a:gd name="connsiteX2" fmla="*/ 2670543 w 3743071"/>
                    <a:gd name="connsiteY2" fmla="*/ 81927 h 1141617"/>
                    <a:gd name="connsiteX3" fmla="*/ 295643 w 3743071"/>
                    <a:gd name="connsiteY3" fmla="*/ 107327 h 1141617"/>
                    <a:gd name="connsiteX4" fmla="*/ 54343 w 3743071"/>
                    <a:gd name="connsiteY4" fmla="*/ 602627 h 1141617"/>
                    <a:gd name="connsiteX5" fmla="*/ 460743 w 3743071"/>
                    <a:gd name="connsiteY5" fmla="*/ 1034427 h 1141617"/>
                    <a:gd name="connsiteX0" fmla="*/ 433140 w 3684200"/>
                    <a:gd name="connsiteY0" fmla="*/ 1157215 h 1264405"/>
                    <a:gd name="connsiteX1" fmla="*/ 3620840 w 3684200"/>
                    <a:gd name="connsiteY1" fmla="*/ 1144515 h 1264405"/>
                    <a:gd name="connsiteX2" fmla="*/ 2096840 w 3684200"/>
                    <a:gd name="connsiteY2" fmla="*/ 52315 h 1264405"/>
                    <a:gd name="connsiteX3" fmla="*/ 268040 w 3684200"/>
                    <a:gd name="connsiteY3" fmla="*/ 230115 h 1264405"/>
                    <a:gd name="connsiteX4" fmla="*/ 26740 w 3684200"/>
                    <a:gd name="connsiteY4" fmla="*/ 725415 h 1264405"/>
                    <a:gd name="connsiteX5" fmla="*/ 433140 w 3684200"/>
                    <a:gd name="connsiteY5" fmla="*/ 1157215 h 1264405"/>
                    <a:gd name="connsiteX0" fmla="*/ 407817 w 3658178"/>
                    <a:gd name="connsiteY0" fmla="*/ 1223049 h 1330239"/>
                    <a:gd name="connsiteX1" fmla="*/ 3595517 w 3658178"/>
                    <a:gd name="connsiteY1" fmla="*/ 1210349 h 1330239"/>
                    <a:gd name="connsiteX2" fmla="*/ 2071517 w 3658178"/>
                    <a:gd name="connsiteY2" fmla="*/ 118149 h 1330239"/>
                    <a:gd name="connsiteX3" fmla="*/ 357017 w 3658178"/>
                    <a:gd name="connsiteY3" fmla="*/ 105449 h 1330239"/>
                    <a:gd name="connsiteX4" fmla="*/ 1417 w 3658178"/>
                    <a:gd name="connsiteY4" fmla="*/ 791249 h 1330239"/>
                    <a:gd name="connsiteX5" fmla="*/ 407817 w 3658178"/>
                    <a:gd name="connsiteY5" fmla="*/ 1223049 h 1330239"/>
                    <a:gd name="connsiteX0" fmla="*/ 407817 w 3658178"/>
                    <a:gd name="connsiteY0" fmla="*/ 1223049 h 1330239"/>
                    <a:gd name="connsiteX1" fmla="*/ 3595517 w 3658178"/>
                    <a:gd name="connsiteY1" fmla="*/ 1210349 h 1330239"/>
                    <a:gd name="connsiteX2" fmla="*/ 2071517 w 3658178"/>
                    <a:gd name="connsiteY2" fmla="*/ 118149 h 1330239"/>
                    <a:gd name="connsiteX3" fmla="*/ 357017 w 3658178"/>
                    <a:gd name="connsiteY3" fmla="*/ 105449 h 1330239"/>
                    <a:gd name="connsiteX4" fmla="*/ 1417 w 3658178"/>
                    <a:gd name="connsiteY4" fmla="*/ 791249 h 1330239"/>
                    <a:gd name="connsiteX5" fmla="*/ 407817 w 3658178"/>
                    <a:gd name="connsiteY5" fmla="*/ 1223049 h 1330239"/>
                    <a:gd name="connsiteX0" fmla="*/ 425312 w 3675673"/>
                    <a:gd name="connsiteY0" fmla="*/ 1223049 h 1330239"/>
                    <a:gd name="connsiteX1" fmla="*/ 3613012 w 3675673"/>
                    <a:gd name="connsiteY1" fmla="*/ 1210349 h 1330239"/>
                    <a:gd name="connsiteX2" fmla="*/ 2089012 w 3675673"/>
                    <a:gd name="connsiteY2" fmla="*/ 118149 h 1330239"/>
                    <a:gd name="connsiteX3" fmla="*/ 374512 w 3675673"/>
                    <a:gd name="connsiteY3" fmla="*/ 105449 h 1330239"/>
                    <a:gd name="connsiteX4" fmla="*/ 18912 w 3675673"/>
                    <a:gd name="connsiteY4" fmla="*/ 791249 h 1330239"/>
                    <a:gd name="connsiteX5" fmla="*/ 425312 w 3675673"/>
                    <a:gd name="connsiteY5" fmla="*/ 1223049 h 133023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3675673" h="1330239">
                      <a:moveTo>
                        <a:pt x="425312" y="1223049"/>
                      </a:moveTo>
                      <a:cubicBezTo>
                        <a:pt x="560779" y="1366982"/>
                        <a:pt x="3244712" y="1369099"/>
                        <a:pt x="3613012" y="1210349"/>
                      </a:cubicBezTo>
                      <a:cubicBezTo>
                        <a:pt x="3981312" y="1051599"/>
                        <a:pt x="2628762" y="302299"/>
                        <a:pt x="2089012" y="118149"/>
                      </a:cubicBezTo>
                      <a:cubicBezTo>
                        <a:pt x="1549262" y="-66001"/>
                        <a:pt x="719529" y="-6734"/>
                        <a:pt x="374512" y="105449"/>
                      </a:cubicBezTo>
                      <a:cubicBezTo>
                        <a:pt x="29495" y="217632"/>
                        <a:pt x="-40355" y="579582"/>
                        <a:pt x="18912" y="791249"/>
                      </a:cubicBezTo>
                      <a:cubicBezTo>
                        <a:pt x="78179" y="1002916"/>
                        <a:pt x="289845" y="1079116"/>
                        <a:pt x="425312" y="1223049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n>
                      <a:solidFill>
                        <a:sysClr val="windowText" lastClr="000000"/>
                      </a:solidFill>
                    </a:ln>
                    <a:solidFill>
                      <a:sysClr val="windowText" lastClr="000000"/>
                    </a:solidFill>
                  </a:endParaRPr>
                </a:p>
              </p:txBody>
            </p:sp>
            <p:sp>
              <p:nvSpPr>
                <p:cNvPr id="142" name="Isosceles Triangle 2">
                  <a:extLst>
                    <a:ext uri="{FF2B5EF4-FFF2-40B4-BE49-F238E27FC236}">
                      <a16:creationId xmlns:a16="http://schemas.microsoft.com/office/drawing/2014/main" id="{F3FB4785-54BF-1612-9A36-76F2DF16328E}"/>
                    </a:ext>
                  </a:extLst>
                </p:cNvPr>
                <p:cNvSpPr/>
                <p:nvPr/>
              </p:nvSpPr>
              <p:spPr>
                <a:xfrm rot="20837633">
                  <a:off x="3809601" y="2427799"/>
                  <a:ext cx="763743" cy="774288"/>
                </a:xfrm>
                <a:custGeom>
                  <a:avLst/>
                  <a:gdLst>
                    <a:gd name="connsiteX0" fmla="*/ 0 w 1060704"/>
                    <a:gd name="connsiteY0" fmla="*/ 914400 h 914400"/>
                    <a:gd name="connsiteX1" fmla="*/ 530352 w 1060704"/>
                    <a:gd name="connsiteY1" fmla="*/ 0 h 914400"/>
                    <a:gd name="connsiteX2" fmla="*/ 1060704 w 1060704"/>
                    <a:gd name="connsiteY2" fmla="*/ 914400 h 914400"/>
                    <a:gd name="connsiteX3" fmla="*/ 0 w 1060704"/>
                    <a:gd name="connsiteY3" fmla="*/ 914400 h 914400"/>
                    <a:gd name="connsiteX0" fmla="*/ 0 w 1072262"/>
                    <a:gd name="connsiteY0" fmla="*/ 914400 h 914400"/>
                    <a:gd name="connsiteX1" fmla="*/ 530352 w 1072262"/>
                    <a:gd name="connsiteY1" fmla="*/ 0 h 914400"/>
                    <a:gd name="connsiteX2" fmla="*/ 1060704 w 1072262"/>
                    <a:gd name="connsiteY2" fmla="*/ 914400 h 914400"/>
                    <a:gd name="connsiteX3" fmla="*/ 0 w 1072262"/>
                    <a:gd name="connsiteY3" fmla="*/ 914400 h 914400"/>
                    <a:gd name="connsiteX0" fmla="*/ 11558 w 1083820"/>
                    <a:gd name="connsiteY0" fmla="*/ 914400 h 914400"/>
                    <a:gd name="connsiteX1" fmla="*/ 541910 w 1083820"/>
                    <a:gd name="connsiteY1" fmla="*/ 0 h 914400"/>
                    <a:gd name="connsiteX2" fmla="*/ 1072262 w 1083820"/>
                    <a:gd name="connsiteY2" fmla="*/ 914400 h 914400"/>
                    <a:gd name="connsiteX3" fmla="*/ 11558 w 1083820"/>
                    <a:gd name="connsiteY3" fmla="*/ 914400 h 91440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32873 w 752471"/>
                    <a:gd name="connsiteY0" fmla="*/ 774700 h 969970"/>
                    <a:gd name="connsiteX1" fmla="*/ 220325 w 752471"/>
                    <a:gd name="connsiteY1" fmla="*/ 0 h 969970"/>
                    <a:gd name="connsiteX2" fmla="*/ 750677 w 752471"/>
                    <a:gd name="connsiteY2" fmla="*/ 914400 h 969970"/>
                    <a:gd name="connsiteX3" fmla="*/ 32873 w 752471"/>
                    <a:gd name="connsiteY3" fmla="*/ 774700 h 969970"/>
                    <a:gd name="connsiteX0" fmla="*/ 83351 w 804599"/>
                    <a:gd name="connsiteY0" fmla="*/ 774849 h 970119"/>
                    <a:gd name="connsiteX1" fmla="*/ 270803 w 804599"/>
                    <a:gd name="connsiteY1" fmla="*/ 149 h 970119"/>
                    <a:gd name="connsiteX2" fmla="*/ 801155 w 804599"/>
                    <a:gd name="connsiteY2" fmla="*/ 914549 h 970119"/>
                    <a:gd name="connsiteX3" fmla="*/ 83351 w 804599"/>
                    <a:gd name="connsiteY3" fmla="*/ 774849 h 970119"/>
                    <a:gd name="connsiteX0" fmla="*/ 18984 w 763743"/>
                    <a:gd name="connsiteY0" fmla="*/ 597084 h 774288"/>
                    <a:gd name="connsiteX1" fmla="*/ 396936 w 763743"/>
                    <a:gd name="connsiteY1" fmla="*/ 184 h 774288"/>
                    <a:gd name="connsiteX2" fmla="*/ 736788 w 763743"/>
                    <a:gd name="connsiteY2" fmla="*/ 736784 h 774288"/>
                    <a:gd name="connsiteX3" fmla="*/ 18984 w 763743"/>
                    <a:gd name="connsiteY3" fmla="*/ 597084 h 7742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63743" h="774288">
                      <a:moveTo>
                        <a:pt x="18984" y="597084"/>
                      </a:moveTo>
                      <a:cubicBezTo>
                        <a:pt x="-37658" y="474317"/>
                        <a:pt x="16952" y="12884"/>
                        <a:pt x="396936" y="184"/>
                      </a:cubicBezTo>
                      <a:cubicBezTo>
                        <a:pt x="776920" y="-12516"/>
                        <a:pt x="799780" y="637301"/>
                        <a:pt x="736788" y="736784"/>
                      </a:cubicBezTo>
                      <a:cubicBezTo>
                        <a:pt x="673796" y="836267"/>
                        <a:pt x="75626" y="719851"/>
                        <a:pt x="18984" y="597084"/>
                      </a:cubicBez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43" name="Oval 142">
                  <a:extLst>
                    <a:ext uri="{FF2B5EF4-FFF2-40B4-BE49-F238E27FC236}">
                      <a16:creationId xmlns:a16="http://schemas.microsoft.com/office/drawing/2014/main" id="{A5D15D85-D4A2-7A89-C4BB-F5BF5C6D3460}"/>
                    </a:ext>
                  </a:extLst>
                </p:cNvPr>
                <p:cNvSpPr/>
                <p:nvPr/>
              </p:nvSpPr>
              <p:spPr>
                <a:xfrm>
                  <a:off x="4725344" y="3140587"/>
                  <a:ext cx="304800" cy="272026"/>
                </a:xfrm>
                <a:prstGeom prst="ellipse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44" name="Freeform 5">
                  <a:extLst>
                    <a:ext uri="{FF2B5EF4-FFF2-40B4-BE49-F238E27FC236}">
                      <a16:creationId xmlns:a16="http://schemas.microsoft.com/office/drawing/2014/main" id="{6C1CC7F7-1CD8-ADD7-32C3-2160F39737FB}"/>
                    </a:ext>
                  </a:extLst>
                </p:cNvPr>
                <p:cNvSpPr/>
                <p:nvPr/>
              </p:nvSpPr>
              <p:spPr>
                <a:xfrm>
                  <a:off x="1397000" y="2793999"/>
                  <a:ext cx="2011119" cy="1284801"/>
                </a:xfrm>
                <a:custGeom>
                  <a:avLst/>
                  <a:gdLst>
                    <a:gd name="connsiteX0" fmla="*/ 292672 w 2007172"/>
                    <a:gd name="connsiteY0" fmla="*/ 152400 h 1282700"/>
                    <a:gd name="connsiteX1" fmla="*/ 191072 w 2007172"/>
                    <a:gd name="connsiteY1" fmla="*/ 292100 h 1282700"/>
                    <a:gd name="connsiteX2" fmla="*/ 127572 w 2007172"/>
                    <a:gd name="connsiteY2" fmla="*/ 622300 h 1282700"/>
                    <a:gd name="connsiteX3" fmla="*/ 241872 w 2007172"/>
                    <a:gd name="connsiteY3" fmla="*/ 825500 h 1282700"/>
                    <a:gd name="connsiteX4" fmla="*/ 470472 w 2007172"/>
                    <a:gd name="connsiteY4" fmla="*/ 1041400 h 1282700"/>
                    <a:gd name="connsiteX5" fmla="*/ 851472 w 2007172"/>
                    <a:gd name="connsiteY5" fmla="*/ 1143000 h 1282700"/>
                    <a:gd name="connsiteX6" fmla="*/ 1168972 w 2007172"/>
                    <a:gd name="connsiteY6" fmla="*/ 1155700 h 1282700"/>
                    <a:gd name="connsiteX7" fmla="*/ 1588072 w 2007172"/>
                    <a:gd name="connsiteY7" fmla="*/ 1130300 h 1282700"/>
                    <a:gd name="connsiteX8" fmla="*/ 2007172 w 2007172"/>
                    <a:gd name="connsiteY8" fmla="*/ 1028700 h 1282700"/>
                    <a:gd name="connsiteX9" fmla="*/ 1778572 w 2007172"/>
                    <a:gd name="connsiteY9" fmla="*/ 1206500 h 1282700"/>
                    <a:gd name="connsiteX10" fmla="*/ 1295972 w 2007172"/>
                    <a:gd name="connsiteY10" fmla="*/ 1270000 h 1282700"/>
                    <a:gd name="connsiteX11" fmla="*/ 991172 w 2007172"/>
                    <a:gd name="connsiteY11" fmla="*/ 1282700 h 1282700"/>
                    <a:gd name="connsiteX12" fmla="*/ 584772 w 2007172"/>
                    <a:gd name="connsiteY12" fmla="*/ 1270000 h 1282700"/>
                    <a:gd name="connsiteX13" fmla="*/ 292672 w 2007172"/>
                    <a:gd name="connsiteY13" fmla="*/ 1104900 h 1282700"/>
                    <a:gd name="connsiteX14" fmla="*/ 102172 w 2007172"/>
                    <a:gd name="connsiteY14" fmla="*/ 889000 h 1282700"/>
                    <a:gd name="connsiteX15" fmla="*/ 13272 w 2007172"/>
                    <a:gd name="connsiteY15" fmla="*/ 660400 h 1282700"/>
                    <a:gd name="connsiteX16" fmla="*/ 572 w 2007172"/>
                    <a:gd name="connsiteY16" fmla="*/ 419100 h 1282700"/>
                    <a:gd name="connsiteX17" fmla="*/ 572 w 2007172"/>
                    <a:gd name="connsiteY17" fmla="*/ 419100 h 1282700"/>
                    <a:gd name="connsiteX18" fmla="*/ 89472 w 2007172"/>
                    <a:gd name="connsiteY18" fmla="*/ 139700 h 1282700"/>
                    <a:gd name="connsiteX19" fmla="*/ 279972 w 2007172"/>
                    <a:gd name="connsiteY19" fmla="*/ 0 h 1282700"/>
                    <a:gd name="connsiteX20" fmla="*/ 356172 w 2007172"/>
                    <a:gd name="connsiteY20" fmla="*/ 0 h 1282700"/>
                    <a:gd name="connsiteX21" fmla="*/ 356172 w 2007172"/>
                    <a:gd name="connsiteY21" fmla="*/ 152400 h 1282700"/>
                    <a:gd name="connsiteX22" fmla="*/ 356172 w 2007172"/>
                    <a:gd name="connsiteY22" fmla="*/ 152400 h 1282700"/>
                    <a:gd name="connsiteX23" fmla="*/ 292672 w 2007172"/>
                    <a:gd name="connsiteY23" fmla="*/ 152400 h 1282700"/>
                    <a:gd name="connsiteX0" fmla="*/ 292672 w 2007172"/>
                    <a:gd name="connsiteY0" fmla="*/ 152400 h 1282700"/>
                    <a:gd name="connsiteX1" fmla="*/ 191072 w 2007172"/>
                    <a:gd name="connsiteY1" fmla="*/ 292100 h 1282700"/>
                    <a:gd name="connsiteX2" fmla="*/ 127572 w 2007172"/>
                    <a:gd name="connsiteY2" fmla="*/ 622300 h 1282700"/>
                    <a:gd name="connsiteX3" fmla="*/ 241872 w 2007172"/>
                    <a:gd name="connsiteY3" fmla="*/ 825500 h 1282700"/>
                    <a:gd name="connsiteX4" fmla="*/ 470472 w 2007172"/>
                    <a:gd name="connsiteY4" fmla="*/ 1041400 h 1282700"/>
                    <a:gd name="connsiteX5" fmla="*/ 851472 w 2007172"/>
                    <a:gd name="connsiteY5" fmla="*/ 1143000 h 1282700"/>
                    <a:gd name="connsiteX6" fmla="*/ 1168972 w 2007172"/>
                    <a:gd name="connsiteY6" fmla="*/ 1155700 h 1282700"/>
                    <a:gd name="connsiteX7" fmla="*/ 1588072 w 2007172"/>
                    <a:gd name="connsiteY7" fmla="*/ 1130300 h 1282700"/>
                    <a:gd name="connsiteX8" fmla="*/ 2007172 w 2007172"/>
                    <a:gd name="connsiteY8" fmla="*/ 1028700 h 1282700"/>
                    <a:gd name="connsiteX9" fmla="*/ 1778572 w 2007172"/>
                    <a:gd name="connsiteY9" fmla="*/ 1206500 h 1282700"/>
                    <a:gd name="connsiteX10" fmla="*/ 1295972 w 2007172"/>
                    <a:gd name="connsiteY10" fmla="*/ 1270000 h 1282700"/>
                    <a:gd name="connsiteX11" fmla="*/ 991172 w 2007172"/>
                    <a:gd name="connsiteY11" fmla="*/ 1282700 h 1282700"/>
                    <a:gd name="connsiteX12" fmla="*/ 584772 w 2007172"/>
                    <a:gd name="connsiteY12" fmla="*/ 1270000 h 1282700"/>
                    <a:gd name="connsiteX13" fmla="*/ 292672 w 2007172"/>
                    <a:gd name="connsiteY13" fmla="*/ 1104900 h 1282700"/>
                    <a:gd name="connsiteX14" fmla="*/ 102172 w 2007172"/>
                    <a:gd name="connsiteY14" fmla="*/ 889000 h 1282700"/>
                    <a:gd name="connsiteX15" fmla="*/ 13272 w 2007172"/>
                    <a:gd name="connsiteY15" fmla="*/ 660400 h 1282700"/>
                    <a:gd name="connsiteX16" fmla="*/ 572 w 2007172"/>
                    <a:gd name="connsiteY16" fmla="*/ 419100 h 1282700"/>
                    <a:gd name="connsiteX17" fmla="*/ 572 w 2007172"/>
                    <a:gd name="connsiteY17" fmla="*/ 419100 h 1282700"/>
                    <a:gd name="connsiteX18" fmla="*/ 89472 w 2007172"/>
                    <a:gd name="connsiteY18" fmla="*/ 139700 h 1282700"/>
                    <a:gd name="connsiteX19" fmla="*/ 279972 w 2007172"/>
                    <a:gd name="connsiteY19" fmla="*/ 0 h 1282700"/>
                    <a:gd name="connsiteX20" fmla="*/ 356172 w 2007172"/>
                    <a:gd name="connsiteY20" fmla="*/ 0 h 1282700"/>
                    <a:gd name="connsiteX21" fmla="*/ 356172 w 2007172"/>
                    <a:gd name="connsiteY21" fmla="*/ 152400 h 1282700"/>
                    <a:gd name="connsiteX22" fmla="*/ 356172 w 2007172"/>
                    <a:gd name="connsiteY22" fmla="*/ 152400 h 1282700"/>
                    <a:gd name="connsiteX23" fmla="*/ 292672 w 2007172"/>
                    <a:gd name="connsiteY23" fmla="*/ 152400 h 1282700"/>
                    <a:gd name="connsiteX0" fmla="*/ 292672 w 2007172"/>
                    <a:gd name="connsiteY0" fmla="*/ 152400 h 1282700"/>
                    <a:gd name="connsiteX1" fmla="*/ 191072 w 2007172"/>
                    <a:gd name="connsiteY1" fmla="*/ 292100 h 1282700"/>
                    <a:gd name="connsiteX2" fmla="*/ 127572 w 2007172"/>
                    <a:gd name="connsiteY2" fmla="*/ 622300 h 1282700"/>
                    <a:gd name="connsiteX3" fmla="*/ 241872 w 2007172"/>
                    <a:gd name="connsiteY3" fmla="*/ 825500 h 1282700"/>
                    <a:gd name="connsiteX4" fmla="*/ 470472 w 2007172"/>
                    <a:gd name="connsiteY4" fmla="*/ 1041400 h 1282700"/>
                    <a:gd name="connsiteX5" fmla="*/ 851472 w 2007172"/>
                    <a:gd name="connsiteY5" fmla="*/ 1143000 h 1282700"/>
                    <a:gd name="connsiteX6" fmla="*/ 1168972 w 2007172"/>
                    <a:gd name="connsiteY6" fmla="*/ 1155700 h 1282700"/>
                    <a:gd name="connsiteX7" fmla="*/ 1588072 w 2007172"/>
                    <a:gd name="connsiteY7" fmla="*/ 1130300 h 1282700"/>
                    <a:gd name="connsiteX8" fmla="*/ 2007172 w 2007172"/>
                    <a:gd name="connsiteY8" fmla="*/ 1028700 h 1282700"/>
                    <a:gd name="connsiteX9" fmla="*/ 1778572 w 2007172"/>
                    <a:gd name="connsiteY9" fmla="*/ 1206500 h 1282700"/>
                    <a:gd name="connsiteX10" fmla="*/ 1295972 w 2007172"/>
                    <a:gd name="connsiteY10" fmla="*/ 1270000 h 1282700"/>
                    <a:gd name="connsiteX11" fmla="*/ 991172 w 2007172"/>
                    <a:gd name="connsiteY11" fmla="*/ 1282700 h 1282700"/>
                    <a:gd name="connsiteX12" fmla="*/ 584772 w 2007172"/>
                    <a:gd name="connsiteY12" fmla="*/ 1270000 h 1282700"/>
                    <a:gd name="connsiteX13" fmla="*/ 292672 w 2007172"/>
                    <a:gd name="connsiteY13" fmla="*/ 1104900 h 1282700"/>
                    <a:gd name="connsiteX14" fmla="*/ 102172 w 2007172"/>
                    <a:gd name="connsiteY14" fmla="*/ 889000 h 1282700"/>
                    <a:gd name="connsiteX15" fmla="*/ 13272 w 2007172"/>
                    <a:gd name="connsiteY15" fmla="*/ 660400 h 1282700"/>
                    <a:gd name="connsiteX16" fmla="*/ 572 w 2007172"/>
                    <a:gd name="connsiteY16" fmla="*/ 419100 h 1282700"/>
                    <a:gd name="connsiteX17" fmla="*/ 572 w 2007172"/>
                    <a:gd name="connsiteY17" fmla="*/ 419100 h 1282700"/>
                    <a:gd name="connsiteX18" fmla="*/ 89472 w 2007172"/>
                    <a:gd name="connsiteY18" fmla="*/ 139700 h 1282700"/>
                    <a:gd name="connsiteX19" fmla="*/ 279972 w 2007172"/>
                    <a:gd name="connsiteY19" fmla="*/ 0 h 1282700"/>
                    <a:gd name="connsiteX20" fmla="*/ 356172 w 2007172"/>
                    <a:gd name="connsiteY20" fmla="*/ 0 h 1282700"/>
                    <a:gd name="connsiteX21" fmla="*/ 356172 w 2007172"/>
                    <a:gd name="connsiteY21" fmla="*/ 152400 h 1282700"/>
                    <a:gd name="connsiteX22" fmla="*/ 356172 w 2007172"/>
                    <a:gd name="connsiteY22" fmla="*/ 152400 h 1282700"/>
                    <a:gd name="connsiteX23" fmla="*/ 292672 w 2007172"/>
                    <a:gd name="connsiteY23" fmla="*/ 152400 h 1282700"/>
                    <a:gd name="connsiteX0" fmla="*/ 292100 w 2006600"/>
                    <a:gd name="connsiteY0" fmla="*/ 152400 h 1282700"/>
                    <a:gd name="connsiteX1" fmla="*/ 190500 w 2006600"/>
                    <a:gd name="connsiteY1" fmla="*/ 292100 h 1282700"/>
                    <a:gd name="connsiteX2" fmla="*/ 127000 w 2006600"/>
                    <a:gd name="connsiteY2" fmla="*/ 622300 h 1282700"/>
                    <a:gd name="connsiteX3" fmla="*/ 241300 w 2006600"/>
                    <a:gd name="connsiteY3" fmla="*/ 825500 h 1282700"/>
                    <a:gd name="connsiteX4" fmla="*/ 469900 w 2006600"/>
                    <a:gd name="connsiteY4" fmla="*/ 1041400 h 1282700"/>
                    <a:gd name="connsiteX5" fmla="*/ 850900 w 2006600"/>
                    <a:gd name="connsiteY5" fmla="*/ 1143000 h 1282700"/>
                    <a:gd name="connsiteX6" fmla="*/ 1168400 w 2006600"/>
                    <a:gd name="connsiteY6" fmla="*/ 1155700 h 1282700"/>
                    <a:gd name="connsiteX7" fmla="*/ 1587500 w 2006600"/>
                    <a:gd name="connsiteY7" fmla="*/ 1130300 h 1282700"/>
                    <a:gd name="connsiteX8" fmla="*/ 2006600 w 2006600"/>
                    <a:gd name="connsiteY8" fmla="*/ 1028700 h 1282700"/>
                    <a:gd name="connsiteX9" fmla="*/ 1778000 w 2006600"/>
                    <a:gd name="connsiteY9" fmla="*/ 1206500 h 1282700"/>
                    <a:gd name="connsiteX10" fmla="*/ 1295400 w 2006600"/>
                    <a:gd name="connsiteY10" fmla="*/ 1270000 h 1282700"/>
                    <a:gd name="connsiteX11" fmla="*/ 990600 w 2006600"/>
                    <a:gd name="connsiteY11" fmla="*/ 1282700 h 1282700"/>
                    <a:gd name="connsiteX12" fmla="*/ 584200 w 2006600"/>
                    <a:gd name="connsiteY12" fmla="*/ 1270000 h 1282700"/>
                    <a:gd name="connsiteX13" fmla="*/ 292100 w 2006600"/>
                    <a:gd name="connsiteY13" fmla="*/ 1104900 h 1282700"/>
                    <a:gd name="connsiteX14" fmla="*/ 101600 w 2006600"/>
                    <a:gd name="connsiteY14" fmla="*/ 889000 h 1282700"/>
                    <a:gd name="connsiteX15" fmla="*/ 12700 w 2006600"/>
                    <a:gd name="connsiteY15" fmla="*/ 660400 h 1282700"/>
                    <a:gd name="connsiteX16" fmla="*/ 0 w 2006600"/>
                    <a:gd name="connsiteY16" fmla="*/ 419100 h 1282700"/>
                    <a:gd name="connsiteX17" fmla="*/ 0 w 2006600"/>
                    <a:gd name="connsiteY17" fmla="*/ 419100 h 1282700"/>
                    <a:gd name="connsiteX18" fmla="*/ 88900 w 2006600"/>
                    <a:gd name="connsiteY18" fmla="*/ 139700 h 1282700"/>
                    <a:gd name="connsiteX19" fmla="*/ 279400 w 2006600"/>
                    <a:gd name="connsiteY19" fmla="*/ 0 h 1282700"/>
                    <a:gd name="connsiteX20" fmla="*/ 355600 w 2006600"/>
                    <a:gd name="connsiteY20" fmla="*/ 0 h 1282700"/>
                    <a:gd name="connsiteX21" fmla="*/ 355600 w 2006600"/>
                    <a:gd name="connsiteY21" fmla="*/ 152400 h 1282700"/>
                    <a:gd name="connsiteX22" fmla="*/ 355600 w 2006600"/>
                    <a:gd name="connsiteY22" fmla="*/ 152400 h 1282700"/>
                    <a:gd name="connsiteX23" fmla="*/ 292100 w 2006600"/>
                    <a:gd name="connsiteY23" fmla="*/ 152400 h 1282700"/>
                    <a:gd name="connsiteX0" fmla="*/ 292100 w 2006600"/>
                    <a:gd name="connsiteY0" fmla="*/ 152400 h 1282700"/>
                    <a:gd name="connsiteX1" fmla="*/ 190500 w 2006600"/>
                    <a:gd name="connsiteY1" fmla="*/ 292100 h 1282700"/>
                    <a:gd name="connsiteX2" fmla="*/ 127000 w 2006600"/>
                    <a:gd name="connsiteY2" fmla="*/ 622300 h 1282700"/>
                    <a:gd name="connsiteX3" fmla="*/ 241300 w 2006600"/>
                    <a:gd name="connsiteY3" fmla="*/ 825500 h 1282700"/>
                    <a:gd name="connsiteX4" fmla="*/ 469900 w 2006600"/>
                    <a:gd name="connsiteY4" fmla="*/ 1041400 h 1282700"/>
                    <a:gd name="connsiteX5" fmla="*/ 850900 w 2006600"/>
                    <a:gd name="connsiteY5" fmla="*/ 1143000 h 1282700"/>
                    <a:gd name="connsiteX6" fmla="*/ 1168400 w 2006600"/>
                    <a:gd name="connsiteY6" fmla="*/ 1155700 h 1282700"/>
                    <a:gd name="connsiteX7" fmla="*/ 1587500 w 2006600"/>
                    <a:gd name="connsiteY7" fmla="*/ 1130300 h 1282700"/>
                    <a:gd name="connsiteX8" fmla="*/ 2006600 w 2006600"/>
                    <a:gd name="connsiteY8" fmla="*/ 1028700 h 1282700"/>
                    <a:gd name="connsiteX9" fmla="*/ 1778000 w 2006600"/>
                    <a:gd name="connsiteY9" fmla="*/ 1206500 h 1282700"/>
                    <a:gd name="connsiteX10" fmla="*/ 1295400 w 2006600"/>
                    <a:gd name="connsiteY10" fmla="*/ 1270000 h 1282700"/>
                    <a:gd name="connsiteX11" fmla="*/ 990600 w 2006600"/>
                    <a:gd name="connsiteY11" fmla="*/ 1282700 h 1282700"/>
                    <a:gd name="connsiteX12" fmla="*/ 584200 w 2006600"/>
                    <a:gd name="connsiteY12" fmla="*/ 1270000 h 1282700"/>
                    <a:gd name="connsiteX13" fmla="*/ 292100 w 2006600"/>
                    <a:gd name="connsiteY13" fmla="*/ 1104900 h 1282700"/>
                    <a:gd name="connsiteX14" fmla="*/ 101600 w 2006600"/>
                    <a:gd name="connsiteY14" fmla="*/ 889000 h 1282700"/>
                    <a:gd name="connsiteX15" fmla="*/ 12700 w 2006600"/>
                    <a:gd name="connsiteY15" fmla="*/ 660400 h 1282700"/>
                    <a:gd name="connsiteX16" fmla="*/ 0 w 2006600"/>
                    <a:gd name="connsiteY16" fmla="*/ 419100 h 1282700"/>
                    <a:gd name="connsiteX17" fmla="*/ 0 w 2006600"/>
                    <a:gd name="connsiteY17" fmla="*/ 419100 h 1282700"/>
                    <a:gd name="connsiteX18" fmla="*/ 88900 w 2006600"/>
                    <a:gd name="connsiteY18" fmla="*/ 139700 h 1282700"/>
                    <a:gd name="connsiteX19" fmla="*/ 279400 w 2006600"/>
                    <a:gd name="connsiteY19" fmla="*/ 0 h 1282700"/>
                    <a:gd name="connsiteX20" fmla="*/ 355600 w 2006600"/>
                    <a:gd name="connsiteY20" fmla="*/ 0 h 1282700"/>
                    <a:gd name="connsiteX21" fmla="*/ 355600 w 2006600"/>
                    <a:gd name="connsiteY21" fmla="*/ 152400 h 1282700"/>
                    <a:gd name="connsiteX22" fmla="*/ 355600 w 2006600"/>
                    <a:gd name="connsiteY22" fmla="*/ 152400 h 1282700"/>
                    <a:gd name="connsiteX23" fmla="*/ 292100 w 2006600"/>
                    <a:gd name="connsiteY23" fmla="*/ 152400 h 1282700"/>
                    <a:gd name="connsiteX0" fmla="*/ 292100 w 2006600"/>
                    <a:gd name="connsiteY0" fmla="*/ 152400 h 1282700"/>
                    <a:gd name="connsiteX1" fmla="*/ 190500 w 2006600"/>
                    <a:gd name="connsiteY1" fmla="*/ 292100 h 1282700"/>
                    <a:gd name="connsiteX2" fmla="*/ 127000 w 2006600"/>
                    <a:gd name="connsiteY2" fmla="*/ 622300 h 1282700"/>
                    <a:gd name="connsiteX3" fmla="*/ 241300 w 2006600"/>
                    <a:gd name="connsiteY3" fmla="*/ 825500 h 1282700"/>
                    <a:gd name="connsiteX4" fmla="*/ 469900 w 2006600"/>
                    <a:gd name="connsiteY4" fmla="*/ 1041400 h 1282700"/>
                    <a:gd name="connsiteX5" fmla="*/ 850900 w 2006600"/>
                    <a:gd name="connsiteY5" fmla="*/ 1143000 h 1282700"/>
                    <a:gd name="connsiteX6" fmla="*/ 1168400 w 2006600"/>
                    <a:gd name="connsiteY6" fmla="*/ 1155700 h 1282700"/>
                    <a:gd name="connsiteX7" fmla="*/ 1587500 w 2006600"/>
                    <a:gd name="connsiteY7" fmla="*/ 1130300 h 1282700"/>
                    <a:gd name="connsiteX8" fmla="*/ 2006600 w 2006600"/>
                    <a:gd name="connsiteY8" fmla="*/ 1028700 h 1282700"/>
                    <a:gd name="connsiteX9" fmla="*/ 1778000 w 2006600"/>
                    <a:gd name="connsiteY9" fmla="*/ 1206500 h 1282700"/>
                    <a:gd name="connsiteX10" fmla="*/ 1295400 w 2006600"/>
                    <a:gd name="connsiteY10" fmla="*/ 1270000 h 1282700"/>
                    <a:gd name="connsiteX11" fmla="*/ 990600 w 2006600"/>
                    <a:gd name="connsiteY11" fmla="*/ 1282700 h 1282700"/>
                    <a:gd name="connsiteX12" fmla="*/ 584200 w 2006600"/>
                    <a:gd name="connsiteY12" fmla="*/ 1270000 h 1282700"/>
                    <a:gd name="connsiteX13" fmla="*/ 292100 w 2006600"/>
                    <a:gd name="connsiteY13" fmla="*/ 1104900 h 1282700"/>
                    <a:gd name="connsiteX14" fmla="*/ 101600 w 2006600"/>
                    <a:gd name="connsiteY14" fmla="*/ 889000 h 1282700"/>
                    <a:gd name="connsiteX15" fmla="*/ 12700 w 2006600"/>
                    <a:gd name="connsiteY15" fmla="*/ 660400 h 1282700"/>
                    <a:gd name="connsiteX16" fmla="*/ 0 w 2006600"/>
                    <a:gd name="connsiteY16" fmla="*/ 419100 h 1282700"/>
                    <a:gd name="connsiteX17" fmla="*/ 0 w 2006600"/>
                    <a:gd name="connsiteY17" fmla="*/ 419100 h 1282700"/>
                    <a:gd name="connsiteX18" fmla="*/ 88900 w 2006600"/>
                    <a:gd name="connsiteY18" fmla="*/ 139700 h 1282700"/>
                    <a:gd name="connsiteX19" fmla="*/ 279400 w 2006600"/>
                    <a:gd name="connsiteY19" fmla="*/ 0 h 1282700"/>
                    <a:gd name="connsiteX20" fmla="*/ 355600 w 2006600"/>
                    <a:gd name="connsiteY20" fmla="*/ 0 h 1282700"/>
                    <a:gd name="connsiteX21" fmla="*/ 355600 w 2006600"/>
                    <a:gd name="connsiteY21" fmla="*/ 152400 h 1282700"/>
                    <a:gd name="connsiteX22" fmla="*/ 355600 w 2006600"/>
                    <a:gd name="connsiteY22" fmla="*/ 152400 h 1282700"/>
                    <a:gd name="connsiteX23" fmla="*/ 292100 w 2006600"/>
                    <a:gd name="connsiteY23" fmla="*/ 152400 h 1282700"/>
                    <a:gd name="connsiteX0" fmla="*/ 292100 w 2006600"/>
                    <a:gd name="connsiteY0" fmla="*/ 152400 h 1287516"/>
                    <a:gd name="connsiteX1" fmla="*/ 190500 w 2006600"/>
                    <a:gd name="connsiteY1" fmla="*/ 292100 h 1287516"/>
                    <a:gd name="connsiteX2" fmla="*/ 127000 w 2006600"/>
                    <a:gd name="connsiteY2" fmla="*/ 622300 h 1287516"/>
                    <a:gd name="connsiteX3" fmla="*/ 241300 w 2006600"/>
                    <a:gd name="connsiteY3" fmla="*/ 825500 h 1287516"/>
                    <a:gd name="connsiteX4" fmla="*/ 469900 w 2006600"/>
                    <a:gd name="connsiteY4" fmla="*/ 1041400 h 1287516"/>
                    <a:gd name="connsiteX5" fmla="*/ 850900 w 2006600"/>
                    <a:gd name="connsiteY5" fmla="*/ 1143000 h 1287516"/>
                    <a:gd name="connsiteX6" fmla="*/ 1168400 w 2006600"/>
                    <a:gd name="connsiteY6" fmla="*/ 1155700 h 1287516"/>
                    <a:gd name="connsiteX7" fmla="*/ 1587500 w 2006600"/>
                    <a:gd name="connsiteY7" fmla="*/ 1130300 h 1287516"/>
                    <a:gd name="connsiteX8" fmla="*/ 2006600 w 2006600"/>
                    <a:gd name="connsiteY8" fmla="*/ 1028700 h 1287516"/>
                    <a:gd name="connsiteX9" fmla="*/ 1778000 w 2006600"/>
                    <a:gd name="connsiteY9" fmla="*/ 1206500 h 1287516"/>
                    <a:gd name="connsiteX10" fmla="*/ 1295400 w 2006600"/>
                    <a:gd name="connsiteY10" fmla="*/ 1270000 h 1287516"/>
                    <a:gd name="connsiteX11" fmla="*/ 990600 w 2006600"/>
                    <a:gd name="connsiteY11" fmla="*/ 1282700 h 1287516"/>
                    <a:gd name="connsiteX12" fmla="*/ 584200 w 2006600"/>
                    <a:gd name="connsiteY12" fmla="*/ 1270000 h 1287516"/>
                    <a:gd name="connsiteX13" fmla="*/ 292100 w 2006600"/>
                    <a:gd name="connsiteY13" fmla="*/ 1104900 h 1287516"/>
                    <a:gd name="connsiteX14" fmla="*/ 101600 w 2006600"/>
                    <a:gd name="connsiteY14" fmla="*/ 889000 h 1287516"/>
                    <a:gd name="connsiteX15" fmla="*/ 12700 w 2006600"/>
                    <a:gd name="connsiteY15" fmla="*/ 660400 h 1287516"/>
                    <a:gd name="connsiteX16" fmla="*/ 0 w 2006600"/>
                    <a:gd name="connsiteY16" fmla="*/ 419100 h 1287516"/>
                    <a:gd name="connsiteX17" fmla="*/ 0 w 2006600"/>
                    <a:gd name="connsiteY17" fmla="*/ 419100 h 1287516"/>
                    <a:gd name="connsiteX18" fmla="*/ 88900 w 2006600"/>
                    <a:gd name="connsiteY18" fmla="*/ 139700 h 1287516"/>
                    <a:gd name="connsiteX19" fmla="*/ 279400 w 2006600"/>
                    <a:gd name="connsiteY19" fmla="*/ 0 h 1287516"/>
                    <a:gd name="connsiteX20" fmla="*/ 355600 w 2006600"/>
                    <a:gd name="connsiteY20" fmla="*/ 0 h 1287516"/>
                    <a:gd name="connsiteX21" fmla="*/ 355600 w 2006600"/>
                    <a:gd name="connsiteY21" fmla="*/ 152400 h 1287516"/>
                    <a:gd name="connsiteX22" fmla="*/ 355600 w 2006600"/>
                    <a:gd name="connsiteY22" fmla="*/ 152400 h 1287516"/>
                    <a:gd name="connsiteX23" fmla="*/ 292100 w 2006600"/>
                    <a:gd name="connsiteY23" fmla="*/ 152400 h 1287516"/>
                    <a:gd name="connsiteX0" fmla="*/ 292100 w 2006600"/>
                    <a:gd name="connsiteY0" fmla="*/ 152400 h 1287516"/>
                    <a:gd name="connsiteX1" fmla="*/ 190500 w 2006600"/>
                    <a:gd name="connsiteY1" fmla="*/ 292100 h 1287516"/>
                    <a:gd name="connsiteX2" fmla="*/ 127000 w 2006600"/>
                    <a:gd name="connsiteY2" fmla="*/ 622300 h 1287516"/>
                    <a:gd name="connsiteX3" fmla="*/ 241300 w 2006600"/>
                    <a:gd name="connsiteY3" fmla="*/ 825500 h 1287516"/>
                    <a:gd name="connsiteX4" fmla="*/ 469900 w 2006600"/>
                    <a:gd name="connsiteY4" fmla="*/ 1041400 h 1287516"/>
                    <a:gd name="connsiteX5" fmla="*/ 850900 w 2006600"/>
                    <a:gd name="connsiteY5" fmla="*/ 1143000 h 1287516"/>
                    <a:gd name="connsiteX6" fmla="*/ 1168400 w 2006600"/>
                    <a:gd name="connsiteY6" fmla="*/ 1155700 h 1287516"/>
                    <a:gd name="connsiteX7" fmla="*/ 1587500 w 2006600"/>
                    <a:gd name="connsiteY7" fmla="*/ 1130300 h 1287516"/>
                    <a:gd name="connsiteX8" fmla="*/ 2006600 w 2006600"/>
                    <a:gd name="connsiteY8" fmla="*/ 1028700 h 1287516"/>
                    <a:gd name="connsiteX9" fmla="*/ 1778000 w 2006600"/>
                    <a:gd name="connsiteY9" fmla="*/ 1206500 h 1287516"/>
                    <a:gd name="connsiteX10" fmla="*/ 1295400 w 2006600"/>
                    <a:gd name="connsiteY10" fmla="*/ 1270000 h 1287516"/>
                    <a:gd name="connsiteX11" fmla="*/ 990600 w 2006600"/>
                    <a:gd name="connsiteY11" fmla="*/ 1282700 h 1287516"/>
                    <a:gd name="connsiteX12" fmla="*/ 584200 w 2006600"/>
                    <a:gd name="connsiteY12" fmla="*/ 1270000 h 1287516"/>
                    <a:gd name="connsiteX13" fmla="*/ 292100 w 2006600"/>
                    <a:gd name="connsiteY13" fmla="*/ 1104900 h 1287516"/>
                    <a:gd name="connsiteX14" fmla="*/ 101600 w 2006600"/>
                    <a:gd name="connsiteY14" fmla="*/ 889000 h 1287516"/>
                    <a:gd name="connsiteX15" fmla="*/ 12700 w 2006600"/>
                    <a:gd name="connsiteY15" fmla="*/ 660400 h 1287516"/>
                    <a:gd name="connsiteX16" fmla="*/ 0 w 2006600"/>
                    <a:gd name="connsiteY16" fmla="*/ 419100 h 1287516"/>
                    <a:gd name="connsiteX17" fmla="*/ 0 w 2006600"/>
                    <a:gd name="connsiteY17" fmla="*/ 419100 h 1287516"/>
                    <a:gd name="connsiteX18" fmla="*/ 88900 w 2006600"/>
                    <a:gd name="connsiteY18" fmla="*/ 139700 h 1287516"/>
                    <a:gd name="connsiteX19" fmla="*/ 279400 w 2006600"/>
                    <a:gd name="connsiteY19" fmla="*/ 0 h 1287516"/>
                    <a:gd name="connsiteX20" fmla="*/ 355600 w 2006600"/>
                    <a:gd name="connsiteY20" fmla="*/ 0 h 1287516"/>
                    <a:gd name="connsiteX21" fmla="*/ 355600 w 2006600"/>
                    <a:gd name="connsiteY21" fmla="*/ 152400 h 1287516"/>
                    <a:gd name="connsiteX22" fmla="*/ 355600 w 2006600"/>
                    <a:gd name="connsiteY22" fmla="*/ 152400 h 1287516"/>
                    <a:gd name="connsiteX23" fmla="*/ 292100 w 2006600"/>
                    <a:gd name="connsiteY23" fmla="*/ 152400 h 1287516"/>
                    <a:gd name="connsiteX0" fmla="*/ 292100 w 2006600"/>
                    <a:gd name="connsiteY0" fmla="*/ 152400 h 1287516"/>
                    <a:gd name="connsiteX1" fmla="*/ 190500 w 2006600"/>
                    <a:gd name="connsiteY1" fmla="*/ 292100 h 1287516"/>
                    <a:gd name="connsiteX2" fmla="*/ 127000 w 2006600"/>
                    <a:gd name="connsiteY2" fmla="*/ 622300 h 1287516"/>
                    <a:gd name="connsiteX3" fmla="*/ 241300 w 2006600"/>
                    <a:gd name="connsiteY3" fmla="*/ 825500 h 1287516"/>
                    <a:gd name="connsiteX4" fmla="*/ 469900 w 2006600"/>
                    <a:gd name="connsiteY4" fmla="*/ 1041400 h 1287516"/>
                    <a:gd name="connsiteX5" fmla="*/ 850900 w 2006600"/>
                    <a:gd name="connsiteY5" fmla="*/ 1143000 h 1287516"/>
                    <a:gd name="connsiteX6" fmla="*/ 1168400 w 2006600"/>
                    <a:gd name="connsiteY6" fmla="*/ 1155700 h 1287516"/>
                    <a:gd name="connsiteX7" fmla="*/ 1587500 w 2006600"/>
                    <a:gd name="connsiteY7" fmla="*/ 1130300 h 1287516"/>
                    <a:gd name="connsiteX8" fmla="*/ 2006600 w 2006600"/>
                    <a:gd name="connsiteY8" fmla="*/ 1028700 h 1287516"/>
                    <a:gd name="connsiteX9" fmla="*/ 1778000 w 2006600"/>
                    <a:gd name="connsiteY9" fmla="*/ 1206500 h 1287516"/>
                    <a:gd name="connsiteX10" fmla="*/ 1295400 w 2006600"/>
                    <a:gd name="connsiteY10" fmla="*/ 1270000 h 1287516"/>
                    <a:gd name="connsiteX11" fmla="*/ 990600 w 2006600"/>
                    <a:gd name="connsiteY11" fmla="*/ 1282700 h 1287516"/>
                    <a:gd name="connsiteX12" fmla="*/ 584200 w 2006600"/>
                    <a:gd name="connsiteY12" fmla="*/ 1270000 h 1287516"/>
                    <a:gd name="connsiteX13" fmla="*/ 292100 w 2006600"/>
                    <a:gd name="connsiteY13" fmla="*/ 1104900 h 1287516"/>
                    <a:gd name="connsiteX14" fmla="*/ 101600 w 2006600"/>
                    <a:gd name="connsiteY14" fmla="*/ 889000 h 1287516"/>
                    <a:gd name="connsiteX15" fmla="*/ 12700 w 2006600"/>
                    <a:gd name="connsiteY15" fmla="*/ 660400 h 1287516"/>
                    <a:gd name="connsiteX16" fmla="*/ 0 w 2006600"/>
                    <a:gd name="connsiteY16" fmla="*/ 419100 h 1287516"/>
                    <a:gd name="connsiteX17" fmla="*/ 0 w 2006600"/>
                    <a:gd name="connsiteY17" fmla="*/ 419100 h 1287516"/>
                    <a:gd name="connsiteX18" fmla="*/ 88900 w 2006600"/>
                    <a:gd name="connsiteY18" fmla="*/ 139700 h 1287516"/>
                    <a:gd name="connsiteX19" fmla="*/ 279400 w 2006600"/>
                    <a:gd name="connsiteY19" fmla="*/ 0 h 1287516"/>
                    <a:gd name="connsiteX20" fmla="*/ 355600 w 2006600"/>
                    <a:gd name="connsiteY20" fmla="*/ 0 h 1287516"/>
                    <a:gd name="connsiteX21" fmla="*/ 355600 w 2006600"/>
                    <a:gd name="connsiteY21" fmla="*/ 152400 h 1287516"/>
                    <a:gd name="connsiteX22" fmla="*/ 355600 w 2006600"/>
                    <a:gd name="connsiteY22" fmla="*/ 152400 h 1287516"/>
                    <a:gd name="connsiteX23" fmla="*/ 292100 w 2006600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355600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587500 w 2011119"/>
                    <a:gd name="connsiteY7" fmla="*/ 1130300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55700 h 1287516"/>
                    <a:gd name="connsiteX7" fmla="*/ 1707243 w 2011119"/>
                    <a:gd name="connsiteY7" fmla="*/ 11139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93800 h 1287516"/>
                    <a:gd name="connsiteX7" fmla="*/ 1707243 w 2011119"/>
                    <a:gd name="connsiteY7" fmla="*/ 11139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850900 w 2011119"/>
                    <a:gd name="connsiteY5" fmla="*/ 1143000 h 1287516"/>
                    <a:gd name="connsiteX6" fmla="*/ 1168400 w 2011119"/>
                    <a:gd name="connsiteY6" fmla="*/ 1193800 h 1287516"/>
                    <a:gd name="connsiteX7" fmla="*/ 1707243 w 2011119"/>
                    <a:gd name="connsiteY7" fmla="*/ 11520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7516"/>
                    <a:gd name="connsiteX1" fmla="*/ 190500 w 2011119"/>
                    <a:gd name="connsiteY1" fmla="*/ 292100 h 1287516"/>
                    <a:gd name="connsiteX2" fmla="*/ 127000 w 2011119"/>
                    <a:gd name="connsiteY2" fmla="*/ 622300 h 1287516"/>
                    <a:gd name="connsiteX3" fmla="*/ 241300 w 2011119"/>
                    <a:gd name="connsiteY3" fmla="*/ 825500 h 1287516"/>
                    <a:gd name="connsiteX4" fmla="*/ 469900 w 2011119"/>
                    <a:gd name="connsiteY4" fmla="*/ 1041400 h 1287516"/>
                    <a:gd name="connsiteX5" fmla="*/ 774700 w 2011119"/>
                    <a:gd name="connsiteY5" fmla="*/ 1159328 h 1287516"/>
                    <a:gd name="connsiteX6" fmla="*/ 1168400 w 2011119"/>
                    <a:gd name="connsiteY6" fmla="*/ 1193800 h 1287516"/>
                    <a:gd name="connsiteX7" fmla="*/ 1707243 w 2011119"/>
                    <a:gd name="connsiteY7" fmla="*/ 1152071 h 1287516"/>
                    <a:gd name="connsiteX8" fmla="*/ 2006600 w 2011119"/>
                    <a:gd name="connsiteY8" fmla="*/ 1028700 h 1287516"/>
                    <a:gd name="connsiteX9" fmla="*/ 1778000 w 2011119"/>
                    <a:gd name="connsiteY9" fmla="*/ 1206500 h 1287516"/>
                    <a:gd name="connsiteX10" fmla="*/ 1295400 w 2011119"/>
                    <a:gd name="connsiteY10" fmla="*/ 1270000 h 1287516"/>
                    <a:gd name="connsiteX11" fmla="*/ 990600 w 2011119"/>
                    <a:gd name="connsiteY11" fmla="*/ 1282700 h 1287516"/>
                    <a:gd name="connsiteX12" fmla="*/ 584200 w 2011119"/>
                    <a:gd name="connsiteY12" fmla="*/ 1270000 h 1287516"/>
                    <a:gd name="connsiteX13" fmla="*/ 292100 w 2011119"/>
                    <a:gd name="connsiteY13" fmla="*/ 1104900 h 1287516"/>
                    <a:gd name="connsiteX14" fmla="*/ 101600 w 2011119"/>
                    <a:gd name="connsiteY14" fmla="*/ 889000 h 1287516"/>
                    <a:gd name="connsiteX15" fmla="*/ 12700 w 2011119"/>
                    <a:gd name="connsiteY15" fmla="*/ 660400 h 1287516"/>
                    <a:gd name="connsiteX16" fmla="*/ 0 w 2011119"/>
                    <a:gd name="connsiteY16" fmla="*/ 419100 h 1287516"/>
                    <a:gd name="connsiteX17" fmla="*/ 0 w 2011119"/>
                    <a:gd name="connsiteY17" fmla="*/ 419100 h 1287516"/>
                    <a:gd name="connsiteX18" fmla="*/ 88900 w 2011119"/>
                    <a:gd name="connsiteY18" fmla="*/ 139700 h 1287516"/>
                    <a:gd name="connsiteX19" fmla="*/ 279400 w 2011119"/>
                    <a:gd name="connsiteY19" fmla="*/ 0 h 1287516"/>
                    <a:gd name="connsiteX20" fmla="*/ 404586 w 2011119"/>
                    <a:gd name="connsiteY20" fmla="*/ 0 h 1287516"/>
                    <a:gd name="connsiteX21" fmla="*/ 355600 w 2011119"/>
                    <a:gd name="connsiteY21" fmla="*/ 152400 h 1287516"/>
                    <a:gd name="connsiteX22" fmla="*/ 355600 w 2011119"/>
                    <a:gd name="connsiteY22" fmla="*/ 152400 h 1287516"/>
                    <a:gd name="connsiteX23" fmla="*/ 292100 w 2011119"/>
                    <a:gd name="connsiteY23" fmla="*/ 152400 h 1287516"/>
                    <a:gd name="connsiteX0" fmla="*/ 292100 w 2011119"/>
                    <a:gd name="connsiteY0" fmla="*/ 152400 h 1284801"/>
                    <a:gd name="connsiteX1" fmla="*/ 190500 w 2011119"/>
                    <a:gd name="connsiteY1" fmla="*/ 292100 h 1284801"/>
                    <a:gd name="connsiteX2" fmla="*/ 127000 w 2011119"/>
                    <a:gd name="connsiteY2" fmla="*/ 622300 h 1284801"/>
                    <a:gd name="connsiteX3" fmla="*/ 241300 w 2011119"/>
                    <a:gd name="connsiteY3" fmla="*/ 825500 h 1284801"/>
                    <a:gd name="connsiteX4" fmla="*/ 469900 w 2011119"/>
                    <a:gd name="connsiteY4" fmla="*/ 1041400 h 1284801"/>
                    <a:gd name="connsiteX5" fmla="*/ 774700 w 2011119"/>
                    <a:gd name="connsiteY5" fmla="*/ 1159328 h 1284801"/>
                    <a:gd name="connsiteX6" fmla="*/ 1168400 w 2011119"/>
                    <a:gd name="connsiteY6" fmla="*/ 1193800 h 1284801"/>
                    <a:gd name="connsiteX7" fmla="*/ 1707243 w 2011119"/>
                    <a:gd name="connsiteY7" fmla="*/ 1152071 h 1284801"/>
                    <a:gd name="connsiteX8" fmla="*/ 2006600 w 2011119"/>
                    <a:gd name="connsiteY8" fmla="*/ 1028700 h 1284801"/>
                    <a:gd name="connsiteX9" fmla="*/ 1778000 w 2011119"/>
                    <a:gd name="connsiteY9" fmla="*/ 1206500 h 1284801"/>
                    <a:gd name="connsiteX10" fmla="*/ 1295400 w 2011119"/>
                    <a:gd name="connsiteY10" fmla="*/ 1270000 h 1284801"/>
                    <a:gd name="connsiteX11" fmla="*/ 990600 w 2011119"/>
                    <a:gd name="connsiteY11" fmla="*/ 1282700 h 1284801"/>
                    <a:gd name="connsiteX12" fmla="*/ 573314 w 2011119"/>
                    <a:gd name="connsiteY12" fmla="*/ 1237343 h 1284801"/>
                    <a:gd name="connsiteX13" fmla="*/ 292100 w 2011119"/>
                    <a:gd name="connsiteY13" fmla="*/ 1104900 h 1284801"/>
                    <a:gd name="connsiteX14" fmla="*/ 101600 w 2011119"/>
                    <a:gd name="connsiteY14" fmla="*/ 889000 h 1284801"/>
                    <a:gd name="connsiteX15" fmla="*/ 12700 w 2011119"/>
                    <a:gd name="connsiteY15" fmla="*/ 660400 h 1284801"/>
                    <a:gd name="connsiteX16" fmla="*/ 0 w 2011119"/>
                    <a:gd name="connsiteY16" fmla="*/ 419100 h 1284801"/>
                    <a:gd name="connsiteX17" fmla="*/ 0 w 2011119"/>
                    <a:gd name="connsiteY17" fmla="*/ 419100 h 1284801"/>
                    <a:gd name="connsiteX18" fmla="*/ 88900 w 2011119"/>
                    <a:gd name="connsiteY18" fmla="*/ 139700 h 1284801"/>
                    <a:gd name="connsiteX19" fmla="*/ 279400 w 2011119"/>
                    <a:gd name="connsiteY19" fmla="*/ 0 h 1284801"/>
                    <a:gd name="connsiteX20" fmla="*/ 404586 w 2011119"/>
                    <a:gd name="connsiteY20" fmla="*/ 0 h 1284801"/>
                    <a:gd name="connsiteX21" fmla="*/ 355600 w 2011119"/>
                    <a:gd name="connsiteY21" fmla="*/ 152400 h 1284801"/>
                    <a:gd name="connsiteX22" fmla="*/ 355600 w 2011119"/>
                    <a:gd name="connsiteY22" fmla="*/ 152400 h 1284801"/>
                    <a:gd name="connsiteX23" fmla="*/ 292100 w 2011119"/>
                    <a:gd name="connsiteY23" fmla="*/ 152400 h 1284801"/>
                    <a:gd name="connsiteX0" fmla="*/ 292100 w 2011119"/>
                    <a:gd name="connsiteY0" fmla="*/ 152400 h 1284801"/>
                    <a:gd name="connsiteX1" fmla="*/ 190500 w 2011119"/>
                    <a:gd name="connsiteY1" fmla="*/ 292100 h 1284801"/>
                    <a:gd name="connsiteX2" fmla="*/ 159657 w 2011119"/>
                    <a:gd name="connsiteY2" fmla="*/ 622300 h 1284801"/>
                    <a:gd name="connsiteX3" fmla="*/ 241300 w 2011119"/>
                    <a:gd name="connsiteY3" fmla="*/ 825500 h 1284801"/>
                    <a:gd name="connsiteX4" fmla="*/ 469900 w 2011119"/>
                    <a:gd name="connsiteY4" fmla="*/ 1041400 h 1284801"/>
                    <a:gd name="connsiteX5" fmla="*/ 774700 w 2011119"/>
                    <a:gd name="connsiteY5" fmla="*/ 1159328 h 1284801"/>
                    <a:gd name="connsiteX6" fmla="*/ 1168400 w 2011119"/>
                    <a:gd name="connsiteY6" fmla="*/ 1193800 h 1284801"/>
                    <a:gd name="connsiteX7" fmla="*/ 1707243 w 2011119"/>
                    <a:gd name="connsiteY7" fmla="*/ 1152071 h 1284801"/>
                    <a:gd name="connsiteX8" fmla="*/ 2006600 w 2011119"/>
                    <a:gd name="connsiteY8" fmla="*/ 1028700 h 1284801"/>
                    <a:gd name="connsiteX9" fmla="*/ 1778000 w 2011119"/>
                    <a:gd name="connsiteY9" fmla="*/ 1206500 h 1284801"/>
                    <a:gd name="connsiteX10" fmla="*/ 1295400 w 2011119"/>
                    <a:gd name="connsiteY10" fmla="*/ 1270000 h 1284801"/>
                    <a:gd name="connsiteX11" fmla="*/ 990600 w 2011119"/>
                    <a:gd name="connsiteY11" fmla="*/ 1282700 h 1284801"/>
                    <a:gd name="connsiteX12" fmla="*/ 573314 w 2011119"/>
                    <a:gd name="connsiteY12" fmla="*/ 1237343 h 1284801"/>
                    <a:gd name="connsiteX13" fmla="*/ 292100 w 2011119"/>
                    <a:gd name="connsiteY13" fmla="*/ 1104900 h 1284801"/>
                    <a:gd name="connsiteX14" fmla="*/ 101600 w 2011119"/>
                    <a:gd name="connsiteY14" fmla="*/ 889000 h 1284801"/>
                    <a:gd name="connsiteX15" fmla="*/ 12700 w 2011119"/>
                    <a:gd name="connsiteY15" fmla="*/ 660400 h 1284801"/>
                    <a:gd name="connsiteX16" fmla="*/ 0 w 2011119"/>
                    <a:gd name="connsiteY16" fmla="*/ 419100 h 1284801"/>
                    <a:gd name="connsiteX17" fmla="*/ 0 w 2011119"/>
                    <a:gd name="connsiteY17" fmla="*/ 419100 h 1284801"/>
                    <a:gd name="connsiteX18" fmla="*/ 88900 w 2011119"/>
                    <a:gd name="connsiteY18" fmla="*/ 139700 h 1284801"/>
                    <a:gd name="connsiteX19" fmla="*/ 279400 w 2011119"/>
                    <a:gd name="connsiteY19" fmla="*/ 0 h 1284801"/>
                    <a:gd name="connsiteX20" fmla="*/ 404586 w 2011119"/>
                    <a:gd name="connsiteY20" fmla="*/ 0 h 1284801"/>
                    <a:gd name="connsiteX21" fmla="*/ 355600 w 2011119"/>
                    <a:gd name="connsiteY21" fmla="*/ 152400 h 1284801"/>
                    <a:gd name="connsiteX22" fmla="*/ 355600 w 2011119"/>
                    <a:gd name="connsiteY22" fmla="*/ 152400 h 1284801"/>
                    <a:gd name="connsiteX23" fmla="*/ 292100 w 2011119"/>
                    <a:gd name="connsiteY23" fmla="*/ 152400 h 128480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</a:cxnLst>
                  <a:rect l="l" t="t" r="r" b="b"/>
                  <a:pathLst>
                    <a:path w="2011119" h="1284801">
                      <a:moveTo>
                        <a:pt x="292100" y="152400"/>
                      </a:moveTo>
                      <a:cubicBezTo>
                        <a:pt x="264583" y="175683"/>
                        <a:pt x="212574" y="213783"/>
                        <a:pt x="190500" y="292100"/>
                      </a:cubicBezTo>
                      <a:cubicBezTo>
                        <a:pt x="168426" y="370417"/>
                        <a:pt x="151190" y="533400"/>
                        <a:pt x="159657" y="622300"/>
                      </a:cubicBezTo>
                      <a:cubicBezTo>
                        <a:pt x="168124" y="711200"/>
                        <a:pt x="189593" y="755650"/>
                        <a:pt x="241300" y="825500"/>
                      </a:cubicBezTo>
                      <a:cubicBezTo>
                        <a:pt x="293007" y="895350"/>
                        <a:pt x="381000" y="985762"/>
                        <a:pt x="469900" y="1041400"/>
                      </a:cubicBezTo>
                      <a:cubicBezTo>
                        <a:pt x="558800" y="1097038"/>
                        <a:pt x="658283" y="1133928"/>
                        <a:pt x="774700" y="1159328"/>
                      </a:cubicBezTo>
                      <a:cubicBezTo>
                        <a:pt x="891117" y="1184728"/>
                        <a:pt x="1012976" y="1195009"/>
                        <a:pt x="1168400" y="1193800"/>
                      </a:cubicBezTo>
                      <a:cubicBezTo>
                        <a:pt x="1323824" y="1192591"/>
                        <a:pt x="1567543" y="1179588"/>
                        <a:pt x="1707243" y="1152071"/>
                      </a:cubicBezTo>
                      <a:cubicBezTo>
                        <a:pt x="1846943" y="1124554"/>
                        <a:pt x="1906814" y="1057124"/>
                        <a:pt x="2006600" y="1028700"/>
                      </a:cubicBezTo>
                      <a:cubicBezTo>
                        <a:pt x="2038350" y="1041400"/>
                        <a:pt x="1896533" y="1166283"/>
                        <a:pt x="1778000" y="1206500"/>
                      </a:cubicBezTo>
                      <a:cubicBezTo>
                        <a:pt x="1659467" y="1246717"/>
                        <a:pt x="1426633" y="1257300"/>
                        <a:pt x="1295400" y="1270000"/>
                      </a:cubicBezTo>
                      <a:cubicBezTo>
                        <a:pt x="1164167" y="1282700"/>
                        <a:pt x="1110948" y="1288143"/>
                        <a:pt x="990600" y="1282700"/>
                      </a:cubicBezTo>
                      <a:cubicBezTo>
                        <a:pt x="870252" y="1277257"/>
                        <a:pt x="689731" y="1266976"/>
                        <a:pt x="573314" y="1237343"/>
                      </a:cubicBezTo>
                      <a:cubicBezTo>
                        <a:pt x="456897" y="1207710"/>
                        <a:pt x="370719" y="1162957"/>
                        <a:pt x="292100" y="1104900"/>
                      </a:cubicBezTo>
                      <a:cubicBezTo>
                        <a:pt x="213481" y="1046843"/>
                        <a:pt x="148167" y="963083"/>
                        <a:pt x="101600" y="889000"/>
                      </a:cubicBezTo>
                      <a:cubicBezTo>
                        <a:pt x="55033" y="814917"/>
                        <a:pt x="29633" y="738717"/>
                        <a:pt x="12700" y="660400"/>
                      </a:cubicBezTo>
                      <a:cubicBezTo>
                        <a:pt x="-4233" y="582083"/>
                        <a:pt x="2117" y="459317"/>
                        <a:pt x="0" y="419100"/>
                      </a:cubicBezTo>
                      <a:lnTo>
                        <a:pt x="0" y="419100"/>
                      </a:lnTo>
                      <a:cubicBezTo>
                        <a:pt x="0" y="419100"/>
                        <a:pt x="42333" y="209550"/>
                        <a:pt x="88900" y="139700"/>
                      </a:cubicBezTo>
                      <a:cubicBezTo>
                        <a:pt x="135467" y="69850"/>
                        <a:pt x="234950" y="23283"/>
                        <a:pt x="279400" y="0"/>
                      </a:cubicBezTo>
                      <a:lnTo>
                        <a:pt x="404586" y="0"/>
                      </a:lnTo>
                      <a:lnTo>
                        <a:pt x="355600" y="152400"/>
                      </a:lnTo>
                      <a:lnTo>
                        <a:pt x="355600" y="152400"/>
                      </a:lnTo>
                      <a:lnTo>
                        <a:pt x="292100" y="152400"/>
                      </a:ln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</p:grpSp>
          <p:sp>
            <p:nvSpPr>
              <p:cNvPr id="139" name="Oval 138">
                <a:extLst>
                  <a:ext uri="{FF2B5EF4-FFF2-40B4-BE49-F238E27FC236}">
                    <a16:creationId xmlns:a16="http://schemas.microsoft.com/office/drawing/2014/main" id="{982B9826-5BF3-688E-EA0A-CC92EF8EED99}"/>
                  </a:ext>
                </a:extLst>
              </p:cNvPr>
              <p:cNvSpPr/>
              <p:nvPr/>
            </p:nvSpPr>
            <p:spPr>
              <a:xfrm>
                <a:off x="1332660" y="1389600"/>
                <a:ext cx="152400" cy="15240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1B0C8814-93D0-63CB-1D72-ACCCE5E07E8D}"/>
                </a:ext>
              </a:extLst>
            </p:cNvPr>
            <p:cNvSpPr txBox="1"/>
            <p:nvPr/>
          </p:nvSpPr>
          <p:spPr>
            <a:xfrm>
              <a:off x="103443" y="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EC21161E-7B0E-CD8F-F6C2-CCBF818E424B}"/>
                </a:ext>
              </a:extLst>
            </p:cNvPr>
            <p:cNvSpPr txBox="1"/>
            <p:nvPr/>
          </p:nvSpPr>
          <p:spPr>
            <a:xfrm>
              <a:off x="4024409" y="312319"/>
              <a:ext cx="5373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e5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773B24AB-5529-3D62-F328-6C4FDFC3C4A3}"/>
                </a:ext>
              </a:extLst>
            </p:cNvPr>
            <p:cNvSpPr txBox="1"/>
            <p:nvPr/>
          </p:nvSpPr>
          <p:spPr>
            <a:xfrm>
              <a:off x="4024409" y="599961"/>
              <a:ext cx="5373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e5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0A99B9A3-2259-B672-DD44-8E373695AA5B}"/>
                </a:ext>
              </a:extLst>
            </p:cNvPr>
            <p:cNvSpPr txBox="1"/>
            <p:nvPr/>
          </p:nvSpPr>
          <p:spPr>
            <a:xfrm>
              <a:off x="4024410" y="890316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e5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14B8C4D9-5616-6397-B3F3-A5206E3541FA}"/>
                </a:ext>
              </a:extLst>
            </p:cNvPr>
            <p:cNvSpPr txBox="1"/>
            <p:nvPr/>
          </p:nvSpPr>
          <p:spPr>
            <a:xfrm>
              <a:off x="4298523" y="117446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grpSp>
          <p:nvGrpSpPr>
            <p:cNvPr id="240" name="Group 239">
              <a:extLst>
                <a:ext uri="{FF2B5EF4-FFF2-40B4-BE49-F238E27FC236}">
                  <a16:creationId xmlns:a16="http://schemas.microsoft.com/office/drawing/2014/main" id="{06157F46-DF6E-C51F-ED51-FF174592611F}"/>
                </a:ext>
              </a:extLst>
            </p:cNvPr>
            <p:cNvGrpSpPr/>
            <p:nvPr/>
          </p:nvGrpSpPr>
          <p:grpSpPr>
            <a:xfrm>
              <a:off x="4496386" y="1309069"/>
              <a:ext cx="1304525" cy="622091"/>
              <a:chOff x="693021" y="3257658"/>
              <a:chExt cx="1304525" cy="622091"/>
            </a:xfrm>
          </p:grpSpPr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DE2678A2-BE31-1269-0AC3-C3AB2F7F3BBE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39" name="Group 238">
                <a:extLst>
                  <a:ext uri="{FF2B5EF4-FFF2-40B4-BE49-F238E27FC236}">
                    <a16:creationId xmlns:a16="http://schemas.microsoft.com/office/drawing/2014/main" id="{8EFFB1EC-9958-1AEE-0864-39753F6815D5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9BBC4D96-F78F-0C0C-DE28-D8002C803451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BF4F7B89-0F58-81E6-761A-69433A7C5A52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34" name="Straight Connector 233">
                  <a:extLst>
                    <a:ext uri="{FF2B5EF4-FFF2-40B4-BE49-F238E27FC236}">
                      <a16:creationId xmlns:a16="http://schemas.microsoft.com/office/drawing/2014/main" id="{B011E13A-FE08-4937-008E-3467F6994C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E0170F5C-AA75-FD16-08D9-A9648016D435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700C9822-7B26-9A97-83A3-0622EBAD3878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52AC5CA8-3437-DAA0-CCA3-F31858C4B280}"/>
                </a:ext>
              </a:extLst>
            </p:cNvPr>
            <p:cNvSpPr txBox="1"/>
            <p:nvPr/>
          </p:nvSpPr>
          <p:spPr>
            <a:xfrm rot="16200000">
              <a:off x="3557539" y="736591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gG ng/ml</a:t>
              </a:r>
            </a:p>
          </p:txBody>
        </p:sp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5B51B743-17FB-363F-795F-1373C8DD89E0}"/>
                </a:ext>
              </a:extLst>
            </p:cNvPr>
            <p:cNvGrpSpPr/>
            <p:nvPr/>
          </p:nvGrpSpPr>
          <p:grpSpPr>
            <a:xfrm>
              <a:off x="6361145" y="1306121"/>
              <a:ext cx="1304525" cy="622091"/>
              <a:chOff x="693021" y="3257658"/>
              <a:chExt cx="1304525" cy="622091"/>
            </a:xfrm>
          </p:grpSpPr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ACFEA400-3DA5-D69D-7A70-1F71BA3CF8F7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43" name="Group 242">
                <a:extLst>
                  <a:ext uri="{FF2B5EF4-FFF2-40B4-BE49-F238E27FC236}">
                    <a16:creationId xmlns:a16="http://schemas.microsoft.com/office/drawing/2014/main" id="{296EA3EE-09CE-381F-FFA4-A683B1137DFC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B3854C2C-321D-A42C-6E54-F99B6446E5C8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45" name="TextBox 244">
                  <a:extLst>
                    <a:ext uri="{FF2B5EF4-FFF2-40B4-BE49-F238E27FC236}">
                      <a16:creationId xmlns:a16="http://schemas.microsoft.com/office/drawing/2014/main" id="{1CA53935-943A-35B3-392F-AD5B59FB8921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46" name="Straight Connector 245">
                  <a:extLst>
                    <a:ext uri="{FF2B5EF4-FFF2-40B4-BE49-F238E27FC236}">
                      <a16:creationId xmlns:a16="http://schemas.microsoft.com/office/drawing/2014/main" id="{46DF1CE0-71CF-9897-D68C-7101BCF0F0A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6C227A56-5B8A-4106-08EF-14FE663B0D2E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48" name="TextBox 247">
                  <a:extLst>
                    <a:ext uri="{FF2B5EF4-FFF2-40B4-BE49-F238E27FC236}">
                      <a16:creationId xmlns:a16="http://schemas.microsoft.com/office/drawing/2014/main" id="{34A8FF12-DF58-8C31-017D-B0D2F9710562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250" name="Group 249">
              <a:extLst>
                <a:ext uri="{FF2B5EF4-FFF2-40B4-BE49-F238E27FC236}">
                  <a16:creationId xmlns:a16="http://schemas.microsoft.com/office/drawing/2014/main" id="{5367A01D-C558-E455-D187-8529E07512CF}"/>
                </a:ext>
              </a:extLst>
            </p:cNvPr>
            <p:cNvGrpSpPr/>
            <p:nvPr/>
          </p:nvGrpSpPr>
          <p:grpSpPr>
            <a:xfrm>
              <a:off x="6283922" y="3467733"/>
              <a:ext cx="1304525" cy="622091"/>
              <a:chOff x="693021" y="3257658"/>
              <a:chExt cx="1304525" cy="622091"/>
            </a:xfrm>
          </p:grpSpPr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929FDF11-1A92-FF1D-62FD-CCE68B3D0A7B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52" name="Group 251">
                <a:extLst>
                  <a:ext uri="{FF2B5EF4-FFF2-40B4-BE49-F238E27FC236}">
                    <a16:creationId xmlns:a16="http://schemas.microsoft.com/office/drawing/2014/main" id="{D185C741-8FA6-A400-89AA-922DA3EE7035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53" name="TextBox 252">
                  <a:extLst>
                    <a:ext uri="{FF2B5EF4-FFF2-40B4-BE49-F238E27FC236}">
                      <a16:creationId xmlns:a16="http://schemas.microsoft.com/office/drawing/2014/main" id="{C74722A0-7B66-C3E3-599B-DE35E7C30731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54" name="TextBox 253">
                  <a:extLst>
                    <a:ext uri="{FF2B5EF4-FFF2-40B4-BE49-F238E27FC236}">
                      <a16:creationId xmlns:a16="http://schemas.microsoft.com/office/drawing/2014/main" id="{CFC72335-8AAF-08AD-B885-CC55D46886E2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55" name="Straight Connector 254">
                  <a:extLst>
                    <a:ext uri="{FF2B5EF4-FFF2-40B4-BE49-F238E27FC236}">
                      <a16:creationId xmlns:a16="http://schemas.microsoft.com/office/drawing/2014/main" id="{54F1F516-957A-9B63-3AD9-8F0228540F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FB0A6684-8D8F-3D61-0970-9E3AD59CC25F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57" name="TextBox 256">
                  <a:extLst>
                    <a:ext uri="{FF2B5EF4-FFF2-40B4-BE49-F238E27FC236}">
                      <a16:creationId xmlns:a16="http://schemas.microsoft.com/office/drawing/2014/main" id="{292ABA84-10CF-B399-8D48-B467D172D410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259" name="Group 258">
              <a:extLst>
                <a:ext uri="{FF2B5EF4-FFF2-40B4-BE49-F238E27FC236}">
                  <a16:creationId xmlns:a16="http://schemas.microsoft.com/office/drawing/2014/main" id="{3F2E1FB1-DC70-55BF-458E-B4A8E5A7A0B9}"/>
                </a:ext>
              </a:extLst>
            </p:cNvPr>
            <p:cNvGrpSpPr/>
            <p:nvPr/>
          </p:nvGrpSpPr>
          <p:grpSpPr>
            <a:xfrm>
              <a:off x="4499711" y="3467733"/>
              <a:ext cx="1304525" cy="622091"/>
              <a:chOff x="693021" y="3257658"/>
              <a:chExt cx="1304525" cy="622091"/>
            </a:xfrm>
          </p:grpSpPr>
          <p:sp>
            <p:nvSpPr>
              <p:cNvPr id="260" name="TextBox 259">
                <a:extLst>
                  <a:ext uri="{FF2B5EF4-FFF2-40B4-BE49-F238E27FC236}">
                    <a16:creationId xmlns:a16="http://schemas.microsoft.com/office/drawing/2014/main" id="{EA062E93-7B50-3B9D-7458-D9C1610FBE1C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61" name="Group 260">
                <a:extLst>
                  <a:ext uri="{FF2B5EF4-FFF2-40B4-BE49-F238E27FC236}">
                    <a16:creationId xmlns:a16="http://schemas.microsoft.com/office/drawing/2014/main" id="{57FA78B9-68DA-68C9-9B95-5896CA0793AD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62" name="TextBox 261">
                  <a:extLst>
                    <a:ext uri="{FF2B5EF4-FFF2-40B4-BE49-F238E27FC236}">
                      <a16:creationId xmlns:a16="http://schemas.microsoft.com/office/drawing/2014/main" id="{58522960-CAF2-6926-F084-F70C223B0784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63" name="TextBox 262">
                  <a:extLst>
                    <a:ext uri="{FF2B5EF4-FFF2-40B4-BE49-F238E27FC236}">
                      <a16:creationId xmlns:a16="http://schemas.microsoft.com/office/drawing/2014/main" id="{ECF20788-97CE-6BD5-794A-3593F556B603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64" name="Straight Connector 263">
                  <a:extLst>
                    <a:ext uri="{FF2B5EF4-FFF2-40B4-BE49-F238E27FC236}">
                      <a16:creationId xmlns:a16="http://schemas.microsoft.com/office/drawing/2014/main" id="{1A8EBD03-439A-ABE3-96B9-53431AC583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9FD62CD4-4F00-A122-0369-12D2A8DE69AE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66" name="TextBox 265">
                  <a:extLst>
                    <a:ext uri="{FF2B5EF4-FFF2-40B4-BE49-F238E27FC236}">
                      <a16:creationId xmlns:a16="http://schemas.microsoft.com/office/drawing/2014/main" id="{3EE199EA-851B-8D4D-4F78-739B0013E3C3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267" name="Group 266">
              <a:extLst>
                <a:ext uri="{FF2B5EF4-FFF2-40B4-BE49-F238E27FC236}">
                  <a16:creationId xmlns:a16="http://schemas.microsoft.com/office/drawing/2014/main" id="{244483AE-6A6C-F4ED-F3FF-BCF9BB278CC6}"/>
                </a:ext>
              </a:extLst>
            </p:cNvPr>
            <p:cNvGrpSpPr/>
            <p:nvPr/>
          </p:nvGrpSpPr>
          <p:grpSpPr>
            <a:xfrm>
              <a:off x="2617574" y="3467733"/>
              <a:ext cx="1304525" cy="622091"/>
              <a:chOff x="693021" y="3257658"/>
              <a:chExt cx="1304525" cy="622091"/>
            </a:xfrm>
          </p:grpSpPr>
          <p:sp>
            <p:nvSpPr>
              <p:cNvPr id="268" name="TextBox 267">
                <a:extLst>
                  <a:ext uri="{FF2B5EF4-FFF2-40B4-BE49-F238E27FC236}">
                    <a16:creationId xmlns:a16="http://schemas.microsoft.com/office/drawing/2014/main" id="{449D24D9-D88A-9973-5535-F4C8F9EA13F4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69" name="Group 268">
                <a:extLst>
                  <a:ext uri="{FF2B5EF4-FFF2-40B4-BE49-F238E27FC236}">
                    <a16:creationId xmlns:a16="http://schemas.microsoft.com/office/drawing/2014/main" id="{D14E87B3-BCFF-CCDE-5FB0-3D88078681CB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70" name="TextBox 269">
                  <a:extLst>
                    <a:ext uri="{FF2B5EF4-FFF2-40B4-BE49-F238E27FC236}">
                      <a16:creationId xmlns:a16="http://schemas.microsoft.com/office/drawing/2014/main" id="{231AC349-63F3-2AAC-F825-5B7800BFA10E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id="{8F3C7FC8-E253-9FFF-A982-E271DE8603B5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72" name="Straight Connector 271">
                  <a:extLst>
                    <a:ext uri="{FF2B5EF4-FFF2-40B4-BE49-F238E27FC236}">
                      <a16:creationId xmlns:a16="http://schemas.microsoft.com/office/drawing/2014/main" id="{2CD901AE-65FD-67E9-A386-8C9755F683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3" name="TextBox 272">
                  <a:extLst>
                    <a:ext uri="{FF2B5EF4-FFF2-40B4-BE49-F238E27FC236}">
                      <a16:creationId xmlns:a16="http://schemas.microsoft.com/office/drawing/2014/main" id="{081A95CF-C111-5142-9F24-0F3759E2246C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74" name="TextBox 273">
                  <a:extLst>
                    <a:ext uri="{FF2B5EF4-FFF2-40B4-BE49-F238E27FC236}">
                      <a16:creationId xmlns:a16="http://schemas.microsoft.com/office/drawing/2014/main" id="{3C559071-1782-BEBF-010C-11B0F3B6AC1E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275" name="Group 274">
              <a:extLst>
                <a:ext uri="{FF2B5EF4-FFF2-40B4-BE49-F238E27FC236}">
                  <a16:creationId xmlns:a16="http://schemas.microsoft.com/office/drawing/2014/main" id="{5624B41A-F001-2A5F-6008-669C6F0F87FF}"/>
                </a:ext>
              </a:extLst>
            </p:cNvPr>
            <p:cNvGrpSpPr/>
            <p:nvPr/>
          </p:nvGrpSpPr>
          <p:grpSpPr>
            <a:xfrm>
              <a:off x="745805" y="3467733"/>
              <a:ext cx="1304525" cy="622091"/>
              <a:chOff x="693021" y="3257658"/>
              <a:chExt cx="1304525" cy="622091"/>
            </a:xfrm>
          </p:grpSpPr>
          <p:sp>
            <p:nvSpPr>
              <p:cNvPr id="276" name="TextBox 275">
                <a:extLst>
                  <a:ext uri="{FF2B5EF4-FFF2-40B4-BE49-F238E27FC236}">
                    <a16:creationId xmlns:a16="http://schemas.microsoft.com/office/drawing/2014/main" id="{E9F70EA3-566B-B7B0-FB50-741395C1D027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77" name="Group 276">
                <a:extLst>
                  <a:ext uri="{FF2B5EF4-FFF2-40B4-BE49-F238E27FC236}">
                    <a16:creationId xmlns:a16="http://schemas.microsoft.com/office/drawing/2014/main" id="{6EDA2745-A4B8-3343-9788-50E5DC4A07A5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78" name="TextBox 277">
                  <a:extLst>
                    <a:ext uri="{FF2B5EF4-FFF2-40B4-BE49-F238E27FC236}">
                      <a16:creationId xmlns:a16="http://schemas.microsoft.com/office/drawing/2014/main" id="{CF652A2D-4C6D-7F8C-15DA-EE44AFD4DFBC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79" name="TextBox 278">
                  <a:extLst>
                    <a:ext uri="{FF2B5EF4-FFF2-40B4-BE49-F238E27FC236}">
                      <a16:creationId xmlns:a16="http://schemas.microsoft.com/office/drawing/2014/main" id="{9F39EF69-A56A-AE2E-31B0-4A820467FA23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80" name="Straight Connector 279">
                  <a:extLst>
                    <a:ext uri="{FF2B5EF4-FFF2-40B4-BE49-F238E27FC236}">
                      <a16:creationId xmlns:a16="http://schemas.microsoft.com/office/drawing/2014/main" id="{0B38BBF5-F714-E872-18C2-508EF80764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1" name="TextBox 280">
                  <a:extLst>
                    <a:ext uri="{FF2B5EF4-FFF2-40B4-BE49-F238E27FC236}">
                      <a16:creationId xmlns:a16="http://schemas.microsoft.com/office/drawing/2014/main" id="{4EB892BD-728E-B9B3-725B-8C8207D587E1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82" name="TextBox 281">
                  <a:extLst>
                    <a:ext uri="{FF2B5EF4-FFF2-40B4-BE49-F238E27FC236}">
                      <a16:creationId xmlns:a16="http://schemas.microsoft.com/office/drawing/2014/main" id="{511A404C-554B-FC7B-1370-FEFD687A7C7D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EAC1FB3-CB6B-420E-9E7B-B66855561012}"/>
                </a:ext>
              </a:extLst>
            </p:cNvPr>
            <p:cNvSpPr txBox="1"/>
            <p:nvPr/>
          </p:nvSpPr>
          <p:spPr>
            <a:xfrm>
              <a:off x="868523" y="2190622"/>
              <a:ext cx="950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otal CD8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B2F338A1-3B1F-2437-4D51-B614033025DF}"/>
                </a:ext>
              </a:extLst>
            </p:cNvPr>
            <p:cNvCxnSpPr>
              <a:cxnSpLocks/>
            </p:cNvCxnSpPr>
            <p:nvPr/>
          </p:nvCxnSpPr>
          <p:spPr>
            <a:xfrm>
              <a:off x="4725863" y="4653494"/>
              <a:ext cx="87403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3" name="Group 282">
              <a:extLst>
                <a:ext uri="{FF2B5EF4-FFF2-40B4-BE49-F238E27FC236}">
                  <a16:creationId xmlns:a16="http://schemas.microsoft.com/office/drawing/2014/main" id="{F02FD2DB-F2F7-0772-EB69-9EDD545F0929}"/>
                </a:ext>
              </a:extLst>
            </p:cNvPr>
            <p:cNvGrpSpPr/>
            <p:nvPr/>
          </p:nvGrpSpPr>
          <p:grpSpPr>
            <a:xfrm>
              <a:off x="6286194" y="5407983"/>
              <a:ext cx="1304525" cy="622091"/>
              <a:chOff x="693021" y="3257658"/>
              <a:chExt cx="1304525" cy="622091"/>
            </a:xfrm>
          </p:grpSpPr>
          <p:sp>
            <p:nvSpPr>
              <p:cNvPr id="284" name="TextBox 283">
                <a:extLst>
                  <a:ext uri="{FF2B5EF4-FFF2-40B4-BE49-F238E27FC236}">
                    <a16:creationId xmlns:a16="http://schemas.microsoft.com/office/drawing/2014/main" id="{25F1B760-905E-74AA-3E9F-D41C9B147833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85" name="Group 284">
                <a:extLst>
                  <a:ext uri="{FF2B5EF4-FFF2-40B4-BE49-F238E27FC236}">
                    <a16:creationId xmlns:a16="http://schemas.microsoft.com/office/drawing/2014/main" id="{AB6D8433-7A67-9F5C-0F8B-A78D60D42EC7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86" name="TextBox 285">
                  <a:extLst>
                    <a:ext uri="{FF2B5EF4-FFF2-40B4-BE49-F238E27FC236}">
                      <a16:creationId xmlns:a16="http://schemas.microsoft.com/office/drawing/2014/main" id="{E5671CC1-81ED-CD6C-1021-155B87497A33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DDE88E59-8E81-3FBC-CCCA-D981F5E78F40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88" name="Straight Connector 287">
                  <a:extLst>
                    <a:ext uri="{FF2B5EF4-FFF2-40B4-BE49-F238E27FC236}">
                      <a16:creationId xmlns:a16="http://schemas.microsoft.com/office/drawing/2014/main" id="{60741D38-AD09-AF8E-95DD-0BE869392A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D836E02B-9C47-7794-CCB6-3F6AE7D286AB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id="{2B7F02F3-A90F-7D44-6F6D-BD6A1E0BF03E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291" name="Group 290">
              <a:extLst>
                <a:ext uri="{FF2B5EF4-FFF2-40B4-BE49-F238E27FC236}">
                  <a16:creationId xmlns:a16="http://schemas.microsoft.com/office/drawing/2014/main" id="{8B3AFD97-A89B-C717-D07A-54F756A27461}"/>
                </a:ext>
              </a:extLst>
            </p:cNvPr>
            <p:cNvGrpSpPr/>
            <p:nvPr/>
          </p:nvGrpSpPr>
          <p:grpSpPr>
            <a:xfrm>
              <a:off x="4501983" y="5407983"/>
              <a:ext cx="1304525" cy="622091"/>
              <a:chOff x="693021" y="3257658"/>
              <a:chExt cx="1304525" cy="622091"/>
            </a:xfrm>
          </p:grpSpPr>
          <p:sp>
            <p:nvSpPr>
              <p:cNvPr id="292" name="TextBox 291">
                <a:extLst>
                  <a:ext uri="{FF2B5EF4-FFF2-40B4-BE49-F238E27FC236}">
                    <a16:creationId xmlns:a16="http://schemas.microsoft.com/office/drawing/2014/main" id="{4ACCBD94-F711-A8F1-33B5-CD5E1D8DDE0C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293" name="Group 292">
                <a:extLst>
                  <a:ext uri="{FF2B5EF4-FFF2-40B4-BE49-F238E27FC236}">
                    <a16:creationId xmlns:a16="http://schemas.microsoft.com/office/drawing/2014/main" id="{F62DFEB5-4498-CFF7-8448-6978D5FB98E8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294" name="TextBox 293">
                  <a:extLst>
                    <a:ext uri="{FF2B5EF4-FFF2-40B4-BE49-F238E27FC236}">
                      <a16:creationId xmlns:a16="http://schemas.microsoft.com/office/drawing/2014/main" id="{F68F7074-ECCF-DB3D-7EE7-06DDF47C7A2C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295" name="TextBox 294">
                  <a:extLst>
                    <a:ext uri="{FF2B5EF4-FFF2-40B4-BE49-F238E27FC236}">
                      <a16:creationId xmlns:a16="http://schemas.microsoft.com/office/drawing/2014/main" id="{D7DF7727-2F10-CC8D-3635-DBCD3F707381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296" name="Straight Connector 295">
                  <a:extLst>
                    <a:ext uri="{FF2B5EF4-FFF2-40B4-BE49-F238E27FC236}">
                      <a16:creationId xmlns:a16="http://schemas.microsoft.com/office/drawing/2014/main" id="{93722BCF-E60B-2ABC-C351-4F89898F8B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id="{A87C9B9B-92E3-36F0-3FD3-4A70356DE2D2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298" name="TextBox 297">
                  <a:extLst>
                    <a:ext uri="{FF2B5EF4-FFF2-40B4-BE49-F238E27FC236}">
                      <a16:creationId xmlns:a16="http://schemas.microsoft.com/office/drawing/2014/main" id="{3AF2FE47-DEDD-DA35-EFC8-B37A1F20C4B0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299" name="Group 298">
              <a:extLst>
                <a:ext uri="{FF2B5EF4-FFF2-40B4-BE49-F238E27FC236}">
                  <a16:creationId xmlns:a16="http://schemas.microsoft.com/office/drawing/2014/main" id="{8FD5F765-3D22-FB3D-4B4B-289139B08F87}"/>
                </a:ext>
              </a:extLst>
            </p:cNvPr>
            <p:cNvGrpSpPr/>
            <p:nvPr/>
          </p:nvGrpSpPr>
          <p:grpSpPr>
            <a:xfrm>
              <a:off x="2619846" y="5407983"/>
              <a:ext cx="1304525" cy="622091"/>
              <a:chOff x="693021" y="3257658"/>
              <a:chExt cx="1304525" cy="622091"/>
            </a:xfrm>
          </p:grpSpPr>
          <p:sp>
            <p:nvSpPr>
              <p:cNvPr id="300" name="TextBox 299">
                <a:extLst>
                  <a:ext uri="{FF2B5EF4-FFF2-40B4-BE49-F238E27FC236}">
                    <a16:creationId xmlns:a16="http://schemas.microsoft.com/office/drawing/2014/main" id="{BA6D6888-239A-2818-73E2-3D05EFA4F37D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301" name="Group 300">
                <a:extLst>
                  <a:ext uri="{FF2B5EF4-FFF2-40B4-BE49-F238E27FC236}">
                    <a16:creationId xmlns:a16="http://schemas.microsoft.com/office/drawing/2014/main" id="{B2C1C450-08CC-EE0E-40CC-342C4A2ED599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302" name="TextBox 301">
                  <a:extLst>
                    <a:ext uri="{FF2B5EF4-FFF2-40B4-BE49-F238E27FC236}">
                      <a16:creationId xmlns:a16="http://schemas.microsoft.com/office/drawing/2014/main" id="{0074EB29-28E7-C9E1-8C41-78C18C1CBD97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303" name="TextBox 302">
                  <a:extLst>
                    <a:ext uri="{FF2B5EF4-FFF2-40B4-BE49-F238E27FC236}">
                      <a16:creationId xmlns:a16="http://schemas.microsoft.com/office/drawing/2014/main" id="{F16BCE55-DFEC-838C-D22C-985E766170B1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304" name="Straight Connector 303">
                  <a:extLst>
                    <a:ext uri="{FF2B5EF4-FFF2-40B4-BE49-F238E27FC236}">
                      <a16:creationId xmlns:a16="http://schemas.microsoft.com/office/drawing/2014/main" id="{F5A79080-D124-EDFA-08E8-4CABA2C0B7C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5" name="TextBox 304">
                  <a:extLst>
                    <a:ext uri="{FF2B5EF4-FFF2-40B4-BE49-F238E27FC236}">
                      <a16:creationId xmlns:a16="http://schemas.microsoft.com/office/drawing/2014/main" id="{4B4A139B-3E34-8AC6-7A63-43177F1EE6D3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306" name="TextBox 305">
                  <a:extLst>
                    <a:ext uri="{FF2B5EF4-FFF2-40B4-BE49-F238E27FC236}">
                      <a16:creationId xmlns:a16="http://schemas.microsoft.com/office/drawing/2014/main" id="{19816BDB-3AF6-91C5-7737-A5CA302C3347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307" name="Group 306">
              <a:extLst>
                <a:ext uri="{FF2B5EF4-FFF2-40B4-BE49-F238E27FC236}">
                  <a16:creationId xmlns:a16="http://schemas.microsoft.com/office/drawing/2014/main" id="{65D8C9C9-E1B1-835C-98F5-B50308789FE1}"/>
                </a:ext>
              </a:extLst>
            </p:cNvPr>
            <p:cNvGrpSpPr/>
            <p:nvPr/>
          </p:nvGrpSpPr>
          <p:grpSpPr>
            <a:xfrm>
              <a:off x="748077" y="5407983"/>
              <a:ext cx="1304525" cy="622091"/>
              <a:chOff x="693021" y="3257658"/>
              <a:chExt cx="1304525" cy="622091"/>
            </a:xfrm>
          </p:grpSpPr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14862C8E-E435-7EE8-0A5D-215306043AFF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309" name="Group 308">
                <a:extLst>
                  <a:ext uri="{FF2B5EF4-FFF2-40B4-BE49-F238E27FC236}">
                    <a16:creationId xmlns:a16="http://schemas.microsoft.com/office/drawing/2014/main" id="{D898DA18-1A16-535A-2FBF-39AF3B153E72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310" name="TextBox 309">
                  <a:extLst>
                    <a:ext uri="{FF2B5EF4-FFF2-40B4-BE49-F238E27FC236}">
                      <a16:creationId xmlns:a16="http://schemas.microsoft.com/office/drawing/2014/main" id="{3F9E41D1-AE7C-577E-9C38-D606A098BC16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311" name="TextBox 310">
                  <a:extLst>
                    <a:ext uri="{FF2B5EF4-FFF2-40B4-BE49-F238E27FC236}">
                      <a16:creationId xmlns:a16="http://schemas.microsoft.com/office/drawing/2014/main" id="{A71D7B01-5521-CEC4-1AF8-2FEAEBF8465D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312" name="Straight Connector 311">
                  <a:extLst>
                    <a:ext uri="{FF2B5EF4-FFF2-40B4-BE49-F238E27FC236}">
                      <a16:creationId xmlns:a16="http://schemas.microsoft.com/office/drawing/2014/main" id="{CBAC5AD4-FDAC-2330-AD20-9D1BD7D688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695BE035-9208-F7A9-D4B8-49D925547E80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314" name="TextBox 313">
                  <a:extLst>
                    <a:ext uri="{FF2B5EF4-FFF2-40B4-BE49-F238E27FC236}">
                      <a16:creationId xmlns:a16="http://schemas.microsoft.com/office/drawing/2014/main" id="{26163D65-40E8-6725-198B-82056B24D97D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grpSp>
          <p:nvGrpSpPr>
            <p:cNvPr id="315" name="Group 314">
              <a:extLst>
                <a:ext uri="{FF2B5EF4-FFF2-40B4-BE49-F238E27FC236}">
                  <a16:creationId xmlns:a16="http://schemas.microsoft.com/office/drawing/2014/main" id="{C2CD74AC-EB0A-AB65-BA89-7EA60BEDADAB}"/>
                </a:ext>
              </a:extLst>
            </p:cNvPr>
            <p:cNvGrpSpPr/>
            <p:nvPr/>
          </p:nvGrpSpPr>
          <p:grpSpPr>
            <a:xfrm>
              <a:off x="800371" y="7182429"/>
              <a:ext cx="1304525" cy="622091"/>
              <a:chOff x="693021" y="3257658"/>
              <a:chExt cx="1304525" cy="622091"/>
            </a:xfrm>
          </p:grpSpPr>
          <p:sp>
            <p:nvSpPr>
              <p:cNvPr id="316" name="TextBox 315">
                <a:extLst>
                  <a:ext uri="{FF2B5EF4-FFF2-40B4-BE49-F238E27FC236}">
                    <a16:creationId xmlns:a16="http://schemas.microsoft.com/office/drawing/2014/main" id="{287709DC-3E3B-D85A-B528-7B2C57D15923}"/>
                  </a:ext>
                </a:extLst>
              </p:cNvPr>
              <p:cNvSpPr txBox="1"/>
              <p:nvPr/>
            </p:nvSpPr>
            <p:spPr>
              <a:xfrm rot="19703585">
                <a:off x="693021" y="3257658"/>
                <a:ext cx="4699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grpSp>
            <p:nvGrpSpPr>
              <p:cNvPr id="317" name="Group 316">
                <a:extLst>
                  <a:ext uri="{FF2B5EF4-FFF2-40B4-BE49-F238E27FC236}">
                    <a16:creationId xmlns:a16="http://schemas.microsoft.com/office/drawing/2014/main" id="{5F99DAB5-0B8E-4BE8-EEDB-18BC3121B084}"/>
                  </a:ext>
                </a:extLst>
              </p:cNvPr>
              <p:cNvGrpSpPr/>
              <p:nvPr/>
            </p:nvGrpSpPr>
            <p:grpSpPr>
              <a:xfrm>
                <a:off x="968746" y="3257658"/>
                <a:ext cx="1028800" cy="622091"/>
                <a:chOff x="968746" y="3257658"/>
                <a:chExt cx="1028800" cy="622091"/>
              </a:xfrm>
            </p:grpSpPr>
            <p:sp>
              <p:nvSpPr>
                <p:cNvPr id="318" name="TextBox 317">
                  <a:extLst>
                    <a:ext uri="{FF2B5EF4-FFF2-40B4-BE49-F238E27FC236}">
                      <a16:creationId xmlns:a16="http://schemas.microsoft.com/office/drawing/2014/main" id="{20CFDA99-B71F-CEA4-BF7F-1F6396D1B8CD}"/>
                    </a:ext>
                  </a:extLst>
                </p:cNvPr>
                <p:cNvSpPr txBox="1"/>
                <p:nvPr/>
              </p:nvSpPr>
              <p:spPr>
                <a:xfrm rot="19703585">
                  <a:off x="968746" y="3257658"/>
                  <a:ext cx="4803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</a:t>
                  </a:r>
                </a:p>
              </p:txBody>
            </p:sp>
            <p:sp>
              <p:nvSpPr>
                <p:cNvPr id="319" name="TextBox 318">
                  <a:extLst>
                    <a:ext uri="{FF2B5EF4-FFF2-40B4-BE49-F238E27FC236}">
                      <a16:creationId xmlns:a16="http://schemas.microsoft.com/office/drawing/2014/main" id="{D323905F-8DF7-1F00-A3CD-5E096315DFF0}"/>
                    </a:ext>
                  </a:extLst>
                </p:cNvPr>
                <p:cNvSpPr txBox="1"/>
                <p:nvPr/>
              </p:nvSpPr>
              <p:spPr>
                <a:xfrm rot="19703585">
                  <a:off x="1575618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</a:t>
                  </a:r>
                </a:p>
              </p:txBody>
            </p:sp>
            <p:cxnSp>
              <p:nvCxnSpPr>
                <p:cNvPr id="320" name="Straight Connector 319">
                  <a:extLst>
                    <a:ext uri="{FF2B5EF4-FFF2-40B4-BE49-F238E27FC236}">
                      <a16:creationId xmlns:a16="http://schemas.microsoft.com/office/drawing/2014/main" id="{4BD1D054-F7EA-5EDD-016A-561E953AE02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6992" y="3496611"/>
                  <a:ext cx="54864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1" name="TextBox 320">
                  <a:extLst>
                    <a:ext uri="{FF2B5EF4-FFF2-40B4-BE49-F238E27FC236}">
                      <a16:creationId xmlns:a16="http://schemas.microsoft.com/office/drawing/2014/main" id="{CCB2C968-A033-7EE7-CDDC-7FBB3C68B798}"/>
                    </a:ext>
                  </a:extLst>
                </p:cNvPr>
                <p:cNvSpPr txBox="1"/>
                <p:nvPr/>
              </p:nvSpPr>
              <p:spPr>
                <a:xfrm>
                  <a:off x="1275085" y="3448862"/>
                  <a:ext cx="722461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C+5</a:t>
                  </a:r>
                  <a:r>
                    <a:rPr lang="el-G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 Protein</a:t>
                  </a:r>
                </a:p>
              </p:txBody>
            </p:sp>
            <p:sp>
              <p:nvSpPr>
                <p:cNvPr id="322" name="TextBox 321">
                  <a:extLst>
                    <a:ext uri="{FF2B5EF4-FFF2-40B4-BE49-F238E27FC236}">
                      <a16:creationId xmlns:a16="http://schemas.microsoft.com/office/drawing/2014/main" id="{6E550398-CEE5-A8A2-F778-1FE966E4C20C}"/>
                    </a:ext>
                  </a:extLst>
                </p:cNvPr>
                <p:cNvSpPr txBox="1"/>
                <p:nvPr/>
              </p:nvSpPr>
              <p:spPr>
                <a:xfrm rot="19703585">
                  <a:off x="1298129" y="3257658"/>
                  <a:ext cx="3938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</a:p>
              </p:txBody>
            </p:sp>
          </p:grpSp>
        </p:grp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id="{D91FB9BB-9C41-E095-19C4-50A787B63AAA}"/>
                </a:ext>
              </a:extLst>
            </p:cNvPr>
            <p:cNvSpPr txBox="1"/>
            <p:nvPr/>
          </p:nvSpPr>
          <p:spPr>
            <a:xfrm>
              <a:off x="10238" y="8082359"/>
              <a:ext cx="1236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19786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Picture 127">
            <a:extLst>
              <a:ext uri="{FF2B5EF4-FFF2-40B4-BE49-F238E27FC236}">
                <a16:creationId xmlns:a16="http://schemas.microsoft.com/office/drawing/2014/main" id="{C269ACBE-1157-DA0D-DF64-42669965E3B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196" t="20374" r="29864" b="15629"/>
          <a:stretch/>
        </p:blipFill>
        <p:spPr>
          <a:xfrm>
            <a:off x="693768" y="1002604"/>
            <a:ext cx="1361233" cy="1177688"/>
          </a:xfrm>
          <a:prstGeom prst="rect">
            <a:avLst/>
          </a:prstGeom>
        </p:spPr>
      </p:pic>
      <p:sp>
        <p:nvSpPr>
          <p:cNvPr id="129" name="TextBox 128">
            <a:extLst>
              <a:ext uri="{FF2B5EF4-FFF2-40B4-BE49-F238E27FC236}">
                <a16:creationId xmlns:a16="http://schemas.microsoft.com/office/drawing/2014/main" id="{0CA72DE4-A364-81D7-F74B-BA406E521C3C}"/>
              </a:ext>
            </a:extLst>
          </p:cNvPr>
          <p:cNvSpPr txBox="1"/>
          <p:nvPr/>
        </p:nvSpPr>
        <p:spPr>
          <a:xfrm>
            <a:off x="347639" y="913336"/>
            <a:ext cx="4203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e5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40B8F202-C875-B7EA-A77F-8C9DA79F5A43}"/>
              </a:ext>
            </a:extLst>
          </p:cNvPr>
          <p:cNvSpPr txBox="1"/>
          <p:nvPr/>
        </p:nvSpPr>
        <p:spPr>
          <a:xfrm>
            <a:off x="347639" y="1133251"/>
            <a:ext cx="4203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e5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AF038D4-3595-CB59-EC96-53C8FB2F5B8D}"/>
              </a:ext>
            </a:extLst>
          </p:cNvPr>
          <p:cNvSpPr txBox="1"/>
          <p:nvPr/>
        </p:nvSpPr>
        <p:spPr>
          <a:xfrm>
            <a:off x="347638" y="1343907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e5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7A628525-499E-75B9-4D78-CDB9B8027C76}"/>
              </a:ext>
            </a:extLst>
          </p:cNvPr>
          <p:cNvSpPr txBox="1"/>
          <p:nvPr/>
        </p:nvSpPr>
        <p:spPr>
          <a:xfrm>
            <a:off x="347638" y="156721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e5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766E7F84-28A3-15C8-3551-33CF9040670C}"/>
              </a:ext>
            </a:extLst>
          </p:cNvPr>
          <p:cNvSpPr txBox="1"/>
          <p:nvPr/>
        </p:nvSpPr>
        <p:spPr>
          <a:xfrm>
            <a:off x="347638" y="177017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e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59B95326-4623-DED2-AE4A-543EB9EE64DB}"/>
              </a:ext>
            </a:extLst>
          </p:cNvPr>
          <p:cNvSpPr txBox="1"/>
          <p:nvPr/>
        </p:nvSpPr>
        <p:spPr>
          <a:xfrm>
            <a:off x="504732" y="1988995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DA8B784B-44C3-467A-29E3-17A125ACA23A}"/>
              </a:ext>
            </a:extLst>
          </p:cNvPr>
          <p:cNvSpPr txBox="1"/>
          <p:nvPr/>
        </p:nvSpPr>
        <p:spPr>
          <a:xfrm rot="16200000">
            <a:off x="-94329" y="1447001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F02477CA-E715-0824-9428-9839215004BA}"/>
              </a:ext>
            </a:extLst>
          </p:cNvPr>
          <p:cNvSpPr txBox="1"/>
          <p:nvPr/>
        </p:nvSpPr>
        <p:spPr>
          <a:xfrm>
            <a:off x="870827" y="765888"/>
            <a:ext cx="998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pic>
        <p:nvPicPr>
          <p:cNvPr id="114" name="Picture 113">
            <a:extLst>
              <a:ext uri="{FF2B5EF4-FFF2-40B4-BE49-F238E27FC236}">
                <a16:creationId xmlns:a16="http://schemas.microsoft.com/office/drawing/2014/main" id="{27705B4D-007E-2D31-C9C0-A937993683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859" t="20592" r="30479" b="16635"/>
          <a:stretch/>
        </p:blipFill>
        <p:spPr>
          <a:xfrm>
            <a:off x="2539177" y="997660"/>
            <a:ext cx="1375677" cy="1165536"/>
          </a:xfrm>
          <a:prstGeom prst="rect">
            <a:avLst/>
          </a:prstGeom>
        </p:spPr>
      </p:pic>
      <p:sp>
        <p:nvSpPr>
          <p:cNvPr id="115" name="TextBox 114">
            <a:extLst>
              <a:ext uri="{FF2B5EF4-FFF2-40B4-BE49-F238E27FC236}">
                <a16:creationId xmlns:a16="http://schemas.microsoft.com/office/drawing/2014/main" id="{7222CE6E-E7AD-EFF8-0DCB-CDB3981A2975}"/>
              </a:ext>
            </a:extLst>
          </p:cNvPr>
          <p:cNvSpPr txBox="1"/>
          <p:nvPr/>
        </p:nvSpPr>
        <p:spPr>
          <a:xfrm>
            <a:off x="2094432" y="914055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0e4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F055367-4B1A-E780-3C11-636C1376027D}"/>
              </a:ext>
            </a:extLst>
          </p:cNvPr>
          <p:cNvSpPr txBox="1"/>
          <p:nvPr/>
        </p:nvSpPr>
        <p:spPr>
          <a:xfrm>
            <a:off x="2094432" y="1182836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5e4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98DC10B6-B479-B13B-A4C6-79D8467A4904}"/>
              </a:ext>
            </a:extLst>
          </p:cNvPr>
          <p:cNvSpPr txBox="1"/>
          <p:nvPr/>
        </p:nvSpPr>
        <p:spPr>
          <a:xfrm>
            <a:off x="2094432" y="1451552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0e4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E9CF62FD-03A3-AE83-2938-994E505EE9E6}"/>
              </a:ext>
            </a:extLst>
          </p:cNvPr>
          <p:cNvSpPr txBox="1"/>
          <p:nvPr/>
        </p:nvSpPr>
        <p:spPr>
          <a:xfrm>
            <a:off x="2094432" y="1716943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e4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30F0C369-1CDC-BEDC-FCFE-3BB65A2729F1}"/>
              </a:ext>
            </a:extLst>
          </p:cNvPr>
          <p:cNvSpPr txBox="1"/>
          <p:nvPr/>
        </p:nvSpPr>
        <p:spPr>
          <a:xfrm>
            <a:off x="2368545" y="198850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06A0AEA-88D7-131E-1654-0108E424CC3C}"/>
              </a:ext>
            </a:extLst>
          </p:cNvPr>
          <p:cNvSpPr txBox="1"/>
          <p:nvPr/>
        </p:nvSpPr>
        <p:spPr>
          <a:xfrm rot="16200000">
            <a:off x="1667449" y="1458159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7B3B3E7C-0A35-7476-F091-197E0F5EBBB3}"/>
              </a:ext>
            </a:extLst>
          </p:cNvPr>
          <p:cNvSpPr txBox="1"/>
          <p:nvPr/>
        </p:nvSpPr>
        <p:spPr>
          <a:xfrm>
            <a:off x="2522001" y="765888"/>
            <a:ext cx="1415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287C7946-67A5-61EE-7111-3B674D546FA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131" t="19858" r="30078" b="15918"/>
          <a:stretch/>
        </p:blipFill>
        <p:spPr>
          <a:xfrm>
            <a:off x="4349499" y="980001"/>
            <a:ext cx="1375677" cy="1193073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3BDF3F07-6F97-54A9-38B0-90503CCD881A}"/>
              </a:ext>
            </a:extLst>
          </p:cNvPr>
          <p:cNvSpPr txBox="1"/>
          <p:nvPr/>
        </p:nvSpPr>
        <p:spPr>
          <a:xfrm>
            <a:off x="4007447" y="90449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e4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AC3F33A-3834-28E5-093D-2819CB159A84}"/>
              </a:ext>
            </a:extLst>
          </p:cNvPr>
          <p:cNvSpPr txBox="1"/>
          <p:nvPr/>
        </p:nvSpPr>
        <p:spPr>
          <a:xfrm>
            <a:off x="4007447" y="1271792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e4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A923115-FACB-9AF0-B8BC-D554FFA4FA74}"/>
              </a:ext>
            </a:extLst>
          </p:cNvPr>
          <p:cNvSpPr txBox="1"/>
          <p:nvPr/>
        </p:nvSpPr>
        <p:spPr>
          <a:xfrm>
            <a:off x="4007447" y="162899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e4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7DF352F-9A9C-96F7-7E16-4025AC448B05}"/>
              </a:ext>
            </a:extLst>
          </p:cNvPr>
          <p:cNvSpPr txBox="1"/>
          <p:nvPr/>
        </p:nvSpPr>
        <p:spPr>
          <a:xfrm>
            <a:off x="4164541" y="198707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52DA2C2-AB7F-5573-8BDE-E654A8C3DD37}"/>
              </a:ext>
            </a:extLst>
          </p:cNvPr>
          <p:cNvSpPr txBox="1"/>
          <p:nvPr/>
        </p:nvSpPr>
        <p:spPr>
          <a:xfrm rot="16200000">
            <a:off x="3560262" y="1443412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8B20BE4-E3E2-07E5-A212-00798D590BB1}"/>
              </a:ext>
            </a:extLst>
          </p:cNvPr>
          <p:cNvSpPr txBox="1"/>
          <p:nvPr/>
        </p:nvSpPr>
        <p:spPr>
          <a:xfrm>
            <a:off x="4075682" y="765888"/>
            <a:ext cx="19191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DF0A8AC4-259C-0D6E-476C-F3A13AB0F6B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317" t="19023" r="28736" b="16337"/>
          <a:stretch/>
        </p:blipFill>
        <p:spPr>
          <a:xfrm>
            <a:off x="6374869" y="973138"/>
            <a:ext cx="1390592" cy="1193073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C9FCCC21-D41E-A3B4-31C8-5B3D0F07B793}"/>
              </a:ext>
            </a:extLst>
          </p:cNvPr>
          <p:cNvSpPr txBox="1"/>
          <p:nvPr/>
        </p:nvSpPr>
        <p:spPr>
          <a:xfrm>
            <a:off x="6036972" y="91294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e5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160A4C9-6819-9B3A-6289-49A57D100054}"/>
              </a:ext>
            </a:extLst>
          </p:cNvPr>
          <p:cNvSpPr txBox="1"/>
          <p:nvPr/>
        </p:nvSpPr>
        <p:spPr>
          <a:xfrm>
            <a:off x="6036972" y="117925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e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C30A12C-3370-00C7-891E-7372003E9C17}"/>
              </a:ext>
            </a:extLst>
          </p:cNvPr>
          <p:cNvSpPr txBox="1"/>
          <p:nvPr/>
        </p:nvSpPr>
        <p:spPr>
          <a:xfrm>
            <a:off x="6036972" y="145490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e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9B5B111-6404-6D86-C211-D100D094A32F}"/>
              </a:ext>
            </a:extLst>
          </p:cNvPr>
          <p:cNvSpPr txBox="1"/>
          <p:nvPr/>
        </p:nvSpPr>
        <p:spPr>
          <a:xfrm>
            <a:off x="6036972" y="171632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e5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8E47571-F3DE-B48E-0B7C-F18F3944E3BE}"/>
              </a:ext>
            </a:extLst>
          </p:cNvPr>
          <p:cNvSpPr txBox="1"/>
          <p:nvPr/>
        </p:nvSpPr>
        <p:spPr>
          <a:xfrm>
            <a:off x="6194066" y="198751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3ADA13D-72A5-0DC8-D2BF-AFFE53E3426C}"/>
              </a:ext>
            </a:extLst>
          </p:cNvPr>
          <p:cNvSpPr txBox="1"/>
          <p:nvPr/>
        </p:nvSpPr>
        <p:spPr>
          <a:xfrm rot="16200000">
            <a:off x="5584350" y="1452669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100792E-505D-2DFE-0788-68EA4DA9A257}"/>
              </a:ext>
            </a:extLst>
          </p:cNvPr>
          <p:cNvSpPr txBox="1"/>
          <p:nvPr/>
        </p:nvSpPr>
        <p:spPr>
          <a:xfrm>
            <a:off x="6315625" y="775413"/>
            <a:ext cx="15023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id="{67EDFE1C-70B0-1863-5224-0360ED8303B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038" t="20163" r="30572" b="16877"/>
          <a:stretch/>
        </p:blipFill>
        <p:spPr>
          <a:xfrm>
            <a:off x="2530420" y="3059510"/>
            <a:ext cx="1375678" cy="1189179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157DA06E-3A29-5B98-2951-D72631742621}"/>
              </a:ext>
            </a:extLst>
          </p:cNvPr>
          <p:cNvSpPr txBox="1"/>
          <p:nvPr/>
        </p:nvSpPr>
        <p:spPr>
          <a:xfrm>
            <a:off x="2194377" y="297392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e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FDB7358-DC4D-4839-BE21-C2273B446E3C}"/>
              </a:ext>
            </a:extLst>
          </p:cNvPr>
          <p:cNvSpPr txBox="1"/>
          <p:nvPr/>
        </p:nvSpPr>
        <p:spPr>
          <a:xfrm>
            <a:off x="2194377" y="319933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e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4E68D81-B565-17C0-BF41-571F61ED0B08}"/>
              </a:ext>
            </a:extLst>
          </p:cNvPr>
          <p:cNvSpPr txBox="1"/>
          <p:nvPr/>
        </p:nvSpPr>
        <p:spPr>
          <a:xfrm>
            <a:off x="2194377" y="342191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e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312BB23-B516-7489-EF38-FE518607AABD}"/>
              </a:ext>
            </a:extLst>
          </p:cNvPr>
          <p:cNvSpPr txBox="1"/>
          <p:nvPr/>
        </p:nvSpPr>
        <p:spPr>
          <a:xfrm>
            <a:off x="2194377" y="364433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e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38CCA2D-DB6D-BF50-9000-8FAF1F0F4A6D}"/>
              </a:ext>
            </a:extLst>
          </p:cNvPr>
          <p:cNvSpPr txBox="1"/>
          <p:nvPr/>
        </p:nvSpPr>
        <p:spPr>
          <a:xfrm>
            <a:off x="2194377" y="385795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e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FDADCF9-3DE2-A469-0D41-2E1D92CC4BAB}"/>
              </a:ext>
            </a:extLst>
          </p:cNvPr>
          <p:cNvSpPr txBox="1"/>
          <p:nvPr/>
        </p:nvSpPr>
        <p:spPr>
          <a:xfrm>
            <a:off x="2351471" y="408730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74B69E7-2F48-B1EC-6D7C-2D728DEDD5E7}"/>
              </a:ext>
            </a:extLst>
          </p:cNvPr>
          <p:cNvSpPr txBox="1"/>
          <p:nvPr/>
        </p:nvSpPr>
        <p:spPr>
          <a:xfrm rot="16200000">
            <a:off x="1750721" y="3525250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72ED437-FB8C-999A-46DA-2B52BC6700FB}"/>
              </a:ext>
            </a:extLst>
          </p:cNvPr>
          <p:cNvSpPr txBox="1"/>
          <p:nvPr/>
        </p:nvSpPr>
        <p:spPr>
          <a:xfrm>
            <a:off x="2552976" y="2821259"/>
            <a:ext cx="1415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7B621F9E-5E8D-92CF-C26B-A25C7AC42D9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9181" t="17711" r="29046" b="16661"/>
          <a:stretch/>
        </p:blipFill>
        <p:spPr>
          <a:xfrm>
            <a:off x="674068" y="3023711"/>
            <a:ext cx="1413453" cy="1231517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C70D60B7-FF05-C18E-E932-ADEFBD2CAC8D}"/>
              </a:ext>
            </a:extLst>
          </p:cNvPr>
          <p:cNvSpPr txBox="1"/>
          <p:nvPr/>
        </p:nvSpPr>
        <p:spPr>
          <a:xfrm>
            <a:off x="340928" y="298656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e5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8936120-4EF3-A482-D7E1-136644526119}"/>
              </a:ext>
            </a:extLst>
          </p:cNvPr>
          <p:cNvSpPr txBox="1"/>
          <p:nvPr/>
        </p:nvSpPr>
        <p:spPr>
          <a:xfrm>
            <a:off x="340928" y="326637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e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6803072-D24A-D71F-9AD7-85889D8F5CD7}"/>
              </a:ext>
            </a:extLst>
          </p:cNvPr>
          <p:cNvSpPr txBox="1"/>
          <p:nvPr/>
        </p:nvSpPr>
        <p:spPr>
          <a:xfrm>
            <a:off x="340928" y="353290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e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1137402-C207-7E96-F777-F33C2114D06E}"/>
              </a:ext>
            </a:extLst>
          </p:cNvPr>
          <p:cNvSpPr txBox="1"/>
          <p:nvPr/>
        </p:nvSpPr>
        <p:spPr>
          <a:xfrm>
            <a:off x="340928" y="380244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e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E31D2D1-26D3-F7ED-FC9F-A26C2B338181}"/>
              </a:ext>
            </a:extLst>
          </p:cNvPr>
          <p:cNvSpPr txBox="1"/>
          <p:nvPr/>
        </p:nvSpPr>
        <p:spPr>
          <a:xfrm>
            <a:off x="498022" y="409059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CBDA158-AC1B-B18C-BAC7-673D15EDF95B}"/>
              </a:ext>
            </a:extLst>
          </p:cNvPr>
          <p:cNvSpPr txBox="1"/>
          <p:nvPr/>
        </p:nvSpPr>
        <p:spPr>
          <a:xfrm>
            <a:off x="851398" y="2821259"/>
            <a:ext cx="998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FAB612C-617E-CBA2-0DF6-06231A848F7F}"/>
              </a:ext>
            </a:extLst>
          </p:cNvPr>
          <p:cNvSpPr txBox="1"/>
          <p:nvPr/>
        </p:nvSpPr>
        <p:spPr>
          <a:xfrm rot="16200000">
            <a:off x="-121476" y="3541020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BDF72904-2CC4-ECE1-2D38-9CED5832EB7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7908" t="20048" r="29001" b="16213"/>
          <a:stretch/>
        </p:blipFill>
        <p:spPr>
          <a:xfrm>
            <a:off x="4355514" y="3065488"/>
            <a:ext cx="1428801" cy="1199599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32CE2174-7533-C924-598F-29E405B4A440}"/>
              </a:ext>
            </a:extLst>
          </p:cNvPr>
          <p:cNvSpPr txBox="1"/>
          <p:nvPr/>
        </p:nvSpPr>
        <p:spPr>
          <a:xfrm>
            <a:off x="4018862" y="298252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e4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086D2AE-5DEE-B16F-734C-9F77A3314EE1}"/>
              </a:ext>
            </a:extLst>
          </p:cNvPr>
          <p:cNvSpPr txBox="1"/>
          <p:nvPr/>
        </p:nvSpPr>
        <p:spPr>
          <a:xfrm>
            <a:off x="4018862" y="325442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e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15ECF51-4CBF-45D6-71C5-B0E872E305F5}"/>
              </a:ext>
            </a:extLst>
          </p:cNvPr>
          <p:cNvSpPr txBox="1"/>
          <p:nvPr/>
        </p:nvSpPr>
        <p:spPr>
          <a:xfrm>
            <a:off x="4018862" y="353397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e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235FCC1-0203-8FA7-F3E2-B602D34CA320}"/>
              </a:ext>
            </a:extLst>
          </p:cNvPr>
          <p:cNvSpPr txBox="1"/>
          <p:nvPr/>
        </p:nvSpPr>
        <p:spPr>
          <a:xfrm>
            <a:off x="4018862" y="381080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e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428E1E7-EB2D-280A-5E00-3CD85A066B00}"/>
              </a:ext>
            </a:extLst>
          </p:cNvPr>
          <p:cNvSpPr txBox="1"/>
          <p:nvPr/>
        </p:nvSpPr>
        <p:spPr>
          <a:xfrm>
            <a:off x="4175956" y="408989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14F0E73-51CA-8251-3E2F-DA9C8E21D672}"/>
              </a:ext>
            </a:extLst>
          </p:cNvPr>
          <p:cNvSpPr txBox="1"/>
          <p:nvPr/>
        </p:nvSpPr>
        <p:spPr>
          <a:xfrm rot="16200000">
            <a:off x="3573866" y="3536686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686996D-565A-938B-2C8C-814626A8C7E3}"/>
              </a:ext>
            </a:extLst>
          </p:cNvPr>
          <p:cNvSpPr txBox="1"/>
          <p:nvPr/>
        </p:nvSpPr>
        <p:spPr>
          <a:xfrm>
            <a:off x="4094848" y="2821259"/>
            <a:ext cx="19191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03F7E028-5238-2BEA-815A-1A80915A8AA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9390" t="18494" r="30070" b="16398"/>
          <a:stretch/>
        </p:blipFill>
        <p:spPr>
          <a:xfrm>
            <a:off x="6384006" y="3039912"/>
            <a:ext cx="1379772" cy="122536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24F20E47-59CA-7C23-6639-2DDC63CEAFED}"/>
              </a:ext>
            </a:extLst>
          </p:cNvPr>
          <p:cNvSpPr txBox="1"/>
          <p:nvPr/>
        </p:nvSpPr>
        <p:spPr>
          <a:xfrm>
            <a:off x="5930321" y="2997136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0e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E20314C-AF4C-55D0-EA8A-832174D64975}"/>
              </a:ext>
            </a:extLst>
          </p:cNvPr>
          <p:cNvSpPr txBox="1"/>
          <p:nvPr/>
        </p:nvSpPr>
        <p:spPr>
          <a:xfrm>
            <a:off x="5930591" y="3266370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5e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F96C7AC-D863-75BD-FF34-E1DDA74D2890}"/>
              </a:ext>
            </a:extLst>
          </p:cNvPr>
          <p:cNvSpPr txBox="1"/>
          <p:nvPr/>
        </p:nvSpPr>
        <p:spPr>
          <a:xfrm>
            <a:off x="5930321" y="3544968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0e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680A52A-166A-BA50-CFD5-B73EA3C86A30}"/>
              </a:ext>
            </a:extLst>
          </p:cNvPr>
          <p:cNvSpPr txBox="1"/>
          <p:nvPr/>
        </p:nvSpPr>
        <p:spPr>
          <a:xfrm>
            <a:off x="5930322" y="3810564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e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B329F29-99F1-9589-CB83-E15017B1B006}"/>
              </a:ext>
            </a:extLst>
          </p:cNvPr>
          <p:cNvSpPr txBox="1"/>
          <p:nvPr/>
        </p:nvSpPr>
        <p:spPr>
          <a:xfrm>
            <a:off x="6204435" y="409151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EB1415C-1CA7-9F61-586D-CEE58B79180B}"/>
              </a:ext>
            </a:extLst>
          </p:cNvPr>
          <p:cNvSpPr txBox="1"/>
          <p:nvPr/>
        </p:nvSpPr>
        <p:spPr>
          <a:xfrm rot="16200000">
            <a:off x="5489273" y="3539788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4CDE478-48FB-6B63-FCF0-2C6616ACC02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0726" t="17393" r="30251" b="15885"/>
          <a:stretch/>
        </p:blipFill>
        <p:spPr>
          <a:xfrm>
            <a:off x="694476" y="5090551"/>
            <a:ext cx="1338899" cy="123151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87B6D4B-A799-3673-7EAE-879ABAD00EDC}"/>
              </a:ext>
            </a:extLst>
          </p:cNvPr>
          <p:cNvSpPr txBox="1"/>
          <p:nvPr/>
        </p:nvSpPr>
        <p:spPr>
          <a:xfrm>
            <a:off x="230929" y="5056601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5e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AB5D74D-DCB6-57C3-3820-029C22B4650B}"/>
              </a:ext>
            </a:extLst>
          </p:cNvPr>
          <p:cNvSpPr txBox="1"/>
          <p:nvPr/>
        </p:nvSpPr>
        <p:spPr>
          <a:xfrm>
            <a:off x="230928" y="5488379"/>
            <a:ext cx="5373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5e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51C5A8-2736-7603-D008-9F4A92BF200D}"/>
              </a:ext>
            </a:extLst>
          </p:cNvPr>
          <p:cNvSpPr txBox="1"/>
          <p:nvPr/>
        </p:nvSpPr>
        <p:spPr>
          <a:xfrm>
            <a:off x="230929" y="5702667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0e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3739CA-C392-17FB-EA22-B0DE649219B0}"/>
              </a:ext>
            </a:extLst>
          </p:cNvPr>
          <p:cNvSpPr txBox="1"/>
          <p:nvPr/>
        </p:nvSpPr>
        <p:spPr>
          <a:xfrm>
            <a:off x="230929" y="5918545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e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C7DF446-B1F4-CB2A-D341-23DA92826D74}"/>
              </a:ext>
            </a:extLst>
          </p:cNvPr>
          <p:cNvSpPr txBox="1"/>
          <p:nvPr/>
        </p:nvSpPr>
        <p:spPr>
          <a:xfrm>
            <a:off x="505042" y="6135605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4A4FA51-9775-F590-48F5-F120D1E19E3A}"/>
              </a:ext>
            </a:extLst>
          </p:cNvPr>
          <p:cNvSpPr txBox="1"/>
          <p:nvPr/>
        </p:nvSpPr>
        <p:spPr>
          <a:xfrm rot="16200000">
            <a:off x="-237030" y="5589251"/>
            <a:ext cx="8643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ularity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9BFAE3-7109-ABB0-D858-CB82CD18D961}"/>
              </a:ext>
            </a:extLst>
          </p:cNvPr>
          <p:cNvSpPr txBox="1"/>
          <p:nvPr/>
        </p:nvSpPr>
        <p:spPr>
          <a:xfrm>
            <a:off x="1026172" y="4956358"/>
            <a:ext cx="6383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8467431-7789-E53C-3930-A90B5C8D2E5C}"/>
              </a:ext>
            </a:extLst>
          </p:cNvPr>
          <p:cNvSpPr txBox="1"/>
          <p:nvPr/>
        </p:nvSpPr>
        <p:spPr>
          <a:xfrm>
            <a:off x="230929" y="5279313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0e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B7CE77-A745-937A-3437-5E67EFC67D95}"/>
              </a:ext>
            </a:extLst>
          </p:cNvPr>
          <p:cNvSpPr txBox="1"/>
          <p:nvPr/>
        </p:nvSpPr>
        <p:spPr>
          <a:xfrm>
            <a:off x="-43480" y="6784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23167A-E236-DB70-380B-6282E9CDC9C8}"/>
              </a:ext>
            </a:extLst>
          </p:cNvPr>
          <p:cNvSpPr txBox="1"/>
          <p:nvPr/>
        </p:nvSpPr>
        <p:spPr>
          <a:xfrm>
            <a:off x="-43480" y="276310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DF5BB7-D032-B9F1-568D-8AB9321AA183}"/>
              </a:ext>
            </a:extLst>
          </p:cNvPr>
          <p:cNvSpPr txBox="1"/>
          <p:nvPr/>
        </p:nvSpPr>
        <p:spPr>
          <a:xfrm>
            <a:off x="-43480" y="484892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43" name="Group 142">
            <a:extLst>
              <a:ext uri="{FF2B5EF4-FFF2-40B4-BE49-F238E27FC236}">
                <a16:creationId xmlns:a16="http://schemas.microsoft.com/office/drawing/2014/main" id="{628B6902-4078-D651-6CD2-5C83A040EBC9}"/>
              </a:ext>
            </a:extLst>
          </p:cNvPr>
          <p:cNvGrpSpPr/>
          <p:nvPr/>
        </p:nvGrpSpPr>
        <p:grpSpPr>
          <a:xfrm>
            <a:off x="743372" y="6283350"/>
            <a:ext cx="1268647" cy="690726"/>
            <a:chOff x="4862728" y="2012515"/>
            <a:chExt cx="1268647" cy="690726"/>
          </a:xfrm>
        </p:grpSpPr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EF625691-1F68-FA05-848E-208132B5C892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539583CC-DCF6-0875-C740-964407A45F7D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8F5983D-63F8-3D9B-7873-86CB42EBC333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011C7434-0ABC-0E3B-AA89-BA08DD1B1EB5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49DD1B1D-D998-B8D4-AF34-21092D39689C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363010D1-FC54-7D82-E1A5-CAAB598729B1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150" name="Group 149">
            <a:extLst>
              <a:ext uri="{FF2B5EF4-FFF2-40B4-BE49-F238E27FC236}">
                <a16:creationId xmlns:a16="http://schemas.microsoft.com/office/drawing/2014/main" id="{81C4A551-D8BA-8824-4641-E035FDEE2293}"/>
              </a:ext>
            </a:extLst>
          </p:cNvPr>
          <p:cNvGrpSpPr/>
          <p:nvPr/>
        </p:nvGrpSpPr>
        <p:grpSpPr>
          <a:xfrm>
            <a:off x="740220" y="4245319"/>
            <a:ext cx="1268647" cy="690726"/>
            <a:chOff x="4862728" y="2012515"/>
            <a:chExt cx="1268647" cy="690726"/>
          </a:xfrm>
        </p:grpSpPr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EC887E8F-966B-F69C-C688-D17A0F47684C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1F2133A6-91A3-F8A4-064C-762349C9CC08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B0ED3FDD-FEDD-EC74-B9B7-0A0C3623B9A6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BE5F571C-0C1D-D6BE-C738-3615A066C776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2011B570-529A-5F75-3AFB-F88446178F50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E482BAE9-8466-CCCE-F405-8F266C90796A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sp>
        <p:nvSpPr>
          <p:cNvPr id="157" name="TextBox 156">
            <a:extLst>
              <a:ext uri="{FF2B5EF4-FFF2-40B4-BE49-F238E27FC236}">
                <a16:creationId xmlns:a16="http://schemas.microsoft.com/office/drawing/2014/main" id="{9D31D901-1B9F-9392-C71F-F5D9BAF6C24C}"/>
              </a:ext>
            </a:extLst>
          </p:cNvPr>
          <p:cNvSpPr txBox="1"/>
          <p:nvPr/>
        </p:nvSpPr>
        <p:spPr>
          <a:xfrm>
            <a:off x="6322147" y="2821259"/>
            <a:ext cx="15023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grpSp>
        <p:nvGrpSpPr>
          <p:cNvPr id="158" name="Group 157">
            <a:extLst>
              <a:ext uri="{FF2B5EF4-FFF2-40B4-BE49-F238E27FC236}">
                <a16:creationId xmlns:a16="http://schemas.microsoft.com/office/drawing/2014/main" id="{89DB2983-C6A4-6FBA-DB55-EC40D6FE4396}"/>
              </a:ext>
            </a:extLst>
          </p:cNvPr>
          <p:cNvGrpSpPr/>
          <p:nvPr/>
        </p:nvGrpSpPr>
        <p:grpSpPr>
          <a:xfrm>
            <a:off x="2602006" y="4245319"/>
            <a:ext cx="1268647" cy="690726"/>
            <a:chOff x="4862728" y="2012515"/>
            <a:chExt cx="1268647" cy="690726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91C42A0D-B90F-45E8-888D-1D4C28AC5A6C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458CDBA5-66E8-DE9C-FA74-D355EC07718B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1D7BF88D-3C46-1BF6-FCE6-87AF540B1232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E6643B61-125C-9D5B-BD06-5F4ACFF7213C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id="{0E247CDC-FDBE-22D1-7F28-DD397383736E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16C05CD8-1B3E-E6DF-9B93-790D13D4A93B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165" name="Group 164">
            <a:extLst>
              <a:ext uri="{FF2B5EF4-FFF2-40B4-BE49-F238E27FC236}">
                <a16:creationId xmlns:a16="http://schemas.microsoft.com/office/drawing/2014/main" id="{71B602DB-6ECF-52A3-6275-E8D13E43188A}"/>
              </a:ext>
            </a:extLst>
          </p:cNvPr>
          <p:cNvGrpSpPr/>
          <p:nvPr/>
        </p:nvGrpSpPr>
        <p:grpSpPr>
          <a:xfrm>
            <a:off x="4422999" y="4246644"/>
            <a:ext cx="1268647" cy="690726"/>
            <a:chOff x="4862728" y="2012515"/>
            <a:chExt cx="1268647" cy="690726"/>
          </a:xfrm>
        </p:grpSpPr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383972C9-053D-3C3E-0362-985A64F12A6C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51A89A2A-C1B0-1B34-F40A-EFF2A5BFD61D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8928D522-807F-F81F-F501-D65158F108AE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C9F2310E-7F0D-5B4B-3C53-5C23F24D3569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79C5A4D1-C2C3-D926-FAB6-704D3B815F92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24150BD-299C-ED12-32AB-51B5A72C7331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172" name="Group 171">
            <a:extLst>
              <a:ext uri="{FF2B5EF4-FFF2-40B4-BE49-F238E27FC236}">
                <a16:creationId xmlns:a16="http://schemas.microsoft.com/office/drawing/2014/main" id="{370E5777-82B8-24A0-7A4D-71CF335F379E}"/>
              </a:ext>
            </a:extLst>
          </p:cNvPr>
          <p:cNvGrpSpPr/>
          <p:nvPr/>
        </p:nvGrpSpPr>
        <p:grpSpPr>
          <a:xfrm>
            <a:off x="6451762" y="4246644"/>
            <a:ext cx="1268647" cy="690726"/>
            <a:chOff x="4862728" y="2012515"/>
            <a:chExt cx="1268647" cy="690726"/>
          </a:xfrm>
        </p:grpSpPr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64CE0F33-3255-FFE0-896D-870F34E4B40E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73EBDF8E-531D-4A88-D7AB-C565FC512374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DA785EAA-8DDE-2A94-0DA3-1EAA2616B4FF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164235C7-5C20-84C3-41A7-16F042C5FF4D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5F9D2E85-ECA0-4958-552A-61CFB5F04F45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3DC3EA44-2909-A1A0-DCB0-40D8DD9F952C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179" name="Group 178">
            <a:extLst>
              <a:ext uri="{FF2B5EF4-FFF2-40B4-BE49-F238E27FC236}">
                <a16:creationId xmlns:a16="http://schemas.microsoft.com/office/drawing/2014/main" id="{1A0153A9-058C-66B7-E561-A4ADAEF8D5EB}"/>
              </a:ext>
            </a:extLst>
          </p:cNvPr>
          <p:cNvGrpSpPr/>
          <p:nvPr/>
        </p:nvGrpSpPr>
        <p:grpSpPr>
          <a:xfrm>
            <a:off x="735542" y="2137083"/>
            <a:ext cx="1268647" cy="690726"/>
            <a:chOff x="4862728" y="2012515"/>
            <a:chExt cx="1268647" cy="690726"/>
          </a:xfrm>
        </p:grpSpPr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9C6BD11F-18D9-773F-1276-3545E632C8A0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AA9F682A-8B62-FE45-4AC1-C839C0F9BDA3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8ACC7198-8242-F62B-5678-8559CE66DA43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87C71DE3-FF56-10F3-C7F6-66C538667A2F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id="{09664B82-BDF6-90DD-1EAF-6D49CDE39604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34D7AFA8-F36C-55B3-9E0D-7F052EE4174F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186" name="Group 185">
            <a:extLst>
              <a:ext uri="{FF2B5EF4-FFF2-40B4-BE49-F238E27FC236}">
                <a16:creationId xmlns:a16="http://schemas.microsoft.com/office/drawing/2014/main" id="{620C0EB4-98A6-42AE-9EE3-09855FF8D5C6}"/>
              </a:ext>
            </a:extLst>
          </p:cNvPr>
          <p:cNvGrpSpPr/>
          <p:nvPr/>
        </p:nvGrpSpPr>
        <p:grpSpPr>
          <a:xfrm>
            <a:off x="2597328" y="2137083"/>
            <a:ext cx="1268647" cy="690726"/>
            <a:chOff x="4862728" y="2012515"/>
            <a:chExt cx="1268647" cy="690726"/>
          </a:xfrm>
        </p:grpSpPr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18A1B17F-DC82-B273-97ED-FAA15BB09116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E9F477DE-9F84-6E01-E80C-90915E934EBF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6FAC113-930A-B89C-A0B8-C2530CE95395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3E485377-1842-CB72-EAE0-09B1E945DFC2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BAA3780C-A7CC-511A-929C-BDC05B21B12E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C1A7ED49-D158-E64D-5D1F-2B1CB37D217E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193" name="Group 192">
            <a:extLst>
              <a:ext uri="{FF2B5EF4-FFF2-40B4-BE49-F238E27FC236}">
                <a16:creationId xmlns:a16="http://schemas.microsoft.com/office/drawing/2014/main" id="{E5730273-EED5-AAF2-4356-E583BF9BAED5}"/>
              </a:ext>
            </a:extLst>
          </p:cNvPr>
          <p:cNvGrpSpPr/>
          <p:nvPr/>
        </p:nvGrpSpPr>
        <p:grpSpPr>
          <a:xfrm>
            <a:off x="4418321" y="2138408"/>
            <a:ext cx="1268647" cy="690726"/>
            <a:chOff x="4862728" y="2012515"/>
            <a:chExt cx="1268647" cy="690726"/>
          </a:xfrm>
        </p:grpSpPr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7E9BE197-A4DB-A0FD-C0E8-EEF6397522F7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7976FC49-1C91-E4AE-1EE9-0DE62D1CE9F2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731D4BA5-CB73-339C-AC99-2EC699E66EEE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8A61D34F-5786-4E28-08F5-1D86072D4CFF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03F67BB1-00E5-6163-38D6-935EA4DAF776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368CAB49-B497-84CC-1D39-D836B9FC0FE8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grpSp>
        <p:nvGrpSpPr>
          <p:cNvPr id="200" name="Group 199">
            <a:extLst>
              <a:ext uri="{FF2B5EF4-FFF2-40B4-BE49-F238E27FC236}">
                <a16:creationId xmlns:a16="http://schemas.microsoft.com/office/drawing/2014/main" id="{CB0AB98E-E975-D380-4DE6-4A3B5B3D3B56}"/>
              </a:ext>
            </a:extLst>
          </p:cNvPr>
          <p:cNvGrpSpPr/>
          <p:nvPr/>
        </p:nvGrpSpPr>
        <p:grpSpPr>
          <a:xfrm>
            <a:off x="6447084" y="2138408"/>
            <a:ext cx="1268647" cy="690726"/>
            <a:chOff x="4862728" y="2012515"/>
            <a:chExt cx="1268647" cy="690726"/>
          </a:xfrm>
        </p:grpSpPr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81713AB3-D8CB-5346-63D9-4BBD78EF8E21}"/>
                </a:ext>
              </a:extLst>
            </p:cNvPr>
            <p:cNvSpPr txBox="1"/>
            <p:nvPr/>
          </p:nvSpPr>
          <p:spPr>
            <a:xfrm rot="19703585">
              <a:off x="4862728" y="2012515"/>
              <a:ext cx="469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A793EE33-173B-26AF-6708-45DB69105917}"/>
                </a:ext>
              </a:extLst>
            </p:cNvPr>
            <p:cNvSpPr txBox="1"/>
            <p:nvPr/>
          </p:nvSpPr>
          <p:spPr>
            <a:xfrm rot="19703585">
              <a:off x="5138453" y="2012515"/>
              <a:ext cx="4803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619A1526-2561-E7C0-912E-2A6AEE082E9A}"/>
                </a:ext>
              </a:extLst>
            </p:cNvPr>
            <p:cNvSpPr txBox="1"/>
            <p:nvPr/>
          </p:nvSpPr>
          <p:spPr>
            <a:xfrm rot="19703585">
              <a:off x="5467018" y="2012515"/>
              <a:ext cx="4003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C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C2FDE2EE-B000-1683-9877-71499C27819E}"/>
                </a:ext>
              </a:extLst>
            </p:cNvPr>
            <p:cNvSpPr txBox="1"/>
            <p:nvPr/>
          </p:nvSpPr>
          <p:spPr>
            <a:xfrm rot="19703585">
              <a:off x="5758862" y="2012515"/>
              <a:ext cx="3725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V</a:t>
              </a:r>
            </a:p>
          </p:txBody>
        </p:sp>
        <p:cxnSp>
          <p:nvCxnSpPr>
            <p:cNvPr id="205" name="Straight Connector 204">
              <a:extLst>
                <a:ext uri="{FF2B5EF4-FFF2-40B4-BE49-F238E27FC236}">
                  <a16:creationId xmlns:a16="http://schemas.microsoft.com/office/drawing/2014/main" id="{B0EC6570-66A7-1554-DC05-FC8870E14766}"/>
                </a:ext>
              </a:extLst>
            </p:cNvPr>
            <p:cNvCxnSpPr>
              <a:cxnSpLocks/>
            </p:cNvCxnSpPr>
            <p:nvPr/>
          </p:nvCxnSpPr>
          <p:spPr>
            <a:xfrm>
              <a:off x="5293014" y="2293316"/>
              <a:ext cx="7194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896CEC19-137C-13B2-926A-9FD920AB17A4}"/>
                </a:ext>
              </a:extLst>
            </p:cNvPr>
            <p:cNvSpPr txBox="1"/>
            <p:nvPr/>
          </p:nvSpPr>
          <p:spPr>
            <a:xfrm>
              <a:off x="5306712" y="2272354"/>
              <a:ext cx="68392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 S Protein</a:t>
              </a:r>
            </a:p>
          </p:txBody>
        </p:sp>
      </p:grpSp>
      <p:sp>
        <p:nvSpPr>
          <p:cNvPr id="207" name="TextBox 206">
            <a:extLst>
              <a:ext uri="{FF2B5EF4-FFF2-40B4-BE49-F238E27FC236}">
                <a16:creationId xmlns:a16="http://schemas.microsoft.com/office/drawing/2014/main" id="{1499798D-7916-DF27-0694-D86E8F90A681}"/>
              </a:ext>
            </a:extLst>
          </p:cNvPr>
          <p:cNvSpPr txBox="1"/>
          <p:nvPr/>
        </p:nvSpPr>
        <p:spPr>
          <a:xfrm>
            <a:off x="69867" y="7223743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5111425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8" name="Group 197">
            <a:extLst>
              <a:ext uri="{FF2B5EF4-FFF2-40B4-BE49-F238E27FC236}">
                <a16:creationId xmlns:a16="http://schemas.microsoft.com/office/drawing/2014/main" id="{FE080AD1-D1F1-631B-4052-07339061B239}"/>
              </a:ext>
            </a:extLst>
          </p:cNvPr>
          <p:cNvGrpSpPr/>
          <p:nvPr/>
        </p:nvGrpSpPr>
        <p:grpSpPr>
          <a:xfrm>
            <a:off x="8140" y="19207"/>
            <a:ext cx="7764895" cy="5639018"/>
            <a:chOff x="-24648" y="1636294"/>
            <a:chExt cx="7764895" cy="5639018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617CCDE-9970-CF51-FAE7-55A5500602F7}"/>
                </a:ext>
              </a:extLst>
            </p:cNvPr>
            <p:cNvSpPr txBox="1"/>
            <p:nvPr/>
          </p:nvSpPr>
          <p:spPr>
            <a:xfrm>
              <a:off x="152753" y="2591944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DE7F4BE-8E56-314D-A838-F61F9B9E6E57}"/>
                </a:ext>
              </a:extLst>
            </p:cNvPr>
            <p:cNvSpPr txBox="1"/>
            <p:nvPr/>
          </p:nvSpPr>
          <p:spPr>
            <a:xfrm>
              <a:off x="152753" y="2819065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92BC402-0AB6-3D00-7DC1-25A0BE2C0A32}"/>
                </a:ext>
              </a:extLst>
            </p:cNvPr>
            <p:cNvSpPr txBox="1"/>
            <p:nvPr/>
          </p:nvSpPr>
          <p:spPr>
            <a:xfrm>
              <a:off x="426866" y="304877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5BB9E70-E70C-5358-ABB9-DF6C7C314D7C}"/>
                </a:ext>
              </a:extLst>
            </p:cNvPr>
            <p:cNvSpPr txBox="1"/>
            <p:nvPr/>
          </p:nvSpPr>
          <p:spPr>
            <a:xfrm rot="16200000">
              <a:off x="-295746" y="2591517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9ABABB0-971E-444E-069D-0C23A866B561}"/>
                </a:ext>
              </a:extLst>
            </p:cNvPr>
            <p:cNvSpPr txBox="1"/>
            <p:nvPr/>
          </p:nvSpPr>
          <p:spPr>
            <a:xfrm>
              <a:off x="152753" y="2137067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0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9BE4558-A92C-5D44-919F-45FB890929B5}"/>
                </a:ext>
              </a:extLst>
            </p:cNvPr>
            <p:cNvSpPr txBox="1"/>
            <p:nvPr/>
          </p:nvSpPr>
          <p:spPr>
            <a:xfrm>
              <a:off x="152753" y="2362796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957431B-5726-0490-12E4-B7EFAA4E7B4A}"/>
                </a:ext>
              </a:extLst>
            </p:cNvPr>
            <p:cNvSpPr txBox="1"/>
            <p:nvPr/>
          </p:nvSpPr>
          <p:spPr>
            <a:xfrm>
              <a:off x="975823" y="1706083"/>
              <a:ext cx="622286" cy="4739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D1B9366-F9CB-1CFA-F041-E7563D89091B}"/>
                </a:ext>
              </a:extLst>
            </p:cNvPr>
            <p:cNvSpPr txBox="1"/>
            <p:nvPr/>
          </p:nvSpPr>
          <p:spPr>
            <a:xfrm>
              <a:off x="2049537" y="2422693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640885D-C03C-2536-C067-B6A6386AB9CB}"/>
                </a:ext>
              </a:extLst>
            </p:cNvPr>
            <p:cNvSpPr txBox="1"/>
            <p:nvPr/>
          </p:nvSpPr>
          <p:spPr>
            <a:xfrm>
              <a:off x="2049537" y="2735277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5541F4A-D27A-D70F-49F3-E1DCD7003B94}"/>
                </a:ext>
              </a:extLst>
            </p:cNvPr>
            <p:cNvSpPr txBox="1"/>
            <p:nvPr/>
          </p:nvSpPr>
          <p:spPr>
            <a:xfrm>
              <a:off x="2323650" y="304970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3629C66-812D-0D66-57F8-8559D2D5E866}"/>
                </a:ext>
              </a:extLst>
            </p:cNvPr>
            <p:cNvSpPr txBox="1"/>
            <p:nvPr/>
          </p:nvSpPr>
          <p:spPr>
            <a:xfrm rot="16200000">
              <a:off x="1613438" y="2574518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CFB5AA1-264E-4D0E-F7FD-41272BA3FAC4}"/>
                </a:ext>
              </a:extLst>
            </p:cNvPr>
            <p:cNvSpPr txBox="1"/>
            <p:nvPr/>
          </p:nvSpPr>
          <p:spPr>
            <a:xfrm>
              <a:off x="2049537" y="2109440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C3E7D76-CA6C-F5C9-3386-C54CEE2537E9}"/>
                </a:ext>
              </a:extLst>
            </p:cNvPr>
            <p:cNvSpPr txBox="1"/>
            <p:nvPr/>
          </p:nvSpPr>
          <p:spPr>
            <a:xfrm>
              <a:off x="2706989" y="1706083"/>
              <a:ext cx="939681" cy="4739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2A57028-1B2F-5CBE-C6DE-A8F282EBDDDC}"/>
                </a:ext>
              </a:extLst>
            </p:cNvPr>
            <p:cNvSpPr txBox="1"/>
            <p:nvPr/>
          </p:nvSpPr>
          <p:spPr>
            <a:xfrm>
              <a:off x="3919504" y="2431845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B706BC8-C93F-F12A-9F86-3F41B8964131}"/>
                </a:ext>
              </a:extLst>
            </p:cNvPr>
            <p:cNvSpPr txBox="1"/>
            <p:nvPr/>
          </p:nvSpPr>
          <p:spPr>
            <a:xfrm>
              <a:off x="3919504" y="2736704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FD071F8-FFDC-382C-ED4D-A7F1C158BA1D}"/>
                </a:ext>
              </a:extLst>
            </p:cNvPr>
            <p:cNvSpPr txBox="1"/>
            <p:nvPr/>
          </p:nvSpPr>
          <p:spPr>
            <a:xfrm>
              <a:off x="4193617" y="306359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A98B11A-A7AD-0EBD-95F8-9C4254D0011F}"/>
                </a:ext>
              </a:extLst>
            </p:cNvPr>
            <p:cNvSpPr txBox="1"/>
            <p:nvPr/>
          </p:nvSpPr>
          <p:spPr>
            <a:xfrm rot="16200000">
              <a:off x="3502381" y="2572874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B56E4AC-BA16-E787-AA80-254E3EBC5E86}"/>
                </a:ext>
              </a:extLst>
            </p:cNvPr>
            <p:cNvSpPr txBox="1"/>
            <p:nvPr/>
          </p:nvSpPr>
          <p:spPr>
            <a:xfrm>
              <a:off x="3919504" y="2113273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A725A5C-A98F-948D-E54F-A88A5DEC83F6}"/>
                </a:ext>
              </a:extLst>
            </p:cNvPr>
            <p:cNvSpPr txBox="1"/>
            <p:nvPr/>
          </p:nvSpPr>
          <p:spPr>
            <a:xfrm>
              <a:off x="4347032" y="1706083"/>
              <a:ext cx="1443024" cy="4739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26DF801-D7CB-EC66-6704-7899777AFA82}"/>
                </a:ext>
              </a:extLst>
            </p:cNvPr>
            <p:cNvSpPr txBox="1"/>
            <p:nvPr/>
          </p:nvSpPr>
          <p:spPr>
            <a:xfrm>
              <a:off x="5816553" y="2437263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42A45C1-7C45-2F75-4ABE-80D5ABCE7FC9}"/>
                </a:ext>
              </a:extLst>
            </p:cNvPr>
            <p:cNvSpPr txBox="1"/>
            <p:nvPr/>
          </p:nvSpPr>
          <p:spPr>
            <a:xfrm>
              <a:off x="5816553" y="2728845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4486EB9-5AB5-2097-EEC5-22BC4D355159}"/>
                </a:ext>
              </a:extLst>
            </p:cNvPr>
            <p:cNvSpPr txBox="1"/>
            <p:nvPr/>
          </p:nvSpPr>
          <p:spPr>
            <a:xfrm>
              <a:off x="6090666" y="303913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A44828B-34A7-7848-699D-EB9E25881D8C}"/>
                </a:ext>
              </a:extLst>
            </p:cNvPr>
            <p:cNvSpPr txBox="1"/>
            <p:nvPr/>
          </p:nvSpPr>
          <p:spPr>
            <a:xfrm>
              <a:off x="5816553" y="2133000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40B3A53-857C-DF1C-6C8F-9BCD5DFEB9A2}"/>
                </a:ext>
              </a:extLst>
            </p:cNvPr>
            <p:cNvSpPr txBox="1"/>
            <p:nvPr/>
          </p:nvSpPr>
          <p:spPr>
            <a:xfrm rot="16200000">
              <a:off x="5364692" y="2585639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A5756A9-A1A7-9A9B-3257-EFADFFEE28C9}"/>
                </a:ext>
              </a:extLst>
            </p:cNvPr>
            <p:cNvSpPr txBox="1"/>
            <p:nvPr/>
          </p:nvSpPr>
          <p:spPr>
            <a:xfrm>
              <a:off x="6431252" y="1706083"/>
              <a:ext cx="1026243" cy="4739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84C4CE5-E738-D901-7DF2-832758B3E4D3}"/>
                </a:ext>
              </a:extLst>
            </p:cNvPr>
            <p:cNvSpPr txBox="1"/>
            <p:nvPr/>
          </p:nvSpPr>
          <p:spPr>
            <a:xfrm>
              <a:off x="237319" y="456007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e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12897B97-68E4-5F40-DB76-36F8E02652E2}"/>
                </a:ext>
              </a:extLst>
            </p:cNvPr>
            <p:cNvSpPr txBox="1"/>
            <p:nvPr/>
          </p:nvSpPr>
          <p:spPr>
            <a:xfrm>
              <a:off x="394413" y="486642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479CB5E-9DBB-EE58-A219-B9F4295F3DB4}"/>
                </a:ext>
              </a:extLst>
            </p:cNvPr>
            <p:cNvSpPr txBox="1"/>
            <p:nvPr/>
          </p:nvSpPr>
          <p:spPr>
            <a:xfrm rot="16200000">
              <a:off x="-226576" y="4405576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C82F00D-6302-59EC-FC0B-2400CD748E2E}"/>
                </a:ext>
              </a:extLst>
            </p:cNvPr>
            <p:cNvSpPr txBox="1"/>
            <p:nvPr/>
          </p:nvSpPr>
          <p:spPr>
            <a:xfrm>
              <a:off x="237319" y="3952434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e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CD69ECF-E83C-F57E-96D9-1B7AE467393F}"/>
                </a:ext>
              </a:extLst>
            </p:cNvPr>
            <p:cNvSpPr txBox="1"/>
            <p:nvPr/>
          </p:nvSpPr>
          <p:spPr>
            <a:xfrm>
              <a:off x="237319" y="4255461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e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68071E6-A00C-9012-35B9-BC9662FC5A32}"/>
                </a:ext>
              </a:extLst>
            </p:cNvPr>
            <p:cNvSpPr txBox="1"/>
            <p:nvPr/>
          </p:nvSpPr>
          <p:spPr>
            <a:xfrm>
              <a:off x="955420" y="3757844"/>
              <a:ext cx="622286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2E31E82-B209-4580-FD0D-D2F436411360}"/>
                </a:ext>
              </a:extLst>
            </p:cNvPr>
            <p:cNvSpPr txBox="1"/>
            <p:nvPr/>
          </p:nvSpPr>
          <p:spPr>
            <a:xfrm>
              <a:off x="2105071" y="463138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e4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54785EA-39CD-F2FF-B094-858313F1A84A}"/>
                </a:ext>
              </a:extLst>
            </p:cNvPr>
            <p:cNvSpPr txBox="1"/>
            <p:nvPr/>
          </p:nvSpPr>
          <p:spPr>
            <a:xfrm>
              <a:off x="2262165" y="486642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7DD642F-D08C-C806-4480-48DC352640E1}"/>
                </a:ext>
              </a:extLst>
            </p:cNvPr>
            <p:cNvSpPr txBox="1"/>
            <p:nvPr/>
          </p:nvSpPr>
          <p:spPr>
            <a:xfrm>
              <a:off x="2105071" y="416533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e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E6970BB-295B-6E74-E146-F5094FEC6920}"/>
                </a:ext>
              </a:extLst>
            </p:cNvPr>
            <p:cNvSpPr txBox="1"/>
            <p:nvPr/>
          </p:nvSpPr>
          <p:spPr>
            <a:xfrm>
              <a:off x="2105071" y="4395411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e4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AD8D053-5FC8-EB3A-2F09-DD4200D97A7D}"/>
                </a:ext>
              </a:extLst>
            </p:cNvPr>
            <p:cNvSpPr txBox="1"/>
            <p:nvPr/>
          </p:nvSpPr>
          <p:spPr>
            <a:xfrm>
              <a:off x="2105071" y="3929937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e4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A683891-A862-E35D-6300-CD1D61C4B6F6}"/>
                </a:ext>
              </a:extLst>
            </p:cNvPr>
            <p:cNvSpPr txBox="1"/>
            <p:nvPr/>
          </p:nvSpPr>
          <p:spPr>
            <a:xfrm rot="16200000">
              <a:off x="1644896" y="4395796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FB13C0F-23FB-7AA2-4CCD-3F0CB5D80701}"/>
                </a:ext>
              </a:extLst>
            </p:cNvPr>
            <p:cNvSpPr txBox="1"/>
            <p:nvPr/>
          </p:nvSpPr>
          <p:spPr>
            <a:xfrm>
              <a:off x="2664403" y="3757844"/>
              <a:ext cx="93968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E37A9BD-9D14-8837-00E4-C4573504598E}"/>
                </a:ext>
              </a:extLst>
            </p:cNvPr>
            <p:cNvSpPr txBox="1"/>
            <p:nvPr/>
          </p:nvSpPr>
          <p:spPr>
            <a:xfrm>
              <a:off x="3910150" y="4249655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3F8F3A1-C254-4456-4EF9-6255C9EDC3B3}"/>
                </a:ext>
              </a:extLst>
            </p:cNvPr>
            <p:cNvSpPr txBox="1"/>
            <p:nvPr/>
          </p:nvSpPr>
          <p:spPr>
            <a:xfrm>
              <a:off x="3910150" y="4563960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4673242-4FF3-7C62-B179-FC033C394696}"/>
                </a:ext>
              </a:extLst>
            </p:cNvPr>
            <p:cNvSpPr txBox="1"/>
            <p:nvPr/>
          </p:nvSpPr>
          <p:spPr>
            <a:xfrm>
              <a:off x="4184263" y="487706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03135F5-9B32-DAD8-F1AA-B0668FA30CD0}"/>
                </a:ext>
              </a:extLst>
            </p:cNvPr>
            <p:cNvSpPr txBox="1"/>
            <p:nvPr/>
          </p:nvSpPr>
          <p:spPr>
            <a:xfrm rot="16200000">
              <a:off x="3476467" y="4401455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DD78112-9C43-EBDC-49E1-77D78CF90A52}"/>
                </a:ext>
              </a:extLst>
            </p:cNvPr>
            <p:cNvSpPr txBox="1"/>
            <p:nvPr/>
          </p:nvSpPr>
          <p:spPr>
            <a:xfrm>
              <a:off x="3910150" y="3936955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e5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9C01C06-8EBB-EEBD-4A15-F51F03017925}"/>
                </a:ext>
              </a:extLst>
            </p:cNvPr>
            <p:cNvSpPr txBox="1"/>
            <p:nvPr/>
          </p:nvSpPr>
          <p:spPr>
            <a:xfrm>
              <a:off x="4328978" y="3757844"/>
              <a:ext cx="144302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808E0EF-0BB3-68C6-CF6A-CFD83FA8BB76}"/>
                </a:ext>
              </a:extLst>
            </p:cNvPr>
            <p:cNvSpPr txBox="1"/>
            <p:nvPr/>
          </p:nvSpPr>
          <p:spPr>
            <a:xfrm>
              <a:off x="5923329" y="4635775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e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EB16292-A912-5D24-A8EB-6073D59DEFB4}"/>
                </a:ext>
              </a:extLst>
            </p:cNvPr>
            <p:cNvSpPr txBox="1"/>
            <p:nvPr/>
          </p:nvSpPr>
          <p:spPr>
            <a:xfrm>
              <a:off x="6080423" y="486415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EAB5EA1-71BD-D7C9-5550-24C9D7E13052}"/>
                </a:ext>
              </a:extLst>
            </p:cNvPr>
            <p:cNvSpPr txBox="1"/>
            <p:nvPr/>
          </p:nvSpPr>
          <p:spPr>
            <a:xfrm>
              <a:off x="5923329" y="417836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e5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E63BAFA-5739-1648-5C5F-A48E65825BC9}"/>
                </a:ext>
              </a:extLst>
            </p:cNvPr>
            <p:cNvSpPr txBox="1"/>
            <p:nvPr/>
          </p:nvSpPr>
          <p:spPr>
            <a:xfrm>
              <a:off x="5923329" y="440456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e5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3865E80-C3B6-DF30-CD09-36E0F7611B45}"/>
                </a:ext>
              </a:extLst>
            </p:cNvPr>
            <p:cNvSpPr txBox="1"/>
            <p:nvPr/>
          </p:nvSpPr>
          <p:spPr>
            <a:xfrm>
              <a:off x="5923329" y="394764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e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887DB17-8039-E87E-BFDC-7123E9500B43}"/>
                </a:ext>
              </a:extLst>
            </p:cNvPr>
            <p:cNvSpPr txBox="1"/>
            <p:nvPr/>
          </p:nvSpPr>
          <p:spPr>
            <a:xfrm rot="16200000">
              <a:off x="5455977" y="4412493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684A6EA-ED72-6339-34F5-6AB1DE5F6FCB}"/>
                </a:ext>
              </a:extLst>
            </p:cNvPr>
            <p:cNvSpPr txBox="1"/>
            <p:nvPr/>
          </p:nvSpPr>
          <p:spPr>
            <a:xfrm>
              <a:off x="6438709" y="3757844"/>
              <a:ext cx="102624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C9E149C-7D1E-2700-BA26-213A1DC75496}"/>
                </a:ext>
              </a:extLst>
            </p:cNvPr>
            <p:cNvSpPr txBox="1"/>
            <p:nvPr/>
          </p:nvSpPr>
          <p:spPr>
            <a:xfrm>
              <a:off x="-24648" y="1636294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54F5A94-F954-3C92-F1FB-E72574EF76F3}"/>
                </a:ext>
              </a:extLst>
            </p:cNvPr>
            <p:cNvSpPr txBox="1"/>
            <p:nvPr/>
          </p:nvSpPr>
          <p:spPr>
            <a:xfrm>
              <a:off x="-24648" y="366873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6A7D2B9-7295-77E2-8B52-5D05A557AF6E}"/>
                </a:ext>
              </a:extLst>
            </p:cNvPr>
            <p:cNvSpPr txBox="1"/>
            <p:nvPr/>
          </p:nvSpPr>
          <p:spPr>
            <a:xfrm>
              <a:off x="-24648" y="542689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E31386D8-9840-D2E3-5F66-EE0501A5A0C3}"/>
                </a:ext>
              </a:extLst>
            </p:cNvPr>
            <p:cNvSpPr txBox="1"/>
            <p:nvPr/>
          </p:nvSpPr>
          <p:spPr>
            <a:xfrm>
              <a:off x="258725" y="6029620"/>
              <a:ext cx="42030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E0A22670-43F2-893B-9710-15BAE062EE0A}"/>
                </a:ext>
              </a:extLst>
            </p:cNvPr>
            <p:cNvSpPr txBox="1"/>
            <p:nvPr/>
          </p:nvSpPr>
          <p:spPr>
            <a:xfrm>
              <a:off x="258725" y="6330657"/>
              <a:ext cx="42030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9A79F8F3-FE1D-28CF-9241-822936820A24}"/>
                </a:ext>
              </a:extLst>
            </p:cNvPr>
            <p:cNvSpPr txBox="1"/>
            <p:nvPr/>
          </p:nvSpPr>
          <p:spPr>
            <a:xfrm>
              <a:off x="411814" y="66229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5855E5A6-3FFB-4B4F-8577-BB46368C33A1}"/>
                </a:ext>
              </a:extLst>
            </p:cNvPr>
            <p:cNvSpPr txBox="1"/>
            <p:nvPr/>
          </p:nvSpPr>
          <p:spPr>
            <a:xfrm rot="16200000">
              <a:off x="-216594" y="6180133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ity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D2DE0E83-BB38-DC1E-81FE-A5E85AF9BE7A}"/>
                </a:ext>
              </a:extLst>
            </p:cNvPr>
            <p:cNvSpPr txBox="1"/>
            <p:nvPr/>
          </p:nvSpPr>
          <p:spPr>
            <a:xfrm>
              <a:off x="258725" y="5740998"/>
              <a:ext cx="42030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e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D6B2E256-CCFC-F24F-DD14-21D08691CAE1}"/>
                </a:ext>
              </a:extLst>
            </p:cNvPr>
            <p:cNvSpPr txBox="1"/>
            <p:nvPr/>
          </p:nvSpPr>
          <p:spPr>
            <a:xfrm>
              <a:off x="912892" y="5558909"/>
              <a:ext cx="6623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 Cells</a:t>
              </a:r>
            </a:p>
          </p:txBody>
        </p:sp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03971CA3-B9F7-0FFC-C83D-E81C221B3D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100" t="17210" r="14526" b="21508"/>
            <a:stretch/>
          </p:blipFill>
          <p:spPr>
            <a:xfrm>
              <a:off x="600970" y="5821212"/>
              <a:ext cx="1338826" cy="968616"/>
            </a:xfrm>
            <a:prstGeom prst="rect">
              <a:avLst/>
            </a:prstGeom>
          </p:spPr>
        </p:pic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936D5583-2E50-E68B-F3D6-CB4164EAF2D8}"/>
                </a:ext>
              </a:extLst>
            </p:cNvPr>
            <p:cNvSpPr/>
            <p:nvPr/>
          </p:nvSpPr>
          <p:spPr>
            <a:xfrm>
              <a:off x="787521" y="5837037"/>
              <a:ext cx="724013" cy="1732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43F72A74-6F83-67E0-6FD9-E8E026241CE9}"/>
                </a:ext>
              </a:extLst>
            </p:cNvPr>
            <p:cNvSpPr/>
            <p:nvPr/>
          </p:nvSpPr>
          <p:spPr>
            <a:xfrm>
              <a:off x="748294" y="5977376"/>
              <a:ext cx="186477" cy="4787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82CD7E31-07EE-253C-DFDC-FC3F7058FC49}"/>
                </a:ext>
              </a:extLst>
            </p:cNvPr>
            <p:cNvSpPr txBox="1"/>
            <p:nvPr/>
          </p:nvSpPr>
          <p:spPr>
            <a:xfrm>
              <a:off x="1058445" y="5825302"/>
              <a:ext cx="1183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4B4CF72E-4F87-4EF8-31CE-7A31AC79B9A1}"/>
                </a:ext>
              </a:extLst>
            </p:cNvPr>
            <p:cNvCxnSpPr>
              <a:cxnSpLocks/>
            </p:cNvCxnSpPr>
            <p:nvPr/>
          </p:nvCxnSpPr>
          <p:spPr>
            <a:xfrm>
              <a:off x="829777" y="5971591"/>
              <a:ext cx="57566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C74A62CD-6105-C85B-ED18-D5843F75C0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5067" t="17616" r="25062" b="20913"/>
            <a:stretch/>
          </p:blipFill>
          <p:spPr>
            <a:xfrm>
              <a:off x="4368715" y="2204491"/>
              <a:ext cx="1421956" cy="1021825"/>
            </a:xfrm>
            <a:prstGeom prst="rect">
              <a:avLst/>
            </a:prstGeom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ABB6D659-0967-FB7D-A3D7-0F7A0DD692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344" t="17355" r="21457" b="21122"/>
            <a:stretch/>
          </p:blipFill>
          <p:spPr>
            <a:xfrm>
              <a:off x="6266774" y="2218010"/>
              <a:ext cx="1353503" cy="991360"/>
            </a:xfrm>
            <a:prstGeom prst="rect">
              <a:avLst/>
            </a:prstGeom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B0206D66-FD2B-C9C0-35C3-8CDB74F051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6385" t="17400" r="19885" b="20817"/>
            <a:stretch/>
          </p:blipFill>
          <p:spPr>
            <a:xfrm>
              <a:off x="2497880" y="2195114"/>
              <a:ext cx="1401507" cy="1035729"/>
            </a:xfrm>
            <a:prstGeom prst="rect">
              <a:avLst/>
            </a:prstGeom>
          </p:spPr>
        </p:pic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93EBC824-1915-AFDA-7E05-3EDEBDD643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9498" t="17433" r="14664" b="21342"/>
            <a:stretch/>
          </p:blipFill>
          <p:spPr>
            <a:xfrm>
              <a:off x="606381" y="2221257"/>
              <a:ext cx="1388861" cy="996939"/>
            </a:xfrm>
            <a:prstGeom prst="rect">
              <a:avLst/>
            </a:prstGeom>
          </p:spPr>
        </p:pic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806498D2-95F5-ACF4-D1C0-6003F5AE3B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8433" t="17192" r="16100" b="21552"/>
            <a:stretch/>
          </p:blipFill>
          <p:spPr>
            <a:xfrm>
              <a:off x="582366" y="4030204"/>
              <a:ext cx="1342354" cy="1002182"/>
            </a:xfrm>
            <a:prstGeom prst="rect">
              <a:avLst/>
            </a:prstGeom>
          </p:spPr>
        </p:pic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3785B3B9-2275-ED1A-AB9C-0D7B65B8A9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5060" t="17328" r="21324" b="20806"/>
            <a:stretch/>
          </p:blipFill>
          <p:spPr>
            <a:xfrm>
              <a:off x="2444493" y="4012792"/>
              <a:ext cx="1356261" cy="1028170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5A6D8A7A-14D0-0335-1CD4-01F3A556C2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4507" t="17994" r="26555" b="21217"/>
            <a:stretch/>
          </p:blipFill>
          <p:spPr>
            <a:xfrm>
              <a:off x="4355146" y="4034726"/>
              <a:ext cx="1371793" cy="1008827"/>
            </a:xfrm>
            <a:prstGeom prst="rect">
              <a:avLst/>
            </a:prstGeom>
          </p:spPr>
        </p:pic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C1E4BD2D-F9E1-142F-C440-342D96DF35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6531" t="16105" r="21124" b="21051"/>
            <a:stretch/>
          </p:blipFill>
          <p:spPr>
            <a:xfrm>
              <a:off x="6267805" y="4014070"/>
              <a:ext cx="1403330" cy="1018315"/>
            </a:xfrm>
            <a:prstGeom prst="rect">
              <a:avLst/>
            </a:prstGeom>
          </p:spPr>
        </p:pic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11BA3B2E-22CF-DA7B-EFFC-3C2700C4B20C}"/>
                </a:ext>
              </a:extLst>
            </p:cNvPr>
            <p:cNvSpPr/>
            <p:nvPr/>
          </p:nvSpPr>
          <p:spPr>
            <a:xfrm>
              <a:off x="806269" y="2272680"/>
              <a:ext cx="724013" cy="1068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40F8BA9D-0FE8-267E-0759-6059A143C96C}"/>
                </a:ext>
              </a:extLst>
            </p:cNvPr>
            <p:cNvSpPr/>
            <p:nvPr/>
          </p:nvSpPr>
          <p:spPr>
            <a:xfrm>
              <a:off x="767042" y="2339328"/>
              <a:ext cx="186477" cy="4787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69C6170E-7E06-3D81-DAAD-87271D827BBB}"/>
                </a:ext>
              </a:extLst>
            </p:cNvPr>
            <p:cNvSpPr txBox="1"/>
            <p:nvPr/>
          </p:nvSpPr>
          <p:spPr>
            <a:xfrm>
              <a:off x="1099680" y="2175319"/>
              <a:ext cx="1183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FEFA1C5A-2695-7E8E-214F-00369D21B8BB}"/>
                </a:ext>
              </a:extLst>
            </p:cNvPr>
            <p:cNvCxnSpPr>
              <a:cxnSpLocks/>
            </p:cNvCxnSpPr>
            <p:nvPr/>
          </p:nvCxnSpPr>
          <p:spPr>
            <a:xfrm>
              <a:off x="858164" y="2340821"/>
              <a:ext cx="57566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0E9C7F1B-9A74-71D1-96CF-0B8E4D6ED0E6}"/>
                </a:ext>
              </a:extLst>
            </p:cNvPr>
            <p:cNvSpPr/>
            <p:nvPr/>
          </p:nvSpPr>
          <p:spPr>
            <a:xfrm>
              <a:off x="1400589" y="2355554"/>
              <a:ext cx="130823" cy="2120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8EEDDEB4-0375-E508-7A79-CECFAAE5E683}"/>
                </a:ext>
              </a:extLst>
            </p:cNvPr>
            <p:cNvGrpSpPr/>
            <p:nvPr/>
          </p:nvGrpSpPr>
          <p:grpSpPr>
            <a:xfrm>
              <a:off x="600980" y="6776761"/>
              <a:ext cx="1408756" cy="498551"/>
              <a:chOff x="2498250" y="4592056"/>
              <a:chExt cx="1408756" cy="498551"/>
            </a:xfrm>
          </p:grpSpPr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93D853A6-E25D-534C-44E0-F527C52A42DD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AFD96B0C-4065-B176-9C02-085C51DB439B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A62FE8D0-A53F-FF48-E43B-43E4B62D6B16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96F3AB89-0118-D4DE-7852-37B29CD692E0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A4B525B5-B41F-B8DC-19FE-D8A1DF02EDB5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id="{89704B4F-20B2-3555-4C25-875798C539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D5997D7B-4F70-E979-3B4A-073FEB4C87BE}"/>
                </a:ext>
              </a:extLst>
            </p:cNvPr>
            <p:cNvGrpSpPr/>
            <p:nvPr/>
          </p:nvGrpSpPr>
          <p:grpSpPr>
            <a:xfrm>
              <a:off x="623993" y="5012132"/>
              <a:ext cx="1408756" cy="498551"/>
              <a:chOff x="2498250" y="4592056"/>
              <a:chExt cx="1408756" cy="498551"/>
            </a:xfrm>
          </p:grpSpPr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A92A3C02-9623-9185-2073-283188934E60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BE43E53F-855D-C3E6-D9D8-C6184CCB00BC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645CE911-8DA3-8489-3831-0FB3FB75EA61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DEC5F39E-7D7B-B05B-2B72-A6DABF2167C6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FE517A23-49EA-C365-F5CF-0777EE9A58E9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2280EACD-CA8F-6B5F-C1AD-54D7BD45D0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9" name="Group 148">
              <a:extLst>
                <a:ext uri="{FF2B5EF4-FFF2-40B4-BE49-F238E27FC236}">
                  <a16:creationId xmlns:a16="http://schemas.microsoft.com/office/drawing/2014/main" id="{3D0F25A9-4DE3-A425-9D95-4499C17E1AD1}"/>
                </a:ext>
              </a:extLst>
            </p:cNvPr>
            <p:cNvGrpSpPr/>
            <p:nvPr/>
          </p:nvGrpSpPr>
          <p:grpSpPr>
            <a:xfrm>
              <a:off x="2494355" y="5012132"/>
              <a:ext cx="1408756" cy="498551"/>
              <a:chOff x="2498250" y="4592056"/>
              <a:chExt cx="1408756" cy="498551"/>
            </a:xfrm>
          </p:grpSpPr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28E7D3CA-F407-E065-85FA-9414E4665671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FABD5BC4-DD33-4660-99E2-370283C5F4B7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E7257A66-FD71-60B2-CA95-07384747B6E2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903A66F2-02E9-2F76-4C09-BE0D53C48A47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E2CD59E2-9A85-A1BD-9B16-02A6008470B4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55" name="Straight Connector 154">
                <a:extLst>
                  <a:ext uri="{FF2B5EF4-FFF2-40B4-BE49-F238E27FC236}">
                    <a16:creationId xmlns:a16="http://schemas.microsoft.com/office/drawing/2014/main" id="{584A3C81-010F-05EE-75B4-9989F165D3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6" name="Group 155">
              <a:extLst>
                <a:ext uri="{FF2B5EF4-FFF2-40B4-BE49-F238E27FC236}">
                  <a16:creationId xmlns:a16="http://schemas.microsoft.com/office/drawing/2014/main" id="{ECA13488-C626-B332-BF21-6685C51F8CB4}"/>
                </a:ext>
              </a:extLst>
            </p:cNvPr>
            <p:cNvGrpSpPr/>
            <p:nvPr/>
          </p:nvGrpSpPr>
          <p:grpSpPr>
            <a:xfrm>
              <a:off x="4419566" y="5012132"/>
              <a:ext cx="1408756" cy="498551"/>
              <a:chOff x="2498250" y="4592056"/>
              <a:chExt cx="1408756" cy="498551"/>
            </a:xfrm>
          </p:grpSpPr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4B222F66-1964-8599-F227-6068F5D8F4C7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597B677F-97A5-C7FB-B746-514BF5833D14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1D440A0B-6934-FC47-B8AD-A78F9BA49BF0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FEE9624D-02BF-47B0-0F93-E219A145353D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C69B6F67-4587-E142-AFC6-5572F440AFED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62" name="Straight Connector 161">
                <a:extLst>
                  <a:ext uri="{FF2B5EF4-FFF2-40B4-BE49-F238E27FC236}">
                    <a16:creationId xmlns:a16="http://schemas.microsoft.com/office/drawing/2014/main" id="{0908082D-3ABA-F3A5-74D8-C127F43390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3" name="Group 162">
              <a:extLst>
                <a:ext uri="{FF2B5EF4-FFF2-40B4-BE49-F238E27FC236}">
                  <a16:creationId xmlns:a16="http://schemas.microsoft.com/office/drawing/2014/main" id="{CCEBEC0E-1034-73D1-FDB8-435377277267}"/>
                </a:ext>
              </a:extLst>
            </p:cNvPr>
            <p:cNvGrpSpPr/>
            <p:nvPr/>
          </p:nvGrpSpPr>
          <p:grpSpPr>
            <a:xfrm>
              <a:off x="6331491" y="5012132"/>
              <a:ext cx="1408756" cy="498551"/>
              <a:chOff x="2498250" y="4592056"/>
              <a:chExt cx="1408756" cy="498551"/>
            </a:xfrm>
          </p:grpSpPr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C7821083-BC72-9D4D-5C40-D29217C992D8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5F0441DA-2DD6-88CB-8F35-16B26CE0CF72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8C6D2AB0-E36E-4DC0-0D97-3F79969C678A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0D64CFC4-EABB-5C83-C301-23EF0BF772F4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069879D6-3D66-AA20-732A-A5FED2574557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69" name="Straight Connector 168">
                <a:extLst>
                  <a:ext uri="{FF2B5EF4-FFF2-40B4-BE49-F238E27FC236}">
                    <a16:creationId xmlns:a16="http://schemas.microsoft.com/office/drawing/2014/main" id="{AC0887FD-046C-5A63-AD66-85FE47B60E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445EA700-FBB5-2249-0A07-CC7C64F410D9}"/>
                </a:ext>
              </a:extLst>
            </p:cNvPr>
            <p:cNvGrpSpPr/>
            <p:nvPr/>
          </p:nvGrpSpPr>
          <p:grpSpPr>
            <a:xfrm>
              <a:off x="655883" y="3193516"/>
              <a:ext cx="1408756" cy="498551"/>
              <a:chOff x="2498250" y="4592056"/>
              <a:chExt cx="1408756" cy="498551"/>
            </a:xfrm>
          </p:grpSpPr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852D3622-C583-CD1C-D6C6-BBE1EF19298D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887D2F8A-BFC2-9C58-CFE3-15145ACFE6F1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AE230E2B-6A2C-7279-AD6C-2D3A8FB497AA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17AC3ADE-B11F-9061-54CF-DA6F54AEEBC7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C41CD7A0-2DD4-F02E-7D09-A6EBFF41C429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76" name="Straight Connector 175">
                <a:extLst>
                  <a:ext uri="{FF2B5EF4-FFF2-40B4-BE49-F238E27FC236}">
                    <a16:creationId xmlns:a16="http://schemas.microsoft.com/office/drawing/2014/main" id="{A464CDC9-A571-51A1-E921-4A646E3E45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7" name="Group 176">
              <a:extLst>
                <a:ext uri="{FF2B5EF4-FFF2-40B4-BE49-F238E27FC236}">
                  <a16:creationId xmlns:a16="http://schemas.microsoft.com/office/drawing/2014/main" id="{9C498520-5BAA-C42F-20AE-4A3065C44C35}"/>
                </a:ext>
              </a:extLst>
            </p:cNvPr>
            <p:cNvGrpSpPr/>
            <p:nvPr/>
          </p:nvGrpSpPr>
          <p:grpSpPr>
            <a:xfrm>
              <a:off x="2550149" y="3193516"/>
              <a:ext cx="1408756" cy="498551"/>
              <a:chOff x="2498250" y="4592056"/>
              <a:chExt cx="1408756" cy="498551"/>
            </a:xfrm>
          </p:grpSpPr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5CC5472D-074D-B512-8BB6-2CD31EAB6C6D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6F6D3EA3-9177-3A55-9AE7-DC2DF08A4702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6CC27004-701E-93A0-1D6B-C397D93FBAE9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F9F6E8B3-5D83-04F4-2051-793961F99C20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9D33E620-9A20-E6A0-58CF-0795C05498D8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83" name="Straight Connector 182">
                <a:extLst>
                  <a:ext uri="{FF2B5EF4-FFF2-40B4-BE49-F238E27FC236}">
                    <a16:creationId xmlns:a16="http://schemas.microsoft.com/office/drawing/2014/main" id="{09331308-E704-F8CC-7B54-D1E14E9EF5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1F6B4352-763E-D8B9-7E95-C0361E7CAD22}"/>
                </a:ext>
              </a:extLst>
            </p:cNvPr>
            <p:cNvGrpSpPr/>
            <p:nvPr/>
          </p:nvGrpSpPr>
          <p:grpSpPr>
            <a:xfrm>
              <a:off x="4427552" y="3193516"/>
              <a:ext cx="1408756" cy="498551"/>
              <a:chOff x="2498250" y="4592056"/>
              <a:chExt cx="1408756" cy="498551"/>
            </a:xfrm>
          </p:grpSpPr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B5047A34-9B07-9649-4EA5-51A6F5573824}"/>
                  </a:ext>
                </a:extLst>
              </p:cNvPr>
              <p:cNvSpPr txBox="1"/>
              <p:nvPr/>
            </p:nvSpPr>
            <p:spPr>
              <a:xfrm>
                <a:off x="3092888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E725B411-7A9B-A885-F654-7042B8A8D2A8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F0E31F24-79D7-D1DD-F71E-E64E3ABCF384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73418A5E-2339-4779-A84E-A67053F970DE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64E9DA27-FD58-44C6-311C-8F34D1BFAE1E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90" name="Straight Connector 189">
                <a:extLst>
                  <a:ext uri="{FF2B5EF4-FFF2-40B4-BE49-F238E27FC236}">
                    <a16:creationId xmlns:a16="http://schemas.microsoft.com/office/drawing/2014/main" id="{BC2AC95D-1464-9CC2-08F3-330DE2E55E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1" name="Group 190">
              <a:extLst>
                <a:ext uri="{FF2B5EF4-FFF2-40B4-BE49-F238E27FC236}">
                  <a16:creationId xmlns:a16="http://schemas.microsoft.com/office/drawing/2014/main" id="{6721C48A-3B11-C850-E0C7-29BD2896EAB6}"/>
                </a:ext>
              </a:extLst>
            </p:cNvPr>
            <p:cNvGrpSpPr/>
            <p:nvPr/>
          </p:nvGrpSpPr>
          <p:grpSpPr>
            <a:xfrm>
              <a:off x="6321549" y="3193516"/>
              <a:ext cx="1408756" cy="498551"/>
              <a:chOff x="2498250" y="4592056"/>
              <a:chExt cx="1408756" cy="498551"/>
            </a:xfrm>
          </p:grpSpPr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F78F807E-6615-1E08-DB05-1D85C7576FD1}"/>
                  </a:ext>
                </a:extLst>
              </p:cNvPr>
              <p:cNvSpPr txBox="1"/>
              <p:nvPr/>
            </p:nvSpPr>
            <p:spPr>
              <a:xfrm>
                <a:off x="3098864" y="4828997"/>
                <a:ext cx="4159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21EAF683-822A-4C31-74BA-B208B9B4E934}"/>
                  </a:ext>
                </a:extLst>
              </p:cNvPr>
              <p:cNvSpPr txBox="1"/>
              <p:nvPr/>
            </p:nvSpPr>
            <p:spPr>
              <a:xfrm rot="-1800000">
                <a:off x="2498250" y="4592056"/>
                <a:ext cx="476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D28746E1-CDC5-E39C-1BF2-E73CB354A558}"/>
                  </a:ext>
                </a:extLst>
              </p:cNvPr>
              <p:cNvSpPr txBox="1"/>
              <p:nvPr/>
            </p:nvSpPr>
            <p:spPr>
              <a:xfrm rot="-1800000">
                <a:off x="2889920" y="4592056"/>
                <a:ext cx="248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E1AD484E-5CCF-7F43-A720-E4F27071EA21}"/>
                  </a:ext>
                </a:extLst>
              </p:cNvPr>
              <p:cNvSpPr txBox="1"/>
              <p:nvPr/>
            </p:nvSpPr>
            <p:spPr>
              <a:xfrm rot="-1800000">
                <a:off x="3101430" y="4592056"/>
                <a:ext cx="39205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848ECF91-5490-5DB9-D076-AD0A1CCFD688}"/>
                  </a:ext>
                </a:extLst>
              </p:cNvPr>
              <p:cNvSpPr txBox="1"/>
              <p:nvPr/>
            </p:nvSpPr>
            <p:spPr>
              <a:xfrm rot="-1800000">
                <a:off x="3345358" y="4592056"/>
                <a:ext cx="5616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+NC</a:t>
                </a:r>
              </a:p>
            </p:txBody>
          </p:sp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C58568CA-CEE2-B2B5-298A-AC2EA0EF01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6100" y="4882507"/>
                <a:ext cx="80440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99" name="TextBox 198">
            <a:extLst>
              <a:ext uri="{FF2B5EF4-FFF2-40B4-BE49-F238E27FC236}">
                <a16:creationId xmlns:a16="http://schemas.microsoft.com/office/drawing/2014/main" id="{A3CEBD1E-F7D2-F633-562A-9A550CF18D69}"/>
              </a:ext>
            </a:extLst>
          </p:cNvPr>
          <p:cNvSpPr txBox="1"/>
          <p:nvPr/>
        </p:nvSpPr>
        <p:spPr>
          <a:xfrm>
            <a:off x="83518" y="5894185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4219817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8534DA9-3C9C-7C06-1AD9-B684E81830CC}"/>
              </a:ext>
            </a:extLst>
          </p:cNvPr>
          <p:cNvSpPr txBox="1"/>
          <p:nvPr/>
        </p:nvSpPr>
        <p:spPr>
          <a:xfrm>
            <a:off x="94403" y="27012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FE9686-8C61-D939-1E7B-E3EC11EEA110}"/>
              </a:ext>
            </a:extLst>
          </p:cNvPr>
          <p:cNvSpPr txBox="1"/>
          <p:nvPr/>
        </p:nvSpPr>
        <p:spPr>
          <a:xfrm>
            <a:off x="4004327" y="27012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B4A9632-2B2C-53B9-5180-9A1FE998ED36}"/>
              </a:ext>
            </a:extLst>
          </p:cNvPr>
          <p:cNvGrpSpPr/>
          <p:nvPr/>
        </p:nvGrpSpPr>
        <p:grpSpPr>
          <a:xfrm>
            <a:off x="878952" y="981627"/>
            <a:ext cx="1950972" cy="320976"/>
            <a:chOff x="5249333" y="6595532"/>
            <a:chExt cx="11070418" cy="2641600"/>
          </a:xfrm>
        </p:grpSpPr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BB71AABE-FDEB-7289-B3FE-F3666F9FEF0D}"/>
                </a:ext>
              </a:extLst>
            </p:cNvPr>
            <p:cNvCxnSpPr>
              <a:cxnSpLocks/>
            </p:cNvCxnSpPr>
            <p:nvPr/>
          </p:nvCxnSpPr>
          <p:spPr>
            <a:xfrm>
              <a:off x="5249333" y="7916332"/>
              <a:ext cx="1097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DFB518CF-0912-1FDA-DAC9-D25F0E65C8B8}"/>
                </a:ext>
              </a:extLst>
            </p:cNvPr>
            <p:cNvCxnSpPr>
              <a:cxnSpLocks/>
            </p:cNvCxnSpPr>
            <p:nvPr/>
          </p:nvCxnSpPr>
          <p:spPr>
            <a:xfrm>
              <a:off x="5283199" y="6595532"/>
              <a:ext cx="0" cy="26416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28A8AA2C-3C74-17E2-531D-131DBECBCB29}"/>
                </a:ext>
              </a:extLst>
            </p:cNvPr>
            <p:cNvCxnSpPr>
              <a:cxnSpLocks/>
            </p:cNvCxnSpPr>
            <p:nvPr/>
          </p:nvCxnSpPr>
          <p:spPr>
            <a:xfrm>
              <a:off x="16319751" y="6595532"/>
              <a:ext cx="0" cy="26416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59E58421-792E-57A9-DCCB-E8576FCA40FA}"/>
              </a:ext>
            </a:extLst>
          </p:cNvPr>
          <p:cNvSpPr txBox="1"/>
          <p:nvPr/>
        </p:nvSpPr>
        <p:spPr>
          <a:xfrm>
            <a:off x="600329" y="364126"/>
            <a:ext cx="56137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ax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F1BC7CE-98BF-DE6D-DACB-0431654FC733}"/>
              </a:ext>
            </a:extLst>
          </p:cNvPr>
          <p:cNvSpPr txBox="1"/>
          <p:nvPr/>
        </p:nvSpPr>
        <p:spPr>
          <a:xfrm>
            <a:off x="2509983" y="364126"/>
            <a:ext cx="639920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ax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y 28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5658DA1-4591-8032-C42D-214C42808DD0}"/>
              </a:ext>
            </a:extLst>
          </p:cNvPr>
          <p:cNvCxnSpPr>
            <a:cxnSpLocks/>
          </p:cNvCxnSpPr>
          <p:nvPr/>
        </p:nvCxnSpPr>
        <p:spPr>
          <a:xfrm>
            <a:off x="2029312" y="1152071"/>
            <a:ext cx="37780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FF28A12-C321-7A04-6F50-75778F070B25}"/>
              </a:ext>
            </a:extLst>
          </p:cNvPr>
          <p:cNvCxnSpPr>
            <a:cxnSpLocks/>
          </p:cNvCxnSpPr>
          <p:nvPr/>
        </p:nvCxnSpPr>
        <p:spPr>
          <a:xfrm>
            <a:off x="4732893" y="981627"/>
            <a:ext cx="0" cy="32097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0AAC66ED-A320-8068-A74F-2FEC00847D65}"/>
              </a:ext>
            </a:extLst>
          </p:cNvPr>
          <p:cNvSpPr txBox="1"/>
          <p:nvPr/>
        </p:nvSpPr>
        <p:spPr>
          <a:xfrm>
            <a:off x="4131185" y="459584"/>
            <a:ext cx="120257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iral Challenge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y 70</a:t>
            </a:r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4728CC41-26CF-683C-73C6-C7F5F5B833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6531711" flipV="1">
            <a:off x="552186" y="1452737"/>
            <a:ext cx="457001" cy="559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38">
            <a:extLst>
              <a:ext uri="{FF2B5EF4-FFF2-40B4-BE49-F238E27FC236}">
                <a16:creationId xmlns:a16="http://schemas.microsoft.com/office/drawing/2014/main" id="{267BB6B4-A510-4C4B-F4E7-777013F980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5397" y="1493361"/>
            <a:ext cx="102466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zh-CN" sz="1100" b="1" kern="0" dirty="0">
                <a:solidFill>
                  <a:prstClr val="black"/>
                </a:solidFill>
                <a:latin typeface="Arial" panose="020B0604020202020204" pitchFamily="34" charset="0"/>
                <a:ea typeface="Kai"/>
                <a:cs typeface="Arial" panose="020B0604020202020204" pitchFamily="34" charset="0"/>
              </a:rPr>
              <a:t>Sub-Q GC or AV+RVPs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19C39D33-0870-4D34-B1D9-ED30E354D520}"/>
              </a:ext>
            </a:extLst>
          </p:cNvPr>
          <p:cNvGrpSpPr/>
          <p:nvPr/>
        </p:nvGrpSpPr>
        <p:grpSpPr>
          <a:xfrm>
            <a:off x="895427" y="1953830"/>
            <a:ext cx="797169" cy="479378"/>
            <a:chOff x="-2590800" y="304800"/>
            <a:chExt cx="4075860" cy="1727201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D536F926-45F5-F888-7A0D-738D3577B391}"/>
                </a:ext>
              </a:extLst>
            </p:cNvPr>
            <p:cNvGrpSpPr/>
            <p:nvPr/>
          </p:nvGrpSpPr>
          <p:grpSpPr>
            <a:xfrm>
              <a:off x="-2590800" y="304800"/>
              <a:ext cx="3999660" cy="1727201"/>
              <a:chOff x="1397000" y="2351599"/>
              <a:chExt cx="3999660" cy="1727201"/>
            </a:xfrm>
          </p:grpSpPr>
          <p:sp>
            <p:nvSpPr>
              <p:cNvPr id="41" name="Isosceles Triangle 2">
                <a:extLst>
                  <a:ext uri="{FF2B5EF4-FFF2-40B4-BE49-F238E27FC236}">
                    <a16:creationId xmlns:a16="http://schemas.microsoft.com/office/drawing/2014/main" id="{A68CD514-F4E8-E9C5-D031-173042714617}"/>
                  </a:ext>
                </a:extLst>
              </p:cNvPr>
              <p:cNvSpPr/>
              <p:nvPr/>
            </p:nvSpPr>
            <p:spPr>
              <a:xfrm rot="20837633">
                <a:off x="4038200" y="2351599"/>
                <a:ext cx="763743" cy="774288"/>
              </a:xfrm>
              <a:custGeom>
                <a:avLst/>
                <a:gdLst>
                  <a:gd name="connsiteX0" fmla="*/ 0 w 1060704"/>
                  <a:gd name="connsiteY0" fmla="*/ 914400 h 914400"/>
                  <a:gd name="connsiteX1" fmla="*/ 530352 w 1060704"/>
                  <a:gd name="connsiteY1" fmla="*/ 0 h 914400"/>
                  <a:gd name="connsiteX2" fmla="*/ 1060704 w 1060704"/>
                  <a:gd name="connsiteY2" fmla="*/ 914400 h 914400"/>
                  <a:gd name="connsiteX3" fmla="*/ 0 w 1060704"/>
                  <a:gd name="connsiteY3" fmla="*/ 914400 h 914400"/>
                  <a:gd name="connsiteX0" fmla="*/ 0 w 1072262"/>
                  <a:gd name="connsiteY0" fmla="*/ 914400 h 914400"/>
                  <a:gd name="connsiteX1" fmla="*/ 530352 w 1072262"/>
                  <a:gd name="connsiteY1" fmla="*/ 0 h 914400"/>
                  <a:gd name="connsiteX2" fmla="*/ 1060704 w 1072262"/>
                  <a:gd name="connsiteY2" fmla="*/ 914400 h 914400"/>
                  <a:gd name="connsiteX3" fmla="*/ 0 w 1072262"/>
                  <a:gd name="connsiteY3" fmla="*/ 914400 h 914400"/>
                  <a:gd name="connsiteX0" fmla="*/ 11558 w 1083820"/>
                  <a:gd name="connsiteY0" fmla="*/ 914400 h 914400"/>
                  <a:gd name="connsiteX1" fmla="*/ 541910 w 1083820"/>
                  <a:gd name="connsiteY1" fmla="*/ 0 h 914400"/>
                  <a:gd name="connsiteX2" fmla="*/ 1072262 w 1083820"/>
                  <a:gd name="connsiteY2" fmla="*/ 914400 h 914400"/>
                  <a:gd name="connsiteX3" fmla="*/ 11558 w 1083820"/>
                  <a:gd name="connsiteY3" fmla="*/ 914400 h 91440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83351 w 804599"/>
                  <a:gd name="connsiteY0" fmla="*/ 774849 h 970119"/>
                  <a:gd name="connsiteX1" fmla="*/ 270803 w 804599"/>
                  <a:gd name="connsiteY1" fmla="*/ 149 h 970119"/>
                  <a:gd name="connsiteX2" fmla="*/ 801155 w 804599"/>
                  <a:gd name="connsiteY2" fmla="*/ 914549 h 970119"/>
                  <a:gd name="connsiteX3" fmla="*/ 83351 w 804599"/>
                  <a:gd name="connsiteY3" fmla="*/ 774849 h 970119"/>
                  <a:gd name="connsiteX0" fmla="*/ 18984 w 763743"/>
                  <a:gd name="connsiteY0" fmla="*/ 597084 h 774288"/>
                  <a:gd name="connsiteX1" fmla="*/ 396936 w 763743"/>
                  <a:gd name="connsiteY1" fmla="*/ 184 h 774288"/>
                  <a:gd name="connsiteX2" fmla="*/ 736788 w 763743"/>
                  <a:gd name="connsiteY2" fmla="*/ 736784 h 774288"/>
                  <a:gd name="connsiteX3" fmla="*/ 18984 w 763743"/>
                  <a:gd name="connsiteY3" fmla="*/ 597084 h 774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63743" h="774288">
                    <a:moveTo>
                      <a:pt x="18984" y="597084"/>
                    </a:moveTo>
                    <a:cubicBezTo>
                      <a:pt x="-37658" y="474317"/>
                      <a:pt x="16952" y="12884"/>
                      <a:pt x="396936" y="184"/>
                    </a:cubicBezTo>
                    <a:cubicBezTo>
                      <a:pt x="776920" y="-12516"/>
                      <a:pt x="799780" y="637301"/>
                      <a:pt x="736788" y="736784"/>
                    </a:cubicBezTo>
                    <a:cubicBezTo>
                      <a:pt x="673796" y="836267"/>
                      <a:pt x="75626" y="719851"/>
                      <a:pt x="18984" y="597084"/>
                    </a:cubicBez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42" name="Freeform 1">
                <a:extLst>
                  <a:ext uri="{FF2B5EF4-FFF2-40B4-BE49-F238E27FC236}">
                    <a16:creationId xmlns:a16="http://schemas.microsoft.com/office/drawing/2014/main" id="{986F14D4-8068-550F-01E4-A2D3154A6F55}"/>
                  </a:ext>
                </a:extLst>
              </p:cNvPr>
              <p:cNvSpPr/>
              <p:nvPr/>
            </p:nvSpPr>
            <p:spPr>
              <a:xfrm>
                <a:off x="1720987" y="2421850"/>
                <a:ext cx="3675673" cy="1330239"/>
              </a:xfrm>
              <a:custGeom>
                <a:avLst/>
                <a:gdLst>
                  <a:gd name="connsiteX0" fmla="*/ 406400 w 3594100"/>
                  <a:gd name="connsiteY0" fmla="*/ 952500 h 952500"/>
                  <a:gd name="connsiteX1" fmla="*/ 3594100 w 3594100"/>
                  <a:gd name="connsiteY1" fmla="*/ 939800 h 952500"/>
                  <a:gd name="connsiteX2" fmla="*/ 2616200 w 3594100"/>
                  <a:gd name="connsiteY2" fmla="*/ 0 h 952500"/>
                  <a:gd name="connsiteX3" fmla="*/ 838200 w 3594100"/>
                  <a:gd name="connsiteY3" fmla="*/ 12700 h 952500"/>
                  <a:gd name="connsiteX4" fmla="*/ 177800 w 3594100"/>
                  <a:gd name="connsiteY4" fmla="*/ 177800 h 952500"/>
                  <a:gd name="connsiteX5" fmla="*/ 0 w 3594100"/>
                  <a:gd name="connsiteY5" fmla="*/ 520700 h 952500"/>
                  <a:gd name="connsiteX6" fmla="*/ 406400 w 3594100"/>
                  <a:gd name="connsiteY6" fmla="*/ 952500 h 952500"/>
                  <a:gd name="connsiteX0" fmla="*/ 406400 w 3681450"/>
                  <a:gd name="connsiteY0" fmla="*/ 1024552 h 1024552"/>
                  <a:gd name="connsiteX1" fmla="*/ 3594100 w 3681450"/>
                  <a:gd name="connsiteY1" fmla="*/ 1011852 h 1024552"/>
                  <a:gd name="connsiteX2" fmla="*/ 2616200 w 3681450"/>
                  <a:gd name="connsiteY2" fmla="*/ 72052 h 1024552"/>
                  <a:gd name="connsiteX3" fmla="*/ 838200 w 3681450"/>
                  <a:gd name="connsiteY3" fmla="*/ 84752 h 1024552"/>
                  <a:gd name="connsiteX4" fmla="*/ 177800 w 3681450"/>
                  <a:gd name="connsiteY4" fmla="*/ 249852 h 1024552"/>
                  <a:gd name="connsiteX5" fmla="*/ 0 w 3681450"/>
                  <a:gd name="connsiteY5" fmla="*/ 592752 h 1024552"/>
                  <a:gd name="connsiteX6" fmla="*/ 406400 w 3681450"/>
                  <a:gd name="connsiteY6" fmla="*/ 1024552 h 1024552"/>
                  <a:gd name="connsiteX0" fmla="*/ 406400 w 3681450"/>
                  <a:gd name="connsiteY0" fmla="*/ 1030895 h 1030895"/>
                  <a:gd name="connsiteX1" fmla="*/ 3594100 w 3681450"/>
                  <a:gd name="connsiteY1" fmla="*/ 1018195 h 1030895"/>
                  <a:gd name="connsiteX2" fmla="*/ 2616200 w 3681450"/>
                  <a:gd name="connsiteY2" fmla="*/ 78395 h 1030895"/>
                  <a:gd name="connsiteX3" fmla="*/ 838200 w 3681450"/>
                  <a:gd name="connsiteY3" fmla="*/ 91095 h 1030895"/>
                  <a:gd name="connsiteX4" fmla="*/ 177800 w 3681450"/>
                  <a:gd name="connsiteY4" fmla="*/ 256195 h 1030895"/>
                  <a:gd name="connsiteX5" fmla="*/ 0 w 3681450"/>
                  <a:gd name="connsiteY5" fmla="*/ 599095 h 1030895"/>
                  <a:gd name="connsiteX6" fmla="*/ 406400 w 3681450"/>
                  <a:gd name="connsiteY6" fmla="*/ 1030895 h 1030895"/>
                  <a:gd name="connsiteX0" fmla="*/ 426405 w 3701455"/>
                  <a:gd name="connsiteY0" fmla="*/ 1030895 h 1030895"/>
                  <a:gd name="connsiteX1" fmla="*/ 3614105 w 3701455"/>
                  <a:gd name="connsiteY1" fmla="*/ 1018195 h 1030895"/>
                  <a:gd name="connsiteX2" fmla="*/ 2636205 w 3701455"/>
                  <a:gd name="connsiteY2" fmla="*/ 78395 h 1030895"/>
                  <a:gd name="connsiteX3" fmla="*/ 858205 w 3701455"/>
                  <a:gd name="connsiteY3" fmla="*/ 91095 h 1030895"/>
                  <a:gd name="connsiteX4" fmla="*/ 197805 w 3701455"/>
                  <a:gd name="connsiteY4" fmla="*/ 256195 h 1030895"/>
                  <a:gd name="connsiteX5" fmla="*/ 20005 w 3701455"/>
                  <a:gd name="connsiteY5" fmla="*/ 599095 h 1030895"/>
                  <a:gd name="connsiteX6" fmla="*/ 426405 w 3701455"/>
                  <a:gd name="connsiteY6" fmla="*/ 1030895 h 1030895"/>
                  <a:gd name="connsiteX0" fmla="*/ 455433 w 3730483"/>
                  <a:gd name="connsiteY0" fmla="*/ 1030895 h 1030895"/>
                  <a:gd name="connsiteX1" fmla="*/ 3643133 w 3730483"/>
                  <a:gd name="connsiteY1" fmla="*/ 1018195 h 1030895"/>
                  <a:gd name="connsiteX2" fmla="*/ 2665233 w 3730483"/>
                  <a:gd name="connsiteY2" fmla="*/ 78395 h 1030895"/>
                  <a:gd name="connsiteX3" fmla="*/ 887233 w 3730483"/>
                  <a:gd name="connsiteY3" fmla="*/ 91095 h 1030895"/>
                  <a:gd name="connsiteX4" fmla="*/ 226833 w 3730483"/>
                  <a:gd name="connsiteY4" fmla="*/ 256195 h 1030895"/>
                  <a:gd name="connsiteX5" fmla="*/ 49033 w 3730483"/>
                  <a:gd name="connsiteY5" fmla="*/ 599095 h 1030895"/>
                  <a:gd name="connsiteX6" fmla="*/ 455433 w 3730483"/>
                  <a:gd name="connsiteY6" fmla="*/ 1030895 h 1030895"/>
                  <a:gd name="connsiteX0" fmla="*/ 455433 w 3730483"/>
                  <a:gd name="connsiteY0" fmla="*/ 1030895 h 1138085"/>
                  <a:gd name="connsiteX1" fmla="*/ 3643133 w 3730483"/>
                  <a:gd name="connsiteY1" fmla="*/ 1018195 h 1138085"/>
                  <a:gd name="connsiteX2" fmla="*/ 2665233 w 3730483"/>
                  <a:gd name="connsiteY2" fmla="*/ 78395 h 1138085"/>
                  <a:gd name="connsiteX3" fmla="*/ 887233 w 3730483"/>
                  <a:gd name="connsiteY3" fmla="*/ 91095 h 1138085"/>
                  <a:gd name="connsiteX4" fmla="*/ 226833 w 3730483"/>
                  <a:gd name="connsiteY4" fmla="*/ 256195 h 1138085"/>
                  <a:gd name="connsiteX5" fmla="*/ 49033 w 3730483"/>
                  <a:gd name="connsiteY5" fmla="*/ 599095 h 1138085"/>
                  <a:gd name="connsiteX6" fmla="*/ 455433 w 3730483"/>
                  <a:gd name="connsiteY6" fmla="*/ 1030895 h 1138085"/>
                  <a:gd name="connsiteX0" fmla="*/ 410132 w 3685182"/>
                  <a:gd name="connsiteY0" fmla="*/ 1018906 h 1126096"/>
                  <a:gd name="connsiteX1" fmla="*/ 3597832 w 3685182"/>
                  <a:gd name="connsiteY1" fmla="*/ 1006206 h 1126096"/>
                  <a:gd name="connsiteX2" fmla="*/ 2619932 w 3685182"/>
                  <a:gd name="connsiteY2" fmla="*/ 66406 h 1126096"/>
                  <a:gd name="connsiteX3" fmla="*/ 841932 w 3685182"/>
                  <a:gd name="connsiteY3" fmla="*/ 79106 h 1126096"/>
                  <a:gd name="connsiteX4" fmla="*/ 245032 w 3685182"/>
                  <a:gd name="connsiteY4" fmla="*/ 91806 h 1126096"/>
                  <a:gd name="connsiteX5" fmla="*/ 3732 w 3685182"/>
                  <a:gd name="connsiteY5" fmla="*/ 587106 h 1126096"/>
                  <a:gd name="connsiteX6" fmla="*/ 410132 w 3685182"/>
                  <a:gd name="connsiteY6" fmla="*/ 1018906 h 1126096"/>
                  <a:gd name="connsiteX0" fmla="*/ 460743 w 3743071"/>
                  <a:gd name="connsiteY0" fmla="*/ 1034427 h 1141617"/>
                  <a:gd name="connsiteX1" fmla="*/ 3648443 w 3743071"/>
                  <a:gd name="connsiteY1" fmla="*/ 1021727 h 1141617"/>
                  <a:gd name="connsiteX2" fmla="*/ 2670543 w 3743071"/>
                  <a:gd name="connsiteY2" fmla="*/ 81927 h 1141617"/>
                  <a:gd name="connsiteX3" fmla="*/ 295643 w 3743071"/>
                  <a:gd name="connsiteY3" fmla="*/ 107327 h 1141617"/>
                  <a:gd name="connsiteX4" fmla="*/ 54343 w 3743071"/>
                  <a:gd name="connsiteY4" fmla="*/ 602627 h 1141617"/>
                  <a:gd name="connsiteX5" fmla="*/ 460743 w 3743071"/>
                  <a:gd name="connsiteY5" fmla="*/ 1034427 h 1141617"/>
                  <a:gd name="connsiteX0" fmla="*/ 433140 w 3684200"/>
                  <a:gd name="connsiteY0" fmla="*/ 1157215 h 1264405"/>
                  <a:gd name="connsiteX1" fmla="*/ 3620840 w 3684200"/>
                  <a:gd name="connsiteY1" fmla="*/ 1144515 h 1264405"/>
                  <a:gd name="connsiteX2" fmla="*/ 2096840 w 3684200"/>
                  <a:gd name="connsiteY2" fmla="*/ 52315 h 1264405"/>
                  <a:gd name="connsiteX3" fmla="*/ 268040 w 3684200"/>
                  <a:gd name="connsiteY3" fmla="*/ 230115 h 1264405"/>
                  <a:gd name="connsiteX4" fmla="*/ 26740 w 3684200"/>
                  <a:gd name="connsiteY4" fmla="*/ 725415 h 1264405"/>
                  <a:gd name="connsiteX5" fmla="*/ 433140 w 3684200"/>
                  <a:gd name="connsiteY5" fmla="*/ 1157215 h 1264405"/>
                  <a:gd name="connsiteX0" fmla="*/ 407817 w 3658178"/>
                  <a:gd name="connsiteY0" fmla="*/ 1223049 h 1330239"/>
                  <a:gd name="connsiteX1" fmla="*/ 3595517 w 3658178"/>
                  <a:gd name="connsiteY1" fmla="*/ 1210349 h 1330239"/>
                  <a:gd name="connsiteX2" fmla="*/ 2071517 w 3658178"/>
                  <a:gd name="connsiteY2" fmla="*/ 118149 h 1330239"/>
                  <a:gd name="connsiteX3" fmla="*/ 357017 w 3658178"/>
                  <a:gd name="connsiteY3" fmla="*/ 105449 h 1330239"/>
                  <a:gd name="connsiteX4" fmla="*/ 1417 w 3658178"/>
                  <a:gd name="connsiteY4" fmla="*/ 791249 h 1330239"/>
                  <a:gd name="connsiteX5" fmla="*/ 407817 w 3658178"/>
                  <a:gd name="connsiteY5" fmla="*/ 1223049 h 1330239"/>
                  <a:gd name="connsiteX0" fmla="*/ 407817 w 3658178"/>
                  <a:gd name="connsiteY0" fmla="*/ 1223049 h 1330239"/>
                  <a:gd name="connsiteX1" fmla="*/ 3595517 w 3658178"/>
                  <a:gd name="connsiteY1" fmla="*/ 1210349 h 1330239"/>
                  <a:gd name="connsiteX2" fmla="*/ 2071517 w 3658178"/>
                  <a:gd name="connsiteY2" fmla="*/ 118149 h 1330239"/>
                  <a:gd name="connsiteX3" fmla="*/ 357017 w 3658178"/>
                  <a:gd name="connsiteY3" fmla="*/ 105449 h 1330239"/>
                  <a:gd name="connsiteX4" fmla="*/ 1417 w 3658178"/>
                  <a:gd name="connsiteY4" fmla="*/ 791249 h 1330239"/>
                  <a:gd name="connsiteX5" fmla="*/ 407817 w 3658178"/>
                  <a:gd name="connsiteY5" fmla="*/ 1223049 h 1330239"/>
                  <a:gd name="connsiteX0" fmla="*/ 425312 w 3675673"/>
                  <a:gd name="connsiteY0" fmla="*/ 1223049 h 1330239"/>
                  <a:gd name="connsiteX1" fmla="*/ 3613012 w 3675673"/>
                  <a:gd name="connsiteY1" fmla="*/ 1210349 h 1330239"/>
                  <a:gd name="connsiteX2" fmla="*/ 2089012 w 3675673"/>
                  <a:gd name="connsiteY2" fmla="*/ 118149 h 1330239"/>
                  <a:gd name="connsiteX3" fmla="*/ 374512 w 3675673"/>
                  <a:gd name="connsiteY3" fmla="*/ 105449 h 1330239"/>
                  <a:gd name="connsiteX4" fmla="*/ 18912 w 3675673"/>
                  <a:gd name="connsiteY4" fmla="*/ 791249 h 1330239"/>
                  <a:gd name="connsiteX5" fmla="*/ 425312 w 3675673"/>
                  <a:gd name="connsiteY5" fmla="*/ 1223049 h 13302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675673" h="1330239">
                    <a:moveTo>
                      <a:pt x="425312" y="1223049"/>
                    </a:moveTo>
                    <a:cubicBezTo>
                      <a:pt x="560779" y="1366982"/>
                      <a:pt x="3244712" y="1369099"/>
                      <a:pt x="3613012" y="1210349"/>
                    </a:cubicBezTo>
                    <a:cubicBezTo>
                      <a:pt x="3981312" y="1051599"/>
                      <a:pt x="2628762" y="302299"/>
                      <a:pt x="2089012" y="118149"/>
                    </a:cubicBezTo>
                    <a:cubicBezTo>
                      <a:pt x="1549262" y="-66001"/>
                      <a:pt x="719529" y="-6734"/>
                      <a:pt x="374512" y="105449"/>
                    </a:cubicBezTo>
                    <a:cubicBezTo>
                      <a:pt x="29495" y="217632"/>
                      <a:pt x="-40355" y="579582"/>
                      <a:pt x="18912" y="791249"/>
                    </a:cubicBezTo>
                    <a:cubicBezTo>
                      <a:pt x="78179" y="1002916"/>
                      <a:pt x="289845" y="1079116"/>
                      <a:pt x="425312" y="1223049"/>
                    </a:cubicBezTo>
                    <a:close/>
                  </a:path>
                </a:pathLst>
              </a:cu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n>
                    <a:solidFill>
                      <a:sysClr val="windowText" lastClr="000000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43" name="Isosceles Triangle 2">
                <a:extLst>
                  <a:ext uri="{FF2B5EF4-FFF2-40B4-BE49-F238E27FC236}">
                    <a16:creationId xmlns:a16="http://schemas.microsoft.com/office/drawing/2014/main" id="{208B278A-5D01-E098-30F9-B883543BB51A}"/>
                  </a:ext>
                </a:extLst>
              </p:cNvPr>
              <p:cNvSpPr/>
              <p:nvPr/>
            </p:nvSpPr>
            <p:spPr>
              <a:xfrm rot="20837633">
                <a:off x="3809601" y="2427799"/>
                <a:ext cx="763743" cy="774288"/>
              </a:xfrm>
              <a:custGeom>
                <a:avLst/>
                <a:gdLst>
                  <a:gd name="connsiteX0" fmla="*/ 0 w 1060704"/>
                  <a:gd name="connsiteY0" fmla="*/ 914400 h 914400"/>
                  <a:gd name="connsiteX1" fmla="*/ 530352 w 1060704"/>
                  <a:gd name="connsiteY1" fmla="*/ 0 h 914400"/>
                  <a:gd name="connsiteX2" fmla="*/ 1060704 w 1060704"/>
                  <a:gd name="connsiteY2" fmla="*/ 914400 h 914400"/>
                  <a:gd name="connsiteX3" fmla="*/ 0 w 1060704"/>
                  <a:gd name="connsiteY3" fmla="*/ 914400 h 914400"/>
                  <a:gd name="connsiteX0" fmla="*/ 0 w 1072262"/>
                  <a:gd name="connsiteY0" fmla="*/ 914400 h 914400"/>
                  <a:gd name="connsiteX1" fmla="*/ 530352 w 1072262"/>
                  <a:gd name="connsiteY1" fmla="*/ 0 h 914400"/>
                  <a:gd name="connsiteX2" fmla="*/ 1060704 w 1072262"/>
                  <a:gd name="connsiteY2" fmla="*/ 914400 h 914400"/>
                  <a:gd name="connsiteX3" fmla="*/ 0 w 1072262"/>
                  <a:gd name="connsiteY3" fmla="*/ 914400 h 914400"/>
                  <a:gd name="connsiteX0" fmla="*/ 11558 w 1083820"/>
                  <a:gd name="connsiteY0" fmla="*/ 914400 h 914400"/>
                  <a:gd name="connsiteX1" fmla="*/ 541910 w 1083820"/>
                  <a:gd name="connsiteY1" fmla="*/ 0 h 914400"/>
                  <a:gd name="connsiteX2" fmla="*/ 1072262 w 1083820"/>
                  <a:gd name="connsiteY2" fmla="*/ 914400 h 914400"/>
                  <a:gd name="connsiteX3" fmla="*/ 11558 w 1083820"/>
                  <a:gd name="connsiteY3" fmla="*/ 914400 h 91440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83351 w 804599"/>
                  <a:gd name="connsiteY0" fmla="*/ 774849 h 970119"/>
                  <a:gd name="connsiteX1" fmla="*/ 270803 w 804599"/>
                  <a:gd name="connsiteY1" fmla="*/ 149 h 970119"/>
                  <a:gd name="connsiteX2" fmla="*/ 801155 w 804599"/>
                  <a:gd name="connsiteY2" fmla="*/ 914549 h 970119"/>
                  <a:gd name="connsiteX3" fmla="*/ 83351 w 804599"/>
                  <a:gd name="connsiteY3" fmla="*/ 774849 h 970119"/>
                  <a:gd name="connsiteX0" fmla="*/ 18984 w 763743"/>
                  <a:gd name="connsiteY0" fmla="*/ 597084 h 774288"/>
                  <a:gd name="connsiteX1" fmla="*/ 396936 w 763743"/>
                  <a:gd name="connsiteY1" fmla="*/ 184 h 774288"/>
                  <a:gd name="connsiteX2" fmla="*/ 736788 w 763743"/>
                  <a:gd name="connsiteY2" fmla="*/ 736784 h 774288"/>
                  <a:gd name="connsiteX3" fmla="*/ 18984 w 763743"/>
                  <a:gd name="connsiteY3" fmla="*/ 597084 h 774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63743" h="774288">
                    <a:moveTo>
                      <a:pt x="18984" y="597084"/>
                    </a:moveTo>
                    <a:cubicBezTo>
                      <a:pt x="-37658" y="474317"/>
                      <a:pt x="16952" y="12884"/>
                      <a:pt x="396936" y="184"/>
                    </a:cubicBezTo>
                    <a:cubicBezTo>
                      <a:pt x="776920" y="-12516"/>
                      <a:pt x="799780" y="637301"/>
                      <a:pt x="736788" y="736784"/>
                    </a:cubicBezTo>
                    <a:cubicBezTo>
                      <a:pt x="673796" y="836267"/>
                      <a:pt x="75626" y="719851"/>
                      <a:pt x="18984" y="597084"/>
                    </a:cubicBez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44" name="Oval 43">
                <a:extLst>
                  <a:ext uri="{FF2B5EF4-FFF2-40B4-BE49-F238E27FC236}">
                    <a16:creationId xmlns:a16="http://schemas.microsoft.com/office/drawing/2014/main" id="{560168FB-DD28-DD53-8EEF-58E120661769}"/>
                  </a:ext>
                </a:extLst>
              </p:cNvPr>
              <p:cNvSpPr/>
              <p:nvPr/>
            </p:nvSpPr>
            <p:spPr>
              <a:xfrm>
                <a:off x="4725344" y="3140587"/>
                <a:ext cx="304800" cy="272026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45" name="Freeform 5">
                <a:extLst>
                  <a:ext uri="{FF2B5EF4-FFF2-40B4-BE49-F238E27FC236}">
                    <a16:creationId xmlns:a16="http://schemas.microsoft.com/office/drawing/2014/main" id="{B8030186-75D9-BD33-2364-4BD087F3698A}"/>
                  </a:ext>
                </a:extLst>
              </p:cNvPr>
              <p:cNvSpPr/>
              <p:nvPr/>
            </p:nvSpPr>
            <p:spPr>
              <a:xfrm>
                <a:off x="1397000" y="2793999"/>
                <a:ext cx="2011119" cy="1284801"/>
              </a:xfrm>
              <a:custGeom>
                <a:avLst/>
                <a:gdLst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707243 w 2011119"/>
                  <a:gd name="connsiteY7" fmla="*/ 11139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139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520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774700 w 2011119"/>
                  <a:gd name="connsiteY5" fmla="*/ 1159328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520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4801"/>
                  <a:gd name="connsiteX1" fmla="*/ 190500 w 2011119"/>
                  <a:gd name="connsiteY1" fmla="*/ 292100 h 1284801"/>
                  <a:gd name="connsiteX2" fmla="*/ 127000 w 2011119"/>
                  <a:gd name="connsiteY2" fmla="*/ 622300 h 1284801"/>
                  <a:gd name="connsiteX3" fmla="*/ 241300 w 2011119"/>
                  <a:gd name="connsiteY3" fmla="*/ 825500 h 1284801"/>
                  <a:gd name="connsiteX4" fmla="*/ 469900 w 2011119"/>
                  <a:gd name="connsiteY4" fmla="*/ 1041400 h 1284801"/>
                  <a:gd name="connsiteX5" fmla="*/ 774700 w 2011119"/>
                  <a:gd name="connsiteY5" fmla="*/ 1159328 h 1284801"/>
                  <a:gd name="connsiteX6" fmla="*/ 1168400 w 2011119"/>
                  <a:gd name="connsiteY6" fmla="*/ 1193800 h 1284801"/>
                  <a:gd name="connsiteX7" fmla="*/ 1707243 w 2011119"/>
                  <a:gd name="connsiteY7" fmla="*/ 1152071 h 1284801"/>
                  <a:gd name="connsiteX8" fmla="*/ 2006600 w 2011119"/>
                  <a:gd name="connsiteY8" fmla="*/ 1028700 h 1284801"/>
                  <a:gd name="connsiteX9" fmla="*/ 1778000 w 2011119"/>
                  <a:gd name="connsiteY9" fmla="*/ 1206500 h 1284801"/>
                  <a:gd name="connsiteX10" fmla="*/ 1295400 w 2011119"/>
                  <a:gd name="connsiteY10" fmla="*/ 1270000 h 1284801"/>
                  <a:gd name="connsiteX11" fmla="*/ 990600 w 2011119"/>
                  <a:gd name="connsiteY11" fmla="*/ 1282700 h 1284801"/>
                  <a:gd name="connsiteX12" fmla="*/ 573314 w 2011119"/>
                  <a:gd name="connsiteY12" fmla="*/ 1237343 h 1284801"/>
                  <a:gd name="connsiteX13" fmla="*/ 292100 w 2011119"/>
                  <a:gd name="connsiteY13" fmla="*/ 1104900 h 1284801"/>
                  <a:gd name="connsiteX14" fmla="*/ 101600 w 2011119"/>
                  <a:gd name="connsiteY14" fmla="*/ 889000 h 1284801"/>
                  <a:gd name="connsiteX15" fmla="*/ 12700 w 2011119"/>
                  <a:gd name="connsiteY15" fmla="*/ 660400 h 1284801"/>
                  <a:gd name="connsiteX16" fmla="*/ 0 w 2011119"/>
                  <a:gd name="connsiteY16" fmla="*/ 419100 h 1284801"/>
                  <a:gd name="connsiteX17" fmla="*/ 0 w 2011119"/>
                  <a:gd name="connsiteY17" fmla="*/ 419100 h 1284801"/>
                  <a:gd name="connsiteX18" fmla="*/ 88900 w 2011119"/>
                  <a:gd name="connsiteY18" fmla="*/ 139700 h 1284801"/>
                  <a:gd name="connsiteX19" fmla="*/ 279400 w 2011119"/>
                  <a:gd name="connsiteY19" fmla="*/ 0 h 1284801"/>
                  <a:gd name="connsiteX20" fmla="*/ 404586 w 2011119"/>
                  <a:gd name="connsiteY20" fmla="*/ 0 h 1284801"/>
                  <a:gd name="connsiteX21" fmla="*/ 355600 w 2011119"/>
                  <a:gd name="connsiteY21" fmla="*/ 152400 h 1284801"/>
                  <a:gd name="connsiteX22" fmla="*/ 355600 w 2011119"/>
                  <a:gd name="connsiteY22" fmla="*/ 152400 h 1284801"/>
                  <a:gd name="connsiteX23" fmla="*/ 292100 w 2011119"/>
                  <a:gd name="connsiteY23" fmla="*/ 152400 h 1284801"/>
                  <a:gd name="connsiteX0" fmla="*/ 292100 w 2011119"/>
                  <a:gd name="connsiteY0" fmla="*/ 152400 h 1284801"/>
                  <a:gd name="connsiteX1" fmla="*/ 190500 w 2011119"/>
                  <a:gd name="connsiteY1" fmla="*/ 292100 h 1284801"/>
                  <a:gd name="connsiteX2" fmla="*/ 159657 w 2011119"/>
                  <a:gd name="connsiteY2" fmla="*/ 622300 h 1284801"/>
                  <a:gd name="connsiteX3" fmla="*/ 241300 w 2011119"/>
                  <a:gd name="connsiteY3" fmla="*/ 825500 h 1284801"/>
                  <a:gd name="connsiteX4" fmla="*/ 469900 w 2011119"/>
                  <a:gd name="connsiteY4" fmla="*/ 1041400 h 1284801"/>
                  <a:gd name="connsiteX5" fmla="*/ 774700 w 2011119"/>
                  <a:gd name="connsiteY5" fmla="*/ 1159328 h 1284801"/>
                  <a:gd name="connsiteX6" fmla="*/ 1168400 w 2011119"/>
                  <a:gd name="connsiteY6" fmla="*/ 1193800 h 1284801"/>
                  <a:gd name="connsiteX7" fmla="*/ 1707243 w 2011119"/>
                  <a:gd name="connsiteY7" fmla="*/ 1152071 h 1284801"/>
                  <a:gd name="connsiteX8" fmla="*/ 2006600 w 2011119"/>
                  <a:gd name="connsiteY8" fmla="*/ 1028700 h 1284801"/>
                  <a:gd name="connsiteX9" fmla="*/ 1778000 w 2011119"/>
                  <a:gd name="connsiteY9" fmla="*/ 1206500 h 1284801"/>
                  <a:gd name="connsiteX10" fmla="*/ 1295400 w 2011119"/>
                  <a:gd name="connsiteY10" fmla="*/ 1270000 h 1284801"/>
                  <a:gd name="connsiteX11" fmla="*/ 990600 w 2011119"/>
                  <a:gd name="connsiteY11" fmla="*/ 1282700 h 1284801"/>
                  <a:gd name="connsiteX12" fmla="*/ 573314 w 2011119"/>
                  <a:gd name="connsiteY12" fmla="*/ 1237343 h 1284801"/>
                  <a:gd name="connsiteX13" fmla="*/ 292100 w 2011119"/>
                  <a:gd name="connsiteY13" fmla="*/ 1104900 h 1284801"/>
                  <a:gd name="connsiteX14" fmla="*/ 101600 w 2011119"/>
                  <a:gd name="connsiteY14" fmla="*/ 889000 h 1284801"/>
                  <a:gd name="connsiteX15" fmla="*/ 12700 w 2011119"/>
                  <a:gd name="connsiteY15" fmla="*/ 660400 h 1284801"/>
                  <a:gd name="connsiteX16" fmla="*/ 0 w 2011119"/>
                  <a:gd name="connsiteY16" fmla="*/ 419100 h 1284801"/>
                  <a:gd name="connsiteX17" fmla="*/ 0 w 2011119"/>
                  <a:gd name="connsiteY17" fmla="*/ 419100 h 1284801"/>
                  <a:gd name="connsiteX18" fmla="*/ 88900 w 2011119"/>
                  <a:gd name="connsiteY18" fmla="*/ 139700 h 1284801"/>
                  <a:gd name="connsiteX19" fmla="*/ 279400 w 2011119"/>
                  <a:gd name="connsiteY19" fmla="*/ 0 h 1284801"/>
                  <a:gd name="connsiteX20" fmla="*/ 404586 w 2011119"/>
                  <a:gd name="connsiteY20" fmla="*/ 0 h 1284801"/>
                  <a:gd name="connsiteX21" fmla="*/ 355600 w 2011119"/>
                  <a:gd name="connsiteY21" fmla="*/ 152400 h 1284801"/>
                  <a:gd name="connsiteX22" fmla="*/ 355600 w 2011119"/>
                  <a:gd name="connsiteY22" fmla="*/ 152400 h 1284801"/>
                  <a:gd name="connsiteX23" fmla="*/ 292100 w 2011119"/>
                  <a:gd name="connsiteY23" fmla="*/ 152400 h 12848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2011119" h="1284801">
                    <a:moveTo>
                      <a:pt x="292100" y="152400"/>
                    </a:moveTo>
                    <a:cubicBezTo>
                      <a:pt x="264583" y="175683"/>
                      <a:pt x="212574" y="213783"/>
                      <a:pt x="190500" y="292100"/>
                    </a:cubicBezTo>
                    <a:cubicBezTo>
                      <a:pt x="168426" y="370417"/>
                      <a:pt x="151190" y="533400"/>
                      <a:pt x="159657" y="622300"/>
                    </a:cubicBezTo>
                    <a:cubicBezTo>
                      <a:pt x="168124" y="711200"/>
                      <a:pt x="189593" y="755650"/>
                      <a:pt x="241300" y="825500"/>
                    </a:cubicBezTo>
                    <a:cubicBezTo>
                      <a:pt x="293007" y="895350"/>
                      <a:pt x="381000" y="985762"/>
                      <a:pt x="469900" y="1041400"/>
                    </a:cubicBezTo>
                    <a:cubicBezTo>
                      <a:pt x="558800" y="1097038"/>
                      <a:pt x="658283" y="1133928"/>
                      <a:pt x="774700" y="1159328"/>
                    </a:cubicBezTo>
                    <a:cubicBezTo>
                      <a:pt x="891117" y="1184728"/>
                      <a:pt x="1012976" y="1195009"/>
                      <a:pt x="1168400" y="1193800"/>
                    </a:cubicBezTo>
                    <a:cubicBezTo>
                      <a:pt x="1323824" y="1192591"/>
                      <a:pt x="1567543" y="1179588"/>
                      <a:pt x="1707243" y="1152071"/>
                    </a:cubicBezTo>
                    <a:cubicBezTo>
                      <a:pt x="1846943" y="1124554"/>
                      <a:pt x="1906814" y="1057124"/>
                      <a:pt x="2006600" y="1028700"/>
                    </a:cubicBezTo>
                    <a:cubicBezTo>
                      <a:pt x="2038350" y="1041400"/>
                      <a:pt x="1896533" y="1166283"/>
                      <a:pt x="1778000" y="1206500"/>
                    </a:cubicBezTo>
                    <a:cubicBezTo>
                      <a:pt x="1659467" y="1246717"/>
                      <a:pt x="1426633" y="1257300"/>
                      <a:pt x="1295400" y="1270000"/>
                    </a:cubicBezTo>
                    <a:cubicBezTo>
                      <a:pt x="1164167" y="1282700"/>
                      <a:pt x="1110948" y="1288143"/>
                      <a:pt x="990600" y="1282700"/>
                    </a:cubicBezTo>
                    <a:cubicBezTo>
                      <a:pt x="870252" y="1277257"/>
                      <a:pt x="689731" y="1266976"/>
                      <a:pt x="573314" y="1237343"/>
                    </a:cubicBezTo>
                    <a:cubicBezTo>
                      <a:pt x="456897" y="1207710"/>
                      <a:pt x="370719" y="1162957"/>
                      <a:pt x="292100" y="1104900"/>
                    </a:cubicBezTo>
                    <a:cubicBezTo>
                      <a:pt x="213481" y="1046843"/>
                      <a:pt x="148167" y="963083"/>
                      <a:pt x="101600" y="889000"/>
                    </a:cubicBezTo>
                    <a:cubicBezTo>
                      <a:pt x="55033" y="814917"/>
                      <a:pt x="29633" y="738717"/>
                      <a:pt x="12700" y="660400"/>
                    </a:cubicBezTo>
                    <a:cubicBezTo>
                      <a:pt x="-4233" y="582083"/>
                      <a:pt x="2117" y="459317"/>
                      <a:pt x="0" y="419100"/>
                    </a:cubicBezTo>
                    <a:lnTo>
                      <a:pt x="0" y="419100"/>
                    </a:lnTo>
                    <a:cubicBezTo>
                      <a:pt x="0" y="419100"/>
                      <a:pt x="42333" y="209550"/>
                      <a:pt x="88900" y="139700"/>
                    </a:cubicBezTo>
                    <a:cubicBezTo>
                      <a:pt x="135467" y="69850"/>
                      <a:pt x="234950" y="23283"/>
                      <a:pt x="279400" y="0"/>
                    </a:cubicBezTo>
                    <a:lnTo>
                      <a:pt x="404586" y="0"/>
                    </a:lnTo>
                    <a:lnTo>
                      <a:pt x="355600" y="152400"/>
                    </a:lnTo>
                    <a:lnTo>
                      <a:pt x="355600" y="152400"/>
                    </a:lnTo>
                    <a:lnTo>
                      <a:pt x="292100" y="152400"/>
                    </a:ln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E82B5542-5045-B4C2-4F08-A231E6419F42}"/>
                </a:ext>
              </a:extLst>
            </p:cNvPr>
            <p:cNvSpPr/>
            <p:nvPr/>
          </p:nvSpPr>
          <p:spPr>
            <a:xfrm>
              <a:off x="1332660" y="1389600"/>
              <a:ext cx="152400" cy="1524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16" name="TextBox 38">
            <a:extLst>
              <a:ext uri="{FF2B5EF4-FFF2-40B4-BE49-F238E27FC236}">
                <a16:creationId xmlns:a16="http://schemas.microsoft.com/office/drawing/2014/main" id="{9D294F74-DFD0-025A-55CB-644EC00532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1664" y="1493361"/>
            <a:ext cx="102932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zh-CN" sz="1100" b="1" kern="0" dirty="0">
                <a:solidFill>
                  <a:prstClr val="black"/>
                </a:solidFill>
                <a:latin typeface="Arial" panose="020B0604020202020204" pitchFamily="34" charset="0"/>
                <a:ea typeface="Kai"/>
                <a:cs typeface="Arial" panose="020B0604020202020204" pitchFamily="34" charset="0"/>
              </a:rPr>
              <a:t>Sub-Q GC or AV+RVPs 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D509B129-23AE-0F87-1108-8C6DB4FA4B47}"/>
              </a:ext>
            </a:extLst>
          </p:cNvPr>
          <p:cNvGrpSpPr/>
          <p:nvPr/>
        </p:nvGrpSpPr>
        <p:grpSpPr>
          <a:xfrm>
            <a:off x="2471091" y="1953830"/>
            <a:ext cx="797169" cy="479378"/>
            <a:chOff x="-2590800" y="304800"/>
            <a:chExt cx="4075860" cy="1727201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0DCC39C1-D56E-A742-9F42-733A08008340}"/>
                </a:ext>
              </a:extLst>
            </p:cNvPr>
            <p:cNvGrpSpPr/>
            <p:nvPr/>
          </p:nvGrpSpPr>
          <p:grpSpPr>
            <a:xfrm>
              <a:off x="-2590800" y="304800"/>
              <a:ext cx="3999660" cy="1727201"/>
              <a:chOff x="1397000" y="2351599"/>
              <a:chExt cx="3999660" cy="1727201"/>
            </a:xfrm>
          </p:grpSpPr>
          <p:sp>
            <p:nvSpPr>
              <p:cNvPr id="34" name="Isosceles Triangle 2">
                <a:extLst>
                  <a:ext uri="{FF2B5EF4-FFF2-40B4-BE49-F238E27FC236}">
                    <a16:creationId xmlns:a16="http://schemas.microsoft.com/office/drawing/2014/main" id="{A065C345-44EF-262E-4769-B6D47B4A741C}"/>
                  </a:ext>
                </a:extLst>
              </p:cNvPr>
              <p:cNvSpPr/>
              <p:nvPr/>
            </p:nvSpPr>
            <p:spPr>
              <a:xfrm rot="20837633">
                <a:off x="4038200" y="2351599"/>
                <a:ext cx="763743" cy="774288"/>
              </a:xfrm>
              <a:custGeom>
                <a:avLst/>
                <a:gdLst>
                  <a:gd name="connsiteX0" fmla="*/ 0 w 1060704"/>
                  <a:gd name="connsiteY0" fmla="*/ 914400 h 914400"/>
                  <a:gd name="connsiteX1" fmla="*/ 530352 w 1060704"/>
                  <a:gd name="connsiteY1" fmla="*/ 0 h 914400"/>
                  <a:gd name="connsiteX2" fmla="*/ 1060704 w 1060704"/>
                  <a:gd name="connsiteY2" fmla="*/ 914400 h 914400"/>
                  <a:gd name="connsiteX3" fmla="*/ 0 w 1060704"/>
                  <a:gd name="connsiteY3" fmla="*/ 914400 h 914400"/>
                  <a:gd name="connsiteX0" fmla="*/ 0 w 1072262"/>
                  <a:gd name="connsiteY0" fmla="*/ 914400 h 914400"/>
                  <a:gd name="connsiteX1" fmla="*/ 530352 w 1072262"/>
                  <a:gd name="connsiteY1" fmla="*/ 0 h 914400"/>
                  <a:gd name="connsiteX2" fmla="*/ 1060704 w 1072262"/>
                  <a:gd name="connsiteY2" fmla="*/ 914400 h 914400"/>
                  <a:gd name="connsiteX3" fmla="*/ 0 w 1072262"/>
                  <a:gd name="connsiteY3" fmla="*/ 914400 h 914400"/>
                  <a:gd name="connsiteX0" fmla="*/ 11558 w 1083820"/>
                  <a:gd name="connsiteY0" fmla="*/ 914400 h 914400"/>
                  <a:gd name="connsiteX1" fmla="*/ 541910 w 1083820"/>
                  <a:gd name="connsiteY1" fmla="*/ 0 h 914400"/>
                  <a:gd name="connsiteX2" fmla="*/ 1072262 w 1083820"/>
                  <a:gd name="connsiteY2" fmla="*/ 914400 h 914400"/>
                  <a:gd name="connsiteX3" fmla="*/ 11558 w 1083820"/>
                  <a:gd name="connsiteY3" fmla="*/ 914400 h 91440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83351 w 804599"/>
                  <a:gd name="connsiteY0" fmla="*/ 774849 h 970119"/>
                  <a:gd name="connsiteX1" fmla="*/ 270803 w 804599"/>
                  <a:gd name="connsiteY1" fmla="*/ 149 h 970119"/>
                  <a:gd name="connsiteX2" fmla="*/ 801155 w 804599"/>
                  <a:gd name="connsiteY2" fmla="*/ 914549 h 970119"/>
                  <a:gd name="connsiteX3" fmla="*/ 83351 w 804599"/>
                  <a:gd name="connsiteY3" fmla="*/ 774849 h 970119"/>
                  <a:gd name="connsiteX0" fmla="*/ 18984 w 763743"/>
                  <a:gd name="connsiteY0" fmla="*/ 597084 h 774288"/>
                  <a:gd name="connsiteX1" fmla="*/ 396936 w 763743"/>
                  <a:gd name="connsiteY1" fmla="*/ 184 h 774288"/>
                  <a:gd name="connsiteX2" fmla="*/ 736788 w 763743"/>
                  <a:gd name="connsiteY2" fmla="*/ 736784 h 774288"/>
                  <a:gd name="connsiteX3" fmla="*/ 18984 w 763743"/>
                  <a:gd name="connsiteY3" fmla="*/ 597084 h 774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63743" h="774288">
                    <a:moveTo>
                      <a:pt x="18984" y="597084"/>
                    </a:moveTo>
                    <a:cubicBezTo>
                      <a:pt x="-37658" y="474317"/>
                      <a:pt x="16952" y="12884"/>
                      <a:pt x="396936" y="184"/>
                    </a:cubicBezTo>
                    <a:cubicBezTo>
                      <a:pt x="776920" y="-12516"/>
                      <a:pt x="799780" y="637301"/>
                      <a:pt x="736788" y="736784"/>
                    </a:cubicBezTo>
                    <a:cubicBezTo>
                      <a:pt x="673796" y="836267"/>
                      <a:pt x="75626" y="719851"/>
                      <a:pt x="18984" y="597084"/>
                    </a:cubicBez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35" name="Freeform 1">
                <a:extLst>
                  <a:ext uri="{FF2B5EF4-FFF2-40B4-BE49-F238E27FC236}">
                    <a16:creationId xmlns:a16="http://schemas.microsoft.com/office/drawing/2014/main" id="{FDC55EB7-2DD5-DD63-1334-7139CADA998B}"/>
                  </a:ext>
                </a:extLst>
              </p:cNvPr>
              <p:cNvSpPr/>
              <p:nvPr/>
            </p:nvSpPr>
            <p:spPr>
              <a:xfrm>
                <a:off x="1720987" y="2421850"/>
                <a:ext cx="3675673" cy="1330239"/>
              </a:xfrm>
              <a:custGeom>
                <a:avLst/>
                <a:gdLst>
                  <a:gd name="connsiteX0" fmla="*/ 406400 w 3594100"/>
                  <a:gd name="connsiteY0" fmla="*/ 952500 h 952500"/>
                  <a:gd name="connsiteX1" fmla="*/ 3594100 w 3594100"/>
                  <a:gd name="connsiteY1" fmla="*/ 939800 h 952500"/>
                  <a:gd name="connsiteX2" fmla="*/ 2616200 w 3594100"/>
                  <a:gd name="connsiteY2" fmla="*/ 0 h 952500"/>
                  <a:gd name="connsiteX3" fmla="*/ 838200 w 3594100"/>
                  <a:gd name="connsiteY3" fmla="*/ 12700 h 952500"/>
                  <a:gd name="connsiteX4" fmla="*/ 177800 w 3594100"/>
                  <a:gd name="connsiteY4" fmla="*/ 177800 h 952500"/>
                  <a:gd name="connsiteX5" fmla="*/ 0 w 3594100"/>
                  <a:gd name="connsiteY5" fmla="*/ 520700 h 952500"/>
                  <a:gd name="connsiteX6" fmla="*/ 406400 w 3594100"/>
                  <a:gd name="connsiteY6" fmla="*/ 952500 h 952500"/>
                  <a:gd name="connsiteX0" fmla="*/ 406400 w 3681450"/>
                  <a:gd name="connsiteY0" fmla="*/ 1024552 h 1024552"/>
                  <a:gd name="connsiteX1" fmla="*/ 3594100 w 3681450"/>
                  <a:gd name="connsiteY1" fmla="*/ 1011852 h 1024552"/>
                  <a:gd name="connsiteX2" fmla="*/ 2616200 w 3681450"/>
                  <a:gd name="connsiteY2" fmla="*/ 72052 h 1024552"/>
                  <a:gd name="connsiteX3" fmla="*/ 838200 w 3681450"/>
                  <a:gd name="connsiteY3" fmla="*/ 84752 h 1024552"/>
                  <a:gd name="connsiteX4" fmla="*/ 177800 w 3681450"/>
                  <a:gd name="connsiteY4" fmla="*/ 249852 h 1024552"/>
                  <a:gd name="connsiteX5" fmla="*/ 0 w 3681450"/>
                  <a:gd name="connsiteY5" fmla="*/ 592752 h 1024552"/>
                  <a:gd name="connsiteX6" fmla="*/ 406400 w 3681450"/>
                  <a:gd name="connsiteY6" fmla="*/ 1024552 h 1024552"/>
                  <a:gd name="connsiteX0" fmla="*/ 406400 w 3681450"/>
                  <a:gd name="connsiteY0" fmla="*/ 1030895 h 1030895"/>
                  <a:gd name="connsiteX1" fmla="*/ 3594100 w 3681450"/>
                  <a:gd name="connsiteY1" fmla="*/ 1018195 h 1030895"/>
                  <a:gd name="connsiteX2" fmla="*/ 2616200 w 3681450"/>
                  <a:gd name="connsiteY2" fmla="*/ 78395 h 1030895"/>
                  <a:gd name="connsiteX3" fmla="*/ 838200 w 3681450"/>
                  <a:gd name="connsiteY3" fmla="*/ 91095 h 1030895"/>
                  <a:gd name="connsiteX4" fmla="*/ 177800 w 3681450"/>
                  <a:gd name="connsiteY4" fmla="*/ 256195 h 1030895"/>
                  <a:gd name="connsiteX5" fmla="*/ 0 w 3681450"/>
                  <a:gd name="connsiteY5" fmla="*/ 599095 h 1030895"/>
                  <a:gd name="connsiteX6" fmla="*/ 406400 w 3681450"/>
                  <a:gd name="connsiteY6" fmla="*/ 1030895 h 1030895"/>
                  <a:gd name="connsiteX0" fmla="*/ 426405 w 3701455"/>
                  <a:gd name="connsiteY0" fmla="*/ 1030895 h 1030895"/>
                  <a:gd name="connsiteX1" fmla="*/ 3614105 w 3701455"/>
                  <a:gd name="connsiteY1" fmla="*/ 1018195 h 1030895"/>
                  <a:gd name="connsiteX2" fmla="*/ 2636205 w 3701455"/>
                  <a:gd name="connsiteY2" fmla="*/ 78395 h 1030895"/>
                  <a:gd name="connsiteX3" fmla="*/ 858205 w 3701455"/>
                  <a:gd name="connsiteY3" fmla="*/ 91095 h 1030895"/>
                  <a:gd name="connsiteX4" fmla="*/ 197805 w 3701455"/>
                  <a:gd name="connsiteY4" fmla="*/ 256195 h 1030895"/>
                  <a:gd name="connsiteX5" fmla="*/ 20005 w 3701455"/>
                  <a:gd name="connsiteY5" fmla="*/ 599095 h 1030895"/>
                  <a:gd name="connsiteX6" fmla="*/ 426405 w 3701455"/>
                  <a:gd name="connsiteY6" fmla="*/ 1030895 h 1030895"/>
                  <a:gd name="connsiteX0" fmla="*/ 455433 w 3730483"/>
                  <a:gd name="connsiteY0" fmla="*/ 1030895 h 1030895"/>
                  <a:gd name="connsiteX1" fmla="*/ 3643133 w 3730483"/>
                  <a:gd name="connsiteY1" fmla="*/ 1018195 h 1030895"/>
                  <a:gd name="connsiteX2" fmla="*/ 2665233 w 3730483"/>
                  <a:gd name="connsiteY2" fmla="*/ 78395 h 1030895"/>
                  <a:gd name="connsiteX3" fmla="*/ 887233 w 3730483"/>
                  <a:gd name="connsiteY3" fmla="*/ 91095 h 1030895"/>
                  <a:gd name="connsiteX4" fmla="*/ 226833 w 3730483"/>
                  <a:gd name="connsiteY4" fmla="*/ 256195 h 1030895"/>
                  <a:gd name="connsiteX5" fmla="*/ 49033 w 3730483"/>
                  <a:gd name="connsiteY5" fmla="*/ 599095 h 1030895"/>
                  <a:gd name="connsiteX6" fmla="*/ 455433 w 3730483"/>
                  <a:gd name="connsiteY6" fmla="*/ 1030895 h 1030895"/>
                  <a:gd name="connsiteX0" fmla="*/ 455433 w 3730483"/>
                  <a:gd name="connsiteY0" fmla="*/ 1030895 h 1138085"/>
                  <a:gd name="connsiteX1" fmla="*/ 3643133 w 3730483"/>
                  <a:gd name="connsiteY1" fmla="*/ 1018195 h 1138085"/>
                  <a:gd name="connsiteX2" fmla="*/ 2665233 w 3730483"/>
                  <a:gd name="connsiteY2" fmla="*/ 78395 h 1138085"/>
                  <a:gd name="connsiteX3" fmla="*/ 887233 w 3730483"/>
                  <a:gd name="connsiteY3" fmla="*/ 91095 h 1138085"/>
                  <a:gd name="connsiteX4" fmla="*/ 226833 w 3730483"/>
                  <a:gd name="connsiteY4" fmla="*/ 256195 h 1138085"/>
                  <a:gd name="connsiteX5" fmla="*/ 49033 w 3730483"/>
                  <a:gd name="connsiteY5" fmla="*/ 599095 h 1138085"/>
                  <a:gd name="connsiteX6" fmla="*/ 455433 w 3730483"/>
                  <a:gd name="connsiteY6" fmla="*/ 1030895 h 1138085"/>
                  <a:gd name="connsiteX0" fmla="*/ 410132 w 3685182"/>
                  <a:gd name="connsiteY0" fmla="*/ 1018906 h 1126096"/>
                  <a:gd name="connsiteX1" fmla="*/ 3597832 w 3685182"/>
                  <a:gd name="connsiteY1" fmla="*/ 1006206 h 1126096"/>
                  <a:gd name="connsiteX2" fmla="*/ 2619932 w 3685182"/>
                  <a:gd name="connsiteY2" fmla="*/ 66406 h 1126096"/>
                  <a:gd name="connsiteX3" fmla="*/ 841932 w 3685182"/>
                  <a:gd name="connsiteY3" fmla="*/ 79106 h 1126096"/>
                  <a:gd name="connsiteX4" fmla="*/ 245032 w 3685182"/>
                  <a:gd name="connsiteY4" fmla="*/ 91806 h 1126096"/>
                  <a:gd name="connsiteX5" fmla="*/ 3732 w 3685182"/>
                  <a:gd name="connsiteY5" fmla="*/ 587106 h 1126096"/>
                  <a:gd name="connsiteX6" fmla="*/ 410132 w 3685182"/>
                  <a:gd name="connsiteY6" fmla="*/ 1018906 h 1126096"/>
                  <a:gd name="connsiteX0" fmla="*/ 460743 w 3743071"/>
                  <a:gd name="connsiteY0" fmla="*/ 1034427 h 1141617"/>
                  <a:gd name="connsiteX1" fmla="*/ 3648443 w 3743071"/>
                  <a:gd name="connsiteY1" fmla="*/ 1021727 h 1141617"/>
                  <a:gd name="connsiteX2" fmla="*/ 2670543 w 3743071"/>
                  <a:gd name="connsiteY2" fmla="*/ 81927 h 1141617"/>
                  <a:gd name="connsiteX3" fmla="*/ 295643 w 3743071"/>
                  <a:gd name="connsiteY3" fmla="*/ 107327 h 1141617"/>
                  <a:gd name="connsiteX4" fmla="*/ 54343 w 3743071"/>
                  <a:gd name="connsiteY4" fmla="*/ 602627 h 1141617"/>
                  <a:gd name="connsiteX5" fmla="*/ 460743 w 3743071"/>
                  <a:gd name="connsiteY5" fmla="*/ 1034427 h 1141617"/>
                  <a:gd name="connsiteX0" fmla="*/ 433140 w 3684200"/>
                  <a:gd name="connsiteY0" fmla="*/ 1157215 h 1264405"/>
                  <a:gd name="connsiteX1" fmla="*/ 3620840 w 3684200"/>
                  <a:gd name="connsiteY1" fmla="*/ 1144515 h 1264405"/>
                  <a:gd name="connsiteX2" fmla="*/ 2096840 w 3684200"/>
                  <a:gd name="connsiteY2" fmla="*/ 52315 h 1264405"/>
                  <a:gd name="connsiteX3" fmla="*/ 268040 w 3684200"/>
                  <a:gd name="connsiteY3" fmla="*/ 230115 h 1264405"/>
                  <a:gd name="connsiteX4" fmla="*/ 26740 w 3684200"/>
                  <a:gd name="connsiteY4" fmla="*/ 725415 h 1264405"/>
                  <a:gd name="connsiteX5" fmla="*/ 433140 w 3684200"/>
                  <a:gd name="connsiteY5" fmla="*/ 1157215 h 1264405"/>
                  <a:gd name="connsiteX0" fmla="*/ 407817 w 3658178"/>
                  <a:gd name="connsiteY0" fmla="*/ 1223049 h 1330239"/>
                  <a:gd name="connsiteX1" fmla="*/ 3595517 w 3658178"/>
                  <a:gd name="connsiteY1" fmla="*/ 1210349 h 1330239"/>
                  <a:gd name="connsiteX2" fmla="*/ 2071517 w 3658178"/>
                  <a:gd name="connsiteY2" fmla="*/ 118149 h 1330239"/>
                  <a:gd name="connsiteX3" fmla="*/ 357017 w 3658178"/>
                  <a:gd name="connsiteY3" fmla="*/ 105449 h 1330239"/>
                  <a:gd name="connsiteX4" fmla="*/ 1417 w 3658178"/>
                  <a:gd name="connsiteY4" fmla="*/ 791249 h 1330239"/>
                  <a:gd name="connsiteX5" fmla="*/ 407817 w 3658178"/>
                  <a:gd name="connsiteY5" fmla="*/ 1223049 h 1330239"/>
                  <a:gd name="connsiteX0" fmla="*/ 407817 w 3658178"/>
                  <a:gd name="connsiteY0" fmla="*/ 1223049 h 1330239"/>
                  <a:gd name="connsiteX1" fmla="*/ 3595517 w 3658178"/>
                  <a:gd name="connsiteY1" fmla="*/ 1210349 h 1330239"/>
                  <a:gd name="connsiteX2" fmla="*/ 2071517 w 3658178"/>
                  <a:gd name="connsiteY2" fmla="*/ 118149 h 1330239"/>
                  <a:gd name="connsiteX3" fmla="*/ 357017 w 3658178"/>
                  <a:gd name="connsiteY3" fmla="*/ 105449 h 1330239"/>
                  <a:gd name="connsiteX4" fmla="*/ 1417 w 3658178"/>
                  <a:gd name="connsiteY4" fmla="*/ 791249 h 1330239"/>
                  <a:gd name="connsiteX5" fmla="*/ 407817 w 3658178"/>
                  <a:gd name="connsiteY5" fmla="*/ 1223049 h 1330239"/>
                  <a:gd name="connsiteX0" fmla="*/ 425312 w 3675673"/>
                  <a:gd name="connsiteY0" fmla="*/ 1223049 h 1330239"/>
                  <a:gd name="connsiteX1" fmla="*/ 3613012 w 3675673"/>
                  <a:gd name="connsiteY1" fmla="*/ 1210349 h 1330239"/>
                  <a:gd name="connsiteX2" fmla="*/ 2089012 w 3675673"/>
                  <a:gd name="connsiteY2" fmla="*/ 118149 h 1330239"/>
                  <a:gd name="connsiteX3" fmla="*/ 374512 w 3675673"/>
                  <a:gd name="connsiteY3" fmla="*/ 105449 h 1330239"/>
                  <a:gd name="connsiteX4" fmla="*/ 18912 w 3675673"/>
                  <a:gd name="connsiteY4" fmla="*/ 791249 h 1330239"/>
                  <a:gd name="connsiteX5" fmla="*/ 425312 w 3675673"/>
                  <a:gd name="connsiteY5" fmla="*/ 1223049 h 13302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675673" h="1330239">
                    <a:moveTo>
                      <a:pt x="425312" y="1223049"/>
                    </a:moveTo>
                    <a:cubicBezTo>
                      <a:pt x="560779" y="1366982"/>
                      <a:pt x="3244712" y="1369099"/>
                      <a:pt x="3613012" y="1210349"/>
                    </a:cubicBezTo>
                    <a:cubicBezTo>
                      <a:pt x="3981312" y="1051599"/>
                      <a:pt x="2628762" y="302299"/>
                      <a:pt x="2089012" y="118149"/>
                    </a:cubicBezTo>
                    <a:cubicBezTo>
                      <a:pt x="1549262" y="-66001"/>
                      <a:pt x="719529" y="-6734"/>
                      <a:pt x="374512" y="105449"/>
                    </a:cubicBezTo>
                    <a:cubicBezTo>
                      <a:pt x="29495" y="217632"/>
                      <a:pt x="-40355" y="579582"/>
                      <a:pt x="18912" y="791249"/>
                    </a:cubicBezTo>
                    <a:cubicBezTo>
                      <a:pt x="78179" y="1002916"/>
                      <a:pt x="289845" y="1079116"/>
                      <a:pt x="425312" y="1223049"/>
                    </a:cubicBezTo>
                    <a:close/>
                  </a:path>
                </a:pathLst>
              </a:cu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n>
                    <a:solidFill>
                      <a:sysClr val="windowText" lastClr="000000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36" name="Isosceles Triangle 2">
                <a:extLst>
                  <a:ext uri="{FF2B5EF4-FFF2-40B4-BE49-F238E27FC236}">
                    <a16:creationId xmlns:a16="http://schemas.microsoft.com/office/drawing/2014/main" id="{F1548FAB-385F-F158-BF41-B38028D95114}"/>
                  </a:ext>
                </a:extLst>
              </p:cNvPr>
              <p:cNvSpPr/>
              <p:nvPr/>
            </p:nvSpPr>
            <p:spPr>
              <a:xfrm rot="20837633">
                <a:off x="3809601" y="2427799"/>
                <a:ext cx="763743" cy="774288"/>
              </a:xfrm>
              <a:custGeom>
                <a:avLst/>
                <a:gdLst>
                  <a:gd name="connsiteX0" fmla="*/ 0 w 1060704"/>
                  <a:gd name="connsiteY0" fmla="*/ 914400 h 914400"/>
                  <a:gd name="connsiteX1" fmla="*/ 530352 w 1060704"/>
                  <a:gd name="connsiteY1" fmla="*/ 0 h 914400"/>
                  <a:gd name="connsiteX2" fmla="*/ 1060704 w 1060704"/>
                  <a:gd name="connsiteY2" fmla="*/ 914400 h 914400"/>
                  <a:gd name="connsiteX3" fmla="*/ 0 w 1060704"/>
                  <a:gd name="connsiteY3" fmla="*/ 914400 h 914400"/>
                  <a:gd name="connsiteX0" fmla="*/ 0 w 1072262"/>
                  <a:gd name="connsiteY0" fmla="*/ 914400 h 914400"/>
                  <a:gd name="connsiteX1" fmla="*/ 530352 w 1072262"/>
                  <a:gd name="connsiteY1" fmla="*/ 0 h 914400"/>
                  <a:gd name="connsiteX2" fmla="*/ 1060704 w 1072262"/>
                  <a:gd name="connsiteY2" fmla="*/ 914400 h 914400"/>
                  <a:gd name="connsiteX3" fmla="*/ 0 w 1072262"/>
                  <a:gd name="connsiteY3" fmla="*/ 914400 h 914400"/>
                  <a:gd name="connsiteX0" fmla="*/ 11558 w 1083820"/>
                  <a:gd name="connsiteY0" fmla="*/ 914400 h 914400"/>
                  <a:gd name="connsiteX1" fmla="*/ 541910 w 1083820"/>
                  <a:gd name="connsiteY1" fmla="*/ 0 h 914400"/>
                  <a:gd name="connsiteX2" fmla="*/ 1072262 w 1083820"/>
                  <a:gd name="connsiteY2" fmla="*/ 914400 h 914400"/>
                  <a:gd name="connsiteX3" fmla="*/ 11558 w 1083820"/>
                  <a:gd name="connsiteY3" fmla="*/ 914400 h 91440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83351 w 804599"/>
                  <a:gd name="connsiteY0" fmla="*/ 774849 h 970119"/>
                  <a:gd name="connsiteX1" fmla="*/ 270803 w 804599"/>
                  <a:gd name="connsiteY1" fmla="*/ 149 h 970119"/>
                  <a:gd name="connsiteX2" fmla="*/ 801155 w 804599"/>
                  <a:gd name="connsiteY2" fmla="*/ 914549 h 970119"/>
                  <a:gd name="connsiteX3" fmla="*/ 83351 w 804599"/>
                  <a:gd name="connsiteY3" fmla="*/ 774849 h 970119"/>
                  <a:gd name="connsiteX0" fmla="*/ 18984 w 763743"/>
                  <a:gd name="connsiteY0" fmla="*/ 597084 h 774288"/>
                  <a:gd name="connsiteX1" fmla="*/ 396936 w 763743"/>
                  <a:gd name="connsiteY1" fmla="*/ 184 h 774288"/>
                  <a:gd name="connsiteX2" fmla="*/ 736788 w 763743"/>
                  <a:gd name="connsiteY2" fmla="*/ 736784 h 774288"/>
                  <a:gd name="connsiteX3" fmla="*/ 18984 w 763743"/>
                  <a:gd name="connsiteY3" fmla="*/ 597084 h 774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63743" h="774288">
                    <a:moveTo>
                      <a:pt x="18984" y="597084"/>
                    </a:moveTo>
                    <a:cubicBezTo>
                      <a:pt x="-37658" y="474317"/>
                      <a:pt x="16952" y="12884"/>
                      <a:pt x="396936" y="184"/>
                    </a:cubicBezTo>
                    <a:cubicBezTo>
                      <a:pt x="776920" y="-12516"/>
                      <a:pt x="799780" y="637301"/>
                      <a:pt x="736788" y="736784"/>
                    </a:cubicBezTo>
                    <a:cubicBezTo>
                      <a:pt x="673796" y="836267"/>
                      <a:pt x="75626" y="719851"/>
                      <a:pt x="18984" y="597084"/>
                    </a:cubicBez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37" name="Oval 36">
                <a:extLst>
                  <a:ext uri="{FF2B5EF4-FFF2-40B4-BE49-F238E27FC236}">
                    <a16:creationId xmlns:a16="http://schemas.microsoft.com/office/drawing/2014/main" id="{1D57CEB3-E30D-A4CF-4675-C268C0FC52DF}"/>
                  </a:ext>
                </a:extLst>
              </p:cNvPr>
              <p:cNvSpPr/>
              <p:nvPr/>
            </p:nvSpPr>
            <p:spPr>
              <a:xfrm>
                <a:off x="4725344" y="3140587"/>
                <a:ext cx="304800" cy="272026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38" name="Freeform 5">
                <a:extLst>
                  <a:ext uri="{FF2B5EF4-FFF2-40B4-BE49-F238E27FC236}">
                    <a16:creationId xmlns:a16="http://schemas.microsoft.com/office/drawing/2014/main" id="{522440C6-F444-7A0D-477D-5C41503750D1}"/>
                  </a:ext>
                </a:extLst>
              </p:cNvPr>
              <p:cNvSpPr/>
              <p:nvPr/>
            </p:nvSpPr>
            <p:spPr>
              <a:xfrm>
                <a:off x="1397000" y="2793999"/>
                <a:ext cx="2011119" cy="1284801"/>
              </a:xfrm>
              <a:custGeom>
                <a:avLst/>
                <a:gdLst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707243 w 2011119"/>
                  <a:gd name="connsiteY7" fmla="*/ 11139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139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520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774700 w 2011119"/>
                  <a:gd name="connsiteY5" fmla="*/ 1159328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520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4801"/>
                  <a:gd name="connsiteX1" fmla="*/ 190500 w 2011119"/>
                  <a:gd name="connsiteY1" fmla="*/ 292100 h 1284801"/>
                  <a:gd name="connsiteX2" fmla="*/ 127000 w 2011119"/>
                  <a:gd name="connsiteY2" fmla="*/ 622300 h 1284801"/>
                  <a:gd name="connsiteX3" fmla="*/ 241300 w 2011119"/>
                  <a:gd name="connsiteY3" fmla="*/ 825500 h 1284801"/>
                  <a:gd name="connsiteX4" fmla="*/ 469900 w 2011119"/>
                  <a:gd name="connsiteY4" fmla="*/ 1041400 h 1284801"/>
                  <a:gd name="connsiteX5" fmla="*/ 774700 w 2011119"/>
                  <a:gd name="connsiteY5" fmla="*/ 1159328 h 1284801"/>
                  <a:gd name="connsiteX6" fmla="*/ 1168400 w 2011119"/>
                  <a:gd name="connsiteY6" fmla="*/ 1193800 h 1284801"/>
                  <a:gd name="connsiteX7" fmla="*/ 1707243 w 2011119"/>
                  <a:gd name="connsiteY7" fmla="*/ 1152071 h 1284801"/>
                  <a:gd name="connsiteX8" fmla="*/ 2006600 w 2011119"/>
                  <a:gd name="connsiteY8" fmla="*/ 1028700 h 1284801"/>
                  <a:gd name="connsiteX9" fmla="*/ 1778000 w 2011119"/>
                  <a:gd name="connsiteY9" fmla="*/ 1206500 h 1284801"/>
                  <a:gd name="connsiteX10" fmla="*/ 1295400 w 2011119"/>
                  <a:gd name="connsiteY10" fmla="*/ 1270000 h 1284801"/>
                  <a:gd name="connsiteX11" fmla="*/ 990600 w 2011119"/>
                  <a:gd name="connsiteY11" fmla="*/ 1282700 h 1284801"/>
                  <a:gd name="connsiteX12" fmla="*/ 573314 w 2011119"/>
                  <a:gd name="connsiteY12" fmla="*/ 1237343 h 1284801"/>
                  <a:gd name="connsiteX13" fmla="*/ 292100 w 2011119"/>
                  <a:gd name="connsiteY13" fmla="*/ 1104900 h 1284801"/>
                  <a:gd name="connsiteX14" fmla="*/ 101600 w 2011119"/>
                  <a:gd name="connsiteY14" fmla="*/ 889000 h 1284801"/>
                  <a:gd name="connsiteX15" fmla="*/ 12700 w 2011119"/>
                  <a:gd name="connsiteY15" fmla="*/ 660400 h 1284801"/>
                  <a:gd name="connsiteX16" fmla="*/ 0 w 2011119"/>
                  <a:gd name="connsiteY16" fmla="*/ 419100 h 1284801"/>
                  <a:gd name="connsiteX17" fmla="*/ 0 w 2011119"/>
                  <a:gd name="connsiteY17" fmla="*/ 419100 h 1284801"/>
                  <a:gd name="connsiteX18" fmla="*/ 88900 w 2011119"/>
                  <a:gd name="connsiteY18" fmla="*/ 139700 h 1284801"/>
                  <a:gd name="connsiteX19" fmla="*/ 279400 w 2011119"/>
                  <a:gd name="connsiteY19" fmla="*/ 0 h 1284801"/>
                  <a:gd name="connsiteX20" fmla="*/ 404586 w 2011119"/>
                  <a:gd name="connsiteY20" fmla="*/ 0 h 1284801"/>
                  <a:gd name="connsiteX21" fmla="*/ 355600 w 2011119"/>
                  <a:gd name="connsiteY21" fmla="*/ 152400 h 1284801"/>
                  <a:gd name="connsiteX22" fmla="*/ 355600 w 2011119"/>
                  <a:gd name="connsiteY22" fmla="*/ 152400 h 1284801"/>
                  <a:gd name="connsiteX23" fmla="*/ 292100 w 2011119"/>
                  <a:gd name="connsiteY23" fmla="*/ 152400 h 1284801"/>
                  <a:gd name="connsiteX0" fmla="*/ 292100 w 2011119"/>
                  <a:gd name="connsiteY0" fmla="*/ 152400 h 1284801"/>
                  <a:gd name="connsiteX1" fmla="*/ 190500 w 2011119"/>
                  <a:gd name="connsiteY1" fmla="*/ 292100 h 1284801"/>
                  <a:gd name="connsiteX2" fmla="*/ 159657 w 2011119"/>
                  <a:gd name="connsiteY2" fmla="*/ 622300 h 1284801"/>
                  <a:gd name="connsiteX3" fmla="*/ 241300 w 2011119"/>
                  <a:gd name="connsiteY3" fmla="*/ 825500 h 1284801"/>
                  <a:gd name="connsiteX4" fmla="*/ 469900 w 2011119"/>
                  <a:gd name="connsiteY4" fmla="*/ 1041400 h 1284801"/>
                  <a:gd name="connsiteX5" fmla="*/ 774700 w 2011119"/>
                  <a:gd name="connsiteY5" fmla="*/ 1159328 h 1284801"/>
                  <a:gd name="connsiteX6" fmla="*/ 1168400 w 2011119"/>
                  <a:gd name="connsiteY6" fmla="*/ 1193800 h 1284801"/>
                  <a:gd name="connsiteX7" fmla="*/ 1707243 w 2011119"/>
                  <a:gd name="connsiteY7" fmla="*/ 1152071 h 1284801"/>
                  <a:gd name="connsiteX8" fmla="*/ 2006600 w 2011119"/>
                  <a:gd name="connsiteY8" fmla="*/ 1028700 h 1284801"/>
                  <a:gd name="connsiteX9" fmla="*/ 1778000 w 2011119"/>
                  <a:gd name="connsiteY9" fmla="*/ 1206500 h 1284801"/>
                  <a:gd name="connsiteX10" fmla="*/ 1295400 w 2011119"/>
                  <a:gd name="connsiteY10" fmla="*/ 1270000 h 1284801"/>
                  <a:gd name="connsiteX11" fmla="*/ 990600 w 2011119"/>
                  <a:gd name="connsiteY11" fmla="*/ 1282700 h 1284801"/>
                  <a:gd name="connsiteX12" fmla="*/ 573314 w 2011119"/>
                  <a:gd name="connsiteY12" fmla="*/ 1237343 h 1284801"/>
                  <a:gd name="connsiteX13" fmla="*/ 292100 w 2011119"/>
                  <a:gd name="connsiteY13" fmla="*/ 1104900 h 1284801"/>
                  <a:gd name="connsiteX14" fmla="*/ 101600 w 2011119"/>
                  <a:gd name="connsiteY14" fmla="*/ 889000 h 1284801"/>
                  <a:gd name="connsiteX15" fmla="*/ 12700 w 2011119"/>
                  <a:gd name="connsiteY15" fmla="*/ 660400 h 1284801"/>
                  <a:gd name="connsiteX16" fmla="*/ 0 w 2011119"/>
                  <a:gd name="connsiteY16" fmla="*/ 419100 h 1284801"/>
                  <a:gd name="connsiteX17" fmla="*/ 0 w 2011119"/>
                  <a:gd name="connsiteY17" fmla="*/ 419100 h 1284801"/>
                  <a:gd name="connsiteX18" fmla="*/ 88900 w 2011119"/>
                  <a:gd name="connsiteY18" fmla="*/ 139700 h 1284801"/>
                  <a:gd name="connsiteX19" fmla="*/ 279400 w 2011119"/>
                  <a:gd name="connsiteY19" fmla="*/ 0 h 1284801"/>
                  <a:gd name="connsiteX20" fmla="*/ 404586 w 2011119"/>
                  <a:gd name="connsiteY20" fmla="*/ 0 h 1284801"/>
                  <a:gd name="connsiteX21" fmla="*/ 355600 w 2011119"/>
                  <a:gd name="connsiteY21" fmla="*/ 152400 h 1284801"/>
                  <a:gd name="connsiteX22" fmla="*/ 355600 w 2011119"/>
                  <a:gd name="connsiteY22" fmla="*/ 152400 h 1284801"/>
                  <a:gd name="connsiteX23" fmla="*/ 292100 w 2011119"/>
                  <a:gd name="connsiteY23" fmla="*/ 152400 h 12848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2011119" h="1284801">
                    <a:moveTo>
                      <a:pt x="292100" y="152400"/>
                    </a:moveTo>
                    <a:cubicBezTo>
                      <a:pt x="264583" y="175683"/>
                      <a:pt x="212574" y="213783"/>
                      <a:pt x="190500" y="292100"/>
                    </a:cubicBezTo>
                    <a:cubicBezTo>
                      <a:pt x="168426" y="370417"/>
                      <a:pt x="151190" y="533400"/>
                      <a:pt x="159657" y="622300"/>
                    </a:cubicBezTo>
                    <a:cubicBezTo>
                      <a:pt x="168124" y="711200"/>
                      <a:pt x="189593" y="755650"/>
                      <a:pt x="241300" y="825500"/>
                    </a:cubicBezTo>
                    <a:cubicBezTo>
                      <a:pt x="293007" y="895350"/>
                      <a:pt x="381000" y="985762"/>
                      <a:pt x="469900" y="1041400"/>
                    </a:cubicBezTo>
                    <a:cubicBezTo>
                      <a:pt x="558800" y="1097038"/>
                      <a:pt x="658283" y="1133928"/>
                      <a:pt x="774700" y="1159328"/>
                    </a:cubicBezTo>
                    <a:cubicBezTo>
                      <a:pt x="891117" y="1184728"/>
                      <a:pt x="1012976" y="1195009"/>
                      <a:pt x="1168400" y="1193800"/>
                    </a:cubicBezTo>
                    <a:cubicBezTo>
                      <a:pt x="1323824" y="1192591"/>
                      <a:pt x="1567543" y="1179588"/>
                      <a:pt x="1707243" y="1152071"/>
                    </a:cubicBezTo>
                    <a:cubicBezTo>
                      <a:pt x="1846943" y="1124554"/>
                      <a:pt x="1906814" y="1057124"/>
                      <a:pt x="2006600" y="1028700"/>
                    </a:cubicBezTo>
                    <a:cubicBezTo>
                      <a:pt x="2038350" y="1041400"/>
                      <a:pt x="1896533" y="1166283"/>
                      <a:pt x="1778000" y="1206500"/>
                    </a:cubicBezTo>
                    <a:cubicBezTo>
                      <a:pt x="1659467" y="1246717"/>
                      <a:pt x="1426633" y="1257300"/>
                      <a:pt x="1295400" y="1270000"/>
                    </a:cubicBezTo>
                    <a:cubicBezTo>
                      <a:pt x="1164167" y="1282700"/>
                      <a:pt x="1110948" y="1288143"/>
                      <a:pt x="990600" y="1282700"/>
                    </a:cubicBezTo>
                    <a:cubicBezTo>
                      <a:pt x="870252" y="1277257"/>
                      <a:pt x="689731" y="1266976"/>
                      <a:pt x="573314" y="1237343"/>
                    </a:cubicBezTo>
                    <a:cubicBezTo>
                      <a:pt x="456897" y="1207710"/>
                      <a:pt x="370719" y="1162957"/>
                      <a:pt x="292100" y="1104900"/>
                    </a:cubicBezTo>
                    <a:cubicBezTo>
                      <a:pt x="213481" y="1046843"/>
                      <a:pt x="148167" y="963083"/>
                      <a:pt x="101600" y="889000"/>
                    </a:cubicBezTo>
                    <a:cubicBezTo>
                      <a:pt x="55033" y="814917"/>
                      <a:pt x="29633" y="738717"/>
                      <a:pt x="12700" y="660400"/>
                    </a:cubicBezTo>
                    <a:cubicBezTo>
                      <a:pt x="-4233" y="582083"/>
                      <a:pt x="2117" y="459317"/>
                      <a:pt x="0" y="419100"/>
                    </a:cubicBezTo>
                    <a:lnTo>
                      <a:pt x="0" y="419100"/>
                    </a:lnTo>
                    <a:cubicBezTo>
                      <a:pt x="0" y="419100"/>
                      <a:pt x="42333" y="209550"/>
                      <a:pt x="88900" y="139700"/>
                    </a:cubicBezTo>
                    <a:cubicBezTo>
                      <a:pt x="135467" y="69850"/>
                      <a:pt x="234950" y="23283"/>
                      <a:pt x="279400" y="0"/>
                    </a:cubicBezTo>
                    <a:lnTo>
                      <a:pt x="404586" y="0"/>
                    </a:lnTo>
                    <a:lnTo>
                      <a:pt x="355600" y="152400"/>
                    </a:lnTo>
                    <a:lnTo>
                      <a:pt x="355600" y="152400"/>
                    </a:lnTo>
                    <a:lnTo>
                      <a:pt x="292100" y="152400"/>
                    </a:ln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1AB9595C-F16B-A860-CB31-EF4F3A694EBB}"/>
                </a:ext>
              </a:extLst>
            </p:cNvPr>
            <p:cNvSpPr/>
            <p:nvPr/>
          </p:nvSpPr>
          <p:spPr>
            <a:xfrm>
              <a:off x="1332660" y="1389600"/>
              <a:ext cx="152400" cy="1524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7048572-8E16-0253-FC81-7F3DFFA28D4B}"/>
              </a:ext>
            </a:extLst>
          </p:cNvPr>
          <p:cNvCxnSpPr>
            <a:cxnSpLocks/>
          </p:cNvCxnSpPr>
          <p:nvPr/>
        </p:nvCxnSpPr>
        <p:spPr>
          <a:xfrm>
            <a:off x="5803698" y="981627"/>
            <a:ext cx="0" cy="32097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2">
            <a:extLst>
              <a:ext uri="{FF2B5EF4-FFF2-40B4-BE49-F238E27FC236}">
                <a16:creationId xmlns:a16="http://schemas.microsoft.com/office/drawing/2014/main" id="{A4FA9ACE-11BB-EBE8-9DDB-104026B7FB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1227728" flipV="1">
            <a:off x="4925204" y="1601193"/>
            <a:ext cx="541594" cy="6626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38">
            <a:extLst>
              <a:ext uri="{FF2B5EF4-FFF2-40B4-BE49-F238E27FC236}">
                <a16:creationId xmlns:a16="http://schemas.microsoft.com/office/drawing/2014/main" id="{60CC787C-C2A8-26C3-FC77-613B113A80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4685" y="1493361"/>
            <a:ext cx="885917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zh-CN" sz="1100" b="1" kern="0" dirty="0">
                <a:solidFill>
                  <a:prstClr val="black"/>
                </a:solidFill>
                <a:latin typeface="Arial" panose="020B0604020202020204" pitchFamily="34" charset="0"/>
                <a:ea typeface="Kai"/>
                <a:cs typeface="Arial" panose="020B0604020202020204" pitchFamily="34" charset="0"/>
              </a:rPr>
              <a:t>I.N. SARS-CoV-2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BF79E04-4EA1-8052-EE0E-AE68DCF6AFC8}"/>
              </a:ext>
            </a:extLst>
          </p:cNvPr>
          <p:cNvGrpSpPr/>
          <p:nvPr/>
        </p:nvGrpSpPr>
        <p:grpSpPr>
          <a:xfrm>
            <a:off x="4097328" y="1953830"/>
            <a:ext cx="797169" cy="479378"/>
            <a:chOff x="-2590800" y="304800"/>
            <a:chExt cx="4075860" cy="1727201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747CDE1C-8155-86CA-4C92-F8F31E859B30}"/>
                </a:ext>
              </a:extLst>
            </p:cNvPr>
            <p:cNvGrpSpPr/>
            <p:nvPr/>
          </p:nvGrpSpPr>
          <p:grpSpPr>
            <a:xfrm>
              <a:off x="-2590800" y="304800"/>
              <a:ext cx="3999660" cy="1727201"/>
              <a:chOff x="1397000" y="2351599"/>
              <a:chExt cx="3999660" cy="1727201"/>
            </a:xfrm>
          </p:grpSpPr>
          <p:sp>
            <p:nvSpPr>
              <p:cNvPr id="27" name="Isosceles Triangle 2">
                <a:extLst>
                  <a:ext uri="{FF2B5EF4-FFF2-40B4-BE49-F238E27FC236}">
                    <a16:creationId xmlns:a16="http://schemas.microsoft.com/office/drawing/2014/main" id="{6D613C5D-BEF9-2C69-BD35-86AEF2E0EBDD}"/>
                  </a:ext>
                </a:extLst>
              </p:cNvPr>
              <p:cNvSpPr/>
              <p:nvPr/>
            </p:nvSpPr>
            <p:spPr>
              <a:xfrm rot="20837633">
                <a:off x="4038200" y="2351599"/>
                <a:ext cx="763743" cy="774288"/>
              </a:xfrm>
              <a:custGeom>
                <a:avLst/>
                <a:gdLst>
                  <a:gd name="connsiteX0" fmla="*/ 0 w 1060704"/>
                  <a:gd name="connsiteY0" fmla="*/ 914400 h 914400"/>
                  <a:gd name="connsiteX1" fmla="*/ 530352 w 1060704"/>
                  <a:gd name="connsiteY1" fmla="*/ 0 h 914400"/>
                  <a:gd name="connsiteX2" fmla="*/ 1060704 w 1060704"/>
                  <a:gd name="connsiteY2" fmla="*/ 914400 h 914400"/>
                  <a:gd name="connsiteX3" fmla="*/ 0 w 1060704"/>
                  <a:gd name="connsiteY3" fmla="*/ 914400 h 914400"/>
                  <a:gd name="connsiteX0" fmla="*/ 0 w 1072262"/>
                  <a:gd name="connsiteY0" fmla="*/ 914400 h 914400"/>
                  <a:gd name="connsiteX1" fmla="*/ 530352 w 1072262"/>
                  <a:gd name="connsiteY1" fmla="*/ 0 h 914400"/>
                  <a:gd name="connsiteX2" fmla="*/ 1060704 w 1072262"/>
                  <a:gd name="connsiteY2" fmla="*/ 914400 h 914400"/>
                  <a:gd name="connsiteX3" fmla="*/ 0 w 1072262"/>
                  <a:gd name="connsiteY3" fmla="*/ 914400 h 914400"/>
                  <a:gd name="connsiteX0" fmla="*/ 11558 w 1083820"/>
                  <a:gd name="connsiteY0" fmla="*/ 914400 h 914400"/>
                  <a:gd name="connsiteX1" fmla="*/ 541910 w 1083820"/>
                  <a:gd name="connsiteY1" fmla="*/ 0 h 914400"/>
                  <a:gd name="connsiteX2" fmla="*/ 1072262 w 1083820"/>
                  <a:gd name="connsiteY2" fmla="*/ 914400 h 914400"/>
                  <a:gd name="connsiteX3" fmla="*/ 11558 w 1083820"/>
                  <a:gd name="connsiteY3" fmla="*/ 914400 h 91440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83351 w 804599"/>
                  <a:gd name="connsiteY0" fmla="*/ 774849 h 970119"/>
                  <a:gd name="connsiteX1" fmla="*/ 270803 w 804599"/>
                  <a:gd name="connsiteY1" fmla="*/ 149 h 970119"/>
                  <a:gd name="connsiteX2" fmla="*/ 801155 w 804599"/>
                  <a:gd name="connsiteY2" fmla="*/ 914549 h 970119"/>
                  <a:gd name="connsiteX3" fmla="*/ 83351 w 804599"/>
                  <a:gd name="connsiteY3" fmla="*/ 774849 h 970119"/>
                  <a:gd name="connsiteX0" fmla="*/ 18984 w 763743"/>
                  <a:gd name="connsiteY0" fmla="*/ 597084 h 774288"/>
                  <a:gd name="connsiteX1" fmla="*/ 396936 w 763743"/>
                  <a:gd name="connsiteY1" fmla="*/ 184 h 774288"/>
                  <a:gd name="connsiteX2" fmla="*/ 736788 w 763743"/>
                  <a:gd name="connsiteY2" fmla="*/ 736784 h 774288"/>
                  <a:gd name="connsiteX3" fmla="*/ 18984 w 763743"/>
                  <a:gd name="connsiteY3" fmla="*/ 597084 h 774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63743" h="774288">
                    <a:moveTo>
                      <a:pt x="18984" y="597084"/>
                    </a:moveTo>
                    <a:cubicBezTo>
                      <a:pt x="-37658" y="474317"/>
                      <a:pt x="16952" y="12884"/>
                      <a:pt x="396936" y="184"/>
                    </a:cubicBezTo>
                    <a:cubicBezTo>
                      <a:pt x="776920" y="-12516"/>
                      <a:pt x="799780" y="637301"/>
                      <a:pt x="736788" y="736784"/>
                    </a:cubicBezTo>
                    <a:cubicBezTo>
                      <a:pt x="673796" y="836267"/>
                      <a:pt x="75626" y="719851"/>
                      <a:pt x="18984" y="597084"/>
                    </a:cubicBez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28" name="Freeform 1">
                <a:extLst>
                  <a:ext uri="{FF2B5EF4-FFF2-40B4-BE49-F238E27FC236}">
                    <a16:creationId xmlns:a16="http://schemas.microsoft.com/office/drawing/2014/main" id="{6D5E01FC-FC8C-F6AA-85D9-B3AFFAAAF400}"/>
                  </a:ext>
                </a:extLst>
              </p:cNvPr>
              <p:cNvSpPr/>
              <p:nvPr/>
            </p:nvSpPr>
            <p:spPr>
              <a:xfrm>
                <a:off x="1720987" y="2421850"/>
                <a:ext cx="3675673" cy="1330239"/>
              </a:xfrm>
              <a:custGeom>
                <a:avLst/>
                <a:gdLst>
                  <a:gd name="connsiteX0" fmla="*/ 406400 w 3594100"/>
                  <a:gd name="connsiteY0" fmla="*/ 952500 h 952500"/>
                  <a:gd name="connsiteX1" fmla="*/ 3594100 w 3594100"/>
                  <a:gd name="connsiteY1" fmla="*/ 939800 h 952500"/>
                  <a:gd name="connsiteX2" fmla="*/ 2616200 w 3594100"/>
                  <a:gd name="connsiteY2" fmla="*/ 0 h 952500"/>
                  <a:gd name="connsiteX3" fmla="*/ 838200 w 3594100"/>
                  <a:gd name="connsiteY3" fmla="*/ 12700 h 952500"/>
                  <a:gd name="connsiteX4" fmla="*/ 177800 w 3594100"/>
                  <a:gd name="connsiteY4" fmla="*/ 177800 h 952500"/>
                  <a:gd name="connsiteX5" fmla="*/ 0 w 3594100"/>
                  <a:gd name="connsiteY5" fmla="*/ 520700 h 952500"/>
                  <a:gd name="connsiteX6" fmla="*/ 406400 w 3594100"/>
                  <a:gd name="connsiteY6" fmla="*/ 952500 h 952500"/>
                  <a:gd name="connsiteX0" fmla="*/ 406400 w 3681450"/>
                  <a:gd name="connsiteY0" fmla="*/ 1024552 h 1024552"/>
                  <a:gd name="connsiteX1" fmla="*/ 3594100 w 3681450"/>
                  <a:gd name="connsiteY1" fmla="*/ 1011852 h 1024552"/>
                  <a:gd name="connsiteX2" fmla="*/ 2616200 w 3681450"/>
                  <a:gd name="connsiteY2" fmla="*/ 72052 h 1024552"/>
                  <a:gd name="connsiteX3" fmla="*/ 838200 w 3681450"/>
                  <a:gd name="connsiteY3" fmla="*/ 84752 h 1024552"/>
                  <a:gd name="connsiteX4" fmla="*/ 177800 w 3681450"/>
                  <a:gd name="connsiteY4" fmla="*/ 249852 h 1024552"/>
                  <a:gd name="connsiteX5" fmla="*/ 0 w 3681450"/>
                  <a:gd name="connsiteY5" fmla="*/ 592752 h 1024552"/>
                  <a:gd name="connsiteX6" fmla="*/ 406400 w 3681450"/>
                  <a:gd name="connsiteY6" fmla="*/ 1024552 h 1024552"/>
                  <a:gd name="connsiteX0" fmla="*/ 406400 w 3681450"/>
                  <a:gd name="connsiteY0" fmla="*/ 1030895 h 1030895"/>
                  <a:gd name="connsiteX1" fmla="*/ 3594100 w 3681450"/>
                  <a:gd name="connsiteY1" fmla="*/ 1018195 h 1030895"/>
                  <a:gd name="connsiteX2" fmla="*/ 2616200 w 3681450"/>
                  <a:gd name="connsiteY2" fmla="*/ 78395 h 1030895"/>
                  <a:gd name="connsiteX3" fmla="*/ 838200 w 3681450"/>
                  <a:gd name="connsiteY3" fmla="*/ 91095 h 1030895"/>
                  <a:gd name="connsiteX4" fmla="*/ 177800 w 3681450"/>
                  <a:gd name="connsiteY4" fmla="*/ 256195 h 1030895"/>
                  <a:gd name="connsiteX5" fmla="*/ 0 w 3681450"/>
                  <a:gd name="connsiteY5" fmla="*/ 599095 h 1030895"/>
                  <a:gd name="connsiteX6" fmla="*/ 406400 w 3681450"/>
                  <a:gd name="connsiteY6" fmla="*/ 1030895 h 1030895"/>
                  <a:gd name="connsiteX0" fmla="*/ 426405 w 3701455"/>
                  <a:gd name="connsiteY0" fmla="*/ 1030895 h 1030895"/>
                  <a:gd name="connsiteX1" fmla="*/ 3614105 w 3701455"/>
                  <a:gd name="connsiteY1" fmla="*/ 1018195 h 1030895"/>
                  <a:gd name="connsiteX2" fmla="*/ 2636205 w 3701455"/>
                  <a:gd name="connsiteY2" fmla="*/ 78395 h 1030895"/>
                  <a:gd name="connsiteX3" fmla="*/ 858205 w 3701455"/>
                  <a:gd name="connsiteY3" fmla="*/ 91095 h 1030895"/>
                  <a:gd name="connsiteX4" fmla="*/ 197805 w 3701455"/>
                  <a:gd name="connsiteY4" fmla="*/ 256195 h 1030895"/>
                  <a:gd name="connsiteX5" fmla="*/ 20005 w 3701455"/>
                  <a:gd name="connsiteY5" fmla="*/ 599095 h 1030895"/>
                  <a:gd name="connsiteX6" fmla="*/ 426405 w 3701455"/>
                  <a:gd name="connsiteY6" fmla="*/ 1030895 h 1030895"/>
                  <a:gd name="connsiteX0" fmla="*/ 455433 w 3730483"/>
                  <a:gd name="connsiteY0" fmla="*/ 1030895 h 1030895"/>
                  <a:gd name="connsiteX1" fmla="*/ 3643133 w 3730483"/>
                  <a:gd name="connsiteY1" fmla="*/ 1018195 h 1030895"/>
                  <a:gd name="connsiteX2" fmla="*/ 2665233 w 3730483"/>
                  <a:gd name="connsiteY2" fmla="*/ 78395 h 1030895"/>
                  <a:gd name="connsiteX3" fmla="*/ 887233 w 3730483"/>
                  <a:gd name="connsiteY3" fmla="*/ 91095 h 1030895"/>
                  <a:gd name="connsiteX4" fmla="*/ 226833 w 3730483"/>
                  <a:gd name="connsiteY4" fmla="*/ 256195 h 1030895"/>
                  <a:gd name="connsiteX5" fmla="*/ 49033 w 3730483"/>
                  <a:gd name="connsiteY5" fmla="*/ 599095 h 1030895"/>
                  <a:gd name="connsiteX6" fmla="*/ 455433 w 3730483"/>
                  <a:gd name="connsiteY6" fmla="*/ 1030895 h 1030895"/>
                  <a:gd name="connsiteX0" fmla="*/ 455433 w 3730483"/>
                  <a:gd name="connsiteY0" fmla="*/ 1030895 h 1138085"/>
                  <a:gd name="connsiteX1" fmla="*/ 3643133 w 3730483"/>
                  <a:gd name="connsiteY1" fmla="*/ 1018195 h 1138085"/>
                  <a:gd name="connsiteX2" fmla="*/ 2665233 w 3730483"/>
                  <a:gd name="connsiteY2" fmla="*/ 78395 h 1138085"/>
                  <a:gd name="connsiteX3" fmla="*/ 887233 w 3730483"/>
                  <a:gd name="connsiteY3" fmla="*/ 91095 h 1138085"/>
                  <a:gd name="connsiteX4" fmla="*/ 226833 w 3730483"/>
                  <a:gd name="connsiteY4" fmla="*/ 256195 h 1138085"/>
                  <a:gd name="connsiteX5" fmla="*/ 49033 w 3730483"/>
                  <a:gd name="connsiteY5" fmla="*/ 599095 h 1138085"/>
                  <a:gd name="connsiteX6" fmla="*/ 455433 w 3730483"/>
                  <a:gd name="connsiteY6" fmla="*/ 1030895 h 1138085"/>
                  <a:gd name="connsiteX0" fmla="*/ 410132 w 3685182"/>
                  <a:gd name="connsiteY0" fmla="*/ 1018906 h 1126096"/>
                  <a:gd name="connsiteX1" fmla="*/ 3597832 w 3685182"/>
                  <a:gd name="connsiteY1" fmla="*/ 1006206 h 1126096"/>
                  <a:gd name="connsiteX2" fmla="*/ 2619932 w 3685182"/>
                  <a:gd name="connsiteY2" fmla="*/ 66406 h 1126096"/>
                  <a:gd name="connsiteX3" fmla="*/ 841932 w 3685182"/>
                  <a:gd name="connsiteY3" fmla="*/ 79106 h 1126096"/>
                  <a:gd name="connsiteX4" fmla="*/ 245032 w 3685182"/>
                  <a:gd name="connsiteY4" fmla="*/ 91806 h 1126096"/>
                  <a:gd name="connsiteX5" fmla="*/ 3732 w 3685182"/>
                  <a:gd name="connsiteY5" fmla="*/ 587106 h 1126096"/>
                  <a:gd name="connsiteX6" fmla="*/ 410132 w 3685182"/>
                  <a:gd name="connsiteY6" fmla="*/ 1018906 h 1126096"/>
                  <a:gd name="connsiteX0" fmla="*/ 460743 w 3743071"/>
                  <a:gd name="connsiteY0" fmla="*/ 1034427 h 1141617"/>
                  <a:gd name="connsiteX1" fmla="*/ 3648443 w 3743071"/>
                  <a:gd name="connsiteY1" fmla="*/ 1021727 h 1141617"/>
                  <a:gd name="connsiteX2" fmla="*/ 2670543 w 3743071"/>
                  <a:gd name="connsiteY2" fmla="*/ 81927 h 1141617"/>
                  <a:gd name="connsiteX3" fmla="*/ 295643 w 3743071"/>
                  <a:gd name="connsiteY3" fmla="*/ 107327 h 1141617"/>
                  <a:gd name="connsiteX4" fmla="*/ 54343 w 3743071"/>
                  <a:gd name="connsiteY4" fmla="*/ 602627 h 1141617"/>
                  <a:gd name="connsiteX5" fmla="*/ 460743 w 3743071"/>
                  <a:gd name="connsiteY5" fmla="*/ 1034427 h 1141617"/>
                  <a:gd name="connsiteX0" fmla="*/ 433140 w 3684200"/>
                  <a:gd name="connsiteY0" fmla="*/ 1157215 h 1264405"/>
                  <a:gd name="connsiteX1" fmla="*/ 3620840 w 3684200"/>
                  <a:gd name="connsiteY1" fmla="*/ 1144515 h 1264405"/>
                  <a:gd name="connsiteX2" fmla="*/ 2096840 w 3684200"/>
                  <a:gd name="connsiteY2" fmla="*/ 52315 h 1264405"/>
                  <a:gd name="connsiteX3" fmla="*/ 268040 w 3684200"/>
                  <a:gd name="connsiteY3" fmla="*/ 230115 h 1264405"/>
                  <a:gd name="connsiteX4" fmla="*/ 26740 w 3684200"/>
                  <a:gd name="connsiteY4" fmla="*/ 725415 h 1264405"/>
                  <a:gd name="connsiteX5" fmla="*/ 433140 w 3684200"/>
                  <a:gd name="connsiteY5" fmla="*/ 1157215 h 1264405"/>
                  <a:gd name="connsiteX0" fmla="*/ 407817 w 3658178"/>
                  <a:gd name="connsiteY0" fmla="*/ 1223049 h 1330239"/>
                  <a:gd name="connsiteX1" fmla="*/ 3595517 w 3658178"/>
                  <a:gd name="connsiteY1" fmla="*/ 1210349 h 1330239"/>
                  <a:gd name="connsiteX2" fmla="*/ 2071517 w 3658178"/>
                  <a:gd name="connsiteY2" fmla="*/ 118149 h 1330239"/>
                  <a:gd name="connsiteX3" fmla="*/ 357017 w 3658178"/>
                  <a:gd name="connsiteY3" fmla="*/ 105449 h 1330239"/>
                  <a:gd name="connsiteX4" fmla="*/ 1417 w 3658178"/>
                  <a:gd name="connsiteY4" fmla="*/ 791249 h 1330239"/>
                  <a:gd name="connsiteX5" fmla="*/ 407817 w 3658178"/>
                  <a:gd name="connsiteY5" fmla="*/ 1223049 h 1330239"/>
                  <a:gd name="connsiteX0" fmla="*/ 407817 w 3658178"/>
                  <a:gd name="connsiteY0" fmla="*/ 1223049 h 1330239"/>
                  <a:gd name="connsiteX1" fmla="*/ 3595517 w 3658178"/>
                  <a:gd name="connsiteY1" fmla="*/ 1210349 h 1330239"/>
                  <a:gd name="connsiteX2" fmla="*/ 2071517 w 3658178"/>
                  <a:gd name="connsiteY2" fmla="*/ 118149 h 1330239"/>
                  <a:gd name="connsiteX3" fmla="*/ 357017 w 3658178"/>
                  <a:gd name="connsiteY3" fmla="*/ 105449 h 1330239"/>
                  <a:gd name="connsiteX4" fmla="*/ 1417 w 3658178"/>
                  <a:gd name="connsiteY4" fmla="*/ 791249 h 1330239"/>
                  <a:gd name="connsiteX5" fmla="*/ 407817 w 3658178"/>
                  <a:gd name="connsiteY5" fmla="*/ 1223049 h 1330239"/>
                  <a:gd name="connsiteX0" fmla="*/ 425312 w 3675673"/>
                  <a:gd name="connsiteY0" fmla="*/ 1223049 h 1330239"/>
                  <a:gd name="connsiteX1" fmla="*/ 3613012 w 3675673"/>
                  <a:gd name="connsiteY1" fmla="*/ 1210349 h 1330239"/>
                  <a:gd name="connsiteX2" fmla="*/ 2089012 w 3675673"/>
                  <a:gd name="connsiteY2" fmla="*/ 118149 h 1330239"/>
                  <a:gd name="connsiteX3" fmla="*/ 374512 w 3675673"/>
                  <a:gd name="connsiteY3" fmla="*/ 105449 h 1330239"/>
                  <a:gd name="connsiteX4" fmla="*/ 18912 w 3675673"/>
                  <a:gd name="connsiteY4" fmla="*/ 791249 h 1330239"/>
                  <a:gd name="connsiteX5" fmla="*/ 425312 w 3675673"/>
                  <a:gd name="connsiteY5" fmla="*/ 1223049 h 13302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675673" h="1330239">
                    <a:moveTo>
                      <a:pt x="425312" y="1223049"/>
                    </a:moveTo>
                    <a:cubicBezTo>
                      <a:pt x="560779" y="1366982"/>
                      <a:pt x="3244712" y="1369099"/>
                      <a:pt x="3613012" y="1210349"/>
                    </a:cubicBezTo>
                    <a:cubicBezTo>
                      <a:pt x="3981312" y="1051599"/>
                      <a:pt x="2628762" y="302299"/>
                      <a:pt x="2089012" y="118149"/>
                    </a:cubicBezTo>
                    <a:cubicBezTo>
                      <a:pt x="1549262" y="-66001"/>
                      <a:pt x="719529" y="-6734"/>
                      <a:pt x="374512" y="105449"/>
                    </a:cubicBezTo>
                    <a:cubicBezTo>
                      <a:pt x="29495" y="217632"/>
                      <a:pt x="-40355" y="579582"/>
                      <a:pt x="18912" y="791249"/>
                    </a:cubicBezTo>
                    <a:cubicBezTo>
                      <a:pt x="78179" y="1002916"/>
                      <a:pt x="289845" y="1079116"/>
                      <a:pt x="425312" y="1223049"/>
                    </a:cubicBezTo>
                    <a:close/>
                  </a:path>
                </a:pathLst>
              </a:cu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n>
                    <a:solidFill>
                      <a:sysClr val="windowText" lastClr="000000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29" name="Isosceles Triangle 2">
                <a:extLst>
                  <a:ext uri="{FF2B5EF4-FFF2-40B4-BE49-F238E27FC236}">
                    <a16:creationId xmlns:a16="http://schemas.microsoft.com/office/drawing/2014/main" id="{6AA223C1-AC14-C0CA-38D2-7B2B72293D3C}"/>
                  </a:ext>
                </a:extLst>
              </p:cNvPr>
              <p:cNvSpPr/>
              <p:nvPr/>
            </p:nvSpPr>
            <p:spPr>
              <a:xfrm rot="20837633">
                <a:off x="3809601" y="2427799"/>
                <a:ext cx="763743" cy="774288"/>
              </a:xfrm>
              <a:custGeom>
                <a:avLst/>
                <a:gdLst>
                  <a:gd name="connsiteX0" fmla="*/ 0 w 1060704"/>
                  <a:gd name="connsiteY0" fmla="*/ 914400 h 914400"/>
                  <a:gd name="connsiteX1" fmla="*/ 530352 w 1060704"/>
                  <a:gd name="connsiteY1" fmla="*/ 0 h 914400"/>
                  <a:gd name="connsiteX2" fmla="*/ 1060704 w 1060704"/>
                  <a:gd name="connsiteY2" fmla="*/ 914400 h 914400"/>
                  <a:gd name="connsiteX3" fmla="*/ 0 w 1060704"/>
                  <a:gd name="connsiteY3" fmla="*/ 914400 h 914400"/>
                  <a:gd name="connsiteX0" fmla="*/ 0 w 1072262"/>
                  <a:gd name="connsiteY0" fmla="*/ 914400 h 914400"/>
                  <a:gd name="connsiteX1" fmla="*/ 530352 w 1072262"/>
                  <a:gd name="connsiteY1" fmla="*/ 0 h 914400"/>
                  <a:gd name="connsiteX2" fmla="*/ 1060704 w 1072262"/>
                  <a:gd name="connsiteY2" fmla="*/ 914400 h 914400"/>
                  <a:gd name="connsiteX3" fmla="*/ 0 w 1072262"/>
                  <a:gd name="connsiteY3" fmla="*/ 914400 h 914400"/>
                  <a:gd name="connsiteX0" fmla="*/ 11558 w 1083820"/>
                  <a:gd name="connsiteY0" fmla="*/ 914400 h 914400"/>
                  <a:gd name="connsiteX1" fmla="*/ 541910 w 1083820"/>
                  <a:gd name="connsiteY1" fmla="*/ 0 h 914400"/>
                  <a:gd name="connsiteX2" fmla="*/ 1072262 w 1083820"/>
                  <a:gd name="connsiteY2" fmla="*/ 914400 h 914400"/>
                  <a:gd name="connsiteX3" fmla="*/ 11558 w 1083820"/>
                  <a:gd name="connsiteY3" fmla="*/ 914400 h 91440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32873 w 752471"/>
                  <a:gd name="connsiteY0" fmla="*/ 774700 h 969970"/>
                  <a:gd name="connsiteX1" fmla="*/ 220325 w 752471"/>
                  <a:gd name="connsiteY1" fmla="*/ 0 h 969970"/>
                  <a:gd name="connsiteX2" fmla="*/ 750677 w 752471"/>
                  <a:gd name="connsiteY2" fmla="*/ 914400 h 969970"/>
                  <a:gd name="connsiteX3" fmla="*/ 32873 w 752471"/>
                  <a:gd name="connsiteY3" fmla="*/ 774700 h 969970"/>
                  <a:gd name="connsiteX0" fmla="*/ 83351 w 804599"/>
                  <a:gd name="connsiteY0" fmla="*/ 774849 h 970119"/>
                  <a:gd name="connsiteX1" fmla="*/ 270803 w 804599"/>
                  <a:gd name="connsiteY1" fmla="*/ 149 h 970119"/>
                  <a:gd name="connsiteX2" fmla="*/ 801155 w 804599"/>
                  <a:gd name="connsiteY2" fmla="*/ 914549 h 970119"/>
                  <a:gd name="connsiteX3" fmla="*/ 83351 w 804599"/>
                  <a:gd name="connsiteY3" fmla="*/ 774849 h 970119"/>
                  <a:gd name="connsiteX0" fmla="*/ 18984 w 763743"/>
                  <a:gd name="connsiteY0" fmla="*/ 597084 h 774288"/>
                  <a:gd name="connsiteX1" fmla="*/ 396936 w 763743"/>
                  <a:gd name="connsiteY1" fmla="*/ 184 h 774288"/>
                  <a:gd name="connsiteX2" fmla="*/ 736788 w 763743"/>
                  <a:gd name="connsiteY2" fmla="*/ 736784 h 774288"/>
                  <a:gd name="connsiteX3" fmla="*/ 18984 w 763743"/>
                  <a:gd name="connsiteY3" fmla="*/ 597084 h 7742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63743" h="774288">
                    <a:moveTo>
                      <a:pt x="18984" y="597084"/>
                    </a:moveTo>
                    <a:cubicBezTo>
                      <a:pt x="-37658" y="474317"/>
                      <a:pt x="16952" y="12884"/>
                      <a:pt x="396936" y="184"/>
                    </a:cubicBezTo>
                    <a:cubicBezTo>
                      <a:pt x="776920" y="-12516"/>
                      <a:pt x="799780" y="637301"/>
                      <a:pt x="736788" y="736784"/>
                    </a:cubicBezTo>
                    <a:cubicBezTo>
                      <a:pt x="673796" y="836267"/>
                      <a:pt x="75626" y="719851"/>
                      <a:pt x="18984" y="597084"/>
                    </a:cubicBez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30" name="Oval 29">
                <a:extLst>
                  <a:ext uri="{FF2B5EF4-FFF2-40B4-BE49-F238E27FC236}">
                    <a16:creationId xmlns:a16="http://schemas.microsoft.com/office/drawing/2014/main" id="{FD39B0E3-A0E8-46F6-C81B-B7A2CB25C687}"/>
                  </a:ext>
                </a:extLst>
              </p:cNvPr>
              <p:cNvSpPr/>
              <p:nvPr/>
            </p:nvSpPr>
            <p:spPr>
              <a:xfrm>
                <a:off x="4725344" y="3140587"/>
                <a:ext cx="304800" cy="272026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31" name="Freeform 5">
                <a:extLst>
                  <a:ext uri="{FF2B5EF4-FFF2-40B4-BE49-F238E27FC236}">
                    <a16:creationId xmlns:a16="http://schemas.microsoft.com/office/drawing/2014/main" id="{98997BF9-9B4D-6EDB-7FFC-09B326ACD957}"/>
                  </a:ext>
                </a:extLst>
              </p:cNvPr>
              <p:cNvSpPr/>
              <p:nvPr/>
            </p:nvSpPr>
            <p:spPr>
              <a:xfrm>
                <a:off x="1397000" y="2793999"/>
                <a:ext cx="2011119" cy="1284801"/>
              </a:xfrm>
              <a:custGeom>
                <a:avLst/>
                <a:gdLst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672 w 2007172"/>
                  <a:gd name="connsiteY0" fmla="*/ 152400 h 1282700"/>
                  <a:gd name="connsiteX1" fmla="*/ 191072 w 2007172"/>
                  <a:gd name="connsiteY1" fmla="*/ 292100 h 1282700"/>
                  <a:gd name="connsiteX2" fmla="*/ 127572 w 2007172"/>
                  <a:gd name="connsiteY2" fmla="*/ 622300 h 1282700"/>
                  <a:gd name="connsiteX3" fmla="*/ 241872 w 2007172"/>
                  <a:gd name="connsiteY3" fmla="*/ 825500 h 1282700"/>
                  <a:gd name="connsiteX4" fmla="*/ 470472 w 2007172"/>
                  <a:gd name="connsiteY4" fmla="*/ 1041400 h 1282700"/>
                  <a:gd name="connsiteX5" fmla="*/ 851472 w 2007172"/>
                  <a:gd name="connsiteY5" fmla="*/ 1143000 h 1282700"/>
                  <a:gd name="connsiteX6" fmla="*/ 1168972 w 2007172"/>
                  <a:gd name="connsiteY6" fmla="*/ 1155700 h 1282700"/>
                  <a:gd name="connsiteX7" fmla="*/ 1588072 w 2007172"/>
                  <a:gd name="connsiteY7" fmla="*/ 1130300 h 1282700"/>
                  <a:gd name="connsiteX8" fmla="*/ 2007172 w 2007172"/>
                  <a:gd name="connsiteY8" fmla="*/ 1028700 h 1282700"/>
                  <a:gd name="connsiteX9" fmla="*/ 1778572 w 2007172"/>
                  <a:gd name="connsiteY9" fmla="*/ 1206500 h 1282700"/>
                  <a:gd name="connsiteX10" fmla="*/ 1295972 w 2007172"/>
                  <a:gd name="connsiteY10" fmla="*/ 1270000 h 1282700"/>
                  <a:gd name="connsiteX11" fmla="*/ 991172 w 2007172"/>
                  <a:gd name="connsiteY11" fmla="*/ 1282700 h 1282700"/>
                  <a:gd name="connsiteX12" fmla="*/ 584772 w 2007172"/>
                  <a:gd name="connsiteY12" fmla="*/ 1270000 h 1282700"/>
                  <a:gd name="connsiteX13" fmla="*/ 292672 w 2007172"/>
                  <a:gd name="connsiteY13" fmla="*/ 1104900 h 1282700"/>
                  <a:gd name="connsiteX14" fmla="*/ 102172 w 2007172"/>
                  <a:gd name="connsiteY14" fmla="*/ 889000 h 1282700"/>
                  <a:gd name="connsiteX15" fmla="*/ 13272 w 2007172"/>
                  <a:gd name="connsiteY15" fmla="*/ 660400 h 1282700"/>
                  <a:gd name="connsiteX16" fmla="*/ 572 w 2007172"/>
                  <a:gd name="connsiteY16" fmla="*/ 419100 h 1282700"/>
                  <a:gd name="connsiteX17" fmla="*/ 572 w 2007172"/>
                  <a:gd name="connsiteY17" fmla="*/ 419100 h 1282700"/>
                  <a:gd name="connsiteX18" fmla="*/ 89472 w 2007172"/>
                  <a:gd name="connsiteY18" fmla="*/ 139700 h 1282700"/>
                  <a:gd name="connsiteX19" fmla="*/ 279972 w 2007172"/>
                  <a:gd name="connsiteY19" fmla="*/ 0 h 1282700"/>
                  <a:gd name="connsiteX20" fmla="*/ 356172 w 2007172"/>
                  <a:gd name="connsiteY20" fmla="*/ 0 h 1282700"/>
                  <a:gd name="connsiteX21" fmla="*/ 356172 w 2007172"/>
                  <a:gd name="connsiteY21" fmla="*/ 152400 h 1282700"/>
                  <a:gd name="connsiteX22" fmla="*/ 356172 w 2007172"/>
                  <a:gd name="connsiteY22" fmla="*/ 152400 h 1282700"/>
                  <a:gd name="connsiteX23" fmla="*/ 292672 w 2007172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2700"/>
                  <a:gd name="connsiteX1" fmla="*/ 190500 w 2006600"/>
                  <a:gd name="connsiteY1" fmla="*/ 292100 h 1282700"/>
                  <a:gd name="connsiteX2" fmla="*/ 127000 w 2006600"/>
                  <a:gd name="connsiteY2" fmla="*/ 622300 h 1282700"/>
                  <a:gd name="connsiteX3" fmla="*/ 241300 w 2006600"/>
                  <a:gd name="connsiteY3" fmla="*/ 825500 h 1282700"/>
                  <a:gd name="connsiteX4" fmla="*/ 469900 w 2006600"/>
                  <a:gd name="connsiteY4" fmla="*/ 1041400 h 1282700"/>
                  <a:gd name="connsiteX5" fmla="*/ 850900 w 2006600"/>
                  <a:gd name="connsiteY5" fmla="*/ 1143000 h 1282700"/>
                  <a:gd name="connsiteX6" fmla="*/ 1168400 w 2006600"/>
                  <a:gd name="connsiteY6" fmla="*/ 1155700 h 1282700"/>
                  <a:gd name="connsiteX7" fmla="*/ 1587500 w 2006600"/>
                  <a:gd name="connsiteY7" fmla="*/ 1130300 h 1282700"/>
                  <a:gd name="connsiteX8" fmla="*/ 2006600 w 2006600"/>
                  <a:gd name="connsiteY8" fmla="*/ 1028700 h 1282700"/>
                  <a:gd name="connsiteX9" fmla="*/ 1778000 w 2006600"/>
                  <a:gd name="connsiteY9" fmla="*/ 1206500 h 1282700"/>
                  <a:gd name="connsiteX10" fmla="*/ 1295400 w 2006600"/>
                  <a:gd name="connsiteY10" fmla="*/ 1270000 h 1282700"/>
                  <a:gd name="connsiteX11" fmla="*/ 990600 w 2006600"/>
                  <a:gd name="connsiteY11" fmla="*/ 1282700 h 1282700"/>
                  <a:gd name="connsiteX12" fmla="*/ 584200 w 2006600"/>
                  <a:gd name="connsiteY12" fmla="*/ 1270000 h 1282700"/>
                  <a:gd name="connsiteX13" fmla="*/ 292100 w 2006600"/>
                  <a:gd name="connsiteY13" fmla="*/ 1104900 h 1282700"/>
                  <a:gd name="connsiteX14" fmla="*/ 101600 w 2006600"/>
                  <a:gd name="connsiteY14" fmla="*/ 889000 h 1282700"/>
                  <a:gd name="connsiteX15" fmla="*/ 12700 w 2006600"/>
                  <a:gd name="connsiteY15" fmla="*/ 660400 h 1282700"/>
                  <a:gd name="connsiteX16" fmla="*/ 0 w 2006600"/>
                  <a:gd name="connsiteY16" fmla="*/ 419100 h 1282700"/>
                  <a:gd name="connsiteX17" fmla="*/ 0 w 2006600"/>
                  <a:gd name="connsiteY17" fmla="*/ 419100 h 1282700"/>
                  <a:gd name="connsiteX18" fmla="*/ 88900 w 2006600"/>
                  <a:gd name="connsiteY18" fmla="*/ 139700 h 1282700"/>
                  <a:gd name="connsiteX19" fmla="*/ 279400 w 2006600"/>
                  <a:gd name="connsiteY19" fmla="*/ 0 h 1282700"/>
                  <a:gd name="connsiteX20" fmla="*/ 355600 w 2006600"/>
                  <a:gd name="connsiteY20" fmla="*/ 0 h 1282700"/>
                  <a:gd name="connsiteX21" fmla="*/ 355600 w 2006600"/>
                  <a:gd name="connsiteY21" fmla="*/ 152400 h 1282700"/>
                  <a:gd name="connsiteX22" fmla="*/ 355600 w 2006600"/>
                  <a:gd name="connsiteY22" fmla="*/ 152400 h 1282700"/>
                  <a:gd name="connsiteX23" fmla="*/ 292100 w 2006600"/>
                  <a:gd name="connsiteY23" fmla="*/ 152400 h 1282700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06600"/>
                  <a:gd name="connsiteY0" fmla="*/ 152400 h 1287516"/>
                  <a:gd name="connsiteX1" fmla="*/ 190500 w 2006600"/>
                  <a:gd name="connsiteY1" fmla="*/ 292100 h 1287516"/>
                  <a:gd name="connsiteX2" fmla="*/ 127000 w 2006600"/>
                  <a:gd name="connsiteY2" fmla="*/ 622300 h 1287516"/>
                  <a:gd name="connsiteX3" fmla="*/ 241300 w 2006600"/>
                  <a:gd name="connsiteY3" fmla="*/ 825500 h 1287516"/>
                  <a:gd name="connsiteX4" fmla="*/ 469900 w 2006600"/>
                  <a:gd name="connsiteY4" fmla="*/ 1041400 h 1287516"/>
                  <a:gd name="connsiteX5" fmla="*/ 850900 w 2006600"/>
                  <a:gd name="connsiteY5" fmla="*/ 1143000 h 1287516"/>
                  <a:gd name="connsiteX6" fmla="*/ 1168400 w 2006600"/>
                  <a:gd name="connsiteY6" fmla="*/ 1155700 h 1287516"/>
                  <a:gd name="connsiteX7" fmla="*/ 1587500 w 2006600"/>
                  <a:gd name="connsiteY7" fmla="*/ 1130300 h 1287516"/>
                  <a:gd name="connsiteX8" fmla="*/ 2006600 w 2006600"/>
                  <a:gd name="connsiteY8" fmla="*/ 1028700 h 1287516"/>
                  <a:gd name="connsiteX9" fmla="*/ 1778000 w 2006600"/>
                  <a:gd name="connsiteY9" fmla="*/ 1206500 h 1287516"/>
                  <a:gd name="connsiteX10" fmla="*/ 1295400 w 2006600"/>
                  <a:gd name="connsiteY10" fmla="*/ 1270000 h 1287516"/>
                  <a:gd name="connsiteX11" fmla="*/ 990600 w 2006600"/>
                  <a:gd name="connsiteY11" fmla="*/ 1282700 h 1287516"/>
                  <a:gd name="connsiteX12" fmla="*/ 584200 w 2006600"/>
                  <a:gd name="connsiteY12" fmla="*/ 1270000 h 1287516"/>
                  <a:gd name="connsiteX13" fmla="*/ 292100 w 2006600"/>
                  <a:gd name="connsiteY13" fmla="*/ 1104900 h 1287516"/>
                  <a:gd name="connsiteX14" fmla="*/ 101600 w 2006600"/>
                  <a:gd name="connsiteY14" fmla="*/ 889000 h 1287516"/>
                  <a:gd name="connsiteX15" fmla="*/ 12700 w 2006600"/>
                  <a:gd name="connsiteY15" fmla="*/ 660400 h 1287516"/>
                  <a:gd name="connsiteX16" fmla="*/ 0 w 2006600"/>
                  <a:gd name="connsiteY16" fmla="*/ 419100 h 1287516"/>
                  <a:gd name="connsiteX17" fmla="*/ 0 w 2006600"/>
                  <a:gd name="connsiteY17" fmla="*/ 419100 h 1287516"/>
                  <a:gd name="connsiteX18" fmla="*/ 88900 w 2006600"/>
                  <a:gd name="connsiteY18" fmla="*/ 139700 h 1287516"/>
                  <a:gd name="connsiteX19" fmla="*/ 279400 w 2006600"/>
                  <a:gd name="connsiteY19" fmla="*/ 0 h 1287516"/>
                  <a:gd name="connsiteX20" fmla="*/ 355600 w 2006600"/>
                  <a:gd name="connsiteY20" fmla="*/ 0 h 1287516"/>
                  <a:gd name="connsiteX21" fmla="*/ 355600 w 2006600"/>
                  <a:gd name="connsiteY21" fmla="*/ 152400 h 1287516"/>
                  <a:gd name="connsiteX22" fmla="*/ 355600 w 2006600"/>
                  <a:gd name="connsiteY22" fmla="*/ 152400 h 1287516"/>
                  <a:gd name="connsiteX23" fmla="*/ 292100 w 2006600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355600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587500 w 2011119"/>
                  <a:gd name="connsiteY7" fmla="*/ 1130300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55700 h 1287516"/>
                  <a:gd name="connsiteX7" fmla="*/ 1707243 w 2011119"/>
                  <a:gd name="connsiteY7" fmla="*/ 11139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139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850900 w 2011119"/>
                  <a:gd name="connsiteY5" fmla="*/ 1143000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520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7516"/>
                  <a:gd name="connsiteX1" fmla="*/ 190500 w 2011119"/>
                  <a:gd name="connsiteY1" fmla="*/ 292100 h 1287516"/>
                  <a:gd name="connsiteX2" fmla="*/ 127000 w 2011119"/>
                  <a:gd name="connsiteY2" fmla="*/ 622300 h 1287516"/>
                  <a:gd name="connsiteX3" fmla="*/ 241300 w 2011119"/>
                  <a:gd name="connsiteY3" fmla="*/ 825500 h 1287516"/>
                  <a:gd name="connsiteX4" fmla="*/ 469900 w 2011119"/>
                  <a:gd name="connsiteY4" fmla="*/ 1041400 h 1287516"/>
                  <a:gd name="connsiteX5" fmla="*/ 774700 w 2011119"/>
                  <a:gd name="connsiteY5" fmla="*/ 1159328 h 1287516"/>
                  <a:gd name="connsiteX6" fmla="*/ 1168400 w 2011119"/>
                  <a:gd name="connsiteY6" fmla="*/ 1193800 h 1287516"/>
                  <a:gd name="connsiteX7" fmla="*/ 1707243 w 2011119"/>
                  <a:gd name="connsiteY7" fmla="*/ 1152071 h 1287516"/>
                  <a:gd name="connsiteX8" fmla="*/ 2006600 w 2011119"/>
                  <a:gd name="connsiteY8" fmla="*/ 1028700 h 1287516"/>
                  <a:gd name="connsiteX9" fmla="*/ 1778000 w 2011119"/>
                  <a:gd name="connsiteY9" fmla="*/ 1206500 h 1287516"/>
                  <a:gd name="connsiteX10" fmla="*/ 1295400 w 2011119"/>
                  <a:gd name="connsiteY10" fmla="*/ 1270000 h 1287516"/>
                  <a:gd name="connsiteX11" fmla="*/ 990600 w 2011119"/>
                  <a:gd name="connsiteY11" fmla="*/ 1282700 h 1287516"/>
                  <a:gd name="connsiteX12" fmla="*/ 584200 w 2011119"/>
                  <a:gd name="connsiteY12" fmla="*/ 1270000 h 1287516"/>
                  <a:gd name="connsiteX13" fmla="*/ 292100 w 2011119"/>
                  <a:gd name="connsiteY13" fmla="*/ 1104900 h 1287516"/>
                  <a:gd name="connsiteX14" fmla="*/ 101600 w 2011119"/>
                  <a:gd name="connsiteY14" fmla="*/ 889000 h 1287516"/>
                  <a:gd name="connsiteX15" fmla="*/ 12700 w 2011119"/>
                  <a:gd name="connsiteY15" fmla="*/ 660400 h 1287516"/>
                  <a:gd name="connsiteX16" fmla="*/ 0 w 2011119"/>
                  <a:gd name="connsiteY16" fmla="*/ 419100 h 1287516"/>
                  <a:gd name="connsiteX17" fmla="*/ 0 w 2011119"/>
                  <a:gd name="connsiteY17" fmla="*/ 419100 h 1287516"/>
                  <a:gd name="connsiteX18" fmla="*/ 88900 w 2011119"/>
                  <a:gd name="connsiteY18" fmla="*/ 139700 h 1287516"/>
                  <a:gd name="connsiteX19" fmla="*/ 279400 w 2011119"/>
                  <a:gd name="connsiteY19" fmla="*/ 0 h 1287516"/>
                  <a:gd name="connsiteX20" fmla="*/ 404586 w 2011119"/>
                  <a:gd name="connsiteY20" fmla="*/ 0 h 1287516"/>
                  <a:gd name="connsiteX21" fmla="*/ 355600 w 2011119"/>
                  <a:gd name="connsiteY21" fmla="*/ 152400 h 1287516"/>
                  <a:gd name="connsiteX22" fmla="*/ 355600 w 2011119"/>
                  <a:gd name="connsiteY22" fmla="*/ 152400 h 1287516"/>
                  <a:gd name="connsiteX23" fmla="*/ 292100 w 2011119"/>
                  <a:gd name="connsiteY23" fmla="*/ 152400 h 1287516"/>
                  <a:gd name="connsiteX0" fmla="*/ 292100 w 2011119"/>
                  <a:gd name="connsiteY0" fmla="*/ 152400 h 1284801"/>
                  <a:gd name="connsiteX1" fmla="*/ 190500 w 2011119"/>
                  <a:gd name="connsiteY1" fmla="*/ 292100 h 1284801"/>
                  <a:gd name="connsiteX2" fmla="*/ 127000 w 2011119"/>
                  <a:gd name="connsiteY2" fmla="*/ 622300 h 1284801"/>
                  <a:gd name="connsiteX3" fmla="*/ 241300 w 2011119"/>
                  <a:gd name="connsiteY3" fmla="*/ 825500 h 1284801"/>
                  <a:gd name="connsiteX4" fmla="*/ 469900 w 2011119"/>
                  <a:gd name="connsiteY4" fmla="*/ 1041400 h 1284801"/>
                  <a:gd name="connsiteX5" fmla="*/ 774700 w 2011119"/>
                  <a:gd name="connsiteY5" fmla="*/ 1159328 h 1284801"/>
                  <a:gd name="connsiteX6" fmla="*/ 1168400 w 2011119"/>
                  <a:gd name="connsiteY6" fmla="*/ 1193800 h 1284801"/>
                  <a:gd name="connsiteX7" fmla="*/ 1707243 w 2011119"/>
                  <a:gd name="connsiteY7" fmla="*/ 1152071 h 1284801"/>
                  <a:gd name="connsiteX8" fmla="*/ 2006600 w 2011119"/>
                  <a:gd name="connsiteY8" fmla="*/ 1028700 h 1284801"/>
                  <a:gd name="connsiteX9" fmla="*/ 1778000 w 2011119"/>
                  <a:gd name="connsiteY9" fmla="*/ 1206500 h 1284801"/>
                  <a:gd name="connsiteX10" fmla="*/ 1295400 w 2011119"/>
                  <a:gd name="connsiteY10" fmla="*/ 1270000 h 1284801"/>
                  <a:gd name="connsiteX11" fmla="*/ 990600 w 2011119"/>
                  <a:gd name="connsiteY11" fmla="*/ 1282700 h 1284801"/>
                  <a:gd name="connsiteX12" fmla="*/ 573314 w 2011119"/>
                  <a:gd name="connsiteY12" fmla="*/ 1237343 h 1284801"/>
                  <a:gd name="connsiteX13" fmla="*/ 292100 w 2011119"/>
                  <a:gd name="connsiteY13" fmla="*/ 1104900 h 1284801"/>
                  <a:gd name="connsiteX14" fmla="*/ 101600 w 2011119"/>
                  <a:gd name="connsiteY14" fmla="*/ 889000 h 1284801"/>
                  <a:gd name="connsiteX15" fmla="*/ 12700 w 2011119"/>
                  <a:gd name="connsiteY15" fmla="*/ 660400 h 1284801"/>
                  <a:gd name="connsiteX16" fmla="*/ 0 w 2011119"/>
                  <a:gd name="connsiteY16" fmla="*/ 419100 h 1284801"/>
                  <a:gd name="connsiteX17" fmla="*/ 0 w 2011119"/>
                  <a:gd name="connsiteY17" fmla="*/ 419100 h 1284801"/>
                  <a:gd name="connsiteX18" fmla="*/ 88900 w 2011119"/>
                  <a:gd name="connsiteY18" fmla="*/ 139700 h 1284801"/>
                  <a:gd name="connsiteX19" fmla="*/ 279400 w 2011119"/>
                  <a:gd name="connsiteY19" fmla="*/ 0 h 1284801"/>
                  <a:gd name="connsiteX20" fmla="*/ 404586 w 2011119"/>
                  <a:gd name="connsiteY20" fmla="*/ 0 h 1284801"/>
                  <a:gd name="connsiteX21" fmla="*/ 355600 w 2011119"/>
                  <a:gd name="connsiteY21" fmla="*/ 152400 h 1284801"/>
                  <a:gd name="connsiteX22" fmla="*/ 355600 w 2011119"/>
                  <a:gd name="connsiteY22" fmla="*/ 152400 h 1284801"/>
                  <a:gd name="connsiteX23" fmla="*/ 292100 w 2011119"/>
                  <a:gd name="connsiteY23" fmla="*/ 152400 h 1284801"/>
                  <a:gd name="connsiteX0" fmla="*/ 292100 w 2011119"/>
                  <a:gd name="connsiteY0" fmla="*/ 152400 h 1284801"/>
                  <a:gd name="connsiteX1" fmla="*/ 190500 w 2011119"/>
                  <a:gd name="connsiteY1" fmla="*/ 292100 h 1284801"/>
                  <a:gd name="connsiteX2" fmla="*/ 159657 w 2011119"/>
                  <a:gd name="connsiteY2" fmla="*/ 622300 h 1284801"/>
                  <a:gd name="connsiteX3" fmla="*/ 241300 w 2011119"/>
                  <a:gd name="connsiteY3" fmla="*/ 825500 h 1284801"/>
                  <a:gd name="connsiteX4" fmla="*/ 469900 w 2011119"/>
                  <a:gd name="connsiteY4" fmla="*/ 1041400 h 1284801"/>
                  <a:gd name="connsiteX5" fmla="*/ 774700 w 2011119"/>
                  <a:gd name="connsiteY5" fmla="*/ 1159328 h 1284801"/>
                  <a:gd name="connsiteX6" fmla="*/ 1168400 w 2011119"/>
                  <a:gd name="connsiteY6" fmla="*/ 1193800 h 1284801"/>
                  <a:gd name="connsiteX7" fmla="*/ 1707243 w 2011119"/>
                  <a:gd name="connsiteY7" fmla="*/ 1152071 h 1284801"/>
                  <a:gd name="connsiteX8" fmla="*/ 2006600 w 2011119"/>
                  <a:gd name="connsiteY8" fmla="*/ 1028700 h 1284801"/>
                  <a:gd name="connsiteX9" fmla="*/ 1778000 w 2011119"/>
                  <a:gd name="connsiteY9" fmla="*/ 1206500 h 1284801"/>
                  <a:gd name="connsiteX10" fmla="*/ 1295400 w 2011119"/>
                  <a:gd name="connsiteY10" fmla="*/ 1270000 h 1284801"/>
                  <a:gd name="connsiteX11" fmla="*/ 990600 w 2011119"/>
                  <a:gd name="connsiteY11" fmla="*/ 1282700 h 1284801"/>
                  <a:gd name="connsiteX12" fmla="*/ 573314 w 2011119"/>
                  <a:gd name="connsiteY12" fmla="*/ 1237343 h 1284801"/>
                  <a:gd name="connsiteX13" fmla="*/ 292100 w 2011119"/>
                  <a:gd name="connsiteY13" fmla="*/ 1104900 h 1284801"/>
                  <a:gd name="connsiteX14" fmla="*/ 101600 w 2011119"/>
                  <a:gd name="connsiteY14" fmla="*/ 889000 h 1284801"/>
                  <a:gd name="connsiteX15" fmla="*/ 12700 w 2011119"/>
                  <a:gd name="connsiteY15" fmla="*/ 660400 h 1284801"/>
                  <a:gd name="connsiteX16" fmla="*/ 0 w 2011119"/>
                  <a:gd name="connsiteY16" fmla="*/ 419100 h 1284801"/>
                  <a:gd name="connsiteX17" fmla="*/ 0 w 2011119"/>
                  <a:gd name="connsiteY17" fmla="*/ 419100 h 1284801"/>
                  <a:gd name="connsiteX18" fmla="*/ 88900 w 2011119"/>
                  <a:gd name="connsiteY18" fmla="*/ 139700 h 1284801"/>
                  <a:gd name="connsiteX19" fmla="*/ 279400 w 2011119"/>
                  <a:gd name="connsiteY19" fmla="*/ 0 h 1284801"/>
                  <a:gd name="connsiteX20" fmla="*/ 404586 w 2011119"/>
                  <a:gd name="connsiteY20" fmla="*/ 0 h 1284801"/>
                  <a:gd name="connsiteX21" fmla="*/ 355600 w 2011119"/>
                  <a:gd name="connsiteY21" fmla="*/ 152400 h 1284801"/>
                  <a:gd name="connsiteX22" fmla="*/ 355600 w 2011119"/>
                  <a:gd name="connsiteY22" fmla="*/ 152400 h 1284801"/>
                  <a:gd name="connsiteX23" fmla="*/ 292100 w 2011119"/>
                  <a:gd name="connsiteY23" fmla="*/ 152400 h 12848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2011119" h="1284801">
                    <a:moveTo>
                      <a:pt x="292100" y="152400"/>
                    </a:moveTo>
                    <a:cubicBezTo>
                      <a:pt x="264583" y="175683"/>
                      <a:pt x="212574" y="213783"/>
                      <a:pt x="190500" y="292100"/>
                    </a:cubicBezTo>
                    <a:cubicBezTo>
                      <a:pt x="168426" y="370417"/>
                      <a:pt x="151190" y="533400"/>
                      <a:pt x="159657" y="622300"/>
                    </a:cubicBezTo>
                    <a:cubicBezTo>
                      <a:pt x="168124" y="711200"/>
                      <a:pt x="189593" y="755650"/>
                      <a:pt x="241300" y="825500"/>
                    </a:cubicBezTo>
                    <a:cubicBezTo>
                      <a:pt x="293007" y="895350"/>
                      <a:pt x="381000" y="985762"/>
                      <a:pt x="469900" y="1041400"/>
                    </a:cubicBezTo>
                    <a:cubicBezTo>
                      <a:pt x="558800" y="1097038"/>
                      <a:pt x="658283" y="1133928"/>
                      <a:pt x="774700" y="1159328"/>
                    </a:cubicBezTo>
                    <a:cubicBezTo>
                      <a:pt x="891117" y="1184728"/>
                      <a:pt x="1012976" y="1195009"/>
                      <a:pt x="1168400" y="1193800"/>
                    </a:cubicBezTo>
                    <a:cubicBezTo>
                      <a:pt x="1323824" y="1192591"/>
                      <a:pt x="1567543" y="1179588"/>
                      <a:pt x="1707243" y="1152071"/>
                    </a:cubicBezTo>
                    <a:cubicBezTo>
                      <a:pt x="1846943" y="1124554"/>
                      <a:pt x="1906814" y="1057124"/>
                      <a:pt x="2006600" y="1028700"/>
                    </a:cubicBezTo>
                    <a:cubicBezTo>
                      <a:pt x="2038350" y="1041400"/>
                      <a:pt x="1896533" y="1166283"/>
                      <a:pt x="1778000" y="1206500"/>
                    </a:cubicBezTo>
                    <a:cubicBezTo>
                      <a:pt x="1659467" y="1246717"/>
                      <a:pt x="1426633" y="1257300"/>
                      <a:pt x="1295400" y="1270000"/>
                    </a:cubicBezTo>
                    <a:cubicBezTo>
                      <a:pt x="1164167" y="1282700"/>
                      <a:pt x="1110948" y="1288143"/>
                      <a:pt x="990600" y="1282700"/>
                    </a:cubicBezTo>
                    <a:cubicBezTo>
                      <a:pt x="870252" y="1277257"/>
                      <a:pt x="689731" y="1266976"/>
                      <a:pt x="573314" y="1237343"/>
                    </a:cubicBezTo>
                    <a:cubicBezTo>
                      <a:pt x="456897" y="1207710"/>
                      <a:pt x="370719" y="1162957"/>
                      <a:pt x="292100" y="1104900"/>
                    </a:cubicBezTo>
                    <a:cubicBezTo>
                      <a:pt x="213481" y="1046843"/>
                      <a:pt x="148167" y="963083"/>
                      <a:pt x="101600" y="889000"/>
                    </a:cubicBezTo>
                    <a:cubicBezTo>
                      <a:pt x="55033" y="814917"/>
                      <a:pt x="29633" y="738717"/>
                      <a:pt x="12700" y="660400"/>
                    </a:cubicBezTo>
                    <a:cubicBezTo>
                      <a:pt x="-4233" y="582083"/>
                      <a:pt x="2117" y="459317"/>
                      <a:pt x="0" y="419100"/>
                    </a:cubicBezTo>
                    <a:lnTo>
                      <a:pt x="0" y="419100"/>
                    </a:lnTo>
                    <a:cubicBezTo>
                      <a:pt x="0" y="419100"/>
                      <a:pt x="42333" y="209550"/>
                      <a:pt x="88900" y="139700"/>
                    </a:cubicBezTo>
                    <a:cubicBezTo>
                      <a:pt x="135467" y="69850"/>
                      <a:pt x="234950" y="23283"/>
                      <a:pt x="279400" y="0"/>
                    </a:cubicBezTo>
                    <a:lnTo>
                      <a:pt x="404586" y="0"/>
                    </a:lnTo>
                    <a:lnTo>
                      <a:pt x="355600" y="152400"/>
                    </a:lnTo>
                    <a:lnTo>
                      <a:pt x="355600" y="152400"/>
                    </a:lnTo>
                    <a:lnTo>
                      <a:pt x="292100" y="152400"/>
                    </a:ln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DD892CF9-3DC3-C211-E1D2-8DD1535E6892}"/>
                </a:ext>
              </a:extLst>
            </p:cNvPr>
            <p:cNvSpPr/>
            <p:nvPr/>
          </p:nvSpPr>
          <p:spPr>
            <a:xfrm>
              <a:off x="1332660" y="1389600"/>
              <a:ext cx="152400" cy="1524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85282463-CD50-EC3C-2B4D-B71A7B8CABBD}"/>
              </a:ext>
            </a:extLst>
          </p:cNvPr>
          <p:cNvSpPr txBox="1"/>
          <p:nvPr/>
        </p:nvSpPr>
        <p:spPr>
          <a:xfrm>
            <a:off x="5275728" y="459584"/>
            <a:ext cx="105509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nd of Study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y 91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33CE5F3-8EA9-5490-E7BA-1B444B030703}"/>
              </a:ext>
            </a:extLst>
          </p:cNvPr>
          <p:cNvCxnSpPr/>
          <p:nvPr/>
        </p:nvCxnSpPr>
        <p:spPr>
          <a:xfrm>
            <a:off x="4827694" y="1405699"/>
            <a:ext cx="93391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6495C2B-8C08-C88B-9468-69A168C9A8D8}"/>
              </a:ext>
            </a:extLst>
          </p:cNvPr>
          <p:cNvSpPr txBox="1"/>
          <p:nvPr/>
        </p:nvSpPr>
        <p:spPr>
          <a:xfrm>
            <a:off x="4932345" y="1174044"/>
            <a:ext cx="7328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3AE2BE9-4F47-4415-1A77-6A4D8EA38D8C}"/>
              </a:ext>
            </a:extLst>
          </p:cNvPr>
          <p:cNvSpPr txBox="1"/>
          <p:nvPr/>
        </p:nvSpPr>
        <p:spPr>
          <a:xfrm>
            <a:off x="94403" y="1905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EEE6E87-3682-235B-CDB3-AAFACB3A24D9}"/>
              </a:ext>
            </a:extLst>
          </p:cNvPr>
          <p:cNvSpPr txBox="1"/>
          <p:nvPr/>
        </p:nvSpPr>
        <p:spPr>
          <a:xfrm>
            <a:off x="1596182" y="2855226"/>
            <a:ext cx="7328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</a:p>
          <a:p>
            <a:pPr algn="ctr"/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.i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1EB5C3F-A241-596B-55A8-BBDC738952BA}"/>
              </a:ext>
            </a:extLst>
          </p:cNvPr>
          <p:cNvSpPr txBox="1"/>
          <p:nvPr/>
        </p:nvSpPr>
        <p:spPr>
          <a:xfrm>
            <a:off x="4707718" y="2855226"/>
            <a:ext cx="172996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%Body Weight Change</a:t>
            </a:r>
          </a:p>
          <a:p>
            <a:pPr algn="ctr"/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.i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445D0D8D-0021-2BE1-726E-FE19DA7A4060}"/>
              </a:ext>
            </a:extLst>
          </p:cNvPr>
          <p:cNvSpPr txBox="1"/>
          <p:nvPr/>
        </p:nvSpPr>
        <p:spPr>
          <a:xfrm>
            <a:off x="-17789" y="532973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pic>
        <p:nvPicPr>
          <p:cNvPr id="116" name="Picture 2">
            <a:extLst>
              <a:ext uri="{FF2B5EF4-FFF2-40B4-BE49-F238E27FC236}">
                <a16:creationId xmlns:a16="http://schemas.microsoft.com/office/drawing/2014/main" id="{B8E39311-6B80-4532-B121-7941541022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6531711" flipV="1">
            <a:off x="2057582" y="1454017"/>
            <a:ext cx="457001" cy="559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" name="Picture 111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616DBD13-7871-41AE-BD33-2AEE0082FF0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5926" y="3286113"/>
            <a:ext cx="3459798" cy="179226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463" y="3287339"/>
            <a:ext cx="3237303" cy="1683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6280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3</TotalTime>
  <Words>1031</Words>
  <Application>Microsoft Office PowerPoint</Application>
  <PresentationFormat>Custom</PresentationFormat>
  <Paragraphs>57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ley Kraham</dc:creator>
  <cp:lastModifiedBy>Liu, Kaili</cp:lastModifiedBy>
  <cp:revision>33</cp:revision>
  <dcterms:created xsi:type="dcterms:W3CDTF">2022-05-12T14:16:50Z</dcterms:created>
  <dcterms:modified xsi:type="dcterms:W3CDTF">2023-03-13T03:52:56Z</dcterms:modified>
</cp:coreProperties>
</file>